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theme/themeOverride1.xml" ContentType="application/vnd.openxmlformats-officedocument.themeOverrid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3.xml" ContentType="application/vnd.openxmlformats-officedocument.drawingml.chart+xml"/>
  <Override PartName="/ppt/charts/chart14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5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charts/chart16.xml" ContentType="application/vnd.openxmlformats-officedocument.drawingml.chart+xml"/>
  <Override PartName="/ppt/charts/chart17.xml" ContentType="application/vnd.openxmlformats-officedocument.drawingml.chart+xml"/>
  <Override PartName="/ppt/charts/chart18.xml" ContentType="application/vnd.openxmlformats-officedocument.drawingml.chart+xml"/>
  <Override PartName="/ppt/charts/chart19.xml" ContentType="application/vnd.openxmlformats-officedocument.drawingml.chart+xml"/>
  <Override PartName="/ppt/charts/chart20.xml" ContentType="application/vnd.openxmlformats-officedocument.drawingml.chart+xml"/>
  <Override PartName="/ppt/charts/chart2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308" r:id="rId2"/>
    <p:sldId id="309" r:id="rId3"/>
    <p:sldId id="312" r:id="rId4"/>
    <p:sldId id="314" r:id="rId5"/>
    <p:sldId id="310" r:id="rId6"/>
  </p:sldIdLst>
  <p:sldSz cx="6858000" cy="9144000" type="letter"/>
  <p:notesSz cx="6797675" cy="99266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951" autoAdjust="0"/>
  </p:normalViewPr>
  <p:slideViewPr>
    <p:cSldViewPr showGuides="1">
      <p:cViewPr>
        <p:scale>
          <a:sx n="100" d="100"/>
          <a:sy n="100" d="100"/>
        </p:scale>
        <p:origin x="1044" y="-2268"/>
      </p:cViewPr>
      <p:guideLst>
        <p:guide orient="horz" pos="2880"/>
        <p:guide pos="2160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9.xlsx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0.xlsx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1.xlsx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2.xlsx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3.xlsx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4.xlsx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16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5.xlsx"/></Relationships>
</file>

<file path=ppt/charts/_rels/chart17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6.xlsx"/></Relationships>
</file>

<file path=ppt/charts/_rels/chart18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7.xlsx"/></Relationships>
</file>

<file path=ppt/charts/_rels/chart19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8.xlsx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20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9.xlsx"/></Relationships>
</file>

<file path=ppt/charts/_rels/chart2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0.xlsx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4.xlsx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5.xlsx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7.xml"/><Relationship Id="rId1" Type="http://schemas.microsoft.com/office/2011/relationships/chartStyle" Target="style7.xml"/><Relationship Id="rId4" Type="http://schemas.openxmlformats.org/officeDocument/2006/relationships/package" Target="../embeddings/Microsoft_Excel_Worksheet6.xlsx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7.xlsx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8.xlsx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50193815719123136"/>
          <c:y val="4.183677727241781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8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48179996963636246"/>
          <c:y val="0.23139251681706677"/>
          <c:w val="0.46544403519541638"/>
          <c:h val="0.454111314377576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グラフ (2)'!$AA$11</c:f>
              <c:strCache>
                <c:ptCount val="1"/>
                <c:pt idx="0">
                  <c:v>Serine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accent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DDF2-43ED-8C91-D08392BAD7B4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accent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DDF2-43ED-8C91-D08392BAD7B4}"/>
              </c:ext>
            </c:extLst>
          </c:dPt>
          <c:cat>
            <c:strRef>
              <c:f>'グラフ (2)'!$W$12:$W$15</c:f>
              <c:strCache>
                <c:ptCount val="4"/>
                <c:pt idx="0">
                  <c:v>Central 1</c:v>
                </c:pt>
                <c:pt idx="1">
                  <c:v>Central 2</c:v>
                </c:pt>
                <c:pt idx="2">
                  <c:v>Edge 3</c:v>
                </c:pt>
                <c:pt idx="3">
                  <c:v>Edge 4</c:v>
                </c:pt>
              </c:strCache>
            </c:strRef>
          </c:cat>
          <c:val>
            <c:numRef>
              <c:f>'グラフ (2)'!$AA$12:$AA$15</c:f>
              <c:numCache>
                <c:formatCode>General</c:formatCode>
                <c:ptCount val="4"/>
                <c:pt idx="0">
                  <c:v>7.3348017169173199E-3</c:v>
                </c:pt>
                <c:pt idx="1">
                  <c:v>4.4838645345845881E-3</c:v>
                </c:pt>
                <c:pt idx="2">
                  <c:v>2.5815402586977219E-3</c:v>
                </c:pt>
                <c:pt idx="3">
                  <c:v>1.6588549246926015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DDF2-43ED-8C91-D08392BAD7B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87982936"/>
        <c:axId val="387985288"/>
      </c:barChart>
      <c:catAx>
        <c:axId val="3879829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87985288"/>
        <c:crosses val="autoZero"/>
        <c:auto val="1"/>
        <c:lblAlgn val="ctr"/>
        <c:lblOffset val="100"/>
        <c:noMultiLvlLbl val="0"/>
      </c:catAx>
      <c:valAx>
        <c:axId val="38798528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dirty="0"/>
                  <a:t>Relative</a:t>
                </a:r>
                <a:r>
                  <a:rPr lang="ja-JP" altLang="en-US" dirty="0"/>
                  <a:t> </a:t>
                </a:r>
                <a:r>
                  <a:rPr lang="en-US" altLang="ja-JP" dirty="0"/>
                  <a:t>peak</a:t>
                </a:r>
                <a:r>
                  <a:rPr lang="ja-JP" altLang="en-US" dirty="0"/>
                  <a:t> </a:t>
                </a:r>
                <a:r>
                  <a:rPr lang="en-US" altLang="ja-JP" dirty="0"/>
                  <a:t>level</a:t>
                </a:r>
                <a:endParaRPr lang="ja-JP" altLang="en-US" dirty="0"/>
              </a:p>
            </c:rich>
          </c:tx>
          <c:layout>
            <c:manualLayout>
              <c:xMode val="edge"/>
              <c:yMode val="edge"/>
              <c:x val="1.0840543290471931E-2"/>
              <c:y val="0.2313925168170667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879829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900"/>
      </a:pPr>
      <a:endParaRPr lang="ja-JP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9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ja-JP" sz="900"/>
              <a:t>Glycine</a:t>
            </a:r>
            <a:endParaRPr lang="ja-JP" altLang="en-US" sz="90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20190418 96hr hyp U87'!$O$58</c:f>
              <c:strCache>
                <c:ptCount val="1"/>
                <c:pt idx="0">
                  <c:v>Normoxi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20190418 96hr hyp U87'!$P$61:$Q$61</c:f>
                <c:numCache>
                  <c:formatCode>General</c:formatCode>
                  <c:ptCount val="2"/>
                  <c:pt idx="0">
                    <c:v>0.44932404058154296</c:v>
                  </c:pt>
                  <c:pt idx="1">
                    <c:v>0.28545220381857417</c:v>
                  </c:pt>
                </c:numCache>
              </c:numRef>
            </c:plus>
            <c:minus>
              <c:numRef>
                <c:f>'20190418 96hr hyp U87'!$P$61:$Q$61</c:f>
                <c:numCache>
                  <c:formatCode>General</c:formatCode>
                  <c:ptCount val="2"/>
                  <c:pt idx="0">
                    <c:v>0.44932404058154296</c:v>
                  </c:pt>
                  <c:pt idx="1">
                    <c:v>0.2854522038185741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20190418 96hr hyp U87'!$P$57:$Q$57</c:f>
              <c:strCache>
                <c:ptCount val="2"/>
                <c:pt idx="0">
                  <c:v>U87</c:v>
                </c:pt>
                <c:pt idx="1">
                  <c:v>T98</c:v>
                </c:pt>
              </c:strCache>
            </c:strRef>
          </c:cat>
          <c:val>
            <c:numRef>
              <c:f>'20190418 96hr hyp U87'!$P$58:$Q$58</c:f>
              <c:numCache>
                <c:formatCode>General</c:formatCode>
                <c:ptCount val="2"/>
                <c:pt idx="0">
                  <c:v>1.2667481208931246</c:v>
                </c:pt>
                <c:pt idx="1">
                  <c:v>1.189643459913899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66D-4C87-93DE-4967B55B9040}"/>
            </c:ext>
          </c:extLst>
        </c:ser>
        <c:ser>
          <c:idx val="1"/>
          <c:order val="1"/>
          <c:tx>
            <c:strRef>
              <c:f>'20190418 96hr hyp U87'!$O$59</c:f>
              <c:strCache>
                <c:ptCount val="1"/>
                <c:pt idx="0">
                  <c:v>Hypoxia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20190418 96hr hyp U87'!$P$62:$Q$62</c:f>
                <c:numCache>
                  <c:formatCode>General</c:formatCode>
                  <c:ptCount val="2"/>
                  <c:pt idx="0">
                    <c:v>0.21449715816745785</c:v>
                  </c:pt>
                  <c:pt idx="1">
                    <c:v>0.13554328643067257</c:v>
                  </c:pt>
                </c:numCache>
              </c:numRef>
            </c:plus>
            <c:minus>
              <c:numRef>
                <c:f>'20190418 96hr hyp U87'!$P$62:$Q$62</c:f>
                <c:numCache>
                  <c:formatCode>General</c:formatCode>
                  <c:ptCount val="2"/>
                  <c:pt idx="0">
                    <c:v>0.21449715816745785</c:v>
                  </c:pt>
                  <c:pt idx="1">
                    <c:v>0.1355432864306725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20190418 96hr hyp U87'!$P$57:$Q$57</c:f>
              <c:strCache>
                <c:ptCount val="2"/>
                <c:pt idx="0">
                  <c:v>U87</c:v>
                </c:pt>
                <c:pt idx="1">
                  <c:v>T98</c:v>
                </c:pt>
              </c:strCache>
            </c:strRef>
          </c:cat>
          <c:val>
            <c:numRef>
              <c:f>'20190418 96hr hyp U87'!$P$59:$Q$59</c:f>
              <c:numCache>
                <c:formatCode>General</c:formatCode>
                <c:ptCount val="2"/>
                <c:pt idx="0">
                  <c:v>1.5413926604649018</c:v>
                </c:pt>
                <c:pt idx="1">
                  <c:v>1.157321380710890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66D-4C87-93DE-4967B55B904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30208143"/>
        <c:axId val="1385518911"/>
      </c:barChart>
      <c:catAx>
        <c:axId val="143020814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385518911"/>
        <c:crosses val="autoZero"/>
        <c:auto val="1"/>
        <c:lblAlgn val="ctr"/>
        <c:lblOffset val="100"/>
        <c:noMultiLvlLbl val="0"/>
      </c:catAx>
      <c:valAx>
        <c:axId val="1385518911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b="1" dirty="0"/>
                  <a:t>Relative peak leve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430208143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9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ja-JP" sz="900"/>
              <a:t>Methionine</a:t>
            </a:r>
            <a:endParaRPr lang="ja-JP" altLang="en-US" sz="90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20190418 96hr hyp U87'!$O$58</c:f>
              <c:strCache>
                <c:ptCount val="1"/>
                <c:pt idx="0">
                  <c:v>Normoxi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20190418 96hr hyp U87'!$R$61:$S$61</c:f>
                <c:numCache>
                  <c:formatCode>General</c:formatCode>
                  <c:ptCount val="2"/>
                  <c:pt idx="0">
                    <c:v>9.5230939304450962E-4</c:v>
                  </c:pt>
                  <c:pt idx="1">
                    <c:v>6.0918590694894817E-3</c:v>
                  </c:pt>
                </c:numCache>
              </c:numRef>
            </c:plus>
            <c:minus>
              <c:numRef>
                <c:f>'20190418 96hr hyp U87'!$R$61:$S$61</c:f>
                <c:numCache>
                  <c:formatCode>General</c:formatCode>
                  <c:ptCount val="2"/>
                  <c:pt idx="0">
                    <c:v>9.5230939304450962E-4</c:v>
                  </c:pt>
                  <c:pt idx="1">
                    <c:v>6.0918590694894817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20190418 96hr hyp U87'!$R$57:$S$57</c:f>
              <c:strCache>
                <c:ptCount val="2"/>
                <c:pt idx="0">
                  <c:v>U87</c:v>
                </c:pt>
                <c:pt idx="1">
                  <c:v>T98</c:v>
                </c:pt>
              </c:strCache>
            </c:strRef>
          </c:cat>
          <c:val>
            <c:numRef>
              <c:f>'20190418 96hr hyp U87'!$R$58:$S$58</c:f>
              <c:numCache>
                <c:formatCode>General</c:formatCode>
                <c:ptCount val="2"/>
                <c:pt idx="0">
                  <c:v>1.0642070978868453E-2</c:v>
                </c:pt>
                <c:pt idx="1">
                  <c:v>2.3141894740014702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8BD-497E-A543-D568FC5EB06A}"/>
            </c:ext>
          </c:extLst>
        </c:ser>
        <c:ser>
          <c:idx val="1"/>
          <c:order val="1"/>
          <c:tx>
            <c:strRef>
              <c:f>'20190418 96hr hyp U87'!$O$59</c:f>
              <c:strCache>
                <c:ptCount val="1"/>
                <c:pt idx="0">
                  <c:v>Hypoxia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20190418 96hr hyp U87'!$R$62:$S$62</c:f>
                <c:numCache>
                  <c:formatCode>General</c:formatCode>
                  <c:ptCount val="2"/>
                  <c:pt idx="0">
                    <c:v>2.7551527102930664E-3</c:v>
                  </c:pt>
                  <c:pt idx="1">
                    <c:v>2.8349605082351225E-3</c:v>
                  </c:pt>
                </c:numCache>
              </c:numRef>
            </c:plus>
            <c:minus>
              <c:numRef>
                <c:f>'20190418 96hr hyp U87'!$R$62:$S$62</c:f>
                <c:numCache>
                  <c:formatCode>General</c:formatCode>
                  <c:ptCount val="2"/>
                  <c:pt idx="0">
                    <c:v>2.7551527102930664E-3</c:v>
                  </c:pt>
                  <c:pt idx="1">
                    <c:v>2.8349605082351225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20190418 96hr hyp U87'!$R$57:$S$57</c:f>
              <c:strCache>
                <c:ptCount val="2"/>
                <c:pt idx="0">
                  <c:v>U87</c:v>
                </c:pt>
                <c:pt idx="1">
                  <c:v>T98</c:v>
                </c:pt>
              </c:strCache>
            </c:strRef>
          </c:cat>
          <c:val>
            <c:numRef>
              <c:f>'20190418 96hr hyp U87'!$R$59:$S$59</c:f>
              <c:numCache>
                <c:formatCode>General</c:formatCode>
                <c:ptCount val="2"/>
                <c:pt idx="0">
                  <c:v>1.233266499490359E-2</c:v>
                </c:pt>
                <c:pt idx="1">
                  <c:v>3.1803510282343815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8BD-497E-A543-D568FC5EB06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386189599"/>
        <c:axId val="1385363263"/>
      </c:barChart>
      <c:catAx>
        <c:axId val="138618959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385363263"/>
        <c:crosses val="autoZero"/>
        <c:auto val="1"/>
        <c:lblAlgn val="ctr"/>
        <c:lblOffset val="100"/>
        <c:noMultiLvlLbl val="0"/>
      </c:catAx>
      <c:valAx>
        <c:axId val="138536326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b="1" dirty="0"/>
                  <a:t>Relative peak leve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386189599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9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ja-JP" sz="900"/>
              <a:t>Serine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20190418 96hr hyp U87'!$O$58</c:f>
              <c:strCache>
                <c:ptCount val="1"/>
                <c:pt idx="0">
                  <c:v>Normoxi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20190418 96hr hyp U87'!$T$61:$U$61</c:f>
                <c:numCache>
                  <c:formatCode>General</c:formatCode>
                  <c:ptCount val="2"/>
                  <c:pt idx="0">
                    <c:v>2.9137800141714427E-2</c:v>
                  </c:pt>
                  <c:pt idx="1">
                    <c:v>1.6927591972218461E-2</c:v>
                  </c:pt>
                </c:numCache>
              </c:numRef>
            </c:plus>
            <c:minus>
              <c:numRef>
                <c:f>'20190418 96hr hyp U87'!$T$61:$U$61</c:f>
                <c:numCache>
                  <c:formatCode>General</c:formatCode>
                  <c:ptCount val="2"/>
                  <c:pt idx="0">
                    <c:v>2.9137800141714427E-2</c:v>
                  </c:pt>
                  <c:pt idx="1">
                    <c:v>1.692759197221846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20190418 96hr hyp U87'!$T$57:$U$57</c:f>
              <c:strCache>
                <c:ptCount val="2"/>
                <c:pt idx="0">
                  <c:v>U87</c:v>
                </c:pt>
                <c:pt idx="1">
                  <c:v>T98</c:v>
                </c:pt>
              </c:strCache>
            </c:strRef>
          </c:cat>
          <c:val>
            <c:numRef>
              <c:f>'20190418 96hr hyp U87'!$T$58:$U$58</c:f>
              <c:numCache>
                <c:formatCode>General</c:formatCode>
                <c:ptCount val="2"/>
                <c:pt idx="0">
                  <c:v>5.3568640206580802E-2</c:v>
                </c:pt>
                <c:pt idx="1">
                  <c:v>8.1062997485662674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F65-4020-8BED-08DB370AEB91}"/>
            </c:ext>
          </c:extLst>
        </c:ser>
        <c:ser>
          <c:idx val="1"/>
          <c:order val="1"/>
          <c:tx>
            <c:strRef>
              <c:f>'20190418 96hr hyp U87'!$O$59</c:f>
              <c:strCache>
                <c:ptCount val="1"/>
                <c:pt idx="0">
                  <c:v>Hypoxia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20190418 96hr hyp U87'!$T$62:$U$62</c:f>
                <c:numCache>
                  <c:formatCode>General</c:formatCode>
                  <c:ptCount val="2"/>
                  <c:pt idx="0">
                    <c:v>8.9369555365607367E-3</c:v>
                  </c:pt>
                  <c:pt idx="1">
                    <c:v>1.3228292913402797E-2</c:v>
                  </c:pt>
                </c:numCache>
              </c:numRef>
            </c:plus>
            <c:minus>
              <c:numRef>
                <c:f>'20190418 96hr hyp U87'!$T$62:$U$62</c:f>
                <c:numCache>
                  <c:formatCode>General</c:formatCode>
                  <c:ptCount val="2"/>
                  <c:pt idx="0">
                    <c:v>8.9369555365607367E-3</c:v>
                  </c:pt>
                  <c:pt idx="1">
                    <c:v>1.322829291340279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20190418 96hr hyp U87'!$T$57:$U$57</c:f>
              <c:strCache>
                <c:ptCount val="2"/>
                <c:pt idx="0">
                  <c:v>U87</c:v>
                </c:pt>
                <c:pt idx="1">
                  <c:v>T98</c:v>
                </c:pt>
              </c:strCache>
            </c:strRef>
          </c:cat>
          <c:val>
            <c:numRef>
              <c:f>'20190418 96hr hyp U87'!$T$59:$U$59</c:f>
              <c:numCache>
                <c:formatCode>General</c:formatCode>
                <c:ptCount val="2"/>
                <c:pt idx="0">
                  <c:v>5.496107329789246E-2</c:v>
                </c:pt>
                <c:pt idx="1">
                  <c:v>6.547915171347112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F65-4020-8BED-08DB370AEB9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281335311"/>
        <c:axId val="1385359935"/>
      </c:barChart>
      <c:catAx>
        <c:axId val="128133531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385359935"/>
        <c:crosses val="autoZero"/>
        <c:auto val="1"/>
        <c:lblAlgn val="ctr"/>
        <c:lblOffset val="100"/>
        <c:noMultiLvlLbl val="0"/>
      </c:catAx>
      <c:valAx>
        <c:axId val="1385359935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b="1" dirty="0"/>
                  <a:t>Relative peak leve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81335311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4049227240240572"/>
          <c:y val="9.7298467197998867E-2"/>
          <c:w val="0.81387803644725432"/>
          <c:h val="0.6047782868638450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P$59</c:f>
              <c:strCache>
                <c:ptCount val="1"/>
                <c:pt idx="0">
                  <c:v>Gln+ Glc+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Q$64:$AK$64</c:f>
                <c:numCache>
                  <c:formatCode>General</c:formatCode>
                  <c:ptCount val="19"/>
                  <c:pt idx="0">
                    <c:v>6.532478485921174E-2</c:v>
                  </c:pt>
                  <c:pt idx="1">
                    <c:v>7.7431454228253815E-2</c:v>
                  </c:pt>
                  <c:pt idx="2">
                    <c:v>7.7430191600734652E-2</c:v>
                  </c:pt>
                  <c:pt idx="3">
                    <c:v>0.11466788443859836</c:v>
                  </c:pt>
                  <c:pt idx="4">
                    <c:v>7.011874843560259E-2</c:v>
                  </c:pt>
                  <c:pt idx="5">
                    <c:v>8.818934831318008E-2</c:v>
                  </c:pt>
                  <c:pt idx="6">
                    <c:v>0.41974957152114667</c:v>
                  </c:pt>
                  <c:pt idx="7">
                    <c:v>0.41780177454815914</c:v>
                  </c:pt>
                  <c:pt idx="8">
                    <c:v>0.4174271012382601</c:v>
                  </c:pt>
                  <c:pt idx="9">
                    <c:v>0.4169074212206284</c:v>
                  </c:pt>
                  <c:pt idx="10">
                    <c:v>0.41821294942014742</c:v>
                  </c:pt>
                  <c:pt idx="11">
                    <c:v>0.41729844827935697</c:v>
                  </c:pt>
                  <c:pt idx="12">
                    <c:v>6.5223423023017188E-2</c:v>
                  </c:pt>
                  <c:pt idx="13">
                    <c:v>6.3965034968554935E-2</c:v>
                  </c:pt>
                  <c:pt idx="14">
                    <c:v>8.5308522863575473E-2</c:v>
                  </c:pt>
                  <c:pt idx="15">
                    <c:v>9.6826522800479861E-2</c:v>
                  </c:pt>
                  <c:pt idx="16">
                    <c:v>8.5151506009084929E-2</c:v>
                  </c:pt>
                  <c:pt idx="17">
                    <c:v>7.6669351429190125E-2</c:v>
                  </c:pt>
                  <c:pt idx="18">
                    <c:v>7.5918405962422941E-2</c:v>
                  </c:pt>
                </c:numCache>
              </c:numRef>
            </c:plus>
            <c:minus>
              <c:numRef>
                <c:f>Sheet1!$Q$64:$AK$64</c:f>
                <c:numCache>
                  <c:formatCode>General</c:formatCode>
                  <c:ptCount val="19"/>
                  <c:pt idx="0">
                    <c:v>6.532478485921174E-2</c:v>
                  </c:pt>
                  <c:pt idx="1">
                    <c:v>7.7431454228253815E-2</c:v>
                  </c:pt>
                  <c:pt idx="2">
                    <c:v>7.7430191600734652E-2</c:v>
                  </c:pt>
                  <c:pt idx="3">
                    <c:v>0.11466788443859836</c:v>
                  </c:pt>
                  <c:pt idx="4">
                    <c:v>7.011874843560259E-2</c:v>
                  </c:pt>
                  <c:pt idx="5">
                    <c:v>8.818934831318008E-2</c:v>
                  </c:pt>
                  <c:pt idx="6">
                    <c:v>0.41974957152114667</c:v>
                  </c:pt>
                  <c:pt idx="7">
                    <c:v>0.41780177454815914</c:v>
                  </c:pt>
                  <c:pt idx="8">
                    <c:v>0.4174271012382601</c:v>
                  </c:pt>
                  <c:pt idx="9">
                    <c:v>0.4169074212206284</c:v>
                  </c:pt>
                  <c:pt idx="10">
                    <c:v>0.41821294942014742</c:v>
                  </c:pt>
                  <c:pt idx="11">
                    <c:v>0.41729844827935697</c:v>
                  </c:pt>
                  <c:pt idx="12">
                    <c:v>6.5223423023017188E-2</c:v>
                  </c:pt>
                  <c:pt idx="13">
                    <c:v>6.3965034968554935E-2</c:v>
                  </c:pt>
                  <c:pt idx="14">
                    <c:v>8.5308522863575473E-2</c:v>
                  </c:pt>
                  <c:pt idx="15">
                    <c:v>9.6826522800479861E-2</c:v>
                  </c:pt>
                  <c:pt idx="16">
                    <c:v>8.5151506009084929E-2</c:v>
                  </c:pt>
                  <c:pt idx="17">
                    <c:v>7.6669351429190125E-2</c:v>
                  </c:pt>
                  <c:pt idx="18">
                    <c:v>7.591840596242294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Sheet1!$Q$57:$AD$58</c:f>
              <c:multiLvlStrCache>
                <c:ptCount val="12"/>
                <c:lvl>
                  <c:pt idx="0">
                    <c:v>PSAT1</c:v>
                  </c:pt>
                  <c:pt idx="1">
                    <c:v>MTHFD1</c:v>
                  </c:pt>
                  <c:pt idx="2">
                    <c:v>MTHFD1L</c:v>
                  </c:pt>
                  <c:pt idx="3">
                    <c:v>MTHFD2</c:v>
                  </c:pt>
                  <c:pt idx="4">
                    <c:v>SHMT1</c:v>
                  </c:pt>
                  <c:pt idx="5">
                    <c:v>SHMT2</c:v>
                  </c:pt>
                  <c:pt idx="6">
                    <c:v>PSAT1</c:v>
                  </c:pt>
                  <c:pt idx="7">
                    <c:v>MTHFD1</c:v>
                  </c:pt>
                  <c:pt idx="8">
                    <c:v>MTHFD1L</c:v>
                  </c:pt>
                  <c:pt idx="9">
                    <c:v>MTHFD2</c:v>
                  </c:pt>
                  <c:pt idx="10">
                    <c:v>SHMT1</c:v>
                  </c:pt>
                  <c:pt idx="11">
                    <c:v>SHMT2</c:v>
                  </c:pt>
                </c:lvl>
                <c:lvl>
                  <c:pt idx="0">
                    <c:v>U87</c:v>
                  </c:pt>
                  <c:pt idx="6">
                    <c:v>T98</c:v>
                  </c:pt>
                </c:lvl>
              </c:multiLvlStrCache>
            </c:multiLvlStrRef>
          </c:cat>
          <c:val>
            <c:numRef>
              <c:f>Sheet1!$Q$59:$AD$59</c:f>
              <c:numCache>
                <c:formatCode>General</c:formatCode>
                <c:ptCount val="12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587-4283-B957-C9EAD8B71349}"/>
            </c:ext>
          </c:extLst>
        </c:ser>
        <c:ser>
          <c:idx val="1"/>
          <c:order val="1"/>
          <c:tx>
            <c:strRef>
              <c:f>Sheet1!$P$60</c:f>
              <c:strCache>
                <c:ptCount val="1"/>
                <c:pt idx="0">
                  <c:v>Gln+, Glc-</c:v>
                </c:pt>
              </c:strCache>
              <c:extLst xmlns:c15="http://schemas.microsoft.com/office/drawing/2012/chart"/>
            </c:strRef>
          </c:tx>
          <c:spPr>
            <a:solidFill>
              <a:schemeClr val="accent3"/>
            </a:solidFill>
            <a:ln>
              <a:solidFill>
                <a:schemeClr val="accent3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Q$65:$AK$65</c:f>
                <c:numCache>
                  <c:formatCode>General</c:formatCode>
                  <c:ptCount val="19"/>
                  <c:pt idx="0">
                    <c:v>4.1008603424251458E-2</c:v>
                  </c:pt>
                  <c:pt idx="1">
                    <c:v>6.2264129508650873E-2</c:v>
                  </c:pt>
                  <c:pt idx="2">
                    <c:v>5.7680360256193969E-2</c:v>
                  </c:pt>
                  <c:pt idx="3">
                    <c:v>2.2901188960525783E-2</c:v>
                  </c:pt>
                  <c:pt idx="4">
                    <c:v>2.2979600592208427E-2</c:v>
                  </c:pt>
                  <c:pt idx="5">
                    <c:v>0.11661043622917029</c:v>
                  </c:pt>
                  <c:pt idx="6">
                    <c:v>3.8940441788239771E-2</c:v>
                  </c:pt>
                  <c:pt idx="7">
                    <c:v>2.2679000580423644E-2</c:v>
                  </c:pt>
                  <c:pt idx="8">
                    <c:v>4.7012106837282651E-2</c:v>
                  </c:pt>
                  <c:pt idx="9">
                    <c:v>1.9541484940409741E-2</c:v>
                  </c:pt>
                  <c:pt idx="10">
                    <c:v>3.536233044649436E-2</c:v>
                  </c:pt>
                  <c:pt idx="11">
                    <c:v>3.8338987979714044E-2</c:v>
                  </c:pt>
                  <c:pt idx="12">
                    <c:v>8.0892716556351454E-2</c:v>
                  </c:pt>
                  <c:pt idx="13">
                    <c:v>5.4518895628542112E-2</c:v>
                  </c:pt>
                  <c:pt idx="14">
                    <c:v>4.8806476860151382E-2</c:v>
                  </c:pt>
                  <c:pt idx="15">
                    <c:v>5.1933872781041099E-2</c:v>
                  </c:pt>
                  <c:pt idx="16">
                    <c:v>0.2071125481668312</c:v>
                  </c:pt>
                  <c:pt idx="17">
                    <c:v>0.11283086876275511</c:v>
                  </c:pt>
                  <c:pt idx="18">
                    <c:v>5.2164795126964134E-2</c:v>
                  </c:pt>
                </c:numCache>
              </c:numRef>
            </c:plus>
            <c:minus>
              <c:numRef>
                <c:f>Sheet1!$Q$65:$AK$65</c:f>
                <c:numCache>
                  <c:formatCode>General</c:formatCode>
                  <c:ptCount val="19"/>
                  <c:pt idx="0">
                    <c:v>4.1008603424251458E-2</c:v>
                  </c:pt>
                  <c:pt idx="1">
                    <c:v>6.2264129508650873E-2</c:v>
                  </c:pt>
                  <c:pt idx="2">
                    <c:v>5.7680360256193969E-2</c:v>
                  </c:pt>
                  <c:pt idx="3">
                    <c:v>2.2901188960525783E-2</c:v>
                  </c:pt>
                  <c:pt idx="4">
                    <c:v>2.2979600592208427E-2</c:v>
                  </c:pt>
                  <c:pt idx="5">
                    <c:v>0.11661043622917029</c:v>
                  </c:pt>
                  <c:pt idx="6">
                    <c:v>3.8940441788239771E-2</c:v>
                  </c:pt>
                  <c:pt idx="7">
                    <c:v>2.2679000580423644E-2</c:v>
                  </c:pt>
                  <c:pt idx="8">
                    <c:v>4.7012106837282651E-2</c:v>
                  </c:pt>
                  <c:pt idx="9">
                    <c:v>1.9541484940409741E-2</c:v>
                  </c:pt>
                  <c:pt idx="10">
                    <c:v>3.536233044649436E-2</c:v>
                  </c:pt>
                  <c:pt idx="11">
                    <c:v>3.8338987979714044E-2</c:v>
                  </c:pt>
                  <c:pt idx="12">
                    <c:v>8.0892716556351454E-2</c:v>
                  </c:pt>
                  <c:pt idx="13">
                    <c:v>5.4518895628542112E-2</c:v>
                  </c:pt>
                  <c:pt idx="14">
                    <c:v>4.8806476860151382E-2</c:v>
                  </c:pt>
                  <c:pt idx="15">
                    <c:v>5.1933872781041099E-2</c:v>
                  </c:pt>
                  <c:pt idx="16">
                    <c:v>0.2071125481668312</c:v>
                  </c:pt>
                  <c:pt idx="17">
                    <c:v>0.11283086876275511</c:v>
                  </c:pt>
                  <c:pt idx="18">
                    <c:v>5.216479512696413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Sheet1!$Q$57:$AD$58</c:f>
              <c:multiLvlStrCache>
                <c:ptCount val="12"/>
                <c:lvl>
                  <c:pt idx="0">
                    <c:v>PSAT1</c:v>
                  </c:pt>
                  <c:pt idx="1">
                    <c:v>MTHFD1</c:v>
                  </c:pt>
                  <c:pt idx="2">
                    <c:v>MTHFD1L</c:v>
                  </c:pt>
                  <c:pt idx="3">
                    <c:v>MTHFD2</c:v>
                  </c:pt>
                  <c:pt idx="4">
                    <c:v>SHMT1</c:v>
                  </c:pt>
                  <c:pt idx="5">
                    <c:v>SHMT2</c:v>
                  </c:pt>
                  <c:pt idx="6">
                    <c:v>PSAT1</c:v>
                  </c:pt>
                  <c:pt idx="7">
                    <c:v>MTHFD1</c:v>
                  </c:pt>
                  <c:pt idx="8">
                    <c:v>MTHFD1L</c:v>
                  </c:pt>
                  <c:pt idx="9">
                    <c:v>MTHFD2</c:v>
                  </c:pt>
                  <c:pt idx="10">
                    <c:v>SHMT1</c:v>
                  </c:pt>
                  <c:pt idx="11">
                    <c:v>SHMT2</c:v>
                  </c:pt>
                </c:lvl>
                <c:lvl>
                  <c:pt idx="0">
                    <c:v>U87</c:v>
                  </c:pt>
                  <c:pt idx="6">
                    <c:v>T98</c:v>
                  </c:pt>
                </c:lvl>
              </c:multiLvlStrCache>
            </c:multiLvlStrRef>
          </c:cat>
          <c:val>
            <c:numRef>
              <c:f>Sheet1!$Q$60:$AD$60</c:f>
              <c:numCache>
                <c:formatCode>General</c:formatCode>
                <c:ptCount val="12"/>
                <c:pt idx="0">
                  <c:v>0.94401387820333083</c:v>
                </c:pt>
                <c:pt idx="1">
                  <c:v>0.89307899938924096</c:v>
                </c:pt>
                <c:pt idx="2">
                  <c:v>0.87613325733646896</c:v>
                </c:pt>
                <c:pt idx="3">
                  <c:v>0.95236766615327473</c:v>
                </c:pt>
                <c:pt idx="4">
                  <c:v>0.97927632818505039</c:v>
                </c:pt>
                <c:pt idx="5">
                  <c:v>1.1263967649616238</c:v>
                </c:pt>
                <c:pt idx="6">
                  <c:v>2.1404097994779923</c:v>
                </c:pt>
                <c:pt idx="7">
                  <c:v>0.75193852053595722</c:v>
                </c:pt>
                <c:pt idx="8">
                  <c:v>1.1559643522706966</c:v>
                </c:pt>
                <c:pt idx="9">
                  <c:v>1.7758319034402821</c:v>
                </c:pt>
                <c:pt idx="10">
                  <c:v>0.86945434244926101</c:v>
                </c:pt>
                <c:pt idx="11">
                  <c:v>1.303458996056378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587-4283-B957-C9EAD8B7134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43428904"/>
        <c:axId val="443429688"/>
        <c:extLst>
          <c:ext xmlns:c15="http://schemas.microsoft.com/office/drawing/2012/chart" uri="{02D57815-91ED-43cb-92C2-25804820EDAC}">
            <c15:filteredBarSeries>
              <c15:ser>
                <c:idx val="2"/>
                <c:order val="2"/>
                <c:tx>
                  <c:strRef>
                    <c:extLst>
                      <c:ext uri="{02D57815-91ED-43cb-92C2-25804820EDAC}">
                        <c15:formulaRef>
                          <c15:sqref>Sheet1!$P$61</c15:sqref>
                        </c15:formulaRef>
                      </c:ext>
                    </c:extLst>
                    <c:strCache>
                      <c:ptCount val="1"/>
                      <c:pt idx="0">
                        <c:v>Gln-, Glc+</c:v>
                      </c:pt>
                    </c:strCache>
                  </c:strRef>
                </c:tx>
                <c:spPr>
                  <a:solidFill>
                    <a:schemeClr val="accent5"/>
                  </a:solidFill>
                  <a:ln>
                    <a:solidFill>
                      <a:schemeClr val="accent5"/>
                    </a:solidFill>
                  </a:ln>
                  <a:effectLst/>
                </c:spPr>
                <c:invertIfNegative val="0"/>
                <c:errBars>
                  <c:errBarType val="both"/>
                  <c:errValType val="cust"/>
                  <c:noEndCap val="0"/>
                  <c:plus>
                    <c:numRef>
                      <c:extLst>
                        <c:ext uri="{02D57815-91ED-43cb-92C2-25804820EDAC}">
                          <c15:formulaRef>
                            <c15:sqref>Sheet1!$Q$66:$AK$66</c15:sqref>
                          </c15:formulaRef>
                        </c:ext>
                      </c:extLst>
                      <c:numCache>
                        <c:formatCode>General</c:formatCode>
                        <c:ptCount val="19"/>
                        <c:pt idx="0">
                          <c:v>8.0750018728968004E-2</c:v>
                        </c:pt>
                        <c:pt idx="1">
                          <c:v>6.079354241283047E-2</c:v>
                        </c:pt>
                        <c:pt idx="2">
                          <c:v>3.3726072946800953E-2</c:v>
                        </c:pt>
                        <c:pt idx="3">
                          <c:v>5.9772680887883026E-2</c:v>
                        </c:pt>
                        <c:pt idx="4">
                          <c:v>5.2477721702717209E-2</c:v>
                        </c:pt>
                        <c:pt idx="5">
                          <c:v>8.6901390729804864E-2</c:v>
                        </c:pt>
                        <c:pt idx="6">
                          <c:v>2.7393915381939176E-2</c:v>
                        </c:pt>
                        <c:pt idx="7">
                          <c:v>0.12723169497272549</c:v>
                        </c:pt>
                        <c:pt idx="8">
                          <c:v>2.4488413983527645E-2</c:v>
                        </c:pt>
                        <c:pt idx="9">
                          <c:v>4.5087212316080531E-2</c:v>
                        </c:pt>
                        <c:pt idx="10">
                          <c:v>3.6211863594024264E-2</c:v>
                        </c:pt>
                        <c:pt idx="11">
                          <c:v>2.5889275160764943E-2</c:v>
                        </c:pt>
                        <c:pt idx="12">
                          <c:v>7.9231685124417445E-2</c:v>
                        </c:pt>
                        <c:pt idx="13">
                          <c:v>9.9570290708037079E-2</c:v>
                        </c:pt>
                        <c:pt idx="14">
                          <c:v>8.4489851164653185E-2</c:v>
                        </c:pt>
                        <c:pt idx="15">
                          <c:v>9.3580154919027325E-2</c:v>
                        </c:pt>
                        <c:pt idx="16">
                          <c:v>8.0063165124379512E-2</c:v>
                        </c:pt>
                        <c:pt idx="17">
                          <c:v>7.8079742158655152E-2</c:v>
                        </c:pt>
                        <c:pt idx="18">
                          <c:v>7.951115188147681E-2</c:v>
                        </c:pt>
                      </c:numCache>
                    </c:numRef>
                  </c:plus>
                  <c:minus>
                    <c:numRef>
                      <c:extLst>
                        <c:ext uri="{02D57815-91ED-43cb-92C2-25804820EDAC}">
                          <c15:formulaRef>
                            <c15:sqref>Sheet1!$Q$66:$AK$66</c15:sqref>
                          </c15:formulaRef>
                        </c:ext>
                      </c:extLst>
                      <c:numCache>
                        <c:formatCode>General</c:formatCode>
                        <c:ptCount val="19"/>
                        <c:pt idx="0">
                          <c:v>8.0750018728968004E-2</c:v>
                        </c:pt>
                        <c:pt idx="1">
                          <c:v>6.079354241283047E-2</c:v>
                        </c:pt>
                        <c:pt idx="2">
                          <c:v>3.3726072946800953E-2</c:v>
                        </c:pt>
                        <c:pt idx="3">
                          <c:v>5.9772680887883026E-2</c:v>
                        </c:pt>
                        <c:pt idx="4">
                          <c:v>5.2477721702717209E-2</c:v>
                        </c:pt>
                        <c:pt idx="5">
                          <c:v>8.6901390729804864E-2</c:v>
                        </c:pt>
                        <c:pt idx="6">
                          <c:v>2.7393915381939176E-2</c:v>
                        </c:pt>
                        <c:pt idx="7">
                          <c:v>0.12723169497272549</c:v>
                        </c:pt>
                        <c:pt idx="8">
                          <c:v>2.4488413983527645E-2</c:v>
                        </c:pt>
                        <c:pt idx="9">
                          <c:v>4.5087212316080531E-2</c:v>
                        </c:pt>
                        <c:pt idx="10">
                          <c:v>3.6211863594024264E-2</c:v>
                        </c:pt>
                        <c:pt idx="11">
                          <c:v>2.5889275160764943E-2</c:v>
                        </c:pt>
                        <c:pt idx="12">
                          <c:v>7.9231685124417445E-2</c:v>
                        </c:pt>
                        <c:pt idx="13">
                          <c:v>9.9570290708037079E-2</c:v>
                        </c:pt>
                        <c:pt idx="14">
                          <c:v>8.4489851164653185E-2</c:v>
                        </c:pt>
                        <c:pt idx="15">
                          <c:v>9.3580154919027325E-2</c:v>
                        </c:pt>
                        <c:pt idx="16">
                          <c:v>8.0063165124379512E-2</c:v>
                        </c:pt>
                        <c:pt idx="17">
                          <c:v>7.8079742158655152E-2</c:v>
                        </c:pt>
                        <c:pt idx="18">
                          <c:v>7.951115188147681E-2</c:v>
                        </c:pt>
                      </c:numCache>
                    </c:numRef>
                  </c:minus>
                  <c:spPr>
                    <a:noFill/>
                    <a:ln w="9525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round/>
                    </a:ln>
                    <a:effectLst/>
                  </c:spPr>
                </c:errBars>
                <c:cat>
                  <c:multiLvlStrRef>
                    <c:extLst>
                      <c:ext uri="{02D57815-91ED-43cb-92C2-25804820EDAC}">
                        <c15:formulaRef>
                          <c15:sqref>Sheet1!$Q$57:$AD$58</c15:sqref>
                        </c15:formulaRef>
                      </c:ext>
                    </c:extLst>
                    <c:multiLvlStrCache>
                      <c:ptCount val="12"/>
                      <c:lvl>
                        <c:pt idx="0">
                          <c:v>PSAT1</c:v>
                        </c:pt>
                        <c:pt idx="1">
                          <c:v>MTHFD1</c:v>
                        </c:pt>
                        <c:pt idx="2">
                          <c:v>MTHFD1L</c:v>
                        </c:pt>
                        <c:pt idx="3">
                          <c:v>MTHFD2</c:v>
                        </c:pt>
                        <c:pt idx="4">
                          <c:v>SHMT1</c:v>
                        </c:pt>
                        <c:pt idx="5">
                          <c:v>SHMT2</c:v>
                        </c:pt>
                        <c:pt idx="6">
                          <c:v>PSAT1</c:v>
                        </c:pt>
                        <c:pt idx="7">
                          <c:v>MTHFD1</c:v>
                        </c:pt>
                        <c:pt idx="8">
                          <c:v>MTHFD1L</c:v>
                        </c:pt>
                        <c:pt idx="9">
                          <c:v>MTHFD2</c:v>
                        </c:pt>
                        <c:pt idx="10">
                          <c:v>SHMT1</c:v>
                        </c:pt>
                        <c:pt idx="11">
                          <c:v>SHMT2</c:v>
                        </c:pt>
                      </c:lvl>
                      <c:lvl>
                        <c:pt idx="0">
                          <c:v>U87</c:v>
                        </c:pt>
                        <c:pt idx="6">
                          <c:v>T98</c:v>
                        </c:pt>
                      </c:lvl>
                    </c:multiLvlStrCache>
                  </c:multiLvlStrRef>
                </c:cat>
                <c:val>
                  <c:numRef>
                    <c:extLst>
                      <c:ext uri="{02D57815-91ED-43cb-92C2-25804820EDAC}">
                        <c15:formulaRef>
                          <c15:sqref>Sheet1!$Q$61:$AD$61</c15:sqref>
                        </c15:formulaRef>
                      </c:ext>
                    </c:extLst>
                    <c:numCache>
                      <c:formatCode>General</c:formatCode>
                      <c:ptCount val="12"/>
                      <c:pt idx="0">
                        <c:v>13.651952859770329</c:v>
                      </c:pt>
                      <c:pt idx="1">
                        <c:v>0.3898340688941761</c:v>
                      </c:pt>
                      <c:pt idx="2">
                        <c:v>1.8222410001890343</c:v>
                      </c:pt>
                      <c:pt idx="3">
                        <c:v>4.2228116982348523</c:v>
                      </c:pt>
                      <c:pt idx="4">
                        <c:v>0.26990921015319624</c:v>
                      </c:pt>
                      <c:pt idx="5">
                        <c:v>3.3437873290440945</c:v>
                      </c:pt>
                      <c:pt idx="6">
                        <c:v>6.7615858369352919</c:v>
                      </c:pt>
                      <c:pt idx="7">
                        <c:v>0.71331822382289289</c:v>
                      </c:pt>
                      <c:pt idx="8">
                        <c:v>2.7841526186897543</c:v>
                      </c:pt>
                      <c:pt idx="9">
                        <c:v>3.7977797395510886</c:v>
                      </c:pt>
                      <c:pt idx="10">
                        <c:v>0.51154651938552964</c:v>
                      </c:pt>
                      <c:pt idx="11">
                        <c:v>2.3923112280962004</c:v>
                      </c:pt>
                    </c:numCache>
                  </c:numRef>
                </c:val>
                <c:extLst>
                  <c:ext xmlns:c16="http://schemas.microsoft.com/office/drawing/2014/chart" uri="{C3380CC4-5D6E-409C-BE32-E72D297353CC}">
                    <c16:uniqueId val="{00000002-4587-4283-B957-C9EAD8B71349}"/>
                  </c:ext>
                </c:extLst>
              </c15:ser>
            </c15:filteredBarSeries>
          </c:ext>
        </c:extLst>
      </c:barChart>
      <c:catAx>
        <c:axId val="4434289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43429688"/>
        <c:crosses val="autoZero"/>
        <c:auto val="1"/>
        <c:lblAlgn val="ctr"/>
        <c:lblOffset val="100"/>
        <c:noMultiLvlLbl val="0"/>
      </c:catAx>
      <c:valAx>
        <c:axId val="443429688"/>
        <c:scaling>
          <c:orientation val="minMax"/>
          <c:max val="6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/>
              <a:lstStyle/>
              <a:p>
                <a:pPr>
                  <a:defRPr b="1"/>
                </a:pPr>
                <a:r>
                  <a:rPr lang="en-US" altLang="ja-JP" b="1" dirty="0"/>
                  <a:t>Gene expression</a:t>
                </a:r>
                <a:endParaRPr lang="ja-JP" altLang="en-US" b="1" dirty="0"/>
              </a:p>
            </c:rich>
          </c:tx>
          <c:overlay val="0"/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43428904"/>
        <c:crosses val="autoZero"/>
        <c:crossBetween val="between"/>
      </c:valAx>
      <c:spPr>
        <a:noFill/>
        <a:ln w="25400">
          <a:noFill/>
        </a:ln>
      </c:spPr>
    </c:plotArea>
    <c:legend>
      <c:legendPos val="b"/>
      <c:layout>
        <c:manualLayout>
          <c:xMode val="edge"/>
          <c:yMode val="edge"/>
          <c:x val="0.67754037506471276"/>
          <c:y val="5.5900331638377862E-2"/>
          <c:w val="0.27543788307113426"/>
          <c:h val="0.14138731397813145"/>
        </c:manualLayout>
      </c:layout>
      <c:overlay val="0"/>
      <c:spPr>
        <a:solidFill>
          <a:schemeClr val="bg1"/>
        </a:solidFill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round/>
    </a:ln>
    <a:effectLst/>
  </c:spPr>
  <c:txPr>
    <a:bodyPr/>
    <a:lstStyle/>
    <a:p>
      <a:pPr>
        <a:defRPr/>
      </a:pPr>
      <a:endParaRPr lang="ja-JP"/>
    </a:p>
  </c:txPr>
  <c:externalData r:id="rId1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520965498733492"/>
          <c:y val="9.2369139755739293E-2"/>
          <c:w val="0.72257516164467739"/>
          <c:h val="0.7509594277924810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N$20</c:f>
              <c:strCache>
                <c:ptCount val="1"/>
                <c:pt idx="0">
                  <c:v>Gln+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O$23:$U$23</c:f>
                <c:numCache>
                  <c:formatCode>General</c:formatCode>
                  <c:ptCount val="6"/>
                  <c:pt idx="0">
                    <c:v>4.1512409997449019E-3</c:v>
                  </c:pt>
                  <c:pt idx="1">
                    <c:v>0.21272819175924371</c:v>
                  </c:pt>
                  <c:pt idx="2">
                    <c:v>1.4930099616499101E-3</c:v>
                  </c:pt>
                  <c:pt idx="3">
                    <c:v>9.0137837838420956E-2</c:v>
                  </c:pt>
                  <c:pt idx="4">
                    <c:v>5.2855031524415341E-2</c:v>
                  </c:pt>
                  <c:pt idx="5">
                    <c:v>5.8071483845613482E-2</c:v>
                  </c:pt>
                </c:numCache>
              </c:numRef>
            </c:plus>
            <c:minus>
              <c:numRef>
                <c:f>Sheet1!$O$23:$U$23</c:f>
                <c:numCache>
                  <c:formatCode>General</c:formatCode>
                  <c:ptCount val="6"/>
                  <c:pt idx="0">
                    <c:v>4.1512409997449019E-3</c:v>
                  </c:pt>
                  <c:pt idx="1">
                    <c:v>0.21272819175924371</c:v>
                  </c:pt>
                  <c:pt idx="2">
                    <c:v>1.4930099616499101E-3</c:v>
                  </c:pt>
                  <c:pt idx="3">
                    <c:v>9.0137837838420956E-2</c:v>
                  </c:pt>
                  <c:pt idx="4">
                    <c:v>5.2855031524415341E-2</c:v>
                  </c:pt>
                  <c:pt idx="5">
                    <c:v>5.807148384561348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O$19:$U$19</c:f>
              <c:strCache>
                <c:ptCount val="6"/>
                <c:pt idx="0">
                  <c:v>PSAT1</c:v>
                </c:pt>
                <c:pt idx="1">
                  <c:v>MTHFD1</c:v>
                </c:pt>
                <c:pt idx="2">
                  <c:v>MTHFD1L</c:v>
                </c:pt>
                <c:pt idx="3">
                  <c:v>MTHFD2</c:v>
                </c:pt>
                <c:pt idx="4">
                  <c:v>SHMT1</c:v>
                </c:pt>
                <c:pt idx="5">
                  <c:v>SHMT2</c:v>
                </c:pt>
              </c:strCache>
            </c:strRef>
          </c:cat>
          <c:val>
            <c:numRef>
              <c:f>Sheet1!$O$20:$U$20</c:f>
              <c:numCache>
                <c:formatCode>General</c:formatCode>
                <c:ptCount val="6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E5B-491B-A627-3067EA289354}"/>
            </c:ext>
          </c:extLst>
        </c:ser>
        <c:ser>
          <c:idx val="1"/>
          <c:order val="1"/>
          <c:tx>
            <c:strRef>
              <c:f>Sheet1!$N$21</c:f>
              <c:strCache>
                <c:ptCount val="1"/>
                <c:pt idx="0">
                  <c:v>Gln-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O$24:$U$24</c:f>
                <c:numCache>
                  <c:formatCode>General</c:formatCode>
                  <c:ptCount val="6"/>
                  <c:pt idx="0">
                    <c:v>9.4575811965448217E-2</c:v>
                  </c:pt>
                  <c:pt idx="1">
                    <c:v>0.20342742204322406</c:v>
                  </c:pt>
                  <c:pt idx="2">
                    <c:v>6.6583928452298477E-2</c:v>
                  </c:pt>
                  <c:pt idx="3">
                    <c:v>8.7790825108500919E-2</c:v>
                  </c:pt>
                  <c:pt idx="4">
                    <c:v>0.1169374769158974</c:v>
                  </c:pt>
                  <c:pt idx="5">
                    <c:v>6.6583928452298477E-2</c:v>
                  </c:pt>
                </c:numCache>
              </c:numRef>
            </c:plus>
            <c:minus>
              <c:numRef>
                <c:f>Sheet1!$O$24:$U$24</c:f>
                <c:numCache>
                  <c:formatCode>General</c:formatCode>
                  <c:ptCount val="6"/>
                  <c:pt idx="0">
                    <c:v>9.4575811965448217E-2</c:v>
                  </c:pt>
                  <c:pt idx="1">
                    <c:v>0.20342742204322406</c:v>
                  </c:pt>
                  <c:pt idx="2">
                    <c:v>6.6583928452298477E-2</c:v>
                  </c:pt>
                  <c:pt idx="3">
                    <c:v>8.7790825108500919E-2</c:v>
                  </c:pt>
                  <c:pt idx="4">
                    <c:v>0.1169374769158974</c:v>
                  </c:pt>
                  <c:pt idx="5">
                    <c:v>6.658392845229847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O$19:$U$19</c:f>
              <c:strCache>
                <c:ptCount val="6"/>
                <c:pt idx="0">
                  <c:v>PSAT1</c:v>
                </c:pt>
                <c:pt idx="1">
                  <c:v>MTHFD1</c:v>
                </c:pt>
                <c:pt idx="2">
                  <c:v>MTHFD1L</c:v>
                </c:pt>
                <c:pt idx="3">
                  <c:v>MTHFD2</c:v>
                </c:pt>
                <c:pt idx="4">
                  <c:v>SHMT1</c:v>
                </c:pt>
                <c:pt idx="5">
                  <c:v>SHMT2</c:v>
                </c:pt>
              </c:strCache>
            </c:strRef>
          </c:cat>
          <c:val>
            <c:numRef>
              <c:f>Sheet1!$O$21:$U$21</c:f>
              <c:numCache>
                <c:formatCode>General</c:formatCode>
                <c:ptCount val="6"/>
                <c:pt idx="0">
                  <c:v>0.8295937987971389</c:v>
                </c:pt>
                <c:pt idx="1">
                  <c:v>1.0817714224584816</c:v>
                </c:pt>
                <c:pt idx="2">
                  <c:v>1.5618857546179985</c:v>
                </c:pt>
                <c:pt idx="3">
                  <c:v>1.4266773239447961</c:v>
                </c:pt>
                <c:pt idx="4">
                  <c:v>1.0245738723086573</c:v>
                </c:pt>
                <c:pt idx="5">
                  <c:v>1.20463441238438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E5B-491B-A627-3067EA28935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7758111"/>
        <c:axId val="117762255"/>
      </c:barChart>
      <c:catAx>
        <c:axId val="11775811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17762255"/>
        <c:crosses val="autoZero"/>
        <c:auto val="1"/>
        <c:lblAlgn val="ctr"/>
        <c:lblOffset val="100"/>
        <c:noMultiLvlLbl val="0"/>
      </c:catAx>
      <c:valAx>
        <c:axId val="117762255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b="1" dirty="0"/>
                  <a:t>Gene express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17758111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69853674143616795"/>
          <c:y val="9.25174003374187E-3"/>
          <c:w val="0.25324251803516917"/>
          <c:h val="4.9293566301992248E-2"/>
        </c:manualLayout>
      </c:layout>
      <c:overlay val="0"/>
      <c:spPr>
        <a:solidFill>
          <a:schemeClr val="bg1"/>
        </a:solidFill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8784116579639307"/>
          <c:y val="5.0925925925925923E-2"/>
          <c:w val="0.67043291486131185"/>
          <c:h val="0.72962288508724682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3">
                <a:lumMod val="75000"/>
              </a:schemeClr>
            </a:solidFill>
            <a:ln>
              <a:solidFill>
                <a:schemeClr val="accent3">
                  <a:lumMod val="75000"/>
                </a:schemeClr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B$29:$G$29</c:f>
                <c:numCache>
                  <c:formatCode>General</c:formatCode>
                  <c:ptCount val="6"/>
                  <c:pt idx="0">
                    <c:v>19.218047073866163</c:v>
                  </c:pt>
                  <c:pt idx="1">
                    <c:v>16.289055630494158</c:v>
                  </c:pt>
                  <c:pt idx="2">
                    <c:v>6.0277137733417083</c:v>
                  </c:pt>
                  <c:pt idx="3">
                    <c:v>11.67618659209133</c:v>
                  </c:pt>
                  <c:pt idx="4">
                    <c:v>64.670962056655256</c:v>
                  </c:pt>
                  <c:pt idx="5">
                    <c:v>15.307950004273339</c:v>
                  </c:pt>
                </c:numCache>
              </c:numRef>
            </c:plus>
            <c:minus>
              <c:numRef>
                <c:f>Sheet1!$B$29:$G$29</c:f>
                <c:numCache>
                  <c:formatCode>General</c:formatCode>
                  <c:ptCount val="6"/>
                  <c:pt idx="0">
                    <c:v>19.218047073866163</c:v>
                  </c:pt>
                  <c:pt idx="1">
                    <c:v>16.289055630494158</c:v>
                  </c:pt>
                  <c:pt idx="2">
                    <c:v>6.0277137733417083</c:v>
                  </c:pt>
                  <c:pt idx="3">
                    <c:v>11.67618659209133</c:v>
                  </c:pt>
                  <c:pt idx="4">
                    <c:v>64.670962056655256</c:v>
                  </c:pt>
                  <c:pt idx="5">
                    <c:v>15.30795000427333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Sheet1!$B$21:$G$22</c:f>
              <c:multiLvlStrCache>
                <c:ptCount val="6"/>
                <c:lvl>
                  <c:pt idx="0">
                    <c:v>Gln+</c:v>
                  </c:pt>
                  <c:pt idx="1">
                    <c:v>Gln-</c:v>
                  </c:pt>
                  <c:pt idx="2">
                    <c:v>Gln- NAC</c:v>
                  </c:pt>
                  <c:pt idx="3">
                    <c:v>Gln+</c:v>
                  </c:pt>
                  <c:pt idx="4">
                    <c:v>Gln-</c:v>
                  </c:pt>
                  <c:pt idx="5">
                    <c:v>Gln- NAC</c:v>
                  </c:pt>
                </c:lvl>
                <c:lvl>
                  <c:pt idx="0">
                    <c:v>Si-Control</c:v>
                  </c:pt>
                  <c:pt idx="3">
                    <c:v>Si-MTHFD2 #1</c:v>
                  </c:pt>
                </c:lvl>
              </c:multiLvlStrCache>
            </c:multiLvlStrRef>
          </c:cat>
          <c:val>
            <c:numRef>
              <c:f>Sheet1!$B$28:$G$28</c:f>
              <c:numCache>
                <c:formatCode>General</c:formatCode>
                <c:ptCount val="6"/>
                <c:pt idx="0">
                  <c:v>150.66666666666666</c:v>
                </c:pt>
                <c:pt idx="1">
                  <c:v>164.66666666666666</c:v>
                </c:pt>
                <c:pt idx="2">
                  <c:v>125.66666666666667</c:v>
                </c:pt>
                <c:pt idx="3">
                  <c:v>220.33333333333334</c:v>
                </c:pt>
                <c:pt idx="4">
                  <c:v>296.66666666666669</c:v>
                </c:pt>
                <c:pt idx="5">
                  <c:v>116.666666666666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EC6-41F3-AA6F-C96D558CE7E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-27"/>
        <c:axId val="510066160"/>
        <c:axId val="510113376"/>
      </c:barChart>
      <c:catAx>
        <c:axId val="5100661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10113376"/>
        <c:crosses val="autoZero"/>
        <c:auto val="1"/>
        <c:lblAlgn val="ctr"/>
        <c:lblOffset val="100"/>
        <c:noMultiLvlLbl val="0"/>
      </c:catAx>
      <c:valAx>
        <c:axId val="51011337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 dirty="0"/>
                  <a:t>ROS signal intensity</a:t>
                </a:r>
              </a:p>
            </c:rich>
          </c:tx>
          <c:layout>
            <c:manualLayout>
              <c:xMode val="edge"/>
              <c:yMode val="edge"/>
              <c:x val="4.1725930231377301E-2"/>
              <c:y val="0.2147600605298930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1006616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900">
          <a:latin typeface="+mn-lt"/>
        </a:defRPr>
      </a:pPr>
      <a:endParaRPr lang="ja-JP"/>
    </a:p>
  </c:txPr>
  <c:externalData r:id="rId3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前計算処理1!$P$42</c:f>
              <c:strCache>
                <c:ptCount val="1"/>
                <c:pt idx="0">
                  <c:v>Gln+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前計算処理1!$V$42:$Y$42</c:f>
                <c:numCache>
                  <c:formatCode>General</c:formatCode>
                  <c:ptCount val="4"/>
                  <c:pt idx="0">
                    <c:v>0.10448801104052513</c:v>
                  </c:pt>
                  <c:pt idx="1">
                    <c:v>0.10692023000240666</c:v>
                  </c:pt>
                  <c:pt idx="2">
                    <c:v>0.28630633785209503</c:v>
                  </c:pt>
                  <c:pt idx="3">
                    <c:v>0.28593499178418685</c:v>
                  </c:pt>
                </c:numCache>
              </c:numRef>
            </c:plus>
            <c:minus>
              <c:numRef>
                <c:f>前計算処理1!$V$42:$Y$42</c:f>
                <c:numCache>
                  <c:formatCode>General</c:formatCode>
                  <c:ptCount val="4"/>
                  <c:pt idx="0">
                    <c:v>0.10448801104052513</c:v>
                  </c:pt>
                  <c:pt idx="1">
                    <c:v>0.10692023000240666</c:v>
                  </c:pt>
                  <c:pt idx="2">
                    <c:v>0.28630633785209503</c:v>
                  </c:pt>
                  <c:pt idx="3">
                    <c:v>0.28593499178418685</c:v>
                  </c:pt>
                </c:numCache>
              </c:numRef>
            </c:minus>
          </c:errBars>
          <c:cat>
            <c:strRef>
              <c:f>前計算処理1!$Q$3:$T$3</c:f>
              <c:strCache>
                <c:ptCount val="4"/>
                <c:pt idx="0">
                  <c:v>0hr</c:v>
                </c:pt>
                <c:pt idx="1">
                  <c:v>24hr</c:v>
                </c:pt>
                <c:pt idx="2">
                  <c:v>48hr</c:v>
                </c:pt>
                <c:pt idx="3">
                  <c:v>72hr</c:v>
                </c:pt>
              </c:strCache>
            </c:strRef>
          </c:cat>
          <c:val>
            <c:numRef>
              <c:f>前計算処理1!$Q$42:$T$42</c:f>
              <c:numCache>
                <c:formatCode>General</c:formatCode>
                <c:ptCount val="4"/>
                <c:pt idx="0">
                  <c:v>1</c:v>
                </c:pt>
                <c:pt idx="1">
                  <c:v>1.7343989443214711</c:v>
                </c:pt>
                <c:pt idx="2">
                  <c:v>4.5694278903456498</c:v>
                </c:pt>
                <c:pt idx="3">
                  <c:v>8.563851523923037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B5AB-4667-836C-E26B0CE7D204}"/>
            </c:ext>
          </c:extLst>
        </c:ser>
        <c:ser>
          <c:idx val="1"/>
          <c:order val="1"/>
          <c:tx>
            <c:strRef>
              <c:f>前計算処理1!$P$43</c:f>
              <c:strCache>
                <c:ptCount val="1"/>
                <c:pt idx="0">
                  <c:v>Gln- control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前計算処理1!$V$43:$Y$43</c:f>
                <c:numCache>
                  <c:formatCode>General</c:formatCode>
                  <c:ptCount val="4"/>
                  <c:pt idx="0">
                    <c:v>0.10448801104052513</c:v>
                  </c:pt>
                  <c:pt idx="1">
                    <c:v>0.3649065787907772</c:v>
                  </c:pt>
                  <c:pt idx="2">
                    <c:v>0.34644026808126721</c:v>
                  </c:pt>
                  <c:pt idx="3">
                    <c:v>0.42058360759241648</c:v>
                  </c:pt>
                </c:numCache>
              </c:numRef>
            </c:plus>
            <c:minus>
              <c:numRef>
                <c:f>前計算処理1!$V$43:$Y$43</c:f>
                <c:numCache>
                  <c:formatCode>General</c:formatCode>
                  <c:ptCount val="4"/>
                  <c:pt idx="0">
                    <c:v>0.10448801104052513</c:v>
                  </c:pt>
                  <c:pt idx="1">
                    <c:v>0.3649065787907772</c:v>
                  </c:pt>
                  <c:pt idx="2">
                    <c:v>0.34644026808126721</c:v>
                  </c:pt>
                  <c:pt idx="3">
                    <c:v>0.42058360759241648</c:v>
                  </c:pt>
                </c:numCache>
              </c:numRef>
            </c:minus>
          </c:errBars>
          <c:cat>
            <c:strRef>
              <c:f>前計算処理1!$Q$3:$T$3</c:f>
              <c:strCache>
                <c:ptCount val="4"/>
                <c:pt idx="0">
                  <c:v>0hr</c:v>
                </c:pt>
                <c:pt idx="1">
                  <c:v>24hr</c:v>
                </c:pt>
                <c:pt idx="2">
                  <c:v>48hr</c:v>
                </c:pt>
                <c:pt idx="3">
                  <c:v>72hr</c:v>
                </c:pt>
              </c:strCache>
            </c:strRef>
          </c:cat>
          <c:val>
            <c:numRef>
              <c:f>前計算処理1!$Q$43:$T$43</c:f>
              <c:numCache>
                <c:formatCode>General</c:formatCode>
                <c:ptCount val="4"/>
                <c:pt idx="0">
                  <c:v>1</c:v>
                </c:pt>
                <c:pt idx="1">
                  <c:v>1.2764558147454452</c:v>
                </c:pt>
                <c:pt idx="2">
                  <c:v>1.9541120381406436</c:v>
                </c:pt>
                <c:pt idx="3">
                  <c:v>4.280708326238719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B5AB-4667-836C-E26B0CE7D204}"/>
            </c:ext>
          </c:extLst>
        </c:ser>
        <c:ser>
          <c:idx val="2"/>
          <c:order val="2"/>
          <c:tx>
            <c:strRef>
              <c:f>前計算処理1!$P$44</c:f>
              <c:strCache>
                <c:ptCount val="1"/>
                <c:pt idx="0">
                  <c:v>Gln- Chl 10μM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前計算処理1!$V$44:$Y$44</c:f>
                <c:numCache>
                  <c:formatCode>General</c:formatCode>
                  <c:ptCount val="4"/>
                  <c:pt idx="0">
                    <c:v>0.10448801104052513</c:v>
                  </c:pt>
                  <c:pt idx="1">
                    <c:v>9.5135142323996794E-2</c:v>
                  </c:pt>
                  <c:pt idx="2">
                    <c:v>0.14432052220210542</c:v>
                  </c:pt>
                  <c:pt idx="3">
                    <c:v>0.29954462073834509</c:v>
                  </c:pt>
                </c:numCache>
              </c:numRef>
            </c:plus>
            <c:minus>
              <c:numRef>
                <c:f>前計算処理1!$V$44:$Y$44</c:f>
                <c:numCache>
                  <c:formatCode>General</c:formatCode>
                  <c:ptCount val="4"/>
                  <c:pt idx="0">
                    <c:v>0.10448801104052513</c:v>
                  </c:pt>
                  <c:pt idx="1">
                    <c:v>9.5135142323996794E-2</c:v>
                  </c:pt>
                  <c:pt idx="2">
                    <c:v>0.14432052220210542</c:v>
                  </c:pt>
                  <c:pt idx="3">
                    <c:v>0.29954462073834509</c:v>
                  </c:pt>
                </c:numCache>
              </c:numRef>
            </c:minus>
          </c:errBars>
          <c:cat>
            <c:strRef>
              <c:f>前計算処理1!$Q$3:$T$3</c:f>
              <c:strCache>
                <c:ptCount val="4"/>
                <c:pt idx="0">
                  <c:v>0hr</c:v>
                </c:pt>
                <c:pt idx="1">
                  <c:v>24hr</c:v>
                </c:pt>
                <c:pt idx="2">
                  <c:v>48hr</c:v>
                </c:pt>
                <c:pt idx="3">
                  <c:v>72hr</c:v>
                </c:pt>
              </c:strCache>
            </c:strRef>
          </c:cat>
          <c:val>
            <c:numRef>
              <c:f>前計算処理1!$Q$44:$T$44</c:f>
              <c:numCache>
                <c:formatCode>General</c:formatCode>
                <c:ptCount val="4"/>
                <c:pt idx="0">
                  <c:v>1</c:v>
                </c:pt>
                <c:pt idx="1">
                  <c:v>1.4249106078665075</c:v>
                </c:pt>
                <c:pt idx="2">
                  <c:v>1.3437340371190192</c:v>
                </c:pt>
                <c:pt idx="3">
                  <c:v>1.763621658436914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B5AB-4667-836C-E26B0CE7D204}"/>
            </c:ext>
          </c:extLst>
        </c:ser>
        <c:ser>
          <c:idx val="3"/>
          <c:order val="3"/>
          <c:tx>
            <c:strRef>
              <c:f>前計算処理1!$P$45</c:f>
              <c:strCache>
                <c:ptCount val="1"/>
                <c:pt idx="0">
                  <c:v>Gln- Chl 20μM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前計算処理1!$V$45:$Y$45</c:f>
                <c:numCache>
                  <c:formatCode>General</c:formatCode>
                  <c:ptCount val="4"/>
                  <c:pt idx="0">
                    <c:v>0.10448801104052513</c:v>
                  </c:pt>
                  <c:pt idx="1">
                    <c:v>6.1044134755408985E-2</c:v>
                  </c:pt>
                  <c:pt idx="2">
                    <c:v>0.18405620151371058</c:v>
                  </c:pt>
                  <c:pt idx="3">
                    <c:v>0.27255834550246683</c:v>
                  </c:pt>
                </c:numCache>
              </c:numRef>
            </c:plus>
            <c:minus>
              <c:numRef>
                <c:f>前計算処理1!$V$45:$Y$45</c:f>
                <c:numCache>
                  <c:formatCode>General</c:formatCode>
                  <c:ptCount val="4"/>
                  <c:pt idx="0">
                    <c:v>0.10448801104052513</c:v>
                  </c:pt>
                  <c:pt idx="1">
                    <c:v>6.1044134755408985E-2</c:v>
                  </c:pt>
                  <c:pt idx="2">
                    <c:v>0.18405620151371058</c:v>
                  </c:pt>
                  <c:pt idx="3">
                    <c:v>0.27255834550246683</c:v>
                  </c:pt>
                </c:numCache>
              </c:numRef>
            </c:minus>
          </c:errBars>
          <c:cat>
            <c:strRef>
              <c:f>前計算処理1!$Q$3:$T$3</c:f>
              <c:strCache>
                <c:ptCount val="4"/>
                <c:pt idx="0">
                  <c:v>0hr</c:v>
                </c:pt>
                <c:pt idx="1">
                  <c:v>24hr</c:v>
                </c:pt>
                <c:pt idx="2">
                  <c:v>48hr</c:v>
                </c:pt>
                <c:pt idx="3">
                  <c:v>72hr</c:v>
                </c:pt>
              </c:strCache>
            </c:strRef>
          </c:cat>
          <c:val>
            <c:numRef>
              <c:f>前計算処理1!$Q$45:$T$45</c:f>
              <c:numCache>
                <c:formatCode>General</c:formatCode>
                <c:ptCount val="4"/>
                <c:pt idx="0">
                  <c:v>1</c:v>
                </c:pt>
                <c:pt idx="1">
                  <c:v>1.2309722458709349</c:v>
                </c:pt>
                <c:pt idx="2">
                  <c:v>1.5625744934445769</c:v>
                </c:pt>
                <c:pt idx="3">
                  <c:v>0.8217691128894941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B5AB-4667-836C-E26B0CE7D204}"/>
            </c:ext>
          </c:extLst>
        </c:ser>
        <c:ser>
          <c:idx val="4"/>
          <c:order val="4"/>
          <c:tx>
            <c:strRef>
              <c:f>前計算処理1!$P$46</c:f>
              <c:strCache>
                <c:ptCount val="1"/>
                <c:pt idx="0">
                  <c:v>Gln- Chl 40μM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前計算処理1!$V$46:$Y$46</c:f>
                <c:numCache>
                  <c:formatCode>General</c:formatCode>
                  <c:ptCount val="4"/>
                  <c:pt idx="0">
                    <c:v>0.10448801104052513</c:v>
                  </c:pt>
                  <c:pt idx="1">
                    <c:v>7.2466800806980702E-2</c:v>
                  </c:pt>
                  <c:pt idx="2">
                    <c:v>0.1318106144209179</c:v>
                  </c:pt>
                  <c:pt idx="3">
                    <c:v>2.4034273024626216E-2</c:v>
                  </c:pt>
                </c:numCache>
              </c:numRef>
            </c:plus>
            <c:minus>
              <c:numRef>
                <c:f>前計算処理1!$V$46:$Y$46</c:f>
                <c:numCache>
                  <c:formatCode>General</c:formatCode>
                  <c:ptCount val="4"/>
                  <c:pt idx="0">
                    <c:v>0.10448801104052513</c:v>
                  </c:pt>
                  <c:pt idx="1">
                    <c:v>7.2466800806980702E-2</c:v>
                  </c:pt>
                  <c:pt idx="2">
                    <c:v>0.1318106144209179</c:v>
                  </c:pt>
                  <c:pt idx="3">
                    <c:v>2.4034273024626216E-2</c:v>
                  </c:pt>
                </c:numCache>
              </c:numRef>
            </c:minus>
          </c:errBars>
          <c:cat>
            <c:strRef>
              <c:f>前計算処理1!$Q$3:$T$3</c:f>
              <c:strCache>
                <c:ptCount val="4"/>
                <c:pt idx="0">
                  <c:v>0hr</c:v>
                </c:pt>
                <c:pt idx="1">
                  <c:v>24hr</c:v>
                </c:pt>
                <c:pt idx="2">
                  <c:v>48hr</c:v>
                </c:pt>
                <c:pt idx="3">
                  <c:v>72hr</c:v>
                </c:pt>
              </c:strCache>
            </c:strRef>
          </c:cat>
          <c:val>
            <c:numRef>
              <c:f>前計算処理1!$Q$46:$T$46</c:f>
              <c:numCache>
                <c:formatCode>General</c:formatCode>
                <c:ptCount val="4"/>
                <c:pt idx="0">
                  <c:v>1</c:v>
                </c:pt>
                <c:pt idx="1">
                  <c:v>1.1066746126340881</c:v>
                </c:pt>
                <c:pt idx="2">
                  <c:v>0.91660990975651269</c:v>
                </c:pt>
                <c:pt idx="3">
                  <c:v>0.3482887791588625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B5AB-4667-836C-E26B0CE7D20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450919624"/>
        <c:axId val="450920408"/>
      </c:lineChart>
      <c:catAx>
        <c:axId val="4509196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450920408"/>
        <c:crosses val="autoZero"/>
        <c:auto val="1"/>
        <c:lblAlgn val="ctr"/>
        <c:lblOffset val="100"/>
        <c:noMultiLvlLbl val="0"/>
      </c:catAx>
      <c:valAx>
        <c:axId val="45092040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elative proliferation</a:t>
                </a:r>
              </a:p>
            </c:rich>
          </c:tx>
          <c:overlay val="0"/>
          <c:spPr>
            <a:noFill/>
            <a:ln w="25400">
              <a:noFill/>
            </a:ln>
          </c:spPr>
        </c:title>
        <c:numFmt formatCode="General" sourceLinked="1"/>
        <c:majorTickMark val="none"/>
        <c:minorTickMark val="none"/>
        <c:tickLblPos val="nextTo"/>
        <c:spPr>
          <a:ln w="9525">
            <a:noFill/>
          </a:ln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450919624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900"/>
      </a:pPr>
      <a:endParaRPr lang="ja-JP"/>
    </a:p>
  </c:txPr>
  <c:externalData r:id="rId1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 b="0"/>
            </a:pPr>
            <a:r>
              <a:rPr lang="en-US" b="0" dirty="0"/>
              <a:t>Methionine</a:t>
            </a:r>
          </a:p>
        </c:rich>
      </c:tx>
      <c:layout>
        <c:manualLayout>
          <c:xMode val="edge"/>
          <c:yMode val="edge"/>
          <c:x val="0.38438746188933887"/>
          <c:y val="4.6573778870815062E-2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p10graph (3)'!$S$1</c:f>
              <c:strCache>
                <c:ptCount val="1"/>
                <c:pt idx="0">
                  <c:v>U87 G+ 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sp10graph (3)'!$X$30:$X$31</c:f>
                <c:numCache>
                  <c:formatCode>General</c:formatCode>
                  <c:ptCount val="2"/>
                  <c:pt idx="0">
                    <c:v>3.3240411353129985E-3</c:v>
                  </c:pt>
                  <c:pt idx="1">
                    <c:v>3.6208561715278068E-5</c:v>
                  </c:pt>
                </c:numCache>
              </c:numRef>
            </c:plus>
            <c:minus>
              <c:numRef>
                <c:f>'sp10graph (3)'!$X$30:$X$31</c:f>
                <c:numCache>
                  <c:formatCode>General</c:formatCode>
                  <c:ptCount val="2"/>
                  <c:pt idx="0">
                    <c:v>3.3240411353129985E-3</c:v>
                  </c:pt>
                  <c:pt idx="1">
                    <c:v>3.6208561715278068E-5</c:v>
                  </c:pt>
                </c:numCache>
              </c:numRef>
            </c:minus>
          </c:errBars>
          <c:cat>
            <c:strRef>
              <c:f>'sp10graph (3)'!$R$30:$R$31</c:f>
              <c:strCache>
                <c:ptCount val="2"/>
                <c:pt idx="0">
                  <c:v>C12</c:v>
                </c:pt>
                <c:pt idx="1">
                  <c:v>C13</c:v>
                </c:pt>
              </c:strCache>
            </c:strRef>
          </c:cat>
          <c:val>
            <c:numRef>
              <c:f>'sp10graph (3)'!$S$30:$S$31</c:f>
              <c:numCache>
                <c:formatCode>General</c:formatCode>
                <c:ptCount val="2"/>
                <c:pt idx="0">
                  <c:v>1.5249527884204639E-2</c:v>
                </c:pt>
                <c:pt idx="1">
                  <c:v>1.8083362825604642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7BD-4EE0-8EFA-2BF9272E96BA}"/>
            </c:ext>
          </c:extLst>
        </c:ser>
        <c:ser>
          <c:idx val="1"/>
          <c:order val="1"/>
          <c:tx>
            <c:strRef>
              <c:f>'sp10graph (3)'!$T$1</c:f>
              <c:strCache>
                <c:ptCount val="1"/>
                <c:pt idx="0">
                  <c:v>U87 G- 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sp10graph (3)'!$Y$30:$Y$31</c:f>
                <c:numCache>
                  <c:formatCode>General</c:formatCode>
                  <c:ptCount val="2"/>
                  <c:pt idx="0">
                    <c:v>1.4933249398883661E-2</c:v>
                  </c:pt>
                  <c:pt idx="1">
                    <c:v>6.9649932968850406E-5</c:v>
                  </c:pt>
                </c:numCache>
              </c:numRef>
            </c:plus>
            <c:minus>
              <c:numRef>
                <c:f>'sp10graph (3)'!$Y$30:$Y$31</c:f>
                <c:numCache>
                  <c:formatCode>General</c:formatCode>
                  <c:ptCount val="2"/>
                  <c:pt idx="0">
                    <c:v>1.4933249398883661E-2</c:v>
                  </c:pt>
                  <c:pt idx="1">
                    <c:v>6.9649932968850406E-5</c:v>
                  </c:pt>
                </c:numCache>
              </c:numRef>
            </c:minus>
          </c:errBars>
          <c:cat>
            <c:strRef>
              <c:f>'sp10graph (3)'!$R$30:$R$31</c:f>
              <c:strCache>
                <c:ptCount val="2"/>
                <c:pt idx="0">
                  <c:v>C12</c:v>
                </c:pt>
                <c:pt idx="1">
                  <c:v>C13</c:v>
                </c:pt>
              </c:strCache>
            </c:strRef>
          </c:cat>
          <c:val>
            <c:numRef>
              <c:f>'sp10graph (3)'!$T$30:$T$31</c:f>
              <c:numCache>
                <c:formatCode>General</c:formatCode>
                <c:ptCount val="2"/>
                <c:pt idx="0">
                  <c:v>8.7770821302176907E-2</c:v>
                </c:pt>
                <c:pt idx="1">
                  <c:v>3.0912074970207366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7BD-4EE0-8EFA-2BF9272E96BA}"/>
            </c:ext>
          </c:extLst>
        </c:ser>
        <c:ser>
          <c:idx val="2"/>
          <c:order val="2"/>
          <c:tx>
            <c:strRef>
              <c:f>'sp10graph (3)'!$U$1</c:f>
              <c:strCache>
                <c:ptCount val="1"/>
                <c:pt idx="0">
                  <c:v>U87 G+ CHL+ 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sp10graph (3)'!$Z$30:$Z$31</c:f>
                <c:numCache>
                  <c:formatCode>General</c:formatCode>
                  <c:ptCount val="2"/>
                  <c:pt idx="0">
                    <c:v>6.423975667430717E-4</c:v>
                  </c:pt>
                  <c:pt idx="1">
                    <c:v>2.7732006685031673E-5</c:v>
                  </c:pt>
                </c:numCache>
              </c:numRef>
            </c:plus>
            <c:minus>
              <c:numRef>
                <c:f>'sp10graph (3)'!$Z$30:$Z$31</c:f>
                <c:numCache>
                  <c:formatCode>General</c:formatCode>
                  <c:ptCount val="2"/>
                  <c:pt idx="0">
                    <c:v>6.423975667430717E-4</c:v>
                  </c:pt>
                  <c:pt idx="1">
                    <c:v>2.7732006685031673E-5</c:v>
                  </c:pt>
                </c:numCache>
              </c:numRef>
            </c:minus>
          </c:errBars>
          <c:cat>
            <c:strRef>
              <c:f>'sp10graph (3)'!$R$30:$R$31</c:f>
              <c:strCache>
                <c:ptCount val="2"/>
                <c:pt idx="0">
                  <c:v>C12</c:v>
                </c:pt>
                <c:pt idx="1">
                  <c:v>C13</c:v>
                </c:pt>
              </c:strCache>
            </c:strRef>
          </c:cat>
          <c:val>
            <c:numRef>
              <c:f>'sp10graph (3)'!$U$30:$U$31</c:f>
              <c:numCache>
                <c:formatCode>General</c:formatCode>
                <c:ptCount val="2"/>
                <c:pt idx="0">
                  <c:v>1.1054489149670542E-2</c:v>
                </c:pt>
                <c:pt idx="1">
                  <c:v>1.5803637932559447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B7BD-4EE0-8EFA-2BF9272E96BA}"/>
            </c:ext>
          </c:extLst>
        </c:ser>
        <c:ser>
          <c:idx val="3"/>
          <c:order val="3"/>
          <c:tx>
            <c:strRef>
              <c:f>'sp10graph (3)'!$V$1</c:f>
              <c:strCache>
                <c:ptCount val="1"/>
                <c:pt idx="0">
                  <c:v>U87 G- CHL+ 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sp10graph (3)'!$AA$30:$AA$31</c:f>
                <c:numCache>
                  <c:formatCode>General</c:formatCode>
                  <c:ptCount val="2"/>
                  <c:pt idx="0">
                    <c:v>3.63470527222627E-3</c:v>
                  </c:pt>
                  <c:pt idx="1">
                    <c:v>5.8096430745281566E-5</c:v>
                  </c:pt>
                </c:numCache>
              </c:numRef>
            </c:plus>
            <c:minus>
              <c:numRef>
                <c:f>'sp10graph (3)'!$AA$30:$AA$31</c:f>
                <c:numCache>
                  <c:formatCode>General</c:formatCode>
                  <c:ptCount val="2"/>
                  <c:pt idx="0">
                    <c:v>3.63470527222627E-3</c:v>
                  </c:pt>
                  <c:pt idx="1">
                    <c:v>5.8096430745281566E-5</c:v>
                  </c:pt>
                </c:numCache>
              </c:numRef>
            </c:minus>
          </c:errBars>
          <c:cat>
            <c:strRef>
              <c:f>'sp10graph (3)'!$R$30:$R$31</c:f>
              <c:strCache>
                <c:ptCount val="2"/>
                <c:pt idx="0">
                  <c:v>C12</c:v>
                </c:pt>
                <c:pt idx="1">
                  <c:v>C13</c:v>
                </c:pt>
              </c:strCache>
            </c:strRef>
          </c:cat>
          <c:val>
            <c:numRef>
              <c:f>'sp10graph (3)'!$V$30:$V$31</c:f>
              <c:numCache>
                <c:formatCode>General</c:formatCode>
                <c:ptCount val="2"/>
                <c:pt idx="0">
                  <c:v>3.3856767310399195E-2</c:v>
                </c:pt>
                <c:pt idx="1">
                  <c:v>2.2747484045155142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B7BD-4EE0-8EFA-2BF9272E96B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50921584"/>
        <c:axId val="450922760"/>
      </c:barChart>
      <c:catAx>
        <c:axId val="45092158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450922760"/>
        <c:crosses val="autoZero"/>
        <c:auto val="1"/>
        <c:lblAlgn val="ctr"/>
        <c:lblOffset val="100"/>
        <c:noMultiLvlLbl val="0"/>
      </c:catAx>
      <c:valAx>
        <c:axId val="450922760"/>
        <c:scaling>
          <c:orientation val="minMax"/>
        </c:scaling>
        <c:delete val="0"/>
        <c:axPos val="l"/>
        <c:majorGridlines/>
        <c:title>
          <c:tx>
            <c:rich>
              <a:bodyPr/>
              <a:lstStyle/>
              <a:p>
                <a:pPr>
                  <a:defRPr/>
                </a:pPr>
                <a:r>
                  <a:rPr lang="en-US" altLang="ja-JP" dirty="0"/>
                  <a:t>Relative peak level</a:t>
                </a:r>
                <a:endParaRPr lang="ja-JP" altLang="en-US" dirty="0"/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45092158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900">
          <a:latin typeface="+mn-lt"/>
        </a:defRPr>
      </a:pPr>
      <a:endParaRPr lang="ja-JP"/>
    </a:p>
  </c:txPr>
  <c:externalData r:id="rId1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 b="0"/>
            </a:pPr>
            <a:r>
              <a:rPr lang="en-US" b="0" dirty="0"/>
              <a:t>Glutamine</a:t>
            </a:r>
          </a:p>
        </c:rich>
      </c:tx>
      <c:layout>
        <c:manualLayout>
          <c:xMode val="edge"/>
          <c:yMode val="edge"/>
          <c:x val="0.43304915125951665"/>
          <c:y val="3.4948565526496472E-2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p10graph (3)'!$S$1</c:f>
              <c:strCache>
                <c:ptCount val="1"/>
                <c:pt idx="0">
                  <c:v>U87 G+ 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sp10graph (3)'!$X$99:$X$100</c:f>
                <c:numCache>
                  <c:formatCode>General</c:formatCode>
                  <c:ptCount val="2"/>
                  <c:pt idx="0">
                    <c:v>0.12003251983347016</c:v>
                  </c:pt>
                  <c:pt idx="1">
                    <c:v>6.5897804992667191E-4</c:v>
                  </c:pt>
                </c:numCache>
              </c:numRef>
            </c:plus>
            <c:minus>
              <c:numRef>
                <c:f>'sp10graph (3)'!$X$99:$X$100</c:f>
                <c:numCache>
                  <c:formatCode>General</c:formatCode>
                  <c:ptCount val="2"/>
                  <c:pt idx="0">
                    <c:v>0.12003251983347016</c:v>
                  </c:pt>
                  <c:pt idx="1">
                    <c:v>6.5897804992667191E-4</c:v>
                  </c:pt>
                </c:numCache>
              </c:numRef>
            </c:minus>
          </c:errBars>
          <c:cat>
            <c:strRef>
              <c:f>'sp10graph (3)'!$R$99:$R$100</c:f>
              <c:strCache>
                <c:ptCount val="2"/>
                <c:pt idx="0">
                  <c:v>C12</c:v>
                </c:pt>
                <c:pt idx="1">
                  <c:v>C13</c:v>
                </c:pt>
              </c:strCache>
            </c:strRef>
          </c:cat>
          <c:val>
            <c:numRef>
              <c:f>'sp10graph (3)'!$S$99:$S$100</c:f>
              <c:numCache>
                <c:formatCode>General</c:formatCode>
                <c:ptCount val="2"/>
                <c:pt idx="0">
                  <c:v>0.52909178552866298</c:v>
                </c:pt>
                <c:pt idx="1">
                  <c:v>1.3196713252627433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620-41BC-85BD-5939E5F2AF71}"/>
            </c:ext>
          </c:extLst>
        </c:ser>
        <c:ser>
          <c:idx val="1"/>
          <c:order val="1"/>
          <c:tx>
            <c:strRef>
              <c:f>'sp10graph (3)'!$T$1</c:f>
              <c:strCache>
                <c:ptCount val="1"/>
                <c:pt idx="0">
                  <c:v>U87 G- </c:v>
                </c:pt>
              </c:strCache>
            </c:strRef>
          </c:tx>
          <c:invertIfNegative val="0"/>
          <c:cat>
            <c:strRef>
              <c:f>'sp10graph (3)'!$R$99:$R$100</c:f>
              <c:strCache>
                <c:ptCount val="2"/>
                <c:pt idx="0">
                  <c:v>C12</c:v>
                </c:pt>
                <c:pt idx="1">
                  <c:v>C13</c:v>
                </c:pt>
              </c:strCache>
            </c:strRef>
          </c:cat>
          <c:val>
            <c:numRef>
              <c:f>'sp10graph (3)'!$T$99:$T$100</c:f>
              <c:numCache>
                <c:formatCode>General</c:formatCode>
                <c:ptCount val="2"/>
                <c:pt idx="0">
                  <c:v>9.4239344237560341E-4</c:v>
                </c:pt>
                <c:pt idx="1">
                  <c:v>1.2012140710101565E-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620-41BC-85BD-5939E5F2AF71}"/>
            </c:ext>
          </c:extLst>
        </c:ser>
        <c:ser>
          <c:idx val="2"/>
          <c:order val="2"/>
          <c:tx>
            <c:strRef>
              <c:f>'sp10graph (3)'!$U$1</c:f>
              <c:strCache>
                <c:ptCount val="1"/>
                <c:pt idx="0">
                  <c:v>U87 G+ CHL+ 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sp10graph (3)'!$Z$99:$Z$100</c:f>
                <c:numCache>
                  <c:formatCode>General</c:formatCode>
                  <c:ptCount val="2"/>
                  <c:pt idx="0">
                    <c:v>3.2335432909426393E-2</c:v>
                  </c:pt>
                  <c:pt idx="1">
                    <c:v>5.284412840049265E-4</c:v>
                  </c:pt>
                </c:numCache>
              </c:numRef>
            </c:plus>
            <c:minus>
              <c:numRef>
                <c:f>'sp10graph (3)'!$Z$99:$Z$100</c:f>
                <c:numCache>
                  <c:formatCode>General</c:formatCode>
                  <c:ptCount val="2"/>
                  <c:pt idx="0">
                    <c:v>3.2335432909426393E-2</c:v>
                  </c:pt>
                  <c:pt idx="1">
                    <c:v>5.284412840049265E-4</c:v>
                  </c:pt>
                </c:numCache>
              </c:numRef>
            </c:minus>
          </c:errBars>
          <c:cat>
            <c:strRef>
              <c:f>'sp10graph (3)'!$R$99:$R$100</c:f>
              <c:strCache>
                <c:ptCount val="2"/>
                <c:pt idx="0">
                  <c:v>C12</c:v>
                </c:pt>
                <c:pt idx="1">
                  <c:v>C13</c:v>
                </c:pt>
              </c:strCache>
            </c:strRef>
          </c:cat>
          <c:val>
            <c:numRef>
              <c:f>'sp10graph (3)'!$U$99:$U$100</c:f>
              <c:numCache>
                <c:formatCode>General</c:formatCode>
                <c:ptCount val="2"/>
                <c:pt idx="0">
                  <c:v>0.43684525665512669</c:v>
                </c:pt>
                <c:pt idx="1">
                  <c:v>1.2893335332966255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F620-41BC-85BD-5939E5F2AF71}"/>
            </c:ext>
          </c:extLst>
        </c:ser>
        <c:ser>
          <c:idx val="3"/>
          <c:order val="3"/>
          <c:tx>
            <c:strRef>
              <c:f>'sp10graph (3)'!$V$1</c:f>
              <c:strCache>
                <c:ptCount val="1"/>
                <c:pt idx="0">
                  <c:v>U87 G- CHL+ </c:v>
                </c:pt>
              </c:strCache>
            </c:strRef>
          </c:tx>
          <c:invertIfNegative val="0"/>
          <c:cat>
            <c:strRef>
              <c:f>'sp10graph (3)'!$R$99:$R$100</c:f>
              <c:strCache>
                <c:ptCount val="2"/>
                <c:pt idx="0">
                  <c:v>C12</c:v>
                </c:pt>
                <c:pt idx="1">
                  <c:v>C13</c:v>
                </c:pt>
              </c:strCache>
            </c:strRef>
          </c:cat>
          <c:val>
            <c:numRef>
              <c:f>'sp10graph (3)'!$V$99:$V$100</c:f>
              <c:numCache>
                <c:formatCode>General</c:formatCode>
                <c:ptCount val="2"/>
                <c:pt idx="0">
                  <c:v>8.1198589765128554E-4</c:v>
                </c:pt>
                <c:pt idx="1">
                  <c:v>1.0391348838190854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F620-41BC-85BD-5939E5F2AF7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50922368"/>
        <c:axId val="450923152"/>
      </c:barChart>
      <c:catAx>
        <c:axId val="45092236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450923152"/>
        <c:crosses val="autoZero"/>
        <c:auto val="1"/>
        <c:lblAlgn val="ctr"/>
        <c:lblOffset val="100"/>
        <c:noMultiLvlLbl val="0"/>
      </c:catAx>
      <c:valAx>
        <c:axId val="450923152"/>
        <c:scaling>
          <c:orientation val="minMax"/>
        </c:scaling>
        <c:delete val="0"/>
        <c:axPos val="l"/>
        <c:majorGridlines/>
        <c:title>
          <c:tx>
            <c:rich>
              <a:bodyPr/>
              <a:lstStyle/>
              <a:p>
                <a:pPr>
                  <a:defRPr/>
                </a:pPr>
                <a:r>
                  <a:rPr lang="en-US" altLang="ja-JP" dirty="0"/>
                  <a:t>Relative peak level</a:t>
                </a:r>
                <a:endParaRPr lang="ja-JP" altLang="en-US" dirty="0"/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45092236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900">
          <a:latin typeface="+mn-lt"/>
        </a:defRPr>
      </a:pPr>
      <a:endParaRPr lang="ja-JP"/>
    </a:p>
  </c:txPr>
  <c:externalData r:id="rId1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 b="0"/>
            </a:pPr>
            <a:r>
              <a:rPr lang="en-US" b="0" dirty="0"/>
              <a:t>Glutamate</a:t>
            </a:r>
          </a:p>
        </c:rich>
      </c:tx>
      <c:layout>
        <c:manualLayout>
          <c:xMode val="edge"/>
          <c:yMode val="edge"/>
          <c:x val="0.41516583579792932"/>
          <c:y val="3.4881772763103322E-2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p10graph (3)'!$S$1</c:f>
              <c:strCache>
                <c:ptCount val="1"/>
                <c:pt idx="0">
                  <c:v>U87 G+ 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sp10graph (3)'!$X$82:$X$83</c:f>
                <c:numCache>
                  <c:formatCode>General</c:formatCode>
                  <c:ptCount val="2"/>
                  <c:pt idx="0">
                    <c:v>0.24337232019429625</c:v>
                  </c:pt>
                  <c:pt idx="1">
                    <c:v>7.9220401955840916E-2</c:v>
                  </c:pt>
                </c:numCache>
              </c:numRef>
            </c:plus>
            <c:minus>
              <c:numRef>
                <c:f>'sp10graph (3)'!$X$82:$X$83</c:f>
                <c:numCache>
                  <c:formatCode>General</c:formatCode>
                  <c:ptCount val="2"/>
                  <c:pt idx="0">
                    <c:v>0.24337232019429625</c:v>
                  </c:pt>
                  <c:pt idx="1">
                    <c:v>7.9220401955840916E-2</c:v>
                  </c:pt>
                </c:numCache>
              </c:numRef>
            </c:minus>
          </c:errBars>
          <c:cat>
            <c:strRef>
              <c:f>'sp10graph (3)'!$R$82:$R$83</c:f>
              <c:strCache>
                <c:ptCount val="2"/>
                <c:pt idx="0">
                  <c:v>C12</c:v>
                </c:pt>
                <c:pt idx="1">
                  <c:v>C13</c:v>
                </c:pt>
              </c:strCache>
            </c:strRef>
          </c:cat>
          <c:val>
            <c:numRef>
              <c:f>'sp10graph (3)'!$S$82:$S$83</c:f>
              <c:numCache>
                <c:formatCode>General</c:formatCode>
                <c:ptCount val="2"/>
                <c:pt idx="0">
                  <c:v>1.1525309880067649</c:v>
                </c:pt>
                <c:pt idx="1">
                  <c:v>0.372996948114944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F15-4B5B-97A4-9468880178D2}"/>
            </c:ext>
          </c:extLst>
        </c:ser>
        <c:ser>
          <c:idx val="1"/>
          <c:order val="1"/>
          <c:tx>
            <c:strRef>
              <c:f>'sp10graph (3)'!$T$1</c:f>
              <c:strCache>
                <c:ptCount val="1"/>
                <c:pt idx="0">
                  <c:v>U87 G- 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sp10graph (3)'!$Y$82:$Y$83</c:f>
                <c:numCache>
                  <c:formatCode>General</c:formatCode>
                  <c:ptCount val="2"/>
                  <c:pt idx="0">
                    <c:v>1.9500820552265055E-2</c:v>
                  </c:pt>
                  <c:pt idx="1">
                    <c:v>1.7631852991323759E-2</c:v>
                  </c:pt>
                </c:numCache>
              </c:numRef>
            </c:plus>
            <c:minus>
              <c:numRef>
                <c:f>'sp10graph (3)'!$Y$82:$Y$83</c:f>
                <c:numCache>
                  <c:formatCode>General</c:formatCode>
                  <c:ptCount val="2"/>
                  <c:pt idx="0">
                    <c:v>1.9500820552265055E-2</c:v>
                  </c:pt>
                  <c:pt idx="1">
                    <c:v>1.7631852991323759E-2</c:v>
                  </c:pt>
                </c:numCache>
              </c:numRef>
            </c:minus>
          </c:errBars>
          <c:cat>
            <c:strRef>
              <c:f>'sp10graph (3)'!$R$82:$R$83</c:f>
              <c:strCache>
                <c:ptCount val="2"/>
                <c:pt idx="0">
                  <c:v>C12</c:v>
                </c:pt>
                <c:pt idx="1">
                  <c:v>C13</c:v>
                </c:pt>
              </c:strCache>
            </c:strRef>
          </c:cat>
          <c:val>
            <c:numRef>
              <c:f>'sp10graph (3)'!$T$82:$T$83</c:f>
              <c:numCache>
                <c:formatCode>General</c:formatCode>
                <c:ptCount val="2"/>
                <c:pt idx="0">
                  <c:v>9.0387619949840195E-2</c:v>
                </c:pt>
                <c:pt idx="1">
                  <c:v>9.6268931080986997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F15-4B5B-97A4-9468880178D2}"/>
            </c:ext>
          </c:extLst>
        </c:ser>
        <c:ser>
          <c:idx val="2"/>
          <c:order val="2"/>
          <c:tx>
            <c:strRef>
              <c:f>'sp10graph (3)'!$U$1</c:f>
              <c:strCache>
                <c:ptCount val="1"/>
                <c:pt idx="0">
                  <c:v>U87 G+ CHL+ 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sp10graph (3)'!$Z$82:$Z$83</c:f>
                <c:numCache>
                  <c:formatCode>General</c:formatCode>
                  <c:ptCount val="2"/>
                  <c:pt idx="0">
                    <c:v>4.723841624463794E-2</c:v>
                  </c:pt>
                  <c:pt idx="1">
                    <c:v>1.1612441363225172E-2</c:v>
                  </c:pt>
                </c:numCache>
              </c:numRef>
            </c:plus>
            <c:minus>
              <c:numRef>
                <c:f>'sp10graph (3)'!$Z$82:$Z$83</c:f>
                <c:numCache>
                  <c:formatCode>General</c:formatCode>
                  <c:ptCount val="2"/>
                  <c:pt idx="0">
                    <c:v>4.723841624463794E-2</c:v>
                  </c:pt>
                  <c:pt idx="1">
                    <c:v>1.1612441363225172E-2</c:v>
                  </c:pt>
                </c:numCache>
              </c:numRef>
            </c:minus>
          </c:errBars>
          <c:cat>
            <c:strRef>
              <c:f>'sp10graph (3)'!$R$82:$R$83</c:f>
              <c:strCache>
                <c:ptCount val="2"/>
                <c:pt idx="0">
                  <c:v>C12</c:v>
                </c:pt>
                <c:pt idx="1">
                  <c:v>C13</c:v>
                </c:pt>
              </c:strCache>
            </c:strRef>
          </c:cat>
          <c:val>
            <c:numRef>
              <c:f>'sp10graph (3)'!$U$82:$U$83</c:f>
              <c:numCache>
                <c:formatCode>General</c:formatCode>
                <c:ptCount val="2"/>
                <c:pt idx="0">
                  <c:v>0.76461965355450534</c:v>
                </c:pt>
                <c:pt idx="1">
                  <c:v>0.203855711420613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F15-4B5B-97A4-9468880178D2}"/>
            </c:ext>
          </c:extLst>
        </c:ser>
        <c:ser>
          <c:idx val="3"/>
          <c:order val="3"/>
          <c:tx>
            <c:strRef>
              <c:f>'sp10graph (3)'!$V$1</c:f>
              <c:strCache>
                <c:ptCount val="1"/>
                <c:pt idx="0">
                  <c:v>U87 G- CHL+ 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sp10graph (3)'!$AA$82:$AA$83</c:f>
                <c:numCache>
                  <c:formatCode>General</c:formatCode>
                  <c:ptCount val="2"/>
                  <c:pt idx="0">
                    <c:v>1.7208719500660585E-3</c:v>
                  </c:pt>
                  <c:pt idx="1">
                    <c:v>2.3843608949135689E-3</c:v>
                  </c:pt>
                </c:numCache>
              </c:numRef>
            </c:plus>
            <c:minus>
              <c:numRef>
                <c:f>'sp10graph (3)'!$AA$82:$AA$83</c:f>
                <c:numCache>
                  <c:formatCode>General</c:formatCode>
                  <c:ptCount val="2"/>
                  <c:pt idx="0">
                    <c:v>1.7208719500660585E-3</c:v>
                  </c:pt>
                  <c:pt idx="1">
                    <c:v>2.3843608949135689E-3</c:v>
                  </c:pt>
                </c:numCache>
              </c:numRef>
            </c:minus>
          </c:errBars>
          <c:cat>
            <c:strRef>
              <c:f>'sp10graph (3)'!$R$82:$R$83</c:f>
              <c:strCache>
                <c:ptCount val="2"/>
                <c:pt idx="0">
                  <c:v>C12</c:v>
                </c:pt>
                <c:pt idx="1">
                  <c:v>C13</c:v>
                </c:pt>
              </c:strCache>
            </c:strRef>
          </c:cat>
          <c:val>
            <c:numRef>
              <c:f>'sp10graph (3)'!$V$82:$V$83</c:f>
              <c:numCache>
                <c:formatCode>General</c:formatCode>
                <c:ptCount val="2"/>
                <c:pt idx="0">
                  <c:v>1.6861630206210797E-2</c:v>
                </c:pt>
                <c:pt idx="1">
                  <c:v>2.1281069605211107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AF15-4B5B-97A4-9468880178D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50923936"/>
        <c:axId val="450927464"/>
      </c:barChart>
      <c:catAx>
        <c:axId val="45092393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450927464"/>
        <c:crosses val="autoZero"/>
        <c:auto val="1"/>
        <c:lblAlgn val="ctr"/>
        <c:lblOffset val="100"/>
        <c:noMultiLvlLbl val="0"/>
      </c:catAx>
      <c:valAx>
        <c:axId val="450927464"/>
        <c:scaling>
          <c:orientation val="minMax"/>
        </c:scaling>
        <c:delete val="0"/>
        <c:axPos val="l"/>
        <c:majorGridlines/>
        <c:title>
          <c:tx>
            <c:rich>
              <a:bodyPr/>
              <a:lstStyle/>
              <a:p>
                <a:pPr>
                  <a:defRPr/>
                </a:pPr>
                <a:r>
                  <a:rPr lang="en-US" altLang="ja-JP" dirty="0"/>
                  <a:t>Relative peak level</a:t>
                </a:r>
                <a:endParaRPr lang="ja-JP" altLang="en-US" dirty="0"/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45092393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900">
          <a:latin typeface="+mn-lt"/>
        </a:defRPr>
      </a:pPr>
      <a:endParaRPr lang="ja-JP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40104514765054905"/>
          <c:y val="4.183677727241781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8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398842324217418"/>
          <c:y val="0.23139251681706677"/>
          <c:w val="0.50566817840823841"/>
          <c:h val="0.454111314377576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グラフ (2)'!$AB$11</c:f>
              <c:strCache>
                <c:ptCount val="1"/>
                <c:pt idx="0">
                  <c:v>Glycine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2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A26E-4C24-98B4-2E07CCAED934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accent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A26E-4C24-98B4-2E07CCAED934}"/>
              </c:ext>
            </c:extLst>
          </c:dPt>
          <c:cat>
            <c:strRef>
              <c:f>'グラフ (2)'!$W$12:$W$15</c:f>
              <c:strCache>
                <c:ptCount val="4"/>
                <c:pt idx="0">
                  <c:v>Central 1</c:v>
                </c:pt>
                <c:pt idx="1">
                  <c:v>Central 2</c:v>
                </c:pt>
                <c:pt idx="2">
                  <c:v>Edge 3</c:v>
                </c:pt>
                <c:pt idx="3">
                  <c:v>Edge 4</c:v>
                </c:pt>
              </c:strCache>
            </c:strRef>
          </c:cat>
          <c:val>
            <c:numRef>
              <c:f>'グラフ (2)'!$AB$12:$AB$15</c:f>
              <c:numCache>
                <c:formatCode>General</c:formatCode>
                <c:ptCount val="4"/>
                <c:pt idx="0">
                  <c:v>0.2924900381275794</c:v>
                </c:pt>
                <c:pt idx="1">
                  <c:v>0.23409720019128821</c:v>
                </c:pt>
                <c:pt idx="2">
                  <c:v>7.4995710154959705E-2</c:v>
                </c:pt>
                <c:pt idx="3">
                  <c:v>5.7196201825315617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A26E-4C24-98B4-2E07CCAED93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41474656"/>
        <c:axId val="441471912"/>
      </c:barChart>
      <c:catAx>
        <c:axId val="4414746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41471912"/>
        <c:crosses val="autoZero"/>
        <c:auto val="1"/>
        <c:lblAlgn val="ctr"/>
        <c:lblOffset val="100"/>
        <c:noMultiLvlLbl val="0"/>
      </c:catAx>
      <c:valAx>
        <c:axId val="44147191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dirty="0"/>
                  <a:t>Relative</a:t>
                </a:r>
                <a:r>
                  <a:rPr lang="ja-JP" altLang="en-US" dirty="0"/>
                  <a:t> </a:t>
                </a:r>
                <a:r>
                  <a:rPr lang="en-US" altLang="ja-JP" dirty="0"/>
                  <a:t>peak</a:t>
                </a:r>
                <a:r>
                  <a:rPr lang="ja-JP" altLang="en-US" dirty="0"/>
                  <a:t> </a:t>
                </a:r>
                <a:r>
                  <a:rPr lang="en-US" altLang="ja-JP" dirty="0"/>
                  <a:t>level</a:t>
                </a:r>
                <a:endParaRPr lang="ja-JP" altLang="en-US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4147465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900"/>
      </a:pPr>
      <a:endParaRPr lang="ja-JP"/>
    </a:p>
  </c:txPr>
  <c:externalData r:id="rId3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 b="0"/>
            </a:pPr>
            <a:r>
              <a:rPr lang="en-US" b="0" dirty="0"/>
              <a:t>Lactate</a:t>
            </a:r>
          </a:p>
        </c:rich>
      </c:tx>
      <c:layout>
        <c:manualLayout>
          <c:xMode val="edge"/>
          <c:yMode val="edge"/>
          <c:x val="0.53572735570620189"/>
          <c:y val="3.4881772763103322E-2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p10graph (3)'!$S$1</c:f>
              <c:strCache>
                <c:ptCount val="1"/>
                <c:pt idx="0">
                  <c:v>U87 G+ 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sp10graph (3)'!$X$3:$X$4</c:f>
                <c:numCache>
                  <c:formatCode>General</c:formatCode>
                  <c:ptCount val="2"/>
                  <c:pt idx="0">
                    <c:v>1.2118631013187341E-3</c:v>
                  </c:pt>
                  <c:pt idx="1">
                    <c:v>1.0532500867129558E-2</c:v>
                  </c:pt>
                </c:numCache>
              </c:numRef>
            </c:plus>
            <c:minus>
              <c:numRef>
                <c:f>'sp10graph (3)'!$X$3:$X$4</c:f>
                <c:numCache>
                  <c:formatCode>General</c:formatCode>
                  <c:ptCount val="2"/>
                  <c:pt idx="0">
                    <c:v>1.2118631013187341E-3</c:v>
                  </c:pt>
                  <c:pt idx="1">
                    <c:v>1.0532500867129558E-2</c:v>
                  </c:pt>
                </c:numCache>
              </c:numRef>
            </c:minus>
          </c:errBars>
          <c:cat>
            <c:strRef>
              <c:f>'sp10graph (3)'!$R$3:$R$4</c:f>
              <c:strCache>
                <c:ptCount val="2"/>
                <c:pt idx="0">
                  <c:v>C12</c:v>
                </c:pt>
                <c:pt idx="1">
                  <c:v>C13</c:v>
                </c:pt>
              </c:strCache>
            </c:strRef>
          </c:cat>
          <c:val>
            <c:numRef>
              <c:f>'sp10graph (3)'!$S$3:$S$4</c:f>
              <c:numCache>
                <c:formatCode>General</c:formatCode>
                <c:ptCount val="2"/>
                <c:pt idx="0">
                  <c:v>3.7881260834109554E-3</c:v>
                </c:pt>
                <c:pt idx="1">
                  <c:v>0.14911613308894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BC4-42B0-9CCB-EE944EA95266}"/>
            </c:ext>
          </c:extLst>
        </c:ser>
        <c:ser>
          <c:idx val="1"/>
          <c:order val="1"/>
          <c:tx>
            <c:strRef>
              <c:f>'sp10graph (3)'!$T$1</c:f>
              <c:strCache>
                <c:ptCount val="1"/>
                <c:pt idx="0">
                  <c:v>U87 G- 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sp10graph (3)'!$Y$3:$Y$4</c:f>
                <c:numCache>
                  <c:formatCode>General</c:formatCode>
                  <c:ptCount val="2"/>
                  <c:pt idx="0">
                    <c:v>2.1193840175366746E-3</c:v>
                  </c:pt>
                  <c:pt idx="1">
                    <c:v>1.233746784119041E-2</c:v>
                  </c:pt>
                </c:numCache>
              </c:numRef>
            </c:plus>
            <c:minus>
              <c:numRef>
                <c:f>'sp10graph (3)'!$Y$3:$Y$4</c:f>
                <c:numCache>
                  <c:formatCode>General</c:formatCode>
                  <c:ptCount val="2"/>
                  <c:pt idx="0">
                    <c:v>2.1193840175366746E-3</c:v>
                  </c:pt>
                  <c:pt idx="1">
                    <c:v>1.233746784119041E-2</c:v>
                  </c:pt>
                </c:numCache>
              </c:numRef>
            </c:minus>
          </c:errBars>
          <c:cat>
            <c:strRef>
              <c:f>'sp10graph (3)'!$R$3:$R$4</c:f>
              <c:strCache>
                <c:ptCount val="2"/>
                <c:pt idx="0">
                  <c:v>C12</c:v>
                </c:pt>
                <c:pt idx="1">
                  <c:v>C13</c:v>
                </c:pt>
              </c:strCache>
            </c:strRef>
          </c:cat>
          <c:val>
            <c:numRef>
              <c:f>'sp10graph (3)'!$T$3:$T$4</c:f>
              <c:numCache>
                <c:formatCode>General</c:formatCode>
                <c:ptCount val="2"/>
                <c:pt idx="0">
                  <c:v>6.2967640228466419E-3</c:v>
                </c:pt>
                <c:pt idx="1">
                  <c:v>6.442005962485782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BC4-42B0-9CCB-EE944EA95266}"/>
            </c:ext>
          </c:extLst>
        </c:ser>
        <c:ser>
          <c:idx val="2"/>
          <c:order val="2"/>
          <c:tx>
            <c:strRef>
              <c:f>'sp10graph (3)'!$U$1</c:f>
              <c:strCache>
                <c:ptCount val="1"/>
                <c:pt idx="0">
                  <c:v>U87 G+ CHL+ 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sp10graph (3)'!$Z$3:$Z$4</c:f>
                <c:numCache>
                  <c:formatCode>General</c:formatCode>
                  <c:ptCount val="2"/>
                  <c:pt idx="0">
                    <c:v>1.0288305973278409E-3</c:v>
                  </c:pt>
                  <c:pt idx="1">
                    <c:v>1.4953735350166867E-3</c:v>
                  </c:pt>
                </c:numCache>
              </c:numRef>
            </c:plus>
            <c:minus>
              <c:numRef>
                <c:f>'sp10graph (3)'!$Z$3:$Z$4</c:f>
                <c:numCache>
                  <c:formatCode>General</c:formatCode>
                  <c:ptCount val="2"/>
                  <c:pt idx="0">
                    <c:v>1.0288305973278409E-3</c:v>
                  </c:pt>
                  <c:pt idx="1">
                    <c:v>1.4953735350166867E-3</c:v>
                  </c:pt>
                </c:numCache>
              </c:numRef>
            </c:minus>
          </c:errBars>
          <c:cat>
            <c:strRef>
              <c:f>'sp10graph (3)'!$R$3:$R$4</c:f>
              <c:strCache>
                <c:ptCount val="2"/>
                <c:pt idx="0">
                  <c:v>C12</c:v>
                </c:pt>
                <c:pt idx="1">
                  <c:v>C13</c:v>
                </c:pt>
              </c:strCache>
            </c:strRef>
          </c:cat>
          <c:val>
            <c:numRef>
              <c:f>'sp10graph (3)'!$U$3:$U$4</c:f>
              <c:numCache>
                <c:formatCode>General</c:formatCode>
                <c:ptCount val="2"/>
                <c:pt idx="0">
                  <c:v>3.0153276141977907E-3</c:v>
                </c:pt>
                <c:pt idx="1">
                  <c:v>0.1145088522731756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BC4-42B0-9CCB-EE944EA95266}"/>
            </c:ext>
          </c:extLst>
        </c:ser>
        <c:ser>
          <c:idx val="3"/>
          <c:order val="3"/>
          <c:tx>
            <c:strRef>
              <c:f>'sp10graph (3)'!$V$1</c:f>
              <c:strCache>
                <c:ptCount val="1"/>
                <c:pt idx="0">
                  <c:v>U87 G- CHL+ 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sp10graph (3)'!$AA$3:$AA$4</c:f>
                <c:numCache>
                  <c:formatCode>General</c:formatCode>
                  <c:ptCount val="2"/>
                  <c:pt idx="0">
                    <c:v>4.3881418681625581E-4</c:v>
                  </c:pt>
                  <c:pt idx="1">
                    <c:v>2.7843188086254982E-3</c:v>
                  </c:pt>
                </c:numCache>
              </c:numRef>
            </c:plus>
            <c:minus>
              <c:numRef>
                <c:f>'sp10graph (3)'!$AA$3:$AA$4</c:f>
                <c:numCache>
                  <c:formatCode>General</c:formatCode>
                  <c:ptCount val="2"/>
                  <c:pt idx="0">
                    <c:v>4.3881418681625581E-4</c:v>
                  </c:pt>
                  <c:pt idx="1">
                    <c:v>2.7843188086254982E-3</c:v>
                  </c:pt>
                </c:numCache>
              </c:numRef>
            </c:minus>
          </c:errBars>
          <c:cat>
            <c:strRef>
              <c:f>'sp10graph (3)'!$R$3:$R$4</c:f>
              <c:strCache>
                <c:ptCount val="2"/>
                <c:pt idx="0">
                  <c:v>C12</c:v>
                </c:pt>
                <c:pt idx="1">
                  <c:v>C13</c:v>
                </c:pt>
              </c:strCache>
            </c:strRef>
          </c:cat>
          <c:val>
            <c:numRef>
              <c:f>'sp10graph (3)'!$V$3:$V$4</c:f>
              <c:numCache>
                <c:formatCode>General</c:formatCode>
                <c:ptCount val="2"/>
                <c:pt idx="0">
                  <c:v>3.3271058313732761E-3</c:v>
                </c:pt>
                <c:pt idx="1">
                  <c:v>2.6674045929737617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6BC4-42B0-9CCB-EE944EA9526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50927072"/>
        <c:axId val="450925504"/>
      </c:barChart>
      <c:catAx>
        <c:axId val="45092707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450925504"/>
        <c:crosses val="autoZero"/>
        <c:auto val="1"/>
        <c:lblAlgn val="ctr"/>
        <c:lblOffset val="100"/>
        <c:noMultiLvlLbl val="0"/>
      </c:catAx>
      <c:valAx>
        <c:axId val="450925504"/>
        <c:scaling>
          <c:orientation val="minMax"/>
        </c:scaling>
        <c:delete val="0"/>
        <c:axPos val="l"/>
        <c:majorGridlines/>
        <c:title>
          <c:tx>
            <c:rich>
              <a:bodyPr/>
              <a:lstStyle/>
              <a:p>
                <a:pPr>
                  <a:defRPr/>
                </a:pPr>
                <a:r>
                  <a:rPr lang="en-US" altLang="ja-JP" dirty="0"/>
                  <a:t>Relative peak level</a:t>
                </a:r>
                <a:endParaRPr lang="ja-JP" altLang="en-US" dirty="0"/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45092707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900">
          <a:latin typeface="+mn-lt"/>
        </a:defRPr>
      </a:pPr>
      <a:endParaRPr lang="ja-JP"/>
    </a:p>
  </c:txPr>
  <c:externalData r:id="rId1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前計算処理1!$P$4</c:f>
              <c:strCache>
                <c:ptCount val="1"/>
                <c:pt idx="0">
                  <c:v>Gln+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前計算処理1!$V$4:$Y$4</c:f>
                <c:numCache>
                  <c:formatCode>General</c:formatCode>
                  <c:ptCount val="4"/>
                  <c:pt idx="0">
                    <c:v>0.11583081664844908</c:v>
                  </c:pt>
                  <c:pt idx="1">
                    <c:v>0.284116605064067</c:v>
                  </c:pt>
                  <c:pt idx="2">
                    <c:v>0.49394105373604991</c:v>
                  </c:pt>
                  <c:pt idx="3">
                    <c:v>0.20543694373984972</c:v>
                  </c:pt>
                </c:numCache>
              </c:numRef>
            </c:plus>
            <c:minus>
              <c:numRef>
                <c:f>前計算処理1!$V$4:$Y$4</c:f>
                <c:numCache>
                  <c:formatCode>General</c:formatCode>
                  <c:ptCount val="4"/>
                  <c:pt idx="0">
                    <c:v>0.11583081664844908</c:v>
                  </c:pt>
                  <c:pt idx="1">
                    <c:v>0.284116605064067</c:v>
                  </c:pt>
                  <c:pt idx="2">
                    <c:v>0.49394105373604991</c:v>
                  </c:pt>
                  <c:pt idx="3">
                    <c:v>0.20543694373984972</c:v>
                  </c:pt>
                </c:numCache>
              </c:numRef>
            </c:minus>
          </c:errBars>
          <c:cat>
            <c:strRef>
              <c:f>前計算処理1!$Q$3:$T$3</c:f>
              <c:strCache>
                <c:ptCount val="4"/>
                <c:pt idx="0">
                  <c:v>0hr</c:v>
                </c:pt>
                <c:pt idx="1">
                  <c:v>24hr</c:v>
                </c:pt>
                <c:pt idx="2">
                  <c:v>48hr</c:v>
                </c:pt>
                <c:pt idx="3">
                  <c:v>72hr</c:v>
                </c:pt>
              </c:strCache>
            </c:strRef>
          </c:cat>
          <c:val>
            <c:numRef>
              <c:f>前計算処理1!$Q$4:$T$4</c:f>
              <c:numCache>
                <c:formatCode>General</c:formatCode>
                <c:ptCount val="4"/>
                <c:pt idx="0">
                  <c:v>1</c:v>
                </c:pt>
                <c:pt idx="1">
                  <c:v>1.6143798378179139</c:v>
                </c:pt>
                <c:pt idx="2">
                  <c:v>3.5184297825285662</c:v>
                </c:pt>
                <c:pt idx="3">
                  <c:v>6.070217471433837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18FA-4DC2-AE4C-FFA43CA8B380}"/>
            </c:ext>
          </c:extLst>
        </c:ser>
        <c:ser>
          <c:idx val="1"/>
          <c:order val="1"/>
          <c:tx>
            <c:strRef>
              <c:f>前計算処理1!$P$5</c:f>
              <c:strCache>
                <c:ptCount val="1"/>
                <c:pt idx="0">
                  <c:v>Gln- control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前計算処理1!$V$5:$Y$5</c:f>
                <c:numCache>
                  <c:formatCode>General</c:formatCode>
                  <c:ptCount val="4"/>
                  <c:pt idx="0">
                    <c:v>0.11583081664844908</c:v>
                  </c:pt>
                  <c:pt idx="1">
                    <c:v>0.3649065787907772</c:v>
                  </c:pt>
                  <c:pt idx="2">
                    <c:v>0.34644026808126721</c:v>
                  </c:pt>
                  <c:pt idx="3">
                    <c:v>0.42058360759241648</c:v>
                  </c:pt>
                </c:numCache>
              </c:numRef>
            </c:plus>
            <c:minus>
              <c:numRef>
                <c:f>前計算処理1!$V$5:$Y$5</c:f>
                <c:numCache>
                  <c:formatCode>General</c:formatCode>
                  <c:ptCount val="4"/>
                  <c:pt idx="0">
                    <c:v>0.11583081664844908</c:v>
                  </c:pt>
                  <c:pt idx="1">
                    <c:v>0.3649065787907772</c:v>
                  </c:pt>
                  <c:pt idx="2">
                    <c:v>0.34644026808126721</c:v>
                  </c:pt>
                  <c:pt idx="3">
                    <c:v>0.42058360759241648</c:v>
                  </c:pt>
                </c:numCache>
              </c:numRef>
            </c:minus>
          </c:errBars>
          <c:cat>
            <c:strRef>
              <c:f>前計算処理1!$Q$3:$T$3</c:f>
              <c:strCache>
                <c:ptCount val="4"/>
                <c:pt idx="0">
                  <c:v>0hr</c:v>
                </c:pt>
                <c:pt idx="1">
                  <c:v>24hr</c:v>
                </c:pt>
                <c:pt idx="2">
                  <c:v>48hr</c:v>
                </c:pt>
                <c:pt idx="3">
                  <c:v>72hr</c:v>
                </c:pt>
              </c:strCache>
            </c:strRef>
          </c:cat>
          <c:val>
            <c:numRef>
              <c:f>前計算処理1!$Q$5:$T$5</c:f>
              <c:numCache>
                <c:formatCode>General</c:formatCode>
                <c:ptCount val="4"/>
                <c:pt idx="0">
                  <c:v>1</c:v>
                </c:pt>
                <c:pt idx="1">
                  <c:v>1.3088370807224476</c:v>
                </c:pt>
                <c:pt idx="2">
                  <c:v>1.7819756726870624</c:v>
                </c:pt>
                <c:pt idx="3">
                  <c:v>2.882602285293033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18FA-4DC2-AE4C-FFA43CA8B380}"/>
            </c:ext>
          </c:extLst>
        </c:ser>
        <c:ser>
          <c:idx val="2"/>
          <c:order val="2"/>
          <c:tx>
            <c:strRef>
              <c:f>前計算処理1!$P$6</c:f>
              <c:strCache>
                <c:ptCount val="1"/>
                <c:pt idx="0">
                  <c:v>Gln- Chl 10μM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前計算処理1!$V$6:$Y$6</c:f>
                <c:numCache>
                  <c:formatCode>General</c:formatCode>
                  <c:ptCount val="4"/>
                  <c:pt idx="0">
                    <c:v>0.11583081664844908</c:v>
                  </c:pt>
                  <c:pt idx="1">
                    <c:v>0.14885635777649997</c:v>
                  </c:pt>
                  <c:pt idx="2">
                    <c:v>0.21813993069746845</c:v>
                  </c:pt>
                  <c:pt idx="3">
                    <c:v>0.23011480266608345</c:v>
                  </c:pt>
                </c:numCache>
              </c:numRef>
            </c:plus>
            <c:minus>
              <c:numRef>
                <c:f>前計算処理1!$V$6:$Y$6</c:f>
                <c:numCache>
                  <c:formatCode>General</c:formatCode>
                  <c:ptCount val="4"/>
                  <c:pt idx="0">
                    <c:v>0.11583081664844908</c:v>
                  </c:pt>
                  <c:pt idx="1">
                    <c:v>0.14885635777649997</c:v>
                  </c:pt>
                  <c:pt idx="2">
                    <c:v>0.21813993069746845</c:v>
                  </c:pt>
                  <c:pt idx="3">
                    <c:v>0.23011480266608345</c:v>
                  </c:pt>
                </c:numCache>
              </c:numRef>
            </c:minus>
          </c:errBars>
          <c:cat>
            <c:strRef>
              <c:f>前計算処理1!$Q$3:$T$3</c:f>
              <c:strCache>
                <c:ptCount val="4"/>
                <c:pt idx="0">
                  <c:v>0hr</c:v>
                </c:pt>
                <c:pt idx="1">
                  <c:v>24hr</c:v>
                </c:pt>
                <c:pt idx="2">
                  <c:v>48hr</c:v>
                </c:pt>
                <c:pt idx="3">
                  <c:v>72hr</c:v>
                </c:pt>
              </c:strCache>
            </c:strRef>
          </c:cat>
          <c:val>
            <c:numRef>
              <c:f>前計算処理1!$Q$6:$T$6</c:f>
              <c:numCache>
                <c:formatCode>General</c:formatCode>
                <c:ptCount val="4"/>
                <c:pt idx="0">
                  <c:v>1</c:v>
                </c:pt>
                <c:pt idx="1">
                  <c:v>0.96678031699225964</c:v>
                </c:pt>
                <c:pt idx="2">
                  <c:v>1.4378916328787321</c:v>
                </c:pt>
                <c:pt idx="3">
                  <c:v>1.242904533726502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18FA-4DC2-AE4C-FFA43CA8B380}"/>
            </c:ext>
          </c:extLst>
        </c:ser>
        <c:ser>
          <c:idx val="3"/>
          <c:order val="3"/>
          <c:tx>
            <c:strRef>
              <c:f>前計算処理1!$P$7</c:f>
              <c:strCache>
                <c:ptCount val="1"/>
                <c:pt idx="0">
                  <c:v>Gln- Chl 20μM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前計算処理1!$V$7:$Y$7</c:f>
                <c:numCache>
                  <c:formatCode>General</c:formatCode>
                  <c:ptCount val="4"/>
                  <c:pt idx="0">
                    <c:v>0.11583081664844908</c:v>
                  </c:pt>
                  <c:pt idx="1">
                    <c:v>0.21609393525290244</c:v>
                  </c:pt>
                  <c:pt idx="2">
                    <c:v>0.22599892330194546</c:v>
                  </c:pt>
                  <c:pt idx="3">
                    <c:v>8.6258576637204348E-2</c:v>
                  </c:pt>
                </c:numCache>
              </c:numRef>
            </c:plus>
            <c:minus>
              <c:numRef>
                <c:f>前計算処理1!$V$7:$Y$7</c:f>
                <c:numCache>
                  <c:formatCode>General</c:formatCode>
                  <c:ptCount val="4"/>
                  <c:pt idx="0">
                    <c:v>0.11583081664844908</c:v>
                  </c:pt>
                  <c:pt idx="1">
                    <c:v>0.21609393525290244</c:v>
                  </c:pt>
                  <c:pt idx="2">
                    <c:v>0.22599892330194546</c:v>
                  </c:pt>
                  <c:pt idx="3">
                    <c:v>8.6258576637204348E-2</c:v>
                  </c:pt>
                </c:numCache>
              </c:numRef>
            </c:minus>
          </c:errBars>
          <c:cat>
            <c:strRef>
              <c:f>前計算処理1!$Q$3:$T$3</c:f>
              <c:strCache>
                <c:ptCount val="4"/>
                <c:pt idx="0">
                  <c:v>0hr</c:v>
                </c:pt>
                <c:pt idx="1">
                  <c:v>24hr</c:v>
                </c:pt>
                <c:pt idx="2">
                  <c:v>48hr</c:v>
                </c:pt>
                <c:pt idx="3">
                  <c:v>72hr</c:v>
                </c:pt>
              </c:strCache>
            </c:strRef>
          </c:cat>
          <c:val>
            <c:numRef>
              <c:f>前計算処理1!$Q$7:$T$7</c:f>
              <c:numCache>
                <c:formatCode>General</c:formatCode>
                <c:ptCount val="4"/>
                <c:pt idx="0">
                  <c:v>1</c:v>
                </c:pt>
                <c:pt idx="1">
                  <c:v>1.0146516771102103</c:v>
                </c:pt>
                <c:pt idx="2">
                  <c:v>1.1576667895318837</c:v>
                </c:pt>
                <c:pt idx="3">
                  <c:v>0.7418908956874309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18FA-4DC2-AE4C-FFA43CA8B380}"/>
            </c:ext>
          </c:extLst>
        </c:ser>
        <c:ser>
          <c:idx val="4"/>
          <c:order val="4"/>
          <c:tx>
            <c:strRef>
              <c:f>前計算処理1!$P$8</c:f>
              <c:strCache>
                <c:ptCount val="1"/>
                <c:pt idx="0">
                  <c:v>Gln- Chl 40μM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前計算処理1!$V$8:$Y$8</c:f>
                <c:numCache>
                  <c:formatCode>General</c:formatCode>
                  <c:ptCount val="4"/>
                  <c:pt idx="0">
                    <c:v>0.11583081664844908</c:v>
                  </c:pt>
                  <c:pt idx="1">
                    <c:v>0.13447703663976637</c:v>
                  </c:pt>
                  <c:pt idx="2">
                    <c:v>4.8170375845419347E-2</c:v>
                  </c:pt>
                  <c:pt idx="3">
                    <c:v>1.7242684304692193E-2</c:v>
                  </c:pt>
                </c:numCache>
              </c:numRef>
            </c:plus>
            <c:minus>
              <c:numRef>
                <c:f>前計算処理1!$V$8:$Y$8</c:f>
                <c:numCache>
                  <c:formatCode>General</c:formatCode>
                  <c:ptCount val="4"/>
                  <c:pt idx="0">
                    <c:v>0.11583081664844908</c:v>
                  </c:pt>
                  <c:pt idx="1">
                    <c:v>0.13447703663976637</c:v>
                  </c:pt>
                  <c:pt idx="2">
                    <c:v>4.8170375845419347E-2</c:v>
                  </c:pt>
                  <c:pt idx="3">
                    <c:v>1.7242684304692193E-2</c:v>
                  </c:pt>
                </c:numCache>
              </c:numRef>
            </c:minus>
          </c:errBars>
          <c:cat>
            <c:strRef>
              <c:f>前計算処理1!$Q$3:$T$3</c:f>
              <c:strCache>
                <c:ptCount val="4"/>
                <c:pt idx="0">
                  <c:v>0hr</c:v>
                </c:pt>
                <c:pt idx="1">
                  <c:v>24hr</c:v>
                </c:pt>
                <c:pt idx="2">
                  <c:v>48hr</c:v>
                </c:pt>
                <c:pt idx="3">
                  <c:v>72hr</c:v>
                </c:pt>
              </c:strCache>
            </c:strRef>
          </c:cat>
          <c:val>
            <c:numRef>
              <c:f>前計算処理1!$Q$8:$T$8</c:f>
              <c:numCache>
                <c:formatCode>General</c:formatCode>
                <c:ptCount val="4"/>
                <c:pt idx="0">
                  <c:v>1</c:v>
                </c:pt>
                <c:pt idx="1">
                  <c:v>0.90135458901584975</c:v>
                </c:pt>
                <c:pt idx="2">
                  <c:v>0.60491153704386291</c:v>
                </c:pt>
                <c:pt idx="3">
                  <c:v>0.3049207519351272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18FA-4DC2-AE4C-FFA43CA8B38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386575904"/>
        <c:axId val="441470344"/>
      </c:lineChart>
      <c:catAx>
        <c:axId val="3865759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441470344"/>
        <c:crosses val="autoZero"/>
        <c:auto val="1"/>
        <c:lblAlgn val="ctr"/>
        <c:lblOffset val="100"/>
        <c:noMultiLvlLbl val="0"/>
      </c:catAx>
      <c:valAx>
        <c:axId val="44147034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elative proliferation</a:t>
                </a:r>
              </a:p>
            </c:rich>
          </c:tx>
          <c:overlay val="0"/>
          <c:spPr>
            <a:noFill/>
            <a:ln w="25400">
              <a:noFill/>
            </a:ln>
          </c:spPr>
        </c:title>
        <c:numFmt formatCode="General" sourceLinked="1"/>
        <c:majorTickMark val="none"/>
        <c:minorTickMark val="none"/>
        <c:tickLblPos val="nextTo"/>
        <c:spPr>
          <a:ln w="9525">
            <a:noFill/>
          </a:ln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386575904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900"/>
      </a:pPr>
      <a:endParaRPr lang="ja-JP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50176267539539221"/>
          <c:y val="4.241488773692082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8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3695346371904627"/>
          <c:y val="0.23458995323786458"/>
          <c:w val="0.57329751214816815"/>
          <c:h val="0.4566825434905671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X$15</c:f>
              <c:strCache>
                <c:ptCount val="1"/>
                <c:pt idx="0">
                  <c:v>Serine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accent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1F5E-4808-B349-09747DDC8CA6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accent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1F5E-4808-B349-09747DDC8CA6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accent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4-4E08-415F-BC14-DB89A45EAB1B}"/>
              </c:ext>
            </c:extLst>
          </c:dPt>
          <c:cat>
            <c:strRef>
              <c:f>Sheet1!$W$16:$W$20</c:f>
              <c:strCache>
                <c:ptCount val="5"/>
                <c:pt idx="0">
                  <c:v>Central 1</c:v>
                </c:pt>
                <c:pt idx="1">
                  <c:v>Central 2</c:v>
                </c:pt>
                <c:pt idx="2">
                  <c:v>Central 3</c:v>
                </c:pt>
                <c:pt idx="3">
                  <c:v>Edge 4</c:v>
                </c:pt>
                <c:pt idx="4">
                  <c:v>Edge 5</c:v>
                </c:pt>
              </c:strCache>
            </c:strRef>
          </c:cat>
          <c:val>
            <c:numRef>
              <c:f>Sheet1!$X$16:$X$20</c:f>
              <c:numCache>
                <c:formatCode>General</c:formatCode>
                <c:ptCount val="5"/>
                <c:pt idx="0">
                  <c:v>0.17448441559329497</c:v>
                </c:pt>
                <c:pt idx="1">
                  <c:v>0.20922096845653096</c:v>
                </c:pt>
                <c:pt idx="2">
                  <c:v>9.0958085473912237E-2</c:v>
                </c:pt>
                <c:pt idx="3">
                  <c:v>7.2612131013185489E-3</c:v>
                </c:pt>
                <c:pt idx="4">
                  <c:v>1.3299687290823394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1F5E-4808-B349-09747DDC8CA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41474264"/>
        <c:axId val="441469168"/>
      </c:barChart>
      <c:catAx>
        <c:axId val="4414742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41469168"/>
        <c:crosses val="autoZero"/>
        <c:auto val="1"/>
        <c:lblAlgn val="ctr"/>
        <c:lblOffset val="100"/>
        <c:noMultiLvlLbl val="0"/>
      </c:catAx>
      <c:valAx>
        <c:axId val="44146916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dirty="0"/>
                  <a:t>Relative</a:t>
                </a:r>
                <a:r>
                  <a:rPr lang="ja-JP" altLang="en-US" dirty="0"/>
                  <a:t> </a:t>
                </a:r>
                <a:r>
                  <a:rPr lang="en-US" altLang="ja-JP" dirty="0"/>
                  <a:t>peak</a:t>
                </a:r>
                <a:r>
                  <a:rPr lang="ja-JP" altLang="en-US" dirty="0"/>
                  <a:t> </a:t>
                </a:r>
                <a:r>
                  <a:rPr lang="en-US" altLang="ja-JP" dirty="0"/>
                  <a:t>level</a:t>
                </a:r>
                <a:endParaRPr lang="ja-JP" altLang="en-US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414742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900"/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38050691349328419"/>
          <c:y val="4.243659571624285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8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32130197155547896"/>
          <c:y val="0.23471001659593901"/>
          <c:w val="0.60361287140336606"/>
          <c:h val="0.4419348191710941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Y$15</c:f>
              <c:strCache>
                <c:ptCount val="1"/>
                <c:pt idx="0">
                  <c:v>Glycine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accent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4911-4152-ADCA-891ED911B5A0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accent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4911-4152-ADCA-891ED911B5A0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accent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4-6035-4E3A-859A-262900357454}"/>
              </c:ext>
            </c:extLst>
          </c:dPt>
          <c:cat>
            <c:strRef>
              <c:f>Sheet1!$W$16:$W$20</c:f>
              <c:strCache>
                <c:ptCount val="5"/>
                <c:pt idx="0">
                  <c:v>Central 1</c:v>
                </c:pt>
                <c:pt idx="1">
                  <c:v>Central 2</c:v>
                </c:pt>
                <c:pt idx="2">
                  <c:v>Central 3</c:v>
                </c:pt>
                <c:pt idx="3">
                  <c:v>Edge 4</c:v>
                </c:pt>
                <c:pt idx="4">
                  <c:v>Edge 5</c:v>
                </c:pt>
              </c:strCache>
            </c:strRef>
          </c:cat>
          <c:val>
            <c:numRef>
              <c:f>Sheet1!$Y$16:$Y$20</c:f>
              <c:numCache>
                <c:formatCode>General</c:formatCode>
                <c:ptCount val="5"/>
                <c:pt idx="0">
                  <c:v>8.4215526382744645</c:v>
                </c:pt>
                <c:pt idx="1">
                  <c:v>7.2905190982991481</c:v>
                </c:pt>
                <c:pt idx="2">
                  <c:v>2.8828955619430463</c:v>
                </c:pt>
                <c:pt idx="3">
                  <c:v>0.25633871792332175</c:v>
                </c:pt>
                <c:pt idx="4">
                  <c:v>0.4368989017173288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4911-4152-ADCA-891ED911B5A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41472304"/>
        <c:axId val="441467600"/>
      </c:barChart>
      <c:catAx>
        <c:axId val="4414723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41467600"/>
        <c:crosses val="autoZero"/>
        <c:auto val="1"/>
        <c:lblAlgn val="ctr"/>
        <c:lblOffset val="100"/>
        <c:noMultiLvlLbl val="0"/>
      </c:catAx>
      <c:valAx>
        <c:axId val="44146760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dirty="0"/>
                  <a:t>Relative</a:t>
                </a:r>
                <a:r>
                  <a:rPr lang="en-US" altLang="ja-JP" baseline="0" dirty="0"/>
                  <a:t> peak level</a:t>
                </a:r>
                <a:endParaRPr lang="ja-JP" altLang="en-US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414723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900"/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47184060416164531"/>
          <c:y val="4.24149113461557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8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42357714355927956"/>
          <c:y val="0.23459008381676313"/>
          <c:w val="0.48276535648404134"/>
          <c:h val="0.4699293864087483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AA$4</c:f>
              <c:strCache>
                <c:ptCount val="1"/>
                <c:pt idx="0">
                  <c:v>Serine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accent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0F8A-4BA9-A96F-1E8209C4E561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accent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0F8A-4BA9-A96F-1E8209C4E561}"/>
              </c:ext>
            </c:extLst>
          </c:dPt>
          <c:cat>
            <c:strRef>
              <c:f>Sheet1!$W$5:$W$8</c:f>
              <c:strCache>
                <c:ptCount val="4"/>
                <c:pt idx="0">
                  <c:v>Central 1</c:v>
                </c:pt>
                <c:pt idx="1">
                  <c:v>Central 2</c:v>
                </c:pt>
                <c:pt idx="2">
                  <c:v>Edge 3</c:v>
                </c:pt>
                <c:pt idx="3">
                  <c:v>Edge 4</c:v>
                </c:pt>
              </c:strCache>
            </c:strRef>
          </c:cat>
          <c:val>
            <c:numRef>
              <c:f>Sheet1!$AA$5:$AA$8</c:f>
              <c:numCache>
                <c:formatCode>General</c:formatCode>
                <c:ptCount val="4"/>
                <c:pt idx="0">
                  <c:v>8.6025137431408761E-3</c:v>
                </c:pt>
                <c:pt idx="1">
                  <c:v>9.7446700413733964E-3</c:v>
                </c:pt>
                <c:pt idx="2">
                  <c:v>7.5042417662716972E-3</c:v>
                </c:pt>
                <c:pt idx="3">
                  <c:v>7.5221045494388156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0F8A-4BA9-A96F-1E8209C4E56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41473088"/>
        <c:axId val="441467992"/>
      </c:barChart>
      <c:catAx>
        <c:axId val="4414730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41467992"/>
        <c:crosses val="autoZero"/>
        <c:auto val="1"/>
        <c:lblAlgn val="ctr"/>
        <c:lblOffset val="100"/>
        <c:noMultiLvlLbl val="0"/>
      </c:catAx>
      <c:valAx>
        <c:axId val="44146799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dirty="0"/>
                  <a:t>Relative</a:t>
                </a:r>
                <a:r>
                  <a:rPr lang="ja-JP" altLang="en-US" dirty="0"/>
                  <a:t> </a:t>
                </a:r>
                <a:r>
                  <a:rPr lang="en-US" altLang="ja-JP" dirty="0"/>
                  <a:t>peak</a:t>
                </a:r>
                <a:r>
                  <a:rPr lang="ja-JP" altLang="en-US" dirty="0"/>
                  <a:t> </a:t>
                </a:r>
                <a:r>
                  <a:rPr lang="en-US" altLang="ja-JP" dirty="0"/>
                  <a:t>level</a:t>
                </a:r>
                <a:endParaRPr lang="ja-JP" altLang="en-US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414730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900"/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38601860833976509"/>
          <c:y val="4.223263196866139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8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36222446840901529"/>
          <c:y val="0.23358192576367906"/>
          <c:w val="0.5276115756902009"/>
          <c:h val="0.4722073810669226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AB$4</c:f>
              <c:strCache>
                <c:ptCount val="1"/>
                <c:pt idx="0">
                  <c:v>Glycine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accent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CFCF-4029-B6F0-9D92E97CB2AC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accent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CFCF-4029-B6F0-9D92E97CB2AC}"/>
              </c:ext>
            </c:extLst>
          </c:dPt>
          <c:cat>
            <c:strRef>
              <c:f>Sheet1!$W$5:$W$8</c:f>
              <c:strCache>
                <c:ptCount val="4"/>
                <c:pt idx="0">
                  <c:v>Central 1</c:v>
                </c:pt>
                <c:pt idx="1">
                  <c:v>Central 2</c:v>
                </c:pt>
                <c:pt idx="2">
                  <c:v>Edge 3</c:v>
                </c:pt>
                <c:pt idx="3">
                  <c:v>Edge 4</c:v>
                </c:pt>
              </c:strCache>
            </c:strRef>
          </c:cat>
          <c:val>
            <c:numRef>
              <c:f>Sheet1!$AB$5:$AB$8</c:f>
              <c:numCache>
                <c:formatCode>General</c:formatCode>
                <c:ptCount val="4"/>
                <c:pt idx="0">
                  <c:v>0.79870570079119829</c:v>
                </c:pt>
                <c:pt idx="1">
                  <c:v>0.87141435007764545</c:v>
                </c:pt>
                <c:pt idx="2">
                  <c:v>0.35099195028803593</c:v>
                </c:pt>
                <c:pt idx="3">
                  <c:v>0.3292570324710499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CFCF-4029-B6F0-9D92E97CB2A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41469952"/>
        <c:axId val="441473872"/>
      </c:barChart>
      <c:catAx>
        <c:axId val="4414699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41473872"/>
        <c:crosses val="autoZero"/>
        <c:auto val="1"/>
        <c:lblAlgn val="ctr"/>
        <c:lblOffset val="100"/>
        <c:noMultiLvlLbl val="0"/>
      </c:catAx>
      <c:valAx>
        <c:axId val="44147387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dirty="0"/>
                  <a:t>Relative</a:t>
                </a:r>
                <a:r>
                  <a:rPr lang="ja-JP" altLang="en-US" dirty="0"/>
                  <a:t> </a:t>
                </a:r>
                <a:r>
                  <a:rPr lang="en-US" altLang="ja-JP" dirty="0"/>
                  <a:t>peak</a:t>
                </a:r>
                <a:r>
                  <a:rPr lang="ja-JP" altLang="en-US" dirty="0"/>
                  <a:t> </a:t>
                </a:r>
                <a:r>
                  <a:rPr lang="en-US" altLang="ja-JP" dirty="0"/>
                  <a:t>level</a:t>
                </a:r>
                <a:endParaRPr lang="ja-JP" altLang="en-US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4146995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900"/>
      </a:pPr>
      <a:endParaRPr lang="ja-JP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4.7786496637499912E-2"/>
          <c:y val="0.22415714593362712"/>
          <c:w val="0.9044270067250002"/>
          <c:h val="0.59194840398250825"/>
        </c:manualLayout>
      </c:layout>
      <c:lineChart>
        <c:grouping val="standard"/>
        <c:varyColors val="0"/>
        <c:ser>
          <c:idx val="0"/>
          <c:order val="0"/>
          <c:tx>
            <c:strRef>
              <c:f>Sheet1!$B$3</c:f>
              <c:strCache>
                <c:ptCount val="1"/>
                <c:pt idx="0">
                  <c:v>contralateral</c:v>
                </c:pt>
              </c:strCache>
            </c:strRef>
          </c:tx>
          <c:spPr>
            <a:ln w="19050" cap="rnd">
              <a:solidFill>
                <a:srgbClr val="9BBB59"/>
              </a:solidFill>
              <a:round/>
            </a:ln>
            <a:effectLst/>
          </c:spPr>
          <c:marker>
            <c:symbol val="none"/>
          </c:marker>
          <c:cat>
            <c:numRef>
              <c:f>Sheet1!$A$4:$A$449</c:f>
              <c:numCache>
                <c:formatCode>0.00_ </c:formatCode>
                <c:ptCount val="446"/>
                <c:pt idx="0">
                  <c:v>4</c:v>
                </c:pt>
                <c:pt idx="1">
                  <c:v>3.992356</c:v>
                </c:pt>
                <c:pt idx="2">
                  <c:v>3.9847109999999999</c:v>
                </c:pt>
                <c:pt idx="3">
                  <c:v>3.9770669999999999</c:v>
                </c:pt>
                <c:pt idx="4">
                  <c:v>3.9694219999999998</c:v>
                </c:pt>
                <c:pt idx="5">
                  <c:v>3.9617779999999998</c:v>
                </c:pt>
                <c:pt idx="6">
                  <c:v>3.9541339999999998</c:v>
                </c:pt>
                <c:pt idx="7">
                  <c:v>3.9464890000000001</c:v>
                </c:pt>
                <c:pt idx="8">
                  <c:v>3.9388450000000002</c:v>
                </c:pt>
                <c:pt idx="9">
                  <c:v>3.9312</c:v>
                </c:pt>
                <c:pt idx="10">
                  <c:v>3.923556</c:v>
                </c:pt>
                <c:pt idx="11">
                  <c:v>3.9159109999999999</c:v>
                </c:pt>
                <c:pt idx="12">
                  <c:v>3.9082669999999999</c:v>
                </c:pt>
                <c:pt idx="13">
                  <c:v>3.900623</c:v>
                </c:pt>
                <c:pt idx="14">
                  <c:v>3.8929779999999998</c:v>
                </c:pt>
                <c:pt idx="15">
                  <c:v>3.8853339999999998</c:v>
                </c:pt>
                <c:pt idx="16">
                  <c:v>3.8776890000000002</c:v>
                </c:pt>
                <c:pt idx="17">
                  <c:v>3.8700450000000002</c:v>
                </c:pt>
                <c:pt idx="18">
                  <c:v>3.8624010000000002</c:v>
                </c:pt>
                <c:pt idx="19">
                  <c:v>3.8547560000000001</c:v>
                </c:pt>
                <c:pt idx="20">
                  <c:v>3.8471120000000001</c:v>
                </c:pt>
                <c:pt idx="21">
                  <c:v>3.839467</c:v>
                </c:pt>
                <c:pt idx="22">
                  <c:v>3.831823</c:v>
                </c:pt>
                <c:pt idx="23">
                  <c:v>3.8241779999999999</c:v>
                </c:pt>
                <c:pt idx="24">
                  <c:v>3.8165339999999999</c:v>
                </c:pt>
                <c:pt idx="25">
                  <c:v>3.8088899999999999</c:v>
                </c:pt>
                <c:pt idx="26">
                  <c:v>3.8012450000000002</c:v>
                </c:pt>
                <c:pt idx="27">
                  <c:v>3.7936009999999998</c:v>
                </c:pt>
                <c:pt idx="28">
                  <c:v>3.7859560000000001</c:v>
                </c:pt>
                <c:pt idx="29">
                  <c:v>3.7783120000000001</c:v>
                </c:pt>
                <c:pt idx="30">
                  <c:v>3.7706680000000001</c:v>
                </c:pt>
                <c:pt idx="31">
                  <c:v>3.763023</c:v>
                </c:pt>
                <c:pt idx="32">
                  <c:v>3.755379</c:v>
                </c:pt>
                <c:pt idx="33">
                  <c:v>3.7477339999999999</c:v>
                </c:pt>
                <c:pt idx="34">
                  <c:v>3.7400899999999999</c:v>
                </c:pt>
                <c:pt idx="35">
                  <c:v>3.7324449999999998</c:v>
                </c:pt>
                <c:pt idx="36">
                  <c:v>3.7248009999999998</c:v>
                </c:pt>
                <c:pt idx="37">
                  <c:v>3.7171569999999998</c:v>
                </c:pt>
                <c:pt idx="38">
                  <c:v>3.7095120000000001</c:v>
                </c:pt>
                <c:pt idx="39">
                  <c:v>3.7018680000000002</c:v>
                </c:pt>
                <c:pt idx="40">
                  <c:v>3.694223</c:v>
                </c:pt>
                <c:pt idx="41">
                  <c:v>3.6865790000000001</c:v>
                </c:pt>
                <c:pt idx="42">
                  <c:v>3.6789350000000001</c:v>
                </c:pt>
                <c:pt idx="43">
                  <c:v>3.6712899999999999</c:v>
                </c:pt>
                <c:pt idx="44">
                  <c:v>3.663646</c:v>
                </c:pt>
                <c:pt idx="45">
                  <c:v>3.6560009999999998</c:v>
                </c:pt>
                <c:pt idx="46">
                  <c:v>3.6483569999999999</c:v>
                </c:pt>
                <c:pt idx="47">
                  <c:v>3.6407120000000002</c:v>
                </c:pt>
                <c:pt idx="48">
                  <c:v>3.6330680000000002</c:v>
                </c:pt>
                <c:pt idx="49">
                  <c:v>3.6254240000000002</c:v>
                </c:pt>
                <c:pt idx="50">
                  <c:v>3.6177790000000001</c:v>
                </c:pt>
                <c:pt idx="51">
                  <c:v>3.6101350000000001</c:v>
                </c:pt>
                <c:pt idx="52">
                  <c:v>3.60249</c:v>
                </c:pt>
                <c:pt idx="53">
                  <c:v>3.594846</c:v>
                </c:pt>
                <c:pt idx="54">
                  <c:v>3.587202</c:v>
                </c:pt>
                <c:pt idx="55">
                  <c:v>3.5795569999999999</c:v>
                </c:pt>
                <c:pt idx="56">
                  <c:v>3.5719129999999999</c:v>
                </c:pt>
                <c:pt idx="57">
                  <c:v>3.5642680000000002</c:v>
                </c:pt>
                <c:pt idx="58">
                  <c:v>3.5566239999999998</c:v>
                </c:pt>
                <c:pt idx="59">
                  <c:v>3.5489799999999998</c:v>
                </c:pt>
                <c:pt idx="60">
                  <c:v>3.5413350000000001</c:v>
                </c:pt>
                <c:pt idx="61">
                  <c:v>3.5336910000000001</c:v>
                </c:pt>
                <c:pt idx="62">
                  <c:v>3.526046</c:v>
                </c:pt>
                <c:pt idx="63">
                  <c:v>3.518402</c:v>
                </c:pt>
                <c:pt idx="64">
                  <c:v>3.5107569999999999</c:v>
                </c:pt>
                <c:pt idx="65">
                  <c:v>3.5031129999999999</c:v>
                </c:pt>
                <c:pt idx="66">
                  <c:v>3.4954689999999999</c:v>
                </c:pt>
                <c:pt idx="67">
                  <c:v>3.4878239999999998</c:v>
                </c:pt>
                <c:pt idx="68">
                  <c:v>3.4801799999999998</c:v>
                </c:pt>
                <c:pt idx="69">
                  <c:v>3.4725350000000001</c:v>
                </c:pt>
                <c:pt idx="70">
                  <c:v>3.4648910000000002</c:v>
                </c:pt>
                <c:pt idx="71">
                  <c:v>3.4572470000000002</c:v>
                </c:pt>
                <c:pt idx="72">
                  <c:v>3.4496020000000001</c:v>
                </c:pt>
                <c:pt idx="73">
                  <c:v>3.4419580000000001</c:v>
                </c:pt>
                <c:pt idx="74">
                  <c:v>3.4343129999999999</c:v>
                </c:pt>
                <c:pt idx="75">
                  <c:v>3.426669</c:v>
                </c:pt>
                <c:pt idx="76">
                  <c:v>3.4190239999999998</c:v>
                </c:pt>
                <c:pt idx="77">
                  <c:v>3.4113799999999999</c:v>
                </c:pt>
                <c:pt idx="78">
                  <c:v>3.4037359999999999</c:v>
                </c:pt>
                <c:pt idx="79">
                  <c:v>3.3960910000000002</c:v>
                </c:pt>
                <c:pt idx="80">
                  <c:v>3.3884470000000002</c:v>
                </c:pt>
                <c:pt idx="81">
                  <c:v>3.3808020000000001</c:v>
                </c:pt>
                <c:pt idx="82">
                  <c:v>3.3731580000000001</c:v>
                </c:pt>
                <c:pt idx="83">
                  <c:v>3.3655140000000001</c:v>
                </c:pt>
                <c:pt idx="84">
                  <c:v>3.357869</c:v>
                </c:pt>
                <c:pt idx="85">
                  <c:v>3.350225</c:v>
                </c:pt>
                <c:pt idx="86">
                  <c:v>3.3425799999999999</c:v>
                </c:pt>
                <c:pt idx="87">
                  <c:v>3.3349359999999999</c:v>
                </c:pt>
                <c:pt idx="88">
                  <c:v>3.3272910000000002</c:v>
                </c:pt>
                <c:pt idx="89">
                  <c:v>3.3196469999999998</c:v>
                </c:pt>
                <c:pt idx="90">
                  <c:v>3.3120029999999998</c:v>
                </c:pt>
                <c:pt idx="91">
                  <c:v>3.3043580000000001</c:v>
                </c:pt>
                <c:pt idx="92">
                  <c:v>3.2967140000000001</c:v>
                </c:pt>
                <c:pt idx="93">
                  <c:v>3.289069</c:v>
                </c:pt>
                <c:pt idx="94">
                  <c:v>3.281425</c:v>
                </c:pt>
                <c:pt idx="95">
                  <c:v>3.2737810000000001</c:v>
                </c:pt>
                <c:pt idx="96">
                  <c:v>3.2661359999999999</c:v>
                </c:pt>
                <c:pt idx="97">
                  <c:v>3.2584919999999999</c:v>
                </c:pt>
                <c:pt idx="98">
                  <c:v>3.2508469999999998</c:v>
                </c:pt>
                <c:pt idx="99">
                  <c:v>3.2432029999999998</c:v>
                </c:pt>
                <c:pt idx="100">
                  <c:v>3.2355589999999999</c:v>
                </c:pt>
                <c:pt idx="101">
                  <c:v>3.2279140000000002</c:v>
                </c:pt>
                <c:pt idx="102">
                  <c:v>3.2202700000000002</c:v>
                </c:pt>
                <c:pt idx="103">
                  <c:v>3.2126250000000001</c:v>
                </c:pt>
                <c:pt idx="104">
                  <c:v>3.2049810000000001</c:v>
                </c:pt>
                <c:pt idx="105">
                  <c:v>3.197336</c:v>
                </c:pt>
                <c:pt idx="106">
                  <c:v>3.189692</c:v>
                </c:pt>
                <c:pt idx="107">
                  <c:v>3.182048</c:v>
                </c:pt>
                <c:pt idx="108">
                  <c:v>3.1744029999999999</c:v>
                </c:pt>
                <c:pt idx="109">
                  <c:v>3.1667589999999999</c:v>
                </c:pt>
                <c:pt idx="110">
                  <c:v>3.1591140000000002</c:v>
                </c:pt>
                <c:pt idx="111">
                  <c:v>3.1514700000000002</c:v>
                </c:pt>
                <c:pt idx="112">
                  <c:v>3.1438259999999998</c:v>
                </c:pt>
                <c:pt idx="113">
                  <c:v>3.1361810000000001</c:v>
                </c:pt>
                <c:pt idx="114">
                  <c:v>3.1285370000000001</c:v>
                </c:pt>
                <c:pt idx="115">
                  <c:v>3.120892</c:v>
                </c:pt>
                <c:pt idx="116">
                  <c:v>3.113248</c:v>
                </c:pt>
                <c:pt idx="117">
                  <c:v>3.1056029999999999</c:v>
                </c:pt>
                <c:pt idx="118">
                  <c:v>3.0979589999999999</c:v>
                </c:pt>
                <c:pt idx="119">
                  <c:v>3.0903149999999999</c:v>
                </c:pt>
                <c:pt idx="120">
                  <c:v>3.0826699999999998</c:v>
                </c:pt>
                <c:pt idx="121">
                  <c:v>3.0750259999999998</c:v>
                </c:pt>
                <c:pt idx="122">
                  <c:v>3.0673810000000001</c:v>
                </c:pt>
                <c:pt idx="123">
                  <c:v>3.0597370000000002</c:v>
                </c:pt>
                <c:pt idx="124">
                  <c:v>3.0520930000000002</c:v>
                </c:pt>
                <c:pt idx="125">
                  <c:v>3.044448</c:v>
                </c:pt>
                <c:pt idx="126">
                  <c:v>3.0368040000000001</c:v>
                </c:pt>
                <c:pt idx="127">
                  <c:v>3.0291589999999999</c:v>
                </c:pt>
                <c:pt idx="128">
                  <c:v>3.021515</c:v>
                </c:pt>
                <c:pt idx="129">
                  <c:v>3.0138699999999998</c:v>
                </c:pt>
                <c:pt idx="130">
                  <c:v>3.0062259999999998</c:v>
                </c:pt>
                <c:pt idx="131">
                  <c:v>2.9985819999999999</c:v>
                </c:pt>
                <c:pt idx="132">
                  <c:v>2.9909370000000002</c:v>
                </c:pt>
                <c:pt idx="133">
                  <c:v>2.9832930000000002</c:v>
                </c:pt>
                <c:pt idx="134">
                  <c:v>2.9756480000000001</c:v>
                </c:pt>
                <c:pt idx="135">
                  <c:v>2.9680040000000001</c:v>
                </c:pt>
                <c:pt idx="136">
                  <c:v>2.9603600000000001</c:v>
                </c:pt>
                <c:pt idx="137">
                  <c:v>2.952715</c:v>
                </c:pt>
                <c:pt idx="138">
                  <c:v>2.945071</c:v>
                </c:pt>
                <c:pt idx="139">
                  <c:v>2.9374259999999999</c:v>
                </c:pt>
                <c:pt idx="140">
                  <c:v>2.9297819999999999</c:v>
                </c:pt>
                <c:pt idx="141">
                  <c:v>2.9221370000000002</c:v>
                </c:pt>
                <c:pt idx="142">
                  <c:v>2.9144929999999998</c:v>
                </c:pt>
                <c:pt idx="143">
                  <c:v>2.9068489999999998</c:v>
                </c:pt>
                <c:pt idx="144">
                  <c:v>2.8992040000000001</c:v>
                </c:pt>
                <c:pt idx="145">
                  <c:v>2.8915600000000001</c:v>
                </c:pt>
                <c:pt idx="146">
                  <c:v>2.883915</c:v>
                </c:pt>
                <c:pt idx="147">
                  <c:v>2.876271</c:v>
                </c:pt>
                <c:pt idx="148">
                  <c:v>2.868627</c:v>
                </c:pt>
                <c:pt idx="149">
                  <c:v>2.8609819999999999</c:v>
                </c:pt>
                <c:pt idx="150">
                  <c:v>2.8533379999999999</c:v>
                </c:pt>
                <c:pt idx="151">
                  <c:v>2.8456929999999998</c:v>
                </c:pt>
                <c:pt idx="152">
                  <c:v>2.8380489999999998</c:v>
                </c:pt>
                <c:pt idx="153">
                  <c:v>2.8304049999999998</c:v>
                </c:pt>
                <c:pt idx="154">
                  <c:v>2.8227600000000002</c:v>
                </c:pt>
                <c:pt idx="155">
                  <c:v>2.8151160000000002</c:v>
                </c:pt>
                <c:pt idx="156">
                  <c:v>2.807471</c:v>
                </c:pt>
                <c:pt idx="157">
                  <c:v>2.7998270000000001</c:v>
                </c:pt>
                <c:pt idx="158">
                  <c:v>2.7921819999999999</c:v>
                </c:pt>
                <c:pt idx="159">
                  <c:v>2.784538</c:v>
                </c:pt>
                <c:pt idx="160">
                  <c:v>2.776894</c:v>
                </c:pt>
                <c:pt idx="161">
                  <c:v>2.7692489999999998</c:v>
                </c:pt>
                <c:pt idx="162">
                  <c:v>2.7616049999999999</c:v>
                </c:pt>
                <c:pt idx="163">
                  <c:v>2.7539600000000002</c:v>
                </c:pt>
                <c:pt idx="164">
                  <c:v>2.7463160000000002</c:v>
                </c:pt>
                <c:pt idx="165">
                  <c:v>2.7386720000000002</c:v>
                </c:pt>
                <c:pt idx="166">
                  <c:v>2.7310270000000001</c:v>
                </c:pt>
                <c:pt idx="167">
                  <c:v>2.7233830000000001</c:v>
                </c:pt>
                <c:pt idx="168">
                  <c:v>2.715738</c:v>
                </c:pt>
                <c:pt idx="169">
                  <c:v>2.708094</c:v>
                </c:pt>
                <c:pt idx="170">
                  <c:v>2.7004489999999999</c:v>
                </c:pt>
                <c:pt idx="171">
                  <c:v>2.6928049999999999</c:v>
                </c:pt>
                <c:pt idx="172">
                  <c:v>2.6851609999999999</c:v>
                </c:pt>
                <c:pt idx="173">
                  <c:v>2.6775159999999998</c:v>
                </c:pt>
                <c:pt idx="174">
                  <c:v>2.6698719999999998</c:v>
                </c:pt>
                <c:pt idx="175">
                  <c:v>2.6622270000000001</c:v>
                </c:pt>
                <c:pt idx="176">
                  <c:v>2.6545830000000001</c:v>
                </c:pt>
                <c:pt idx="177">
                  <c:v>2.6469390000000002</c:v>
                </c:pt>
                <c:pt idx="178">
                  <c:v>2.639294</c:v>
                </c:pt>
                <c:pt idx="179">
                  <c:v>2.63165</c:v>
                </c:pt>
                <c:pt idx="180">
                  <c:v>2.6240049999999999</c:v>
                </c:pt>
                <c:pt idx="181">
                  <c:v>2.6163609999999999</c:v>
                </c:pt>
                <c:pt idx="182">
                  <c:v>2.6087159999999998</c:v>
                </c:pt>
                <c:pt idx="183">
                  <c:v>2.6010719999999998</c:v>
                </c:pt>
                <c:pt idx="184">
                  <c:v>2.5934279999999998</c:v>
                </c:pt>
                <c:pt idx="185">
                  <c:v>2.5857830000000002</c:v>
                </c:pt>
                <c:pt idx="186">
                  <c:v>2.5781390000000002</c:v>
                </c:pt>
                <c:pt idx="187">
                  <c:v>2.5704940000000001</c:v>
                </c:pt>
                <c:pt idx="188">
                  <c:v>2.5628500000000001</c:v>
                </c:pt>
                <c:pt idx="189">
                  <c:v>2.5552060000000001</c:v>
                </c:pt>
                <c:pt idx="190">
                  <c:v>2.547561</c:v>
                </c:pt>
                <c:pt idx="191">
                  <c:v>2.539917</c:v>
                </c:pt>
                <c:pt idx="192">
                  <c:v>2.5322719999999999</c:v>
                </c:pt>
                <c:pt idx="193">
                  <c:v>2.5246279999999999</c:v>
                </c:pt>
                <c:pt idx="194">
                  <c:v>2.5169839999999999</c:v>
                </c:pt>
                <c:pt idx="195">
                  <c:v>2.5093390000000002</c:v>
                </c:pt>
                <c:pt idx="196">
                  <c:v>2.5016949999999998</c:v>
                </c:pt>
                <c:pt idx="197">
                  <c:v>2.4940500000000001</c:v>
                </c:pt>
                <c:pt idx="198">
                  <c:v>2.4864060000000001</c:v>
                </c:pt>
                <c:pt idx="199">
                  <c:v>2.478761</c:v>
                </c:pt>
                <c:pt idx="200">
                  <c:v>2.471117</c:v>
                </c:pt>
                <c:pt idx="201">
                  <c:v>2.463473</c:v>
                </c:pt>
                <c:pt idx="202">
                  <c:v>2.4558279999999999</c:v>
                </c:pt>
                <c:pt idx="203">
                  <c:v>2.4481839999999999</c:v>
                </c:pt>
                <c:pt idx="204">
                  <c:v>2.4405389999999998</c:v>
                </c:pt>
                <c:pt idx="205">
                  <c:v>2.4328949999999998</c:v>
                </c:pt>
                <c:pt idx="206">
                  <c:v>2.4252509999999998</c:v>
                </c:pt>
                <c:pt idx="207">
                  <c:v>2.4176060000000001</c:v>
                </c:pt>
                <c:pt idx="208">
                  <c:v>2.4099620000000002</c:v>
                </c:pt>
                <c:pt idx="209">
                  <c:v>2.402317</c:v>
                </c:pt>
                <c:pt idx="210">
                  <c:v>2.3946730000000001</c:v>
                </c:pt>
                <c:pt idx="211">
                  <c:v>2.3870279999999999</c:v>
                </c:pt>
                <c:pt idx="212">
                  <c:v>2.3793839999999999</c:v>
                </c:pt>
                <c:pt idx="213">
                  <c:v>2.37174</c:v>
                </c:pt>
                <c:pt idx="214">
                  <c:v>2.3640949999999998</c:v>
                </c:pt>
                <c:pt idx="215">
                  <c:v>2.3564509999999999</c:v>
                </c:pt>
                <c:pt idx="216">
                  <c:v>2.3488060000000002</c:v>
                </c:pt>
                <c:pt idx="217">
                  <c:v>2.3411620000000002</c:v>
                </c:pt>
                <c:pt idx="218">
                  <c:v>2.3335180000000002</c:v>
                </c:pt>
                <c:pt idx="219">
                  <c:v>2.3258730000000001</c:v>
                </c:pt>
                <c:pt idx="220">
                  <c:v>2.3182290000000001</c:v>
                </c:pt>
                <c:pt idx="221">
                  <c:v>2.310584</c:v>
                </c:pt>
                <c:pt idx="222">
                  <c:v>2.30294</c:v>
                </c:pt>
                <c:pt idx="223">
                  <c:v>2.2952949999999999</c:v>
                </c:pt>
                <c:pt idx="224">
                  <c:v>2.2876509999999999</c:v>
                </c:pt>
                <c:pt idx="225">
                  <c:v>2.2800069999999999</c:v>
                </c:pt>
                <c:pt idx="226">
                  <c:v>2.2723620000000002</c:v>
                </c:pt>
                <c:pt idx="227">
                  <c:v>2.2647179999999998</c:v>
                </c:pt>
                <c:pt idx="228">
                  <c:v>2.2570730000000001</c:v>
                </c:pt>
                <c:pt idx="229">
                  <c:v>2.2494290000000001</c:v>
                </c:pt>
                <c:pt idx="230">
                  <c:v>2.2417850000000001</c:v>
                </c:pt>
                <c:pt idx="231">
                  <c:v>2.23414</c:v>
                </c:pt>
                <c:pt idx="232">
                  <c:v>2.226496</c:v>
                </c:pt>
                <c:pt idx="233">
                  <c:v>2.2188509999999999</c:v>
                </c:pt>
                <c:pt idx="234">
                  <c:v>2.2112069999999999</c:v>
                </c:pt>
                <c:pt idx="235">
                  <c:v>2.2035619999999998</c:v>
                </c:pt>
                <c:pt idx="236">
                  <c:v>2.1959179999999998</c:v>
                </c:pt>
                <c:pt idx="237">
                  <c:v>2.1882739999999998</c:v>
                </c:pt>
                <c:pt idx="238">
                  <c:v>2.1806290000000002</c:v>
                </c:pt>
                <c:pt idx="239">
                  <c:v>2.1729850000000002</c:v>
                </c:pt>
                <c:pt idx="240">
                  <c:v>2.16534</c:v>
                </c:pt>
                <c:pt idx="241">
                  <c:v>2.1576960000000001</c:v>
                </c:pt>
                <c:pt idx="242">
                  <c:v>2.1500520000000001</c:v>
                </c:pt>
                <c:pt idx="243">
                  <c:v>2.142407</c:v>
                </c:pt>
                <c:pt idx="244">
                  <c:v>2.134763</c:v>
                </c:pt>
                <c:pt idx="245">
                  <c:v>2.1271179999999998</c:v>
                </c:pt>
                <c:pt idx="246">
                  <c:v>2.1194739999999999</c:v>
                </c:pt>
                <c:pt idx="247">
                  <c:v>2.1118299999999999</c:v>
                </c:pt>
                <c:pt idx="248">
                  <c:v>2.1041850000000002</c:v>
                </c:pt>
                <c:pt idx="249">
                  <c:v>2.0965410000000002</c:v>
                </c:pt>
                <c:pt idx="250">
                  <c:v>2.0888960000000001</c:v>
                </c:pt>
                <c:pt idx="251">
                  <c:v>2.0812520000000001</c:v>
                </c:pt>
                <c:pt idx="252">
                  <c:v>2.073607</c:v>
                </c:pt>
                <c:pt idx="253">
                  <c:v>2.065963</c:v>
                </c:pt>
                <c:pt idx="254">
                  <c:v>2.058319</c:v>
                </c:pt>
                <c:pt idx="255">
                  <c:v>2.0506739999999999</c:v>
                </c:pt>
                <c:pt idx="256">
                  <c:v>2.0430299999999999</c:v>
                </c:pt>
                <c:pt idx="257">
                  <c:v>2.0353850000000002</c:v>
                </c:pt>
                <c:pt idx="258">
                  <c:v>2.0277409999999998</c:v>
                </c:pt>
                <c:pt idx="259">
                  <c:v>2.0200969999999998</c:v>
                </c:pt>
                <c:pt idx="260">
                  <c:v>2.0124520000000001</c:v>
                </c:pt>
                <c:pt idx="261">
                  <c:v>2.0048080000000001</c:v>
                </c:pt>
                <c:pt idx="262">
                  <c:v>1.997163</c:v>
                </c:pt>
                <c:pt idx="263">
                  <c:v>1.989519</c:v>
                </c:pt>
                <c:pt idx="264">
                  <c:v>1.9818750000000001</c:v>
                </c:pt>
                <c:pt idx="265">
                  <c:v>1.9742310000000001</c:v>
                </c:pt>
                <c:pt idx="266">
                  <c:v>1.9665859999999999</c:v>
                </c:pt>
                <c:pt idx="267">
                  <c:v>1.958942</c:v>
                </c:pt>
                <c:pt idx="268">
                  <c:v>1.951298</c:v>
                </c:pt>
                <c:pt idx="269">
                  <c:v>1.9436530000000001</c:v>
                </c:pt>
                <c:pt idx="270">
                  <c:v>1.9360090000000001</c:v>
                </c:pt>
                <c:pt idx="271">
                  <c:v>1.9283650000000001</c:v>
                </c:pt>
                <c:pt idx="272">
                  <c:v>1.92072</c:v>
                </c:pt>
                <c:pt idx="273">
                  <c:v>1.913076</c:v>
                </c:pt>
                <c:pt idx="274">
                  <c:v>1.905432</c:v>
                </c:pt>
                <c:pt idx="275">
                  <c:v>1.897788</c:v>
                </c:pt>
                <c:pt idx="276">
                  <c:v>1.8901429999999999</c:v>
                </c:pt>
                <c:pt idx="277">
                  <c:v>1.8824989999999999</c:v>
                </c:pt>
                <c:pt idx="278">
                  <c:v>1.8748549999999999</c:v>
                </c:pt>
                <c:pt idx="279">
                  <c:v>1.86721</c:v>
                </c:pt>
                <c:pt idx="280">
                  <c:v>1.8595660000000001</c:v>
                </c:pt>
                <c:pt idx="281">
                  <c:v>1.8519220000000001</c:v>
                </c:pt>
                <c:pt idx="282">
                  <c:v>1.8442780000000001</c:v>
                </c:pt>
                <c:pt idx="283">
                  <c:v>1.836633</c:v>
                </c:pt>
                <c:pt idx="284">
                  <c:v>1.828989</c:v>
                </c:pt>
                <c:pt idx="285">
                  <c:v>1.821345</c:v>
                </c:pt>
                <c:pt idx="286">
                  <c:v>1.8137000000000001</c:v>
                </c:pt>
                <c:pt idx="287">
                  <c:v>1.8060560000000001</c:v>
                </c:pt>
                <c:pt idx="288">
                  <c:v>1.7984119999999999</c:v>
                </c:pt>
                <c:pt idx="289">
                  <c:v>1.790767</c:v>
                </c:pt>
                <c:pt idx="290">
                  <c:v>1.783123</c:v>
                </c:pt>
                <c:pt idx="291">
                  <c:v>1.775479</c:v>
                </c:pt>
                <c:pt idx="292">
                  <c:v>1.767835</c:v>
                </c:pt>
                <c:pt idx="293">
                  <c:v>1.7601899999999999</c:v>
                </c:pt>
                <c:pt idx="294">
                  <c:v>1.7525459999999999</c:v>
                </c:pt>
                <c:pt idx="295">
                  <c:v>1.744902</c:v>
                </c:pt>
                <c:pt idx="296">
                  <c:v>1.7372570000000001</c:v>
                </c:pt>
                <c:pt idx="297">
                  <c:v>1.7296130000000001</c:v>
                </c:pt>
                <c:pt idx="298">
                  <c:v>1.7219690000000001</c:v>
                </c:pt>
                <c:pt idx="299">
                  <c:v>1.714324</c:v>
                </c:pt>
                <c:pt idx="300">
                  <c:v>1.70668</c:v>
                </c:pt>
                <c:pt idx="301">
                  <c:v>1.699036</c:v>
                </c:pt>
                <c:pt idx="302">
                  <c:v>1.691392</c:v>
                </c:pt>
                <c:pt idx="303">
                  <c:v>1.6837470000000001</c:v>
                </c:pt>
                <c:pt idx="304">
                  <c:v>1.6761029999999999</c:v>
                </c:pt>
                <c:pt idx="305">
                  <c:v>1.6684589999999999</c:v>
                </c:pt>
                <c:pt idx="306">
                  <c:v>1.660814</c:v>
                </c:pt>
                <c:pt idx="307">
                  <c:v>1.65317</c:v>
                </c:pt>
                <c:pt idx="308">
                  <c:v>1.645526</c:v>
                </c:pt>
                <c:pt idx="309">
                  <c:v>1.6378820000000001</c:v>
                </c:pt>
                <c:pt idx="310">
                  <c:v>1.6302369999999999</c:v>
                </c:pt>
                <c:pt idx="311">
                  <c:v>1.622593</c:v>
                </c:pt>
                <c:pt idx="312">
                  <c:v>1.614949</c:v>
                </c:pt>
                <c:pt idx="313">
                  <c:v>1.6073040000000001</c:v>
                </c:pt>
                <c:pt idx="314">
                  <c:v>1.5996600000000001</c:v>
                </c:pt>
                <c:pt idx="315">
                  <c:v>1.5920160000000001</c:v>
                </c:pt>
                <c:pt idx="316">
                  <c:v>1.584371</c:v>
                </c:pt>
                <c:pt idx="317">
                  <c:v>1.576727</c:v>
                </c:pt>
                <c:pt idx="318">
                  <c:v>1.569083</c:v>
                </c:pt>
                <c:pt idx="319">
                  <c:v>1.561439</c:v>
                </c:pt>
                <c:pt idx="320">
                  <c:v>1.5537939999999999</c:v>
                </c:pt>
                <c:pt idx="321">
                  <c:v>1.5461499999999999</c:v>
                </c:pt>
                <c:pt idx="322">
                  <c:v>1.5385059999999999</c:v>
                </c:pt>
                <c:pt idx="323">
                  <c:v>1.530861</c:v>
                </c:pt>
                <c:pt idx="324">
                  <c:v>1.523217</c:v>
                </c:pt>
                <c:pt idx="325">
                  <c:v>1.5155730000000001</c:v>
                </c:pt>
                <c:pt idx="326">
                  <c:v>1.5079279999999999</c:v>
                </c:pt>
                <c:pt idx="327">
                  <c:v>1.500284</c:v>
                </c:pt>
                <c:pt idx="328">
                  <c:v>1.49264</c:v>
                </c:pt>
                <c:pt idx="329">
                  <c:v>1.484996</c:v>
                </c:pt>
                <c:pt idx="330">
                  <c:v>1.4773510000000001</c:v>
                </c:pt>
                <c:pt idx="331">
                  <c:v>1.4697070000000001</c:v>
                </c:pt>
                <c:pt idx="332">
                  <c:v>1.4620629999999999</c:v>
                </c:pt>
                <c:pt idx="333">
                  <c:v>1.454418</c:v>
                </c:pt>
                <c:pt idx="334">
                  <c:v>1.446774</c:v>
                </c:pt>
                <c:pt idx="335">
                  <c:v>1.43913</c:v>
                </c:pt>
                <c:pt idx="336">
                  <c:v>1.431486</c:v>
                </c:pt>
                <c:pt idx="337">
                  <c:v>1.4238409999999999</c:v>
                </c:pt>
                <c:pt idx="338">
                  <c:v>1.4161969999999999</c:v>
                </c:pt>
                <c:pt idx="339">
                  <c:v>1.4085529999999999</c:v>
                </c:pt>
                <c:pt idx="340">
                  <c:v>1.400908</c:v>
                </c:pt>
                <c:pt idx="341">
                  <c:v>1.3932640000000001</c:v>
                </c:pt>
                <c:pt idx="342">
                  <c:v>1.3856200000000001</c:v>
                </c:pt>
                <c:pt idx="343">
                  <c:v>1.3779749999999999</c:v>
                </c:pt>
                <c:pt idx="344">
                  <c:v>1.370331</c:v>
                </c:pt>
                <c:pt idx="345">
                  <c:v>1.362687</c:v>
                </c:pt>
                <c:pt idx="346">
                  <c:v>1.355043</c:v>
                </c:pt>
                <c:pt idx="347">
                  <c:v>1.3473980000000001</c:v>
                </c:pt>
                <c:pt idx="348">
                  <c:v>1.3397539999999999</c:v>
                </c:pt>
                <c:pt idx="349">
                  <c:v>1.3321099999999999</c:v>
                </c:pt>
                <c:pt idx="350">
                  <c:v>1.324465</c:v>
                </c:pt>
                <c:pt idx="351">
                  <c:v>1.316821</c:v>
                </c:pt>
                <c:pt idx="352">
                  <c:v>1.309177</c:v>
                </c:pt>
                <c:pt idx="353">
                  <c:v>1.3015330000000001</c:v>
                </c:pt>
                <c:pt idx="354">
                  <c:v>1.2938879999999999</c:v>
                </c:pt>
                <c:pt idx="355">
                  <c:v>1.2862439999999999</c:v>
                </c:pt>
                <c:pt idx="356">
                  <c:v>1.2786</c:v>
                </c:pt>
                <c:pt idx="357">
                  <c:v>1.2709550000000001</c:v>
                </c:pt>
                <c:pt idx="358">
                  <c:v>1.2633110000000001</c:v>
                </c:pt>
                <c:pt idx="359">
                  <c:v>1.2556670000000001</c:v>
                </c:pt>
                <c:pt idx="360">
                  <c:v>1.248022</c:v>
                </c:pt>
                <c:pt idx="361">
                  <c:v>1.240378</c:v>
                </c:pt>
                <c:pt idx="362">
                  <c:v>1.232734</c:v>
                </c:pt>
                <c:pt idx="363">
                  <c:v>1.22509</c:v>
                </c:pt>
                <c:pt idx="364">
                  <c:v>1.2174450000000001</c:v>
                </c:pt>
                <c:pt idx="365">
                  <c:v>1.2098009999999999</c:v>
                </c:pt>
                <c:pt idx="366">
                  <c:v>1.2021569999999999</c:v>
                </c:pt>
                <c:pt idx="367">
                  <c:v>1.194512</c:v>
                </c:pt>
                <c:pt idx="368">
                  <c:v>1.186868</c:v>
                </c:pt>
                <c:pt idx="369">
                  <c:v>1.179224</c:v>
                </c:pt>
                <c:pt idx="370">
                  <c:v>1.1715789999999999</c:v>
                </c:pt>
                <c:pt idx="371">
                  <c:v>1.1639349999999999</c:v>
                </c:pt>
                <c:pt idx="372">
                  <c:v>1.156291</c:v>
                </c:pt>
                <c:pt idx="373">
                  <c:v>1.148647</c:v>
                </c:pt>
                <c:pt idx="374">
                  <c:v>1.1410020000000001</c:v>
                </c:pt>
                <c:pt idx="375">
                  <c:v>1.1333580000000001</c:v>
                </c:pt>
                <c:pt idx="376">
                  <c:v>1.1257140000000001</c:v>
                </c:pt>
                <c:pt idx="377">
                  <c:v>1.118069</c:v>
                </c:pt>
                <c:pt idx="378">
                  <c:v>1.110425</c:v>
                </c:pt>
                <c:pt idx="379">
                  <c:v>1.102781</c:v>
                </c:pt>
                <c:pt idx="380">
                  <c:v>1.095137</c:v>
                </c:pt>
                <c:pt idx="381">
                  <c:v>1.0874919999999999</c:v>
                </c:pt>
                <c:pt idx="382">
                  <c:v>1.0798479999999999</c:v>
                </c:pt>
                <c:pt idx="383">
                  <c:v>1.0722039999999999</c:v>
                </c:pt>
                <c:pt idx="384">
                  <c:v>1.064559</c:v>
                </c:pt>
                <c:pt idx="385">
                  <c:v>1.056915</c:v>
                </c:pt>
                <c:pt idx="386">
                  <c:v>1.0492710000000001</c:v>
                </c:pt>
                <c:pt idx="387">
                  <c:v>1.0416259999999999</c:v>
                </c:pt>
                <c:pt idx="388">
                  <c:v>1.033982</c:v>
                </c:pt>
                <c:pt idx="389">
                  <c:v>1.026338</c:v>
                </c:pt>
                <c:pt idx="390">
                  <c:v>1.018694</c:v>
                </c:pt>
                <c:pt idx="391">
                  <c:v>1.0110490000000001</c:v>
                </c:pt>
                <c:pt idx="392">
                  <c:v>1.0034050000000001</c:v>
                </c:pt>
                <c:pt idx="393">
                  <c:v>0.99576100000000001</c:v>
                </c:pt>
                <c:pt idx="394">
                  <c:v>0.98811599999999999</c:v>
                </c:pt>
                <c:pt idx="395">
                  <c:v>0.98047200000000001</c:v>
                </c:pt>
                <c:pt idx="396">
                  <c:v>0.97282800000000003</c:v>
                </c:pt>
                <c:pt idx="397">
                  <c:v>0.96518300000000001</c:v>
                </c:pt>
                <c:pt idx="398">
                  <c:v>0.95753900000000003</c:v>
                </c:pt>
                <c:pt idx="399">
                  <c:v>0.94989500000000004</c:v>
                </c:pt>
                <c:pt idx="400">
                  <c:v>0.94225099999999995</c:v>
                </c:pt>
                <c:pt idx="401">
                  <c:v>0.93460600000000005</c:v>
                </c:pt>
                <c:pt idx="402">
                  <c:v>0.92696199999999995</c:v>
                </c:pt>
                <c:pt idx="403">
                  <c:v>0.91931799999999997</c:v>
                </c:pt>
                <c:pt idx="404">
                  <c:v>0.91167299999999996</c:v>
                </c:pt>
                <c:pt idx="405">
                  <c:v>0.90402899999999997</c:v>
                </c:pt>
                <c:pt idx="406">
                  <c:v>0.89638499999999999</c:v>
                </c:pt>
                <c:pt idx="407">
                  <c:v>0.888741</c:v>
                </c:pt>
                <c:pt idx="408">
                  <c:v>0.88109599999999999</c:v>
                </c:pt>
                <c:pt idx="409">
                  <c:v>0.87345200000000001</c:v>
                </c:pt>
                <c:pt idx="410">
                  <c:v>0.86580800000000002</c:v>
                </c:pt>
                <c:pt idx="411">
                  <c:v>0.85816300000000001</c:v>
                </c:pt>
                <c:pt idx="412">
                  <c:v>0.85051900000000002</c:v>
                </c:pt>
                <c:pt idx="413">
                  <c:v>0.84287500000000004</c:v>
                </c:pt>
                <c:pt idx="414">
                  <c:v>0.83523000000000003</c:v>
                </c:pt>
                <c:pt idx="415">
                  <c:v>0.82758600000000004</c:v>
                </c:pt>
                <c:pt idx="416">
                  <c:v>0.81994199999999995</c:v>
                </c:pt>
                <c:pt idx="417">
                  <c:v>0.81229799999999996</c:v>
                </c:pt>
                <c:pt idx="418">
                  <c:v>0.80465299999999995</c:v>
                </c:pt>
                <c:pt idx="419">
                  <c:v>0.79700899999999997</c:v>
                </c:pt>
                <c:pt idx="420">
                  <c:v>0.78936499999999998</c:v>
                </c:pt>
                <c:pt idx="421">
                  <c:v>0.78171999999999997</c:v>
                </c:pt>
                <c:pt idx="422">
                  <c:v>0.77407599999999999</c:v>
                </c:pt>
                <c:pt idx="423">
                  <c:v>0.766432</c:v>
                </c:pt>
                <c:pt idx="424">
                  <c:v>0.75878800000000002</c:v>
                </c:pt>
                <c:pt idx="425">
                  <c:v>0.75114300000000001</c:v>
                </c:pt>
                <c:pt idx="426">
                  <c:v>0.74349900000000002</c:v>
                </c:pt>
                <c:pt idx="427">
                  <c:v>0.73585500000000004</c:v>
                </c:pt>
                <c:pt idx="428">
                  <c:v>0.72821000000000002</c:v>
                </c:pt>
                <c:pt idx="429">
                  <c:v>0.72056600000000004</c:v>
                </c:pt>
                <c:pt idx="430">
                  <c:v>0.71292199999999994</c:v>
                </c:pt>
                <c:pt idx="431">
                  <c:v>0.70527700000000004</c:v>
                </c:pt>
                <c:pt idx="432">
                  <c:v>0.69763299999999995</c:v>
                </c:pt>
                <c:pt idx="433">
                  <c:v>0.68998899999999996</c:v>
                </c:pt>
                <c:pt idx="434">
                  <c:v>0.68234499999999998</c:v>
                </c:pt>
                <c:pt idx="435">
                  <c:v>0.67469999999999997</c:v>
                </c:pt>
                <c:pt idx="436">
                  <c:v>0.66705599999999998</c:v>
                </c:pt>
                <c:pt idx="437">
                  <c:v>0.659412</c:v>
                </c:pt>
                <c:pt idx="438">
                  <c:v>0.65176699999999999</c:v>
                </c:pt>
                <c:pt idx="439">
                  <c:v>0.644123</c:v>
                </c:pt>
                <c:pt idx="440">
                  <c:v>0.63647900000000002</c:v>
                </c:pt>
                <c:pt idx="441">
                  <c:v>0.628834</c:v>
                </c:pt>
                <c:pt idx="442">
                  <c:v>0.62119000000000002</c:v>
                </c:pt>
                <c:pt idx="443">
                  <c:v>0.61354600000000004</c:v>
                </c:pt>
                <c:pt idx="444">
                  <c:v>0.60590200000000005</c:v>
                </c:pt>
                <c:pt idx="445">
                  <c:v>0.59825700000000004</c:v>
                </c:pt>
              </c:numCache>
            </c:numRef>
          </c:cat>
          <c:val>
            <c:numRef>
              <c:f>Sheet1!$B$4:$B$449</c:f>
              <c:numCache>
                <c:formatCode>0.00E+00</c:formatCode>
                <c:ptCount val="446"/>
                <c:pt idx="0">
                  <c:v>292973</c:v>
                </c:pt>
                <c:pt idx="1">
                  <c:v>261682</c:v>
                </c:pt>
                <c:pt idx="2">
                  <c:v>250471</c:v>
                </c:pt>
                <c:pt idx="3">
                  <c:v>263236</c:v>
                </c:pt>
                <c:pt idx="4">
                  <c:v>315282</c:v>
                </c:pt>
                <c:pt idx="5">
                  <c:v>380070</c:v>
                </c:pt>
                <c:pt idx="6">
                  <c:v>514723</c:v>
                </c:pt>
                <c:pt idx="7">
                  <c:v>776603</c:v>
                </c:pt>
                <c:pt idx="8">
                  <c:v>1065210</c:v>
                </c:pt>
                <c:pt idx="9">
                  <c:v>1376270</c:v>
                </c:pt>
                <c:pt idx="10">
                  <c:v>1746650</c:v>
                </c:pt>
                <c:pt idx="11">
                  <c:v>2051440</c:v>
                </c:pt>
                <c:pt idx="12">
                  <c:v>2087110</c:v>
                </c:pt>
                <c:pt idx="13">
                  <c:v>1853290</c:v>
                </c:pt>
                <c:pt idx="14">
                  <c:v>1490600</c:v>
                </c:pt>
                <c:pt idx="15">
                  <c:v>1133280</c:v>
                </c:pt>
                <c:pt idx="16">
                  <c:v>873552</c:v>
                </c:pt>
                <c:pt idx="17">
                  <c:v>703678</c:v>
                </c:pt>
                <c:pt idx="18">
                  <c:v>592715</c:v>
                </c:pt>
                <c:pt idx="19">
                  <c:v>542256</c:v>
                </c:pt>
                <c:pt idx="20">
                  <c:v>530212</c:v>
                </c:pt>
                <c:pt idx="21">
                  <c:v>540571</c:v>
                </c:pt>
                <c:pt idx="22">
                  <c:v>557487</c:v>
                </c:pt>
                <c:pt idx="23">
                  <c:v>602833</c:v>
                </c:pt>
                <c:pt idx="24">
                  <c:v>674511</c:v>
                </c:pt>
                <c:pt idx="25">
                  <c:v>747412</c:v>
                </c:pt>
                <c:pt idx="26">
                  <c:v>789784</c:v>
                </c:pt>
                <c:pt idx="27">
                  <c:v>797456</c:v>
                </c:pt>
                <c:pt idx="28">
                  <c:v>798032</c:v>
                </c:pt>
                <c:pt idx="29">
                  <c:v>835358</c:v>
                </c:pt>
                <c:pt idx="30">
                  <c:v>931339</c:v>
                </c:pt>
                <c:pt idx="31">
                  <c:v>1034070</c:v>
                </c:pt>
                <c:pt idx="32">
                  <c:v>1066410</c:v>
                </c:pt>
                <c:pt idx="33">
                  <c:v>1016010</c:v>
                </c:pt>
                <c:pt idx="34">
                  <c:v>903630</c:v>
                </c:pt>
                <c:pt idx="35">
                  <c:v>804886</c:v>
                </c:pt>
                <c:pt idx="36">
                  <c:v>785215</c:v>
                </c:pt>
                <c:pt idx="37">
                  <c:v>828388</c:v>
                </c:pt>
                <c:pt idx="38">
                  <c:v>852309</c:v>
                </c:pt>
                <c:pt idx="39">
                  <c:v>809498</c:v>
                </c:pt>
                <c:pt idx="40">
                  <c:v>712415</c:v>
                </c:pt>
                <c:pt idx="41">
                  <c:v>605453</c:v>
                </c:pt>
                <c:pt idx="42">
                  <c:v>541873</c:v>
                </c:pt>
                <c:pt idx="43">
                  <c:v>543540</c:v>
                </c:pt>
                <c:pt idx="44">
                  <c:v>591161</c:v>
                </c:pt>
                <c:pt idx="45">
                  <c:v>684528</c:v>
                </c:pt>
                <c:pt idx="46">
                  <c:v>844384</c:v>
                </c:pt>
                <c:pt idx="47">
                  <c:v>1033920</c:v>
                </c:pt>
                <c:pt idx="48">
                  <c:v>1147800</c:v>
                </c:pt>
                <c:pt idx="49">
                  <c:v>1113240</c:v>
                </c:pt>
                <c:pt idx="50">
                  <c:v>955445</c:v>
                </c:pt>
                <c:pt idx="51">
                  <c:v>764839</c:v>
                </c:pt>
                <c:pt idx="52">
                  <c:v>631616</c:v>
                </c:pt>
                <c:pt idx="53">
                  <c:v>588009</c:v>
                </c:pt>
                <c:pt idx="54">
                  <c:v>660919</c:v>
                </c:pt>
                <c:pt idx="55">
                  <c:v>879075</c:v>
                </c:pt>
                <c:pt idx="56">
                  <c:v>1186520</c:v>
                </c:pt>
                <c:pt idx="57">
                  <c:v>1464850</c:v>
                </c:pt>
                <c:pt idx="58">
                  <c:v>1622390</c:v>
                </c:pt>
                <c:pt idx="59">
                  <c:v>1619610</c:v>
                </c:pt>
                <c:pt idx="60">
                  <c:v>1466990</c:v>
                </c:pt>
                <c:pt idx="61">
                  <c:v>1231620</c:v>
                </c:pt>
                <c:pt idx="62">
                  <c:v>988429</c:v>
                </c:pt>
                <c:pt idx="63">
                  <c:v>790992</c:v>
                </c:pt>
                <c:pt idx="64">
                  <c:v>668601</c:v>
                </c:pt>
                <c:pt idx="65">
                  <c:v>610217</c:v>
                </c:pt>
                <c:pt idx="66">
                  <c:v>582107</c:v>
                </c:pt>
                <c:pt idx="67">
                  <c:v>567584</c:v>
                </c:pt>
                <c:pt idx="68">
                  <c:v>560346</c:v>
                </c:pt>
                <c:pt idx="69">
                  <c:v>555270</c:v>
                </c:pt>
                <c:pt idx="70">
                  <c:v>545381</c:v>
                </c:pt>
                <c:pt idx="71">
                  <c:v>525913</c:v>
                </c:pt>
                <c:pt idx="72">
                  <c:v>499446</c:v>
                </c:pt>
                <c:pt idx="73">
                  <c:v>469323</c:v>
                </c:pt>
                <c:pt idx="74">
                  <c:v>436851</c:v>
                </c:pt>
                <c:pt idx="75">
                  <c:v>402632</c:v>
                </c:pt>
                <c:pt idx="76">
                  <c:v>368312</c:v>
                </c:pt>
                <c:pt idx="77">
                  <c:v>337096</c:v>
                </c:pt>
                <c:pt idx="78">
                  <c:v>311577</c:v>
                </c:pt>
                <c:pt idx="79">
                  <c:v>294434</c:v>
                </c:pt>
                <c:pt idx="80">
                  <c:v>285465</c:v>
                </c:pt>
                <c:pt idx="81">
                  <c:v>280566</c:v>
                </c:pt>
                <c:pt idx="82">
                  <c:v>275998</c:v>
                </c:pt>
                <c:pt idx="83">
                  <c:v>271540</c:v>
                </c:pt>
                <c:pt idx="84">
                  <c:v>270145</c:v>
                </c:pt>
                <c:pt idx="85">
                  <c:v>264513</c:v>
                </c:pt>
                <c:pt idx="86">
                  <c:v>242495</c:v>
                </c:pt>
                <c:pt idx="87">
                  <c:v>201932</c:v>
                </c:pt>
                <c:pt idx="88">
                  <c:v>155360</c:v>
                </c:pt>
                <c:pt idx="89">
                  <c:v>121859</c:v>
                </c:pt>
                <c:pt idx="90">
                  <c:v>112641</c:v>
                </c:pt>
                <c:pt idx="91">
                  <c:v>123938</c:v>
                </c:pt>
                <c:pt idx="92">
                  <c:v>145141</c:v>
                </c:pt>
                <c:pt idx="93">
                  <c:v>182476</c:v>
                </c:pt>
                <c:pt idx="94">
                  <c:v>237161</c:v>
                </c:pt>
                <c:pt idx="95">
                  <c:v>289397</c:v>
                </c:pt>
                <c:pt idx="96">
                  <c:v>317815</c:v>
                </c:pt>
                <c:pt idx="97">
                  <c:v>357462</c:v>
                </c:pt>
                <c:pt idx="98">
                  <c:v>463626</c:v>
                </c:pt>
                <c:pt idx="99">
                  <c:v>568529</c:v>
                </c:pt>
                <c:pt idx="100">
                  <c:v>790194</c:v>
                </c:pt>
                <c:pt idx="101">
                  <c:v>1287400</c:v>
                </c:pt>
                <c:pt idx="102">
                  <c:v>1911430</c:v>
                </c:pt>
                <c:pt idx="103">
                  <c:v>2297070</c:v>
                </c:pt>
                <c:pt idx="104">
                  <c:v>2275030</c:v>
                </c:pt>
                <c:pt idx="105">
                  <c:v>1938730</c:v>
                </c:pt>
                <c:pt idx="106">
                  <c:v>1478670</c:v>
                </c:pt>
                <c:pt idx="107">
                  <c:v>1072650</c:v>
                </c:pt>
                <c:pt idx="108">
                  <c:v>780145</c:v>
                </c:pt>
                <c:pt idx="109">
                  <c:v>576346</c:v>
                </c:pt>
                <c:pt idx="110">
                  <c:v>450022</c:v>
                </c:pt>
                <c:pt idx="111">
                  <c:v>367776</c:v>
                </c:pt>
                <c:pt idx="112">
                  <c:v>308995</c:v>
                </c:pt>
                <c:pt idx="113">
                  <c:v>268780</c:v>
                </c:pt>
                <c:pt idx="114">
                  <c:v>244246</c:v>
                </c:pt>
                <c:pt idx="115">
                  <c:v>230483</c:v>
                </c:pt>
                <c:pt idx="116">
                  <c:v>221690</c:v>
                </c:pt>
                <c:pt idx="117">
                  <c:v>216189</c:v>
                </c:pt>
                <c:pt idx="118">
                  <c:v>213466</c:v>
                </c:pt>
                <c:pt idx="119">
                  <c:v>217937</c:v>
                </c:pt>
                <c:pt idx="120">
                  <c:v>234506</c:v>
                </c:pt>
                <c:pt idx="121">
                  <c:v>286902</c:v>
                </c:pt>
                <c:pt idx="122">
                  <c:v>454376</c:v>
                </c:pt>
                <c:pt idx="123">
                  <c:v>666530</c:v>
                </c:pt>
                <c:pt idx="124">
                  <c:v>893243</c:v>
                </c:pt>
                <c:pt idx="125">
                  <c:v>1397340</c:v>
                </c:pt>
                <c:pt idx="126">
                  <c:v>2205500</c:v>
                </c:pt>
                <c:pt idx="127">
                  <c:v>2874860</c:v>
                </c:pt>
                <c:pt idx="128">
                  <c:v>2990900</c:v>
                </c:pt>
                <c:pt idx="129">
                  <c:v>2566670</c:v>
                </c:pt>
                <c:pt idx="130">
                  <c:v>1894480</c:v>
                </c:pt>
                <c:pt idx="131">
                  <c:v>1293460</c:v>
                </c:pt>
                <c:pt idx="132">
                  <c:v>909414</c:v>
                </c:pt>
                <c:pt idx="133">
                  <c:v>670689</c:v>
                </c:pt>
                <c:pt idx="134">
                  <c:v>502141</c:v>
                </c:pt>
                <c:pt idx="135">
                  <c:v>384278</c:v>
                </c:pt>
                <c:pt idx="136">
                  <c:v>309551</c:v>
                </c:pt>
                <c:pt idx="137">
                  <c:v>299207</c:v>
                </c:pt>
                <c:pt idx="138">
                  <c:v>339839</c:v>
                </c:pt>
                <c:pt idx="139">
                  <c:v>396998</c:v>
                </c:pt>
                <c:pt idx="140">
                  <c:v>443259</c:v>
                </c:pt>
                <c:pt idx="141">
                  <c:v>457109</c:v>
                </c:pt>
                <c:pt idx="142">
                  <c:v>432891</c:v>
                </c:pt>
                <c:pt idx="143">
                  <c:v>378473</c:v>
                </c:pt>
                <c:pt idx="144">
                  <c:v>313635</c:v>
                </c:pt>
                <c:pt idx="145">
                  <c:v>259043</c:v>
                </c:pt>
                <c:pt idx="146">
                  <c:v>218530</c:v>
                </c:pt>
                <c:pt idx="147">
                  <c:v>184997</c:v>
                </c:pt>
                <c:pt idx="148">
                  <c:v>158717</c:v>
                </c:pt>
                <c:pt idx="149">
                  <c:v>149615</c:v>
                </c:pt>
                <c:pt idx="150">
                  <c:v>158472</c:v>
                </c:pt>
                <c:pt idx="151">
                  <c:v>173292</c:v>
                </c:pt>
                <c:pt idx="152">
                  <c:v>182769</c:v>
                </c:pt>
                <c:pt idx="153">
                  <c:v>185606</c:v>
                </c:pt>
                <c:pt idx="154">
                  <c:v>191151</c:v>
                </c:pt>
                <c:pt idx="155">
                  <c:v>199151</c:v>
                </c:pt>
                <c:pt idx="156">
                  <c:v>208486</c:v>
                </c:pt>
                <c:pt idx="157">
                  <c:v>231208</c:v>
                </c:pt>
                <c:pt idx="158">
                  <c:v>265836</c:v>
                </c:pt>
                <c:pt idx="159">
                  <c:v>290465</c:v>
                </c:pt>
                <c:pt idx="160">
                  <c:v>274574</c:v>
                </c:pt>
                <c:pt idx="161">
                  <c:v>229347</c:v>
                </c:pt>
                <c:pt idx="162">
                  <c:v>206175</c:v>
                </c:pt>
                <c:pt idx="163">
                  <c:v>224555</c:v>
                </c:pt>
                <c:pt idx="164">
                  <c:v>246966</c:v>
                </c:pt>
                <c:pt idx="165">
                  <c:v>232660</c:v>
                </c:pt>
                <c:pt idx="166">
                  <c:v>182661</c:v>
                </c:pt>
                <c:pt idx="167">
                  <c:v>121630</c:v>
                </c:pt>
                <c:pt idx="168">
                  <c:v>66221.7</c:v>
                </c:pt>
                <c:pt idx="169">
                  <c:v>28912.799999999999</c:v>
                </c:pt>
                <c:pt idx="170">
                  <c:v>16045.2</c:v>
                </c:pt>
                <c:pt idx="171">
                  <c:v>29188.7</c:v>
                </c:pt>
                <c:pt idx="172">
                  <c:v>43285.1</c:v>
                </c:pt>
                <c:pt idx="173">
                  <c:v>56184.6</c:v>
                </c:pt>
                <c:pt idx="174">
                  <c:v>89936.3</c:v>
                </c:pt>
                <c:pt idx="175">
                  <c:v>152923</c:v>
                </c:pt>
                <c:pt idx="176">
                  <c:v>216209</c:v>
                </c:pt>
                <c:pt idx="177">
                  <c:v>236236</c:v>
                </c:pt>
                <c:pt idx="178">
                  <c:v>220035</c:v>
                </c:pt>
                <c:pt idx="179">
                  <c:v>214128</c:v>
                </c:pt>
                <c:pt idx="180">
                  <c:v>243449</c:v>
                </c:pt>
                <c:pt idx="181">
                  <c:v>281121</c:v>
                </c:pt>
                <c:pt idx="182">
                  <c:v>292956</c:v>
                </c:pt>
                <c:pt idx="183">
                  <c:v>279949</c:v>
                </c:pt>
                <c:pt idx="184">
                  <c:v>258913</c:v>
                </c:pt>
                <c:pt idx="185">
                  <c:v>243144</c:v>
                </c:pt>
                <c:pt idx="186">
                  <c:v>230917</c:v>
                </c:pt>
                <c:pt idx="187">
                  <c:v>216704</c:v>
                </c:pt>
                <c:pt idx="188">
                  <c:v>205609</c:v>
                </c:pt>
                <c:pt idx="189">
                  <c:v>201590</c:v>
                </c:pt>
                <c:pt idx="190">
                  <c:v>204212</c:v>
                </c:pt>
                <c:pt idx="191">
                  <c:v>216829</c:v>
                </c:pt>
                <c:pt idx="192">
                  <c:v>224110</c:v>
                </c:pt>
                <c:pt idx="193">
                  <c:v>221051</c:v>
                </c:pt>
                <c:pt idx="194">
                  <c:v>230859</c:v>
                </c:pt>
                <c:pt idx="195">
                  <c:v>261500</c:v>
                </c:pt>
                <c:pt idx="196">
                  <c:v>287642</c:v>
                </c:pt>
                <c:pt idx="197">
                  <c:v>291514</c:v>
                </c:pt>
                <c:pt idx="198">
                  <c:v>282311</c:v>
                </c:pt>
                <c:pt idx="199">
                  <c:v>276607</c:v>
                </c:pt>
                <c:pt idx="200">
                  <c:v>309549</c:v>
                </c:pt>
                <c:pt idx="201">
                  <c:v>383767</c:v>
                </c:pt>
                <c:pt idx="202">
                  <c:v>457749</c:v>
                </c:pt>
                <c:pt idx="203">
                  <c:v>480329</c:v>
                </c:pt>
                <c:pt idx="204">
                  <c:v>459963</c:v>
                </c:pt>
                <c:pt idx="205">
                  <c:v>419547</c:v>
                </c:pt>
                <c:pt idx="206">
                  <c:v>374136</c:v>
                </c:pt>
                <c:pt idx="207">
                  <c:v>331774</c:v>
                </c:pt>
                <c:pt idx="208">
                  <c:v>302831</c:v>
                </c:pt>
                <c:pt idx="209">
                  <c:v>285926</c:v>
                </c:pt>
                <c:pt idx="210">
                  <c:v>290570</c:v>
                </c:pt>
                <c:pt idx="211">
                  <c:v>350012</c:v>
                </c:pt>
                <c:pt idx="212">
                  <c:v>463274</c:v>
                </c:pt>
                <c:pt idx="213">
                  <c:v>600557</c:v>
                </c:pt>
                <c:pt idx="214">
                  <c:v>746776</c:v>
                </c:pt>
                <c:pt idx="215">
                  <c:v>873233</c:v>
                </c:pt>
                <c:pt idx="216">
                  <c:v>934528</c:v>
                </c:pt>
                <c:pt idx="217">
                  <c:v>899746</c:v>
                </c:pt>
                <c:pt idx="218">
                  <c:v>787911</c:v>
                </c:pt>
                <c:pt idx="219">
                  <c:v>635682</c:v>
                </c:pt>
                <c:pt idx="220">
                  <c:v>488203</c:v>
                </c:pt>
                <c:pt idx="221">
                  <c:v>395047</c:v>
                </c:pt>
                <c:pt idx="222">
                  <c:v>397575</c:v>
                </c:pt>
                <c:pt idx="223">
                  <c:v>491999</c:v>
                </c:pt>
                <c:pt idx="224">
                  <c:v>614070</c:v>
                </c:pt>
                <c:pt idx="225">
                  <c:v>692352</c:v>
                </c:pt>
                <c:pt idx="226">
                  <c:v>702840</c:v>
                </c:pt>
                <c:pt idx="227">
                  <c:v>664253</c:v>
                </c:pt>
                <c:pt idx="228">
                  <c:v>607638</c:v>
                </c:pt>
                <c:pt idx="229">
                  <c:v>558809</c:v>
                </c:pt>
                <c:pt idx="230">
                  <c:v>531897</c:v>
                </c:pt>
                <c:pt idx="231">
                  <c:v>529182</c:v>
                </c:pt>
                <c:pt idx="232">
                  <c:v>542285</c:v>
                </c:pt>
                <c:pt idx="233">
                  <c:v>557163</c:v>
                </c:pt>
                <c:pt idx="234">
                  <c:v>566101</c:v>
                </c:pt>
                <c:pt idx="235">
                  <c:v>576102</c:v>
                </c:pt>
                <c:pt idx="236">
                  <c:v>590001</c:v>
                </c:pt>
                <c:pt idx="237">
                  <c:v>610776</c:v>
                </c:pt>
                <c:pt idx="238">
                  <c:v>644935</c:v>
                </c:pt>
                <c:pt idx="239">
                  <c:v>679826</c:v>
                </c:pt>
                <c:pt idx="240">
                  <c:v>697121</c:v>
                </c:pt>
                <c:pt idx="241">
                  <c:v>691498</c:v>
                </c:pt>
                <c:pt idx="242">
                  <c:v>683128</c:v>
                </c:pt>
                <c:pt idx="243">
                  <c:v>694083</c:v>
                </c:pt>
                <c:pt idx="244">
                  <c:v>736417</c:v>
                </c:pt>
                <c:pt idx="245">
                  <c:v>805249</c:v>
                </c:pt>
                <c:pt idx="246">
                  <c:v>872953</c:v>
                </c:pt>
                <c:pt idx="247">
                  <c:v>912205</c:v>
                </c:pt>
                <c:pt idx="248">
                  <c:v>914315</c:v>
                </c:pt>
                <c:pt idx="249">
                  <c:v>903594</c:v>
                </c:pt>
                <c:pt idx="250">
                  <c:v>917672</c:v>
                </c:pt>
                <c:pt idx="251">
                  <c:v>949215</c:v>
                </c:pt>
                <c:pt idx="252">
                  <c:v>984824</c:v>
                </c:pt>
                <c:pt idx="253">
                  <c:v>1053350</c:v>
                </c:pt>
                <c:pt idx="254">
                  <c:v>1196810</c:v>
                </c:pt>
                <c:pt idx="255">
                  <c:v>1483450</c:v>
                </c:pt>
                <c:pt idx="256">
                  <c:v>1693970</c:v>
                </c:pt>
                <c:pt idx="257">
                  <c:v>1955020</c:v>
                </c:pt>
                <c:pt idx="258">
                  <c:v>2579730</c:v>
                </c:pt>
                <c:pt idx="259">
                  <c:v>3408640</c:v>
                </c:pt>
                <c:pt idx="260">
                  <c:v>3849460</c:v>
                </c:pt>
                <c:pt idx="261">
                  <c:v>3606660</c:v>
                </c:pt>
                <c:pt idx="262">
                  <c:v>2881920</c:v>
                </c:pt>
                <c:pt idx="263">
                  <c:v>2037610</c:v>
                </c:pt>
                <c:pt idx="264">
                  <c:v>1384100</c:v>
                </c:pt>
                <c:pt idx="265">
                  <c:v>992406</c:v>
                </c:pt>
                <c:pt idx="266">
                  <c:v>753848</c:v>
                </c:pt>
                <c:pt idx="267">
                  <c:v>623612</c:v>
                </c:pt>
                <c:pt idx="268">
                  <c:v>540418</c:v>
                </c:pt>
                <c:pt idx="269">
                  <c:v>473702</c:v>
                </c:pt>
                <c:pt idx="270">
                  <c:v>427092</c:v>
                </c:pt>
                <c:pt idx="271">
                  <c:v>399402</c:v>
                </c:pt>
                <c:pt idx="272">
                  <c:v>381618</c:v>
                </c:pt>
                <c:pt idx="273">
                  <c:v>368600</c:v>
                </c:pt>
                <c:pt idx="274">
                  <c:v>357336</c:v>
                </c:pt>
                <c:pt idx="275">
                  <c:v>346192</c:v>
                </c:pt>
                <c:pt idx="276">
                  <c:v>330191</c:v>
                </c:pt>
                <c:pt idx="277">
                  <c:v>312262</c:v>
                </c:pt>
                <c:pt idx="278">
                  <c:v>292595</c:v>
                </c:pt>
                <c:pt idx="279">
                  <c:v>272617</c:v>
                </c:pt>
                <c:pt idx="280">
                  <c:v>254000</c:v>
                </c:pt>
                <c:pt idx="281">
                  <c:v>239224</c:v>
                </c:pt>
                <c:pt idx="282">
                  <c:v>231139</c:v>
                </c:pt>
                <c:pt idx="283">
                  <c:v>231598</c:v>
                </c:pt>
                <c:pt idx="284">
                  <c:v>238261</c:v>
                </c:pt>
                <c:pt idx="285">
                  <c:v>246828</c:v>
                </c:pt>
                <c:pt idx="286">
                  <c:v>253521</c:v>
                </c:pt>
                <c:pt idx="287">
                  <c:v>258608</c:v>
                </c:pt>
                <c:pt idx="288">
                  <c:v>261355</c:v>
                </c:pt>
                <c:pt idx="289">
                  <c:v>261232</c:v>
                </c:pt>
                <c:pt idx="290">
                  <c:v>260445</c:v>
                </c:pt>
                <c:pt idx="291">
                  <c:v>265388</c:v>
                </c:pt>
                <c:pt idx="292">
                  <c:v>277400</c:v>
                </c:pt>
                <c:pt idx="293">
                  <c:v>287905</c:v>
                </c:pt>
                <c:pt idx="294">
                  <c:v>290215</c:v>
                </c:pt>
                <c:pt idx="295">
                  <c:v>283876</c:v>
                </c:pt>
                <c:pt idx="296">
                  <c:v>276258</c:v>
                </c:pt>
                <c:pt idx="297">
                  <c:v>273867</c:v>
                </c:pt>
                <c:pt idx="298">
                  <c:v>277949</c:v>
                </c:pt>
                <c:pt idx="299">
                  <c:v>283929</c:v>
                </c:pt>
                <c:pt idx="300">
                  <c:v>290463</c:v>
                </c:pt>
                <c:pt idx="301">
                  <c:v>297526</c:v>
                </c:pt>
                <c:pt idx="302">
                  <c:v>299992</c:v>
                </c:pt>
                <c:pt idx="303">
                  <c:v>296186</c:v>
                </c:pt>
                <c:pt idx="304">
                  <c:v>286924</c:v>
                </c:pt>
                <c:pt idx="305">
                  <c:v>274730</c:v>
                </c:pt>
                <c:pt idx="306">
                  <c:v>265709</c:v>
                </c:pt>
                <c:pt idx="307">
                  <c:v>260215</c:v>
                </c:pt>
                <c:pt idx="308">
                  <c:v>251070</c:v>
                </c:pt>
                <c:pt idx="309">
                  <c:v>236172</c:v>
                </c:pt>
                <c:pt idx="310">
                  <c:v>221645</c:v>
                </c:pt>
                <c:pt idx="311">
                  <c:v>211711</c:v>
                </c:pt>
                <c:pt idx="312">
                  <c:v>208690</c:v>
                </c:pt>
                <c:pt idx="313">
                  <c:v>210151</c:v>
                </c:pt>
                <c:pt idx="314">
                  <c:v>213441</c:v>
                </c:pt>
                <c:pt idx="315">
                  <c:v>216653</c:v>
                </c:pt>
                <c:pt idx="316">
                  <c:v>218359</c:v>
                </c:pt>
                <c:pt idx="317">
                  <c:v>217610</c:v>
                </c:pt>
                <c:pt idx="318">
                  <c:v>214439</c:v>
                </c:pt>
                <c:pt idx="319">
                  <c:v>209604</c:v>
                </c:pt>
                <c:pt idx="320">
                  <c:v>207903</c:v>
                </c:pt>
                <c:pt idx="321">
                  <c:v>212089</c:v>
                </c:pt>
                <c:pt idx="322">
                  <c:v>219754</c:v>
                </c:pt>
                <c:pt idx="323">
                  <c:v>227608</c:v>
                </c:pt>
                <c:pt idx="324">
                  <c:v>238528</c:v>
                </c:pt>
                <c:pt idx="325">
                  <c:v>251993</c:v>
                </c:pt>
                <c:pt idx="326">
                  <c:v>263046</c:v>
                </c:pt>
                <c:pt idx="327">
                  <c:v>266517</c:v>
                </c:pt>
                <c:pt idx="328">
                  <c:v>262983</c:v>
                </c:pt>
                <c:pt idx="329">
                  <c:v>258786</c:v>
                </c:pt>
                <c:pt idx="330">
                  <c:v>257663</c:v>
                </c:pt>
                <c:pt idx="331">
                  <c:v>261490</c:v>
                </c:pt>
                <c:pt idx="332">
                  <c:v>270697</c:v>
                </c:pt>
                <c:pt idx="333">
                  <c:v>281634</c:v>
                </c:pt>
                <c:pt idx="334">
                  <c:v>289508</c:v>
                </c:pt>
                <c:pt idx="335">
                  <c:v>290904</c:v>
                </c:pt>
                <c:pt idx="336">
                  <c:v>284343</c:v>
                </c:pt>
                <c:pt idx="337">
                  <c:v>275175</c:v>
                </c:pt>
                <c:pt idx="338">
                  <c:v>269914</c:v>
                </c:pt>
                <c:pt idx="339">
                  <c:v>266523</c:v>
                </c:pt>
                <c:pt idx="340">
                  <c:v>264082</c:v>
                </c:pt>
                <c:pt idx="341">
                  <c:v>264954</c:v>
                </c:pt>
                <c:pt idx="342">
                  <c:v>267305</c:v>
                </c:pt>
                <c:pt idx="343">
                  <c:v>267491</c:v>
                </c:pt>
                <c:pt idx="344">
                  <c:v>269508</c:v>
                </c:pt>
                <c:pt idx="345">
                  <c:v>276618</c:v>
                </c:pt>
                <c:pt idx="346">
                  <c:v>278462</c:v>
                </c:pt>
                <c:pt idx="347">
                  <c:v>264313</c:v>
                </c:pt>
                <c:pt idx="348">
                  <c:v>233408</c:v>
                </c:pt>
                <c:pt idx="349">
                  <c:v>203432</c:v>
                </c:pt>
                <c:pt idx="350">
                  <c:v>179647</c:v>
                </c:pt>
                <c:pt idx="351">
                  <c:v>165490</c:v>
                </c:pt>
                <c:pt idx="352">
                  <c:v>168655</c:v>
                </c:pt>
                <c:pt idx="353">
                  <c:v>184998</c:v>
                </c:pt>
                <c:pt idx="354">
                  <c:v>200112</c:v>
                </c:pt>
                <c:pt idx="355">
                  <c:v>200260</c:v>
                </c:pt>
                <c:pt idx="356">
                  <c:v>183684</c:v>
                </c:pt>
                <c:pt idx="357">
                  <c:v>159188</c:v>
                </c:pt>
                <c:pt idx="358">
                  <c:v>138233</c:v>
                </c:pt>
                <c:pt idx="359">
                  <c:v>126878</c:v>
                </c:pt>
                <c:pt idx="360">
                  <c:v>123903</c:v>
                </c:pt>
                <c:pt idx="361">
                  <c:v>125660</c:v>
                </c:pt>
                <c:pt idx="362">
                  <c:v>125619</c:v>
                </c:pt>
                <c:pt idx="363">
                  <c:v>123433</c:v>
                </c:pt>
                <c:pt idx="364">
                  <c:v>123625</c:v>
                </c:pt>
                <c:pt idx="365">
                  <c:v>124000</c:v>
                </c:pt>
                <c:pt idx="366">
                  <c:v>122209</c:v>
                </c:pt>
                <c:pt idx="367">
                  <c:v>115155</c:v>
                </c:pt>
                <c:pt idx="368">
                  <c:v>105651</c:v>
                </c:pt>
                <c:pt idx="369">
                  <c:v>97764.6</c:v>
                </c:pt>
                <c:pt idx="370">
                  <c:v>93388</c:v>
                </c:pt>
                <c:pt idx="371">
                  <c:v>88564.3</c:v>
                </c:pt>
                <c:pt idx="372">
                  <c:v>84479.9</c:v>
                </c:pt>
                <c:pt idx="373">
                  <c:v>85573.8</c:v>
                </c:pt>
                <c:pt idx="374">
                  <c:v>87761.5</c:v>
                </c:pt>
                <c:pt idx="375">
                  <c:v>90131.3</c:v>
                </c:pt>
                <c:pt idx="376">
                  <c:v>92725.8</c:v>
                </c:pt>
                <c:pt idx="377">
                  <c:v>98864</c:v>
                </c:pt>
                <c:pt idx="378">
                  <c:v>106239</c:v>
                </c:pt>
                <c:pt idx="379">
                  <c:v>113640</c:v>
                </c:pt>
                <c:pt idx="380">
                  <c:v>118476</c:v>
                </c:pt>
                <c:pt idx="381">
                  <c:v>118842</c:v>
                </c:pt>
                <c:pt idx="382">
                  <c:v>118702</c:v>
                </c:pt>
                <c:pt idx="383">
                  <c:v>119965</c:v>
                </c:pt>
                <c:pt idx="384">
                  <c:v>124160</c:v>
                </c:pt>
                <c:pt idx="385">
                  <c:v>134351</c:v>
                </c:pt>
                <c:pt idx="386">
                  <c:v>149793</c:v>
                </c:pt>
                <c:pt idx="387">
                  <c:v>166598</c:v>
                </c:pt>
                <c:pt idx="388">
                  <c:v>182736</c:v>
                </c:pt>
                <c:pt idx="389">
                  <c:v>199963</c:v>
                </c:pt>
                <c:pt idx="390">
                  <c:v>221511</c:v>
                </c:pt>
                <c:pt idx="391">
                  <c:v>244921</c:v>
                </c:pt>
                <c:pt idx="392">
                  <c:v>269626</c:v>
                </c:pt>
                <c:pt idx="393">
                  <c:v>295043</c:v>
                </c:pt>
                <c:pt idx="394">
                  <c:v>321764</c:v>
                </c:pt>
                <c:pt idx="395">
                  <c:v>347005</c:v>
                </c:pt>
                <c:pt idx="396">
                  <c:v>373911</c:v>
                </c:pt>
                <c:pt idx="397">
                  <c:v>402439</c:v>
                </c:pt>
                <c:pt idx="398">
                  <c:v>426868</c:v>
                </c:pt>
                <c:pt idx="399">
                  <c:v>444864</c:v>
                </c:pt>
                <c:pt idx="400">
                  <c:v>455490</c:v>
                </c:pt>
                <c:pt idx="401">
                  <c:v>460616</c:v>
                </c:pt>
                <c:pt idx="402">
                  <c:v>463754</c:v>
                </c:pt>
                <c:pt idx="403">
                  <c:v>465852</c:v>
                </c:pt>
                <c:pt idx="404">
                  <c:v>465498</c:v>
                </c:pt>
                <c:pt idx="405">
                  <c:v>463617</c:v>
                </c:pt>
                <c:pt idx="406">
                  <c:v>459334</c:v>
                </c:pt>
                <c:pt idx="407">
                  <c:v>447732</c:v>
                </c:pt>
                <c:pt idx="408">
                  <c:v>429176</c:v>
                </c:pt>
                <c:pt idx="409">
                  <c:v>406500</c:v>
                </c:pt>
                <c:pt idx="410">
                  <c:v>381214</c:v>
                </c:pt>
                <c:pt idx="411">
                  <c:v>354805</c:v>
                </c:pt>
                <c:pt idx="412">
                  <c:v>328813</c:v>
                </c:pt>
                <c:pt idx="413">
                  <c:v>305320</c:v>
                </c:pt>
                <c:pt idx="414">
                  <c:v>284031</c:v>
                </c:pt>
                <c:pt idx="415">
                  <c:v>262887</c:v>
                </c:pt>
                <c:pt idx="416">
                  <c:v>240260</c:v>
                </c:pt>
                <c:pt idx="417">
                  <c:v>215584</c:v>
                </c:pt>
                <c:pt idx="418">
                  <c:v>188163</c:v>
                </c:pt>
                <c:pt idx="419">
                  <c:v>160386</c:v>
                </c:pt>
                <c:pt idx="420">
                  <c:v>137999</c:v>
                </c:pt>
                <c:pt idx="421">
                  <c:v>120904</c:v>
                </c:pt>
                <c:pt idx="422">
                  <c:v>107707</c:v>
                </c:pt>
                <c:pt idx="423">
                  <c:v>95080.7</c:v>
                </c:pt>
                <c:pt idx="424">
                  <c:v>82549.7</c:v>
                </c:pt>
                <c:pt idx="425">
                  <c:v>71321.5</c:v>
                </c:pt>
                <c:pt idx="426">
                  <c:v>67322.2</c:v>
                </c:pt>
                <c:pt idx="427">
                  <c:v>67154</c:v>
                </c:pt>
                <c:pt idx="428">
                  <c:v>68117.2</c:v>
                </c:pt>
                <c:pt idx="429">
                  <c:v>67882.8</c:v>
                </c:pt>
                <c:pt idx="430">
                  <c:v>68345.8</c:v>
                </c:pt>
                <c:pt idx="431">
                  <c:v>67894.899999999994</c:v>
                </c:pt>
                <c:pt idx="432">
                  <c:v>61197.7</c:v>
                </c:pt>
                <c:pt idx="433">
                  <c:v>47688.9</c:v>
                </c:pt>
                <c:pt idx="434">
                  <c:v>31666.3</c:v>
                </c:pt>
                <c:pt idx="435">
                  <c:v>21190.400000000001</c:v>
                </c:pt>
                <c:pt idx="436">
                  <c:v>18087.8</c:v>
                </c:pt>
                <c:pt idx="437">
                  <c:v>19569.099999999999</c:v>
                </c:pt>
                <c:pt idx="438">
                  <c:v>21526.6</c:v>
                </c:pt>
                <c:pt idx="439">
                  <c:v>25340.6</c:v>
                </c:pt>
                <c:pt idx="440">
                  <c:v>34214.6</c:v>
                </c:pt>
                <c:pt idx="441">
                  <c:v>43906.400000000001</c:v>
                </c:pt>
                <c:pt idx="442">
                  <c:v>48660.4</c:v>
                </c:pt>
                <c:pt idx="443">
                  <c:v>48103</c:v>
                </c:pt>
                <c:pt idx="444">
                  <c:v>43225.8</c:v>
                </c:pt>
                <c:pt idx="445">
                  <c:v>35721.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9C31-4A1B-9DD8-F246F11BD6D0}"/>
            </c:ext>
          </c:extLst>
        </c:ser>
        <c:ser>
          <c:idx val="1"/>
          <c:order val="1"/>
          <c:tx>
            <c:strRef>
              <c:f>Sheet1!$D$3</c:f>
              <c:strCache>
                <c:ptCount val="1"/>
                <c:pt idx="0">
                  <c:v>central (necrosis)</c:v>
                </c:pt>
              </c:strCache>
            </c:strRef>
          </c:tx>
          <c:spPr>
            <a:ln w="19050" cap="rnd">
              <a:solidFill>
                <a:srgbClr val="C0504D"/>
              </a:solidFill>
              <a:round/>
            </a:ln>
            <a:effectLst/>
          </c:spPr>
          <c:marker>
            <c:symbol val="none"/>
          </c:marker>
          <c:cat>
            <c:numRef>
              <c:f>Sheet1!$A$4:$A$449</c:f>
              <c:numCache>
                <c:formatCode>0.00_ </c:formatCode>
                <c:ptCount val="446"/>
                <c:pt idx="0">
                  <c:v>4</c:v>
                </c:pt>
                <c:pt idx="1">
                  <c:v>3.992356</c:v>
                </c:pt>
                <c:pt idx="2">
                  <c:v>3.9847109999999999</c:v>
                </c:pt>
                <c:pt idx="3">
                  <c:v>3.9770669999999999</c:v>
                </c:pt>
                <c:pt idx="4">
                  <c:v>3.9694219999999998</c:v>
                </c:pt>
                <c:pt idx="5">
                  <c:v>3.9617779999999998</c:v>
                </c:pt>
                <c:pt idx="6">
                  <c:v>3.9541339999999998</c:v>
                </c:pt>
                <c:pt idx="7">
                  <c:v>3.9464890000000001</c:v>
                </c:pt>
                <c:pt idx="8">
                  <c:v>3.9388450000000002</c:v>
                </c:pt>
                <c:pt idx="9">
                  <c:v>3.9312</c:v>
                </c:pt>
                <c:pt idx="10">
                  <c:v>3.923556</c:v>
                </c:pt>
                <c:pt idx="11">
                  <c:v>3.9159109999999999</c:v>
                </c:pt>
                <c:pt idx="12">
                  <c:v>3.9082669999999999</c:v>
                </c:pt>
                <c:pt idx="13">
                  <c:v>3.900623</c:v>
                </c:pt>
                <c:pt idx="14">
                  <c:v>3.8929779999999998</c:v>
                </c:pt>
                <c:pt idx="15">
                  <c:v>3.8853339999999998</c:v>
                </c:pt>
                <c:pt idx="16">
                  <c:v>3.8776890000000002</c:v>
                </c:pt>
                <c:pt idx="17">
                  <c:v>3.8700450000000002</c:v>
                </c:pt>
                <c:pt idx="18">
                  <c:v>3.8624010000000002</c:v>
                </c:pt>
                <c:pt idx="19">
                  <c:v>3.8547560000000001</c:v>
                </c:pt>
                <c:pt idx="20">
                  <c:v>3.8471120000000001</c:v>
                </c:pt>
                <c:pt idx="21">
                  <c:v>3.839467</c:v>
                </c:pt>
                <c:pt idx="22">
                  <c:v>3.831823</c:v>
                </c:pt>
                <c:pt idx="23">
                  <c:v>3.8241779999999999</c:v>
                </c:pt>
                <c:pt idx="24">
                  <c:v>3.8165339999999999</c:v>
                </c:pt>
                <c:pt idx="25">
                  <c:v>3.8088899999999999</c:v>
                </c:pt>
                <c:pt idx="26">
                  <c:v>3.8012450000000002</c:v>
                </c:pt>
                <c:pt idx="27">
                  <c:v>3.7936009999999998</c:v>
                </c:pt>
                <c:pt idx="28">
                  <c:v>3.7859560000000001</c:v>
                </c:pt>
                <c:pt idx="29">
                  <c:v>3.7783120000000001</c:v>
                </c:pt>
                <c:pt idx="30">
                  <c:v>3.7706680000000001</c:v>
                </c:pt>
                <c:pt idx="31">
                  <c:v>3.763023</c:v>
                </c:pt>
                <c:pt idx="32">
                  <c:v>3.755379</c:v>
                </c:pt>
                <c:pt idx="33">
                  <c:v>3.7477339999999999</c:v>
                </c:pt>
                <c:pt idx="34">
                  <c:v>3.7400899999999999</c:v>
                </c:pt>
                <c:pt idx="35">
                  <c:v>3.7324449999999998</c:v>
                </c:pt>
                <c:pt idx="36">
                  <c:v>3.7248009999999998</c:v>
                </c:pt>
                <c:pt idx="37">
                  <c:v>3.7171569999999998</c:v>
                </c:pt>
                <c:pt idx="38">
                  <c:v>3.7095120000000001</c:v>
                </c:pt>
                <c:pt idx="39">
                  <c:v>3.7018680000000002</c:v>
                </c:pt>
                <c:pt idx="40">
                  <c:v>3.694223</c:v>
                </c:pt>
                <c:pt idx="41">
                  <c:v>3.6865790000000001</c:v>
                </c:pt>
                <c:pt idx="42">
                  <c:v>3.6789350000000001</c:v>
                </c:pt>
                <c:pt idx="43">
                  <c:v>3.6712899999999999</c:v>
                </c:pt>
                <c:pt idx="44">
                  <c:v>3.663646</c:v>
                </c:pt>
                <c:pt idx="45">
                  <c:v>3.6560009999999998</c:v>
                </c:pt>
                <c:pt idx="46">
                  <c:v>3.6483569999999999</c:v>
                </c:pt>
                <c:pt idx="47">
                  <c:v>3.6407120000000002</c:v>
                </c:pt>
                <c:pt idx="48">
                  <c:v>3.6330680000000002</c:v>
                </c:pt>
                <c:pt idx="49">
                  <c:v>3.6254240000000002</c:v>
                </c:pt>
                <c:pt idx="50">
                  <c:v>3.6177790000000001</c:v>
                </c:pt>
                <c:pt idx="51">
                  <c:v>3.6101350000000001</c:v>
                </c:pt>
                <c:pt idx="52">
                  <c:v>3.60249</c:v>
                </c:pt>
                <c:pt idx="53">
                  <c:v>3.594846</c:v>
                </c:pt>
                <c:pt idx="54">
                  <c:v>3.587202</c:v>
                </c:pt>
                <c:pt idx="55">
                  <c:v>3.5795569999999999</c:v>
                </c:pt>
                <c:pt idx="56">
                  <c:v>3.5719129999999999</c:v>
                </c:pt>
                <c:pt idx="57">
                  <c:v>3.5642680000000002</c:v>
                </c:pt>
                <c:pt idx="58">
                  <c:v>3.5566239999999998</c:v>
                </c:pt>
                <c:pt idx="59">
                  <c:v>3.5489799999999998</c:v>
                </c:pt>
                <c:pt idx="60">
                  <c:v>3.5413350000000001</c:v>
                </c:pt>
                <c:pt idx="61">
                  <c:v>3.5336910000000001</c:v>
                </c:pt>
                <c:pt idx="62">
                  <c:v>3.526046</c:v>
                </c:pt>
                <c:pt idx="63">
                  <c:v>3.518402</c:v>
                </c:pt>
                <c:pt idx="64">
                  <c:v>3.5107569999999999</c:v>
                </c:pt>
                <c:pt idx="65">
                  <c:v>3.5031129999999999</c:v>
                </c:pt>
                <c:pt idx="66">
                  <c:v>3.4954689999999999</c:v>
                </c:pt>
                <c:pt idx="67">
                  <c:v>3.4878239999999998</c:v>
                </c:pt>
                <c:pt idx="68">
                  <c:v>3.4801799999999998</c:v>
                </c:pt>
                <c:pt idx="69">
                  <c:v>3.4725350000000001</c:v>
                </c:pt>
                <c:pt idx="70">
                  <c:v>3.4648910000000002</c:v>
                </c:pt>
                <c:pt idx="71">
                  <c:v>3.4572470000000002</c:v>
                </c:pt>
                <c:pt idx="72">
                  <c:v>3.4496020000000001</c:v>
                </c:pt>
                <c:pt idx="73">
                  <c:v>3.4419580000000001</c:v>
                </c:pt>
                <c:pt idx="74">
                  <c:v>3.4343129999999999</c:v>
                </c:pt>
                <c:pt idx="75">
                  <c:v>3.426669</c:v>
                </c:pt>
                <c:pt idx="76">
                  <c:v>3.4190239999999998</c:v>
                </c:pt>
                <c:pt idx="77">
                  <c:v>3.4113799999999999</c:v>
                </c:pt>
                <c:pt idx="78">
                  <c:v>3.4037359999999999</c:v>
                </c:pt>
                <c:pt idx="79">
                  <c:v>3.3960910000000002</c:v>
                </c:pt>
                <c:pt idx="80">
                  <c:v>3.3884470000000002</c:v>
                </c:pt>
                <c:pt idx="81">
                  <c:v>3.3808020000000001</c:v>
                </c:pt>
                <c:pt idx="82">
                  <c:v>3.3731580000000001</c:v>
                </c:pt>
                <c:pt idx="83">
                  <c:v>3.3655140000000001</c:v>
                </c:pt>
                <c:pt idx="84">
                  <c:v>3.357869</c:v>
                </c:pt>
                <c:pt idx="85">
                  <c:v>3.350225</c:v>
                </c:pt>
                <c:pt idx="86">
                  <c:v>3.3425799999999999</c:v>
                </c:pt>
                <c:pt idx="87">
                  <c:v>3.3349359999999999</c:v>
                </c:pt>
                <c:pt idx="88">
                  <c:v>3.3272910000000002</c:v>
                </c:pt>
                <c:pt idx="89">
                  <c:v>3.3196469999999998</c:v>
                </c:pt>
                <c:pt idx="90">
                  <c:v>3.3120029999999998</c:v>
                </c:pt>
                <c:pt idx="91">
                  <c:v>3.3043580000000001</c:v>
                </c:pt>
                <c:pt idx="92">
                  <c:v>3.2967140000000001</c:v>
                </c:pt>
                <c:pt idx="93">
                  <c:v>3.289069</c:v>
                </c:pt>
                <c:pt idx="94">
                  <c:v>3.281425</c:v>
                </c:pt>
                <c:pt idx="95">
                  <c:v>3.2737810000000001</c:v>
                </c:pt>
                <c:pt idx="96">
                  <c:v>3.2661359999999999</c:v>
                </c:pt>
                <c:pt idx="97">
                  <c:v>3.2584919999999999</c:v>
                </c:pt>
                <c:pt idx="98">
                  <c:v>3.2508469999999998</c:v>
                </c:pt>
                <c:pt idx="99">
                  <c:v>3.2432029999999998</c:v>
                </c:pt>
                <c:pt idx="100">
                  <c:v>3.2355589999999999</c:v>
                </c:pt>
                <c:pt idx="101">
                  <c:v>3.2279140000000002</c:v>
                </c:pt>
                <c:pt idx="102">
                  <c:v>3.2202700000000002</c:v>
                </c:pt>
                <c:pt idx="103">
                  <c:v>3.2126250000000001</c:v>
                </c:pt>
                <c:pt idx="104">
                  <c:v>3.2049810000000001</c:v>
                </c:pt>
                <c:pt idx="105">
                  <c:v>3.197336</c:v>
                </c:pt>
                <c:pt idx="106">
                  <c:v>3.189692</c:v>
                </c:pt>
                <c:pt idx="107">
                  <c:v>3.182048</c:v>
                </c:pt>
                <c:pt idx="108">
                  <c:v>3.1744029999999999</c:v>
                </c:pt>
                <c:pt idx="109">
                  <c:v>3.1667589999999999</c:v>
                </c:pt>
                <c:pt idx="110">
                  <c:v>3.1591140000000002</c:v>
                </c:pt>
                <c:pt idx="111">
                  <c:v>3.1514700000000002</c:v>
                </c:pt>
                <c:pt idx="112">
                  <c:v>3.1438259999999998</c:v>
                </c:pt>
                <c:pt idx="113">
                  <c:v>3.1361810000000001</c:v>
                </c:pt>
                <c:pt idx="114">
                  <c:v>3.1285370000000001</c:v>
                </c:pt>
                <c:pt idx="115">
                  <c:v>3.120892</c:v>
                </c:pt>
                <c:pt idx="116">
                  <c:v>3.113248</c:v>
                </c:pt>
                <c:pt idx="117">
                  <c:v>3.1056029999999999</c:v>
                </c:pt>
                <c:pt idx="118">
                  <c:v>3.0979589999999999</c:v>
                </c:pt>
                <c:pt idx="119">
                  <c:v>3.0903149999999999</c:v>
                </c:pt>
                <c:pt idx="120">
                  <c:v>3.0826699999999998</c:v>
                </c:pt>
                <c:pt idx="121">
                  <c:v>3.0750259999999998</c:v>
                </c:pt>
                <c:pt idx="122">
                  <c:v>3.0673810000000001</c:v>
                </c:pt>
                <c:pt idx="123">
                  <c:v>3.0597370000000002</c:v>
                </c:pt>
                <c:pt idx="124">
                  <c:v>3.0520930000000002</c:v>
                </c:pt>
                <c:pt idx="125">
                  <c:v>3.044448</c:v>
                </c:pt>
                <c:pt idx="126">
                  <c:v>3.0368040000000001</c:v>
                </c:pt>
                <c:pt idx="127">
                  <c:v>3.0291589999999999</c:v>
                </c:pt>
                <c:pt idx="128">
                  <c:v>3.021515</c:v>
                </c:pt>
                <c:pt idx="129">
                  <c:v>3.0138699999999998</c:v>
                </c:pt>
                <c:pt idx="130">
                  <c:v>3.0062259999999998</c:v>
                </c:pt>
                <c:pt idx="131">
                  <c:v>2.9985819999999999</c:v>
                </c:pt>
                <c:pt idx="132">
                  <c:v>2.9909370000000002</c:v>
                </c:pt>
                <c:pt idx="133">
                  <c:v>2.9832930000000002</c:v>
                </c:pt>
                <c:pt idx="134">
                  <c:v>2.9756480000000001</c:v>
                </c:pt>
                <c:pt idx="135">
                  <c:v>2.9680040000000001</c:v>
                </c:pt>
                <c:pt idx="136">
                  <c:v>2.9603600000000001</c:v>
                </c:pt>
                <c:pt idx="137">
                  <c:v>2.952715</c:v>
                </c:pt>
                <c:pt idx="138">
                  <c:v>2.945071</c:v>
                </c:pt>
                <c:pt idx="139">
                  <c:v>2.9374259999999999</c:v>
                </c:pt>
                <c:pt idx="140">
                  <c:v>2.9297819999999999</c:v>
                </c:pt>
                <c:pt idx="141">
                  <c:v>2.9221370000000002</c:v>
                </c:pt>
                <c:pt idx="142">
                  <c:v>2.9144929999999998</c:v>
                </c:pt>
                <c:pt idx="143">
                  <c:v>2.9068489999999998</c:v>
                </c:pt>
                <c:pt idx="144">
                  <c:v>2.8992040000000001</c:v>
                </c:pt>
                <c:pt idx="145">
                  <c:v>2.8915600000000001</c:v>
                </c:pt>
                <c:pt idx="146">
                  <c:v>2.883915</c:v>
                </c:pt>
                <c:pt idx="147">
                  <c:v>2.876271</c:v>
                </c:pt>
                <c:pt idx="148">
                  <c:v>2.868627</c:v>
                </c:pt>
                <c:pt idx="149">
                  <c:v>2.8609819999999999</c:v>
                </c:pt>
                <c:pt idx="150">
                  <c:v>2.8533379999999999</c:v>
                </c:pt>
                <c:pt idx="151">
                  <c:v>2.8456929999999998</c:v>
                </c:pt>
                <c:pt idx="152">
                  <c:v>2.8380489999999998</c:v>
                </c:pt>
                <c:pt idx="153">
                  <c:v>2.8304049999999998</c:v>
                </c:pt>
                <c:pt idx="154">
                  <c:v>2.8227600000000002</c:v>
                </c:pt>
                <c:pt idx="155">
                  <c:v>2.8151160000000002</c:v>
                </c:pt>
                <c:pt idx="156">
                  <c:v>2.807471</c:v>
                </c:pt>
                <c:pt idx="157">
                  <c:v>2.7998270000000001</c:v>
                </c:pt>
                <c:pt idx="158">
                  <c:v>2.7921819999999999</c:v>
                </c:pt>
                <c:pt idx="159">
                  <c:v>2.784538</c:v>
                </c:pt>
                <c:pt idx="160">
                  <c:v>2.776894</c:v>
                </c:pt>
                <c:pt idx="161">
                  <c:v>2.7692489999999998</c:v>
                </c:pt>
                <c:pt idx="162">
                  <c:v>2.7616049999999999</c:v>
                </c:pt>
                <c:pt idx="163">
                  <c:v>2.7539600000000002</c:v>
                </c:pt>
                <c:pt idx="164">
                  <c:v>2.7463160000000002</c:v>
                </c:pt>
                <c:pt idx="165">
                  <c:v>2.7386720000000002</c:v>
                </c:pt>
                <c:pt idx="166">
                  <c:v>2.7310270000000001</c:v>
                </c:pt>
                <c:pt idx="167">
                  <c:v>2.7233830000000001</c:v>
                </c:pt>
                <c:pt idx="168">
                  <c:v>2.715738</c:v>
                </c:pt>
                <c:pt idx="169">
                  <c:v>2.708094</c:v>
                </c:pt>
                <c:pt idx="170">
                  <c:v>2.7004489999999999</c:v>
                </c:pt>
                <c:pt idx="171">
                  <c:v>2.6928049999999999</c:v>
                </c:pt>
                <c:pt idx="172">
                  <c:v>2.6851609999999999</c:v>
                </c:pt>
                <c:pt idx="173">
                  <c:v>2.6775159999999998</c:v>
                </c:pt>
                <c:pt idx="174">
                  <c:v>2.6698719999999998</c:v>
                </c:pt>
                <c:pt idx="175">
                  <c:v>2.6622270000000001</c:v>
                </c:pt>
                <c:pt idx="176">
                  <c:v>2.6545830000000001</c:v>
                </c:pt>
                <c:pt idx="177">
                  <c:v>2.6469390000000002</c:v>
                </c:pt>
                <c:pt idx="178">
                  <c:v>2.639294</c:v>
                </c:pt>
                <c:pt idx="179">
                  <c:v>2.63165</c:v>
                </c:pt>
                <c:pt idx="180">
                  <c:v>2.6240049999999999</c:v>
                </c:pt>
                <c:pt idx="181">
                  <c:v>2.6163609999999999</c:v>
                </c:pt>
                <c:pt idx="182">
                  <c:v>2.6087159999999998</c:v>
                </c:pt>
                <c:pt idx="183">
                  <c:v>2.6010719999999998</c:v>
                </c:pt>
                <c:pt idx="184">
                  <c:v>2.5934279999999998</c:v>
                </c:pt>
                <c:pt idx="185">
                  <c:v>2.5857830000000002</c:v>
                </c:pt>
                <c:pt idx="186">
                  <c:v>2.5781390000000002</c:v>
                </c:pt>
                <c:pt idx="187">
                  <c:v>2.5704940000000001</c:v>
                </c:pt>
                <c:pt idx="188">
                  <c:v>2.5628500000000001</c:v>
                </c:pt>
                <c:pt idx="189">
                  <c:v>2.5552060000000001</c:v>
                </c:pt>
                <c:pt idx="190">
                  <c:v>2.547561</c:v>
                </c:pt>
                <c:pt idx="191">
                  <c:v>2.539917</c:v>
                </c:pt>
                <c:pt idx="192">
                  <c:v>2.5322719999999999</c:v>
                </c:pt>
                <c:pt idx="193">
                  <c:v>2.5246279999999999</c:v>
                </c:pt>
                <c:pt idx="194">
                  <c:v>2.5169839999999999</c:v>
                </c:pt>
                <c:pt idx="195">
                  <c:v>2.5093390000000002</c:v>
                </c:pt>
                <c:pt idx="196">
                  <c:v>2.5016949999999998</c:v>
                </c:pt>
                <c:pt idx="197">
                  <c:v>2.4940500000000001</c:v>
                </c:pt>
                <c:pt idx="198">
                  <c:v>2.4864060000000001</c:v>
                </c:pt>
                <c:pt idx="199">
                  <c:v>2.478761</c:v>
                </c:pt>
                <c:pt idx="200">
                  <c:v>2.471117</c:v>
                </c:pt>
                <c:pt idx="201">
                  <c:v>2.463473</c:v>
                </c:pt>
                <c:pt idx="202">
                  <c:v>2.4558279999999999</c:v>
                </c:pt>
                <c:pt idx="203">
                  <c:v>2.4481839999999999</c:v>
                </c:pt>
                <c:pt idx="204">
                  <c:v>2.4405389999999998</c:v>
                </c:pt>
                <c:pt idx="205">
                  <c:v>2.4328949999999998</c:v>
                </c:pt>
                <c:pt idx="206">
                  <c:v>2.4252509999999998</c:v>
                </c:pt>
                <c:pt idx="207">
                  <c:v>2.4176060000000001</c:v>
                </c:pt>
                <c:pt idx="208">
                  <c:v>2.4099620000000002</c:v>
                </c:pt>
                <c:pt idx="209">
                  <c:v>2.402317</c:v>
                </c:pt>
                <c:pt idx="210">
                  <c:v>2.3946730000000001</c:v>
                </c:pt>
                <c:pt idx="211">
                  <c:v>2.3870279999999999</c:v>
                </c:pt>
                <c:pt idx="212">
                  <c:v>2.3793839999999999</c:v>
                </c:pt>
                <c:pt idx="213">
                  <c:v>2.37174</c:v>
                </c:pt>
                <c:pt idx="214">
                  <c:v>2.3640949999999998</c:v>
                </c:pt>
                <c:pt idx="215">
                  <c:v>2.3564509999999999</c:v>
                </c:pt>
                <c:pt idx="216">
                  <c:v>2.3488060000000002</c:v>
                </c:pt>
                <c:pt idx="217">
                  <c:v>2.3411620000000002</c:v>
                </c:pt>
                <c:pt idx="218">
                  <c:v>2.3335180000000002</c:v>
                </c:pt>
                <c:pt idx="219">
                  <c:v>2.3258730000000001</c:v>
                </c:pt>
                <c:pt idx="220">
                  <c:v>2.3182290000000001</c:v>
                </c:pt>
                <c:pt idx="221">
                  <c:v>2.310584</c:v>
                </c:pt>
                <c:pt idx="222">
                  <c:v>2.30294</c:v>
                </c:pt>
                <c:pt idx="223">
                  <c:v>2.2952949999999999</c:v>
                </c:pt>
                <c:pt idx="224">
                  <c:v>2.2876509999999999</c:v>
                </c:pt>
                <c:pt idx="225">
                  <c:v>2.2800069999999999</c:v>
                </c:pt>
                <c:pt idx="226">
                  <c:v>2.2723620000000002</c:v>
                </c:pt>
                <c:pt idx="227">
                  <c:v>2.2647179999999998</c:v>
                </c:pt>
                <c:pt idx="228">
                  <c:v>2.2570730000000001</c:v>
                </c:pt>
                <c:pt idx="229">
                  <c:v>2.2494290000000001</c:v>
                </c:pt>
                <c:pt idx="230">
                  <c:v>2.2417850000000001</c:v>
                </c:pt>
                <c:pt idx="231">
                  <c:v>2.23414</c:v>
                </c:pt>
                <c:pt idx="232">
                  <c:v>2.226496</c:v>
                </c:pt>
                <c:pt idx="233">
                  <c:v>2.2188509999999999</c:v>
                </c:pt>
                <c:pt idx="234">
                  <c:v>2.2112069999999999</c:v>
                </c:pt>
                <c:pt idx="235">
                  <c:v>2.2035619999999998</c:v>
                </c:pt>
                <c:pt idx="236">
                  <c:v>2.1959179999999998</c:v>
                </c:pt>
                <c:pt idx="237">
                  <c:v>2.1882739999999998</c:v>
                </c:pt>
                <c:pt idx="238">
                  <c:v>2.1806290000000002</c:v>
                </c:pt>
                <c:pt idx="239">
                  <c:v>2.1729850000000002</c:v>
                </c:pt>
                <c:pt idx="240">
                  <c:v>2.16534</c:v>
                </c:pt>
                <c:pt idx="241">
                  <c:v>2.1576960000000001</c:v>
                </c:pt>
                <c:pt idx="242">
                  <c:v>2.1500520000000001</c:v>
                </c:pt>
                <c:pt idx="243">
                  <c:v>2.142407</c:v>
                </c:pt>
                <c:pt idx="244">
                  <c:v>2.134763</c:v>
                </c:pt>
                <c:pt idx="245">
                  <c:v>2.1271179999999998</c:v>
                </c:pt>
                <c:pt idx="246">
                  <c:v>2.1194739999999999</c:v>
                </c:pt>
                <c:pt idx="247">
                  <c:v>2.1118299999999999</c:v>
                </c:pt>
                <c:pt idx="248">
                  <c:v>2.1041850000000002</c:v>
                </c:pt>
                <c:pt idx="249">
                  <c:v>2.0965410000000002</c:v>
                </c:pt>
                <c:pt idx="250">
                  <c:v>2.0888960000000001</c:v>
                </c:pt>
                <c:pt idx="251">
                  <c:v>2.0812520000000001</c:v>
                </c:pt>
                <c:pt idx="252">
                  <c:v>2.073607</c:v>
                </c:pt>
                <c:pt idx="253">
                  <c:v>2.065963</c:v>
                </c:pt>
                <c:pt idx="254">
                  <c:v>2.058319</c:v>
                </c:pt>
                <c:pt idx="255">
                  <c:v>2.0506739999999999</c:v>
                </c:pt>
                <c:pt idx="256">
                  <c:v>2.0430299999999999</c:v>
                </c:pt>
                <c:pt idx="257">
                  <c:v>2.0353850000000002</c:v>
                </c:pt>
                <c:pt idx="258">
                  <c:v>2.0277409999999998</c:v>
                </c:pt>
                <c:pt idx="259">
                  <c:v>2.0200969999999998</c:v>
                </c:pt>
                <c:pt idx="260">
                  <c:v>2.0124520000000001</c:v>
                </c:pt>
                <c:pt idx="261">
                  <c:v>2.0048080000000001</c:v>
                </c:pt>
                <c:pt idx="262">
                  <c:v>1.997163</c:v>
                </c:pt>
                <c:pt idx="263">
                  <c:v>1.989519</c:v>
                </c:pt>
                <c:pt idx="264">
                  <c:v>1.9818750000000001</c:v>
                </c:pt>
                <c:pt idx="265">
                  <c:v>1.9742310000000001</c:v>
                </c:pt>
                <c:pt idx="266">
                  <c:v>1.9665859999999999</c:v>
                </c:pt>
                <c:pt idx="267">
                  <c:v>1.958942</c:v>
                </c:pt>
                <c:pt idx="268">
                  <c:v>1.951298</c:v>
                </c:pt>
                <c:pt idx="269">
                  <c:v>1.9436530000000001</c:v>
                </c:pt>
                <c:pt idx="270">
                  <c:v>1.9360090000000001</c:v>
                </c:pt>
                <c:pt idx="271">
                  <c:v>1.9283650000000001</c:v>
                </c:pt>
                <c:pt idx="272">
                  <c:v>1.92072</c:v>
                </c:pt>
                <c:pt idx="273">
                  <c:v>1.913076</c:v>
                </c:pt>
                <c:pt idx="274">
                  <c:v>1.905432</c:v>
                </c:pt>
                <c:pt idx="275">
                  <c:v>1.897788</c:v>
                </c:pt>
                <c:pt idx="276">
                  <c:v>1.8901429999999999</c:v>
                </c:pt>
                <c:pt idx="277">
                  <c:v>1.8824989999999999</c:v>
                </c:pt>
                <c:pt idx="278">
                  <c:v>1.8748549999999999</c:v>
                </c:pt>
                <c:pt idx="279">
                  <c:v>1.86721</c:v>
                </c:pt>
                <c:pt idx="280">
                  <c:v>1.8595660000000001</c:v>
                </c:pt>
                <c:pt idx="281">
                  <c:v>1.8519220000000001</c:v>
                </c:pt>
                <c:pt idx="282">
                  <c:v>1.8442780000000001</c:v>
                </c:pt>
                <c:pt idx="283">
                  <c:v>1.836633</c:v>
                </c:pt>
                <c:pt idx="284">
                  <c:v>1.828989</c:v>
                </c:pt>
                <c:pt idx="285">
                  <c:v>1.821345</c:v>
                </c:pt>
                <c:pt idx="286">
                  <c:v>1.8137000000000001</c:v>
                </c:pt>
                <c:pt idx="287">
                  <c:v>1.8060560000000001</c:v>
                </c:pt>
                <c:pt idx="288">
                  <c:v>1.7984119999999999</c:v>
                </c:pt>
                <c:pt idx="289">
                  <c:v>1.790767</c:v>
                </c:pt>
                <c:pt idx="290">
                  <c:v>1.783123</c:v>
                </c:pt>
                <c:pt idx="291">
                  <c:v>1.775479</c:v>
                </c:pt>
                <c:pt idx="292">
                  <c:v>1.767835</c:v>
                </c:pt>
                <c:pt idx="293">
                  <c:v>1.7601899999999999</c:v>
                </c:pt>
                <c:pt idx="294">
                  <c:v>1.7525459999999999</c:v>
                </c:pt>
                <c:pt idx="295">
                  <c:v>1.744902</c:v>
                </c:pt>
                <c:pt idx="296">
                  <c:v>1.7372570000000001</c:v>
                </c:pt>
                <c:pt idx="297">
                  <c:v>1.7296130000000001</c:v>
                </c:pt>
                <c:pt idx="298">
                  <c:v>1.7219690000000001</c:v>
                </c:pt>
                <c:pt idx="299">
                  <c:v>1.714324</c:v>
                </c:pt>
                <c:pt idx="300">
                  <c:v>1.70668</c:v>
                </c:pt>
                <c:pt idx="301">
                  <c:v>1.699036</c:v>
                </c:pt>
                <c:pt idx="302">
                  <c:v>1.691392</c:v>
                </c:pt>
                <c:pt idx="303">
                  <c:v>1.6837470000000001</c:v>
                </c:pt>
                <c:pt idx="304">
                  <c:v>1.6761029999999999</c:v>
                </c:pt>
                <c:pt idx="305">
                  <c:v>1.6684589999999999</c:v>
                </c:pt>
                <c:pt idx="306">
                  <c:v>1.660814</c:v>
                </c:pt>
                <c:pt idx="307">
                  <c:v>1.65317</c:v>
                </c:pt>
                <c:pt idx="308">
                  <c:v>1.645526</c:v>
                </c:pt>
                <c:pt idx="309">
                  <c:v>1.6378820000000001</c:v>
                </c:pt>
                <c:pt idx="310">
                  <c:v>1.6302369999999999</c:v>
                </c:pt>
                <c:pt idx="311">
                  <c:v>1.622593</c:v>
                </c:pt>
                <c:pt idx="312">
                  <c:v>1.614949</c:v>
                </c:pt>
                <c:pt idx="313">
                  <c:v>1.6073040000000001</c:v>
                </c:pt>
                <c:pt idx="314">
                  <c:v>1.5996600000000001</c:v>
                </c:pt>
                <c:pt idx="315">
                  <c:v>1.5920160000000001</c:v>
                </c:pt>
                <c:pt idx="316">
                  <c:v>1.584371</c:v>
                </c:pt>
                <c:pt idx="317">
                  <c:v>1.576727</c:v>
                </c:pt>
                <c:pt idx="318">
                  <c:v>1.569083</c:v>
                </c:pt>
                <c:pt idx="319">
                  <c:v>1.561439</c:v>
                </c:pt>
                <c:pt idx="320">
                  <c:v>1.5537939999999999</c:v>
                </c:pt>
                <c:pt idx="321">
                  <c:v>1.5461499999999999</c:v>
                </c:pt>
                <c:pt idx="322">
                  <c:v>1.5385059999999999</c:v>
                </c:pt>
                <c:pt idx="323">
                  <c:v>1.530861</c:v>
                </c:pt>
                <c:pt idx="324">
                  <c:v>1.523217</c:v>
                </c:pt>
                <c:pt idx="325">
                  <c:v>1.5155730000000001</c:v>
                </c:pt>
                <c:pt idx="326">
                  <c:v>1.5079279999999999</c:v>
                </c:pt>
                <c:pt idx="327">
                  <c:v>1.500284</c:v>
                </c:pt>
                <c:pt idx="328">
                  <c:v>1.49264</c:v>
                </c:pt>
                <c:pt idx="329">
                  <c:v>1.484996</c:v>
                </c:pt>
                <c:pt idx="330">
                  <c:v>1.4773510000000001</c:v>
                </c:pt>
                <c:pt idx="331">
                  <c:v>1.4697070000000001</c:v>
                </c:pt>
                <c:pt idx="332">
                  <c:v>1.4620629999999999</c:v>
                </c:pt>
                <c:pt idx="333">
                  <c:v>1.454418</c:v>
                </c:pt>
                <c:pt idx="334">
                  <c:v>1.446774</c:v>
                </c:pt>
                <c:pt idx="335">
                  <c:v>1.43913</c:v>
                </c:pt>
                <c:pt idx="336">
                  <c:v>1.431486</c:v>
                </c:pt>
                <c:pt idx="337">
                  <c:v>1.4238409999999999</c:v>
                </c:pt>
                <c:pt idx="338">
                  <c:v>1.4161969999999999</c:v>
                </c:pt>
                <c:pt idx="339">
                  <c:v>1.4085529999999999</c:v>
                </c:pt>
                <c:pt idx="340">
                  <c:v>1.400908</c:v>
                </c:pt>
                <c:pt idx="341">
                  <c:v>1.3932640000000001</c:v>
                </c:pt>
                <c:pt idx="342">
                  <c:v>1.3856200000000001</c:v>
                </c:pt>
                <c:pt idx="343">
                  <c:v>1.3779749999999999</c:v>
                </c:pt>
                <c:pt idx="344">
                  <c:v>1.370331</c:v>
                </c:pt>
                <c:pt idx="345">
                  <c:v>1.362687</c:v>
                </c:pt>
                <c:pt idx="346">
                  <c:v>1.355043</c:v>
                </c:pt>
                <c:pt idx="347">
                  <c:v>1.3473980000000001</c:v>
                </c:pt>
                <c:pt idx="348">
                  <c:v>1.3397539999999999</c:v>
                </c:pt>
                <c:pt idx="349">
                  <c:v>1.3321099999999999</c:v>
                </c:pt>
                <c:pt idx="350">
                  <c:v>1.324465</c:v>
                </c:pt>
                <c:pt idx="351">
                  <c:v>1.316821</c:v>
                </c:pt>
                <c:pt idx="352">
                  <c:v>1.309177</c:v>
                </c:pt>
                <c:pt idx="353">
                  <c:v>1.3015330000000001</c:v>
                </c:pt>
                <c:pt idx="354">
                  <c:v>1.2938879999999999</c:v>
                </c:pt>
                <c:pt idx="355">
                  <c:v>1.2862439999999999</c:v>
                </c:pt>
                <c:pt idx="356">
                  <c:v>1.2786</c:v>
                </c:pt>
                <c:pt idx="357">
                  <c:v>1.2709550000000001</c:v>
                </c:pt>
                <c:pt idx="358">
                  <c:v>1.2633110000000001</c:v>
                </c:pt>
                <c:pt idx="359">
                  <c:v>1.2556670000000001</c:v>
                </c:pt>
                <c:pt idx="360">
                  <c:v>1.248022</c:v>
                </c:pt>
                <c:pt idx="361">
                  <c:v>1.240378</c:v>
                </c:pt>
                <c:pt idx="362">
                  <c:v>1.232734</c:v>
                </c:pt>
                <c:pt idx="363">
                  <c:v>1.22509</c:v>
                </c:pt>
                <c:pt idx="364">
                  <c:v>1.2174450000000001</c:v>
                </c:pt>
                <c:pt idx="365">
                  <c:v>1.2098009999999999</c:v>
                </c:pt>
                <c:pt idx="366">
                  <c:v>1.2021569999999999</c:v>
                </c:pt>
                <c:pt idx="367">
                  <c:v>1.194512</c:v>
                </c:pt>
                <c:pt idx="368">
                  <c:v>1.186868</c:v>
                </c:pt>
                <c:pt idx="369">
                  <c:v>1.179224</c:v>
                </c:pt>
                <c:pt idx="370">
                  <c:v>1.1715789999999999</c:v>
                </c:pt>
                <c:pt idx="371">
                  <c:v>1.1639349999999999</c:v>
                </c:pt>
                <c:pt idx="372">
                  <c:v>1.156291</c:v>
                </c:pt>
                <c:pt idx="373">
                  <c:v>1.148647</c:v>
                </c:pt>
                <c:pt idx="374">
                  <c:v>1.1410020000000001</c:v>
                </c:pt>
                <c:pt idx="375">
                  <c:v>1.1333580000000001</c:v>
                </c:pt>
                <c:pt idx="376">
                  <c:v>1.1257140000000001</c:v>
                </c:pt>
                <c:pt idx="377">
                  <c:v>1.118069</c:v>
                </c:pt>
                <c:pt idx="378">
                  <c:v>1.110425</c:v>
                </c:pt>
                <c:pt idx="379">
                  <c:v>1.102781</c:v>
                </c:pt>
                <c:pt idx="380">
                  <c:v>1.095137</c:v>
                </c:pt>
                <c:pt idx="381">
                  <c:v>1.0874919999999999</c:v>
                </c:pt>
                <c:pt idx="382">
                  <c:v>1.0798479999999999</c:v>
                </c:pt>
                <c:pt idx="383">
                  <c:v>1.0722039999999999</c:v>
                </c:pt>
                <c:pt idx="384">
                  <c:v>1.064559</c:v>
                </c:pt>
                <c:pt idx="385">
                  <c:v>1.056915</c:v>
                </c:pt>
                <c:pt idx="386">
                  <c:v>1.0492710000000001</c:v>
                </c:pt>
                <c:pt idx="387">
                  <c:v>1.0416259999999999</c:v>
                </c:pt>
                <c:pt idx="388">
                  <c:v>1.033982</c:v>
                </c:pt>
                <c:pt idx="389">
                  <c:v>1.026338</c:v>
                </c:pt>
                <c:pt idx="390">
                  <c:v>1.018694</c:v>
                </c:pt>
                <c:pt idx="391">
                  <c:v>1.0110490000000001</c:v>
                </c:pt>
                <c:pt idx="392">
                  <c:v>1.0034050000000001</c:v>
                </c:pt>
                <c:pt idx="393">
                  <c:v>0.99576100000000001</c:v>
                </c:pt>
                <c:pt idx="394">
                  <c:v>0.98811599999999999</c:v>
                </c:pt>
                <c:pt idx="395">
                  <c:v>0.98047200000000001</c:v>
                </c:pt>
                <c:pt idx="396">
                  <c:v>0.97282800000000003</c:v>
                </c:pt>
                <c:pt idx="397">
                  <c:v>0.96518300000000001</c:v>
                </c:pt>
                <c:pt idx="398">
                  <c:v>0.95753900000000003</c:v>
                </c:pt>
                <c:pt idx="399">
                  <c:v>0.94989500000000004</c:v>
                </c:pt>
                <c:pt idx="400">
                  <c:v>0.94225099999999995</c:v>
                </c:pt>
                <c:pt idx="401">
                  <c:v>0.93460600000000005</c:v>
                </c:pt>
                <c:pt idx="402">
                  <c:v>0.92696199999999995</c:v>
                </c:pt>
                <c:pt idx="403">
                  <c:v>0.91931799999999997</c:v>
                </c:pt>
                <c:pt idx="404">
                  <c:v>0.91167299999999996</c:v>
                </c:pt>
                <c:pt idx="405">
                  <c:v>0.90402899999999997</c:v>
                </c:pt>
                <c:pt idx="406">
                  <c:v>0.89638499999999999</c:v>
                </c:pt>
                <c:pt idx="407">
                  <c:v>0.888741</c:v>
                </c:pt>
                <c:pt idx="408">
                  <c:v>0.88109599999999999</c:v>
                </c:pt>
                <c:pt idx="409">
                  <c:v>0.87345200000000001</c:v>
                </c:pt>
                <c:pt idx="410">
                  <c:v>0.86580800000000002</c:v>
                </c:pt>
                <c:pt idx="411">
                  <c:v>0.85816300000000001</c:v>
                </c:pt>
                <c:pt idx="412">
                  <c:v>0.85051900000000002</c:v>
                </c:pt>
                <c:pt idx="413">
                  <c:v>0.84287500000000004</c:v>
                </c:pt>
                <c:pt idx="414">
                  <c:v>0.83523000000000003</c:v>
                </c:pt>
                <c:pt idx="415">
                  <c:v>0.82758600000000004</c:v>
                </c:pt>
                <c:pt idx="416">
                  <c:v>0.81994199999999995</c:v>
                </c:pt>
                <c:pt idx="417">
                  <c:v>0.81229799999999996</c:v>
                </c:pt>
                <c:pt idx="418">
                  <c:v>0.80465299999999995</c:v>
                </c:pt>
                <c:pt idx="419">
                  <c:v>0.79700899999999997</c:v>
                </c:pt>
                <c:pt idx="420">
                  <c:v>0.78936499999999998</c:v>
                </c:pt>
                <c:pt idx="421">
                  <c:v>0.78171999999999997</c:v>
                </c:pt>
                <c:pt idx="422">
                  <c:v>0.77407599999999999</c:v>
                </c:pt>
                <c:pt idx="423">
                  <c:v>0.766432</c:v>
                </c:pt>
                <c:pt idx="424">
                  <c:v>0.75878800000000002</c:v>
                </c:pt>
                <c:pt idx="425">
                  <c:v>0.75114300000000001</c:v>
                </c:pt>
                <c:pt idx="426">
                  <c:v>0.74349900000000002</c:v>
                </c:pt>
                <c:pt idx="427">
                  <c:v>0.73585500000000004</c:v>
                </c:pt>
                <c:pt idx="428">
                  <c:v>0.72821000000000002</c:v>
                </c:pt>
                <c:pt idx="429">
                  <c:v>0.72056600000000004</c:v>
                </c:pt>
                <c:pt idx="430">
                  <c:v>0.71292199999999994</c:v>
                </c:pt>
                <c:pt idx="431">
                  <c:v>0.70527700000000004</c:v>
                </c:pt>
                <c:pt idx="432">
                  <c:v>0.69763299999999995</c:v>
                </c:pt>
                <c:pt idx="433">
                  <c:v>0.68998899999999996</c:v>
                </c:pt>
                <c:pt idx="434">
                  <c:v>0.68234499999999998</c:v>
                </c:pt>
                <c:pt idx="435">
                  <c:v>0.67469999999999997</c:v>
                </c:pt>
                <c:pt idx="436">
                  <c:v>0.66705599999999998</c:v>
                </c:pt>
                <c:pt idx="437">
                  <c:v>0.659412</c:v>
                </c:pt>
                <c:pt idx="438">
                  <c:v>0.65176699999999999</c:v>
                </c:pt>
                <c:pt idx="439">
                  <c:v>0.644123</c:v>
                </c:pt>
                <c:pt idx="440">
                  <c:v>0.63647900000000002</c:v>
                </c:pt>
                <c:pt idx="441">
                  <c:v>0.628834</c:v>
                </c:pt>
                <c:pt idx="442">
                  <c:v>0.62119000000000002</c:v>
                </c:pt>
                <c:pt idx="443">
                  <c:v>0.61354600000000004</c:v>
                </c:pt>
                <c:pt idx="444">
                  <c:v>0.60590200000000005</c:v>
                </c:pt>
                <c:pt idx="445">
                  <c:v>0.59825700000000004</c:v>
                </c:pt>
              </c:numCache>
            </c:numRef>
          </c:cat>
          <c:val>
            <c:numRef>
              <c:f>Sheet1!$D$4:$D$449</c:f>
              <c:numCache>
                <c:formatCode>0.00E+00</c:formatCode>
                <c:ptCount val="446"/>
                <c:pt idx="0">
                  <c:v>314542</c:v>
                </c:pt>
                <c:pt idx="1">
                  <c:v>327883</c:v>
                </c:pt>
                <c:pt idx="2">
                  <c:v>368210</c:v>
                </c:pt>
                <c:pt idx="3">
                  <c:v>398489</c:v>
                </c:pt>
                <c:pt idx="4">
                  <c:v>461483</c:v>
                </c:pt>
                <c:pt idx="5">
                  <c:v>490117</c:v>
                </c:pt>
                <c:pt idx="6">
                  <c:v>544666</c:v>
                </c:pt>
                <c:pt idx="7">
                  <c:v>559442</c:v>
                </c:pt>
                <c:pt idx="8">
                  <c:v>577171</c:v>
                </c:pt>
                <c:pt idx="9">
                  <c:v>573530</c:v>
                </c:pt>
                <c:pt idx="10">
                  <c:v>556533</c:v>
                </c:pt>
                <c:pt idx="11">
                  <c:v>537257</c:v>
                </c:pt>
                <c:pt idx="12">
                  <c:v>517463</c:v>
                </c:pt>
                <c:pt idx="13">
                  <c:v>480995</c:v>
                </c:pt>
                <c:pt idx="14">
                  <c:v>477725</c:v>
                </c:pt>
                <c:pt idx="15">
                  <c:v>444448</c:v>
                </c:pt>
                <c:pt idx="16">
                  <c:v>457014</c:v>
                </c:pt>
                <c:pt idx="17">
                  <c:v>438322</c:v>
                </c:pt>
                <c:pt idx="18">
                  <c:v>460302</c:v>
                </c:pt>
                <c:pt idx="19">
                  <c:v>458352</c:v>
                </c:pt>
                <c:pt idx="20">
                  <c:v>494127</c:v>
                </c:pt>
                <c:pt idx="21">
                  <c:v>504058</c:v>
                </c:pt>
                <c:pt idx="22">
                  <c:v>551915</c:v>
                </c:pt>
                <c:pt idx="23">
                  <c:v>562007</c:v>
                </c:pt>
                <c:pt idx="24">
                  <c:v>608261</c:v>
                </c:pt>
                <c:pt idx="25">
                  <c:v>615242</c:v>
                </c:pt>
                <c:pt idx="26">
                  <c:v>646807</c:v>
                </c:pt>
                <c:pt idx="27">
                  <c:v>666825</c:v>
                </c:pt>
                <c:pt idx="28">
                  <c:v>672912</c:v>
                </c:pt>
                <c:pt idx="29">
                  <c:v>698783</c:v>
                </c:pt>
                <c:pt idx="30">
                  <c:v>663063</c:v>
                </c:pt>
                <c:pt idx="31">
                  <c:v>669554</c:v>
                </c:pt>
                <c:pt idx="32">
                  <c:v>606513</c:v>
                </c:pt>
                <c:pt idx="33">
                  <c:v>600094</c:v>
                </c:pt>
                <c:pt idx="34">
                  <c:v>536720</c:v>
                </c:pt>
                <c:pt idx="35">
                  <c:v>535450</c:v>
                </c:pt>
                <c:pt idx="36">
                  <c:v>484308</c:v>
                </c:pt>
                <c:pt idx="37">
                  <c:v>484348</c:v>
                </c:pt>
                <c:pt idx="38">
                  <c:v>444312</c:v>
                </c:pt>
                <c:pt idx="39">
                  <c:v>437775</c:v>
                </c:pt>
                <c:pt idx="40">
                  <c:v>411273</c:v>
                </c:pt>
                <c:pt idx="41">
                  <c:v>401565</c:v>
                </c:pt>
                <c:pt idx="42">
                  <c:v>393534</c:v>
                </c:pt>
                <c:pt idx="43">
                  <c:v>386728</c:v>
                </c:pt>
                <c:pt idx="44">
                  <c:v>396788</c:v>
                </c:pt>
                <c:pt idx="45">
                  <c:v>397003</c:v>
                </c:pt>
                <c:pt idx="46">
                  <c:v>411205</c:v>
                </c:pt>
                <c:pt idx="47">
                  <c:v>409193</c:v>
                </c:pt>
                <c:pt idx="48">
                  <c:v>413614</c:v>
                </c:pt>
                <c:pt idx="49">
                  <c:v>396003</c:v>
                </c:pt>
                <c:pt idx="50">
                  <c:v>392494</c:v>
                </c:pt>
                <c:pt idx="51">
                  <c:v>369576</c:v>
                </c:pt>
                <c:pt idx="52">
                  <c:v>369349</c:v>
                </c:pt>
                <c:pt idx="53">
                  <c:v>357044</c:v>
                </c:pt>
                <c:pt idx="54">
                  <c:v>365619</c:v>
                </c:pt>
                <c:pt idx="55">
                  <c:v>361922</c:v>
                </c:pt>
                <c:pt idx="56">
                  <c:v>368686</c:v>
                </c:pt>
                <c:pt idx="57">
                  <c:v>360415</c:v>
                </c:pt>
                <c:pt idx="58">
                  <c:v>349445</c:v>
                </c:pt>
                <c:pt idx="59">
                  <c:v>331308</c:v>
                </c:pt>
                <c:pt idx="60">
                  <c:v>301110</c:v>
                </c:pt>
                <c:pt idx="61">
                  <c:v>282480</c:v>
                </c:pt>
                <c:pt idx="62">
                  <c:v>246199</c:v>
                </c:pt>
                <c:pt idx="63">
                  <c:v>236954</c:v>
                </c:pt>
                <c:pt idx="64">
                  <c:v>203809</c:v>
                </c:pt>
                <c:pt idx="65">
                  <c:v>205479</c:v>
                </c:pt>
                <c:pt idx="66">
                  <c:v>175074</c:v>
                </c:pt>
                <c:pt idx="67">
                  <c:v>181190</c:v>
                </c:pt>
                <c:pt idx="68">
                  <c:v>151698</c:v>
                </c:pt>
                <c:pt idx="69">
                  <c:v>159765</c:v>
                </c:pt>
                <c:pt idx="70">
                  <c:v>133764</c:v>
                </c:pt>
                <c:pt idx="71">
                  <c:v>141732</c:v>
                </c:pt>
                <c:pt idx="72">
                  <c:v>123074</c:v>
                </c:pt>
                <c:pt idx="73">
                  <c:v>129832</c:v>
                </c:pt>
                <c:pt idx="74">
                  <c:v>120985</c:v>
                </c:pt>
                <c:pt idx="75">
                  <c:v>124688</c:v>
                </c:pt>
                <c:pt idx="76">
                  <c:v>122808</c:v>
                </c:pt>
                <c:pt idx="77">
                  <c:v>123515</c:v>
                </c:pt>
                <c:pt idx="78">
                  <c:v>124860</c:v>
                </c:pt>
                <c:pt idx="79">
                  <c:v>123699</c:v>
                </c:pt>
                <c:pt idx="80">
                  <c:v>127231</c:v>
                </c:pt>
                <c:pt idx="81">
                  <c:v>125776</c:v>
                </c:pt>
                <c:pt idx="82">
                  <c:v>131391</c:v>
                </c:pt>
                <c:pt idx="83">
                  <c:v>126612</c:v>
                </c:pt>
                <c:pt idx="84">
                  <c:v>126063</c:v>
                </c:pt>
                <c:pt idx="85">
                  <c:v>96220.6</c:v>
                </c:pt>
                <c:pt idx="86">
                  <c:v>94381.2</c:v>
                </c:pt>
                <c:pt idx="87">
                  <c:v>86738.8</c:v>
                </c:pt>
                <c:pt idx="88">
                  <c:v>94406.5</c:v>
                </c:pt>
                <c:pt idx="89">
                  <c:v>118037</c:v>
                </c:pt>
                <c:pt idx="90">
                  <c:v>141505</c:v>
                </c:pt>
                <c:pt idx="91">
                  <c:v>203664</c:v>
                </c:pt>
                <c:pt idx="92">
                  <c:v>243946</c:v>
                </c:pt>
                <c:pt idx="93">
                  <c:v>339867</c:v>
                </c:pt>
                <c:pt idx="94">
                  <c:v>390975</c:v>
                </c:pt>
                <c:pt idx="95">
                  <c:v>511286</c:v>
                </c:pt>
                <c:pt idx="96">
                  <c:v>566716</c:v>
                </c:pt>
                <c:pt idx="97">
                  <c:v>716006</c:v>
                </c:pt>
                <c:pt idx="98">
                  <c:v>779136</c:v>
                </c:pt>
                <c:pt idx="99">
                  <c:v>970140</c:v>
                </c:pt>
                <c:pt idx="100">
                  <c:v>1021360</c:v>
                </c:pt>
                <c:pt idx="101">
                  <c:v>1167450</c:v>
                </c:pt>
                <c:pt idx="102">
                  <c:v>1157920</c:v>
                </c:pt>
                <c:pt idx="103">
                  <c:v>1152410</c:v>
                </c:pt>
                <c:pt idx="104">
                  <c:v>1065630</c:v>
                </c:pt>
                <c:pt idx="105">
                  <c:v>934912</c:v>
                </c:pt>
                <c:pt idx="106">
                  <c:v>813650</c:v>
                </c:pt>
                <c:pt idx="107">
                  <c:v>667800</c:v>
                </c:pt>
                <c:pt idx="108">
                  <c:v>550461</c:v>
                </c:pt>
                <c:pt idx="109">
                  <c:v>442662</c:v>
                </c:pt>
                <c:pt idx="110">
                  <c:v>364232</c:v>
                </c:pt>
                <c:pt idx="111">
                  <c:v>297811</c:v>
                </c:pt>
                <c:pt idx="112">
                  <c:v>254280</c:v>
                </c:pt>
                <c:pt idx="113">
                  <c:v>205873</c:v>
                </c:pt>
                <c:pt idx="114">
                  <c:v>191789</c:v>
                </c:pt>
                <c:pt idx="115">
                  <c:v>165673</c:v>
                </c:pt>
                <c:pt idx="116">
                  <c:v>187222</c:v>
                </c:pt>
                <c:pt idx="117">
                  <c:v>195951</c:v>
                </c:pt>
                <c:pt idx="118">
                  <c:v>251677</c:v>
                </c:pt>
                <c:pt idx="119">
                  <c:v>289113</c:v>
                </c:pt>
                <c:pt idx="120">
                  <c:v>367684</c:v>
                </c:pt>
                <c:pt idx="121">
                  <c:v>404045</c:v>
                </c:pt>
                <c:pt idx="122">
                  <c:v>499339</c:v>
                </c:pt>
                <c:pt idx="123">
                  <c:v>525012</c:v>
                </c:pt>
                <c:pt idx="124">
                  <c:v>599473</c:v>
                </c:pt>
                <c:pt idx="125">
                  <c:v>596575</c:v>
                </c:pt>
                <c:pt idx="126">
                  <c:v>609839</c:v>
                </c:pt>
                <c:pt idx="127">
                  <c:v>584607</c:v>
                </c:pt>
                <c:pt idx="128">
                  <c:v>552282</c:v>
                </c:pt>
                <c:pt idx="129">
                  <c:v>523195</c:v>
                </c:pt>
                <c:pt idx="130">
                  <c:v>484172</c:v>
                </c:pt>
                <c:pt idx="131">
                  <c:v>459840</c:v>
                </c:pt>
                <c:pt idx="132">
                  <c:v>424703</c:v>
                </c:pt>
                <c:pt idx="133">
                  <c:v>404148</c:v>
                </c:pt>
                <c:pt idx="134">
                  <c:v>384212</c:v>
                </c:pt>
                <c:pt idx="135">
                  <c:v>370016</c:v>
                </c:pt>
                <c:pt idx="136">
                  <c:v>370743</c:v>
                </c:pt>
                <c:pt idx="137">
                  <c:v>360855</c:v>
                </c:pt>
                <c:pt idx="138">
                  <c:v>374370</c:v>
                </c:pt>
                <c:pt idx="139">
                  <c:v>361957</c:v>
                </c:pt>
                <c:pt idx="140">
                  <c:v>376406</c:v>
                </c:pt>
                <c:pt idx="141">
                  <c:v>359787</c:v>
                </c:pt>
                <c:pt idx="142">
                  <c:v>371043</c:v>
                </c:pt>
                <c:pt idx="143">
                  <c:v>354962</c:v>
                </c:pt>
                <c:pt idx="144">
                  <c:v>360340</c:v>
                </c:pt>
                <c:pt idx="145">
                  <c:v>349870</c:v>
                </c:pt>
                <c:pt idx="146">
                  <c:v>355885</c:v>
                </c:pt>
                <c:pt idx="147">
                  <c:v>354403</c:v>
                </c:pt>
                <c:pt idx="148">
                  <c:v>360222</c:v>
                </c:pt>
                <c:pt idx="149">
                  <c:v>364677</c:v>
                </c:pt>
                <c:pt idx="150">
                  <c:v>367238</c:v>
                </c:pt>
                <c:pt idx="151">
                  <c:v>373261</c:v>
                </c:pt>
                <c:pt idx="152">
                  <c:v>372836</c:v>
                </c:pt>
                <c:pt idx="153">
                  <c:v>377767</c:v>
                </c:pt>
                <c:pt idx="154">
                  <c:v>379044</c:v>
                </c:pt>
                <c:pt idx="155">
                  <c:v>380562</c:v>
                </c:pt>
                <c:pt idx="156">
                  <c:v>386471</c:v>
                </c:pt>
                <c:pt idx="157">
                  <c:v>380979</c:v>
                </c:pt>
                <c:pt idx="158">
                  <c:v>389052</c:v>
                </c:pt>
                <c:pt idx="159">
                  <c:v>376775</c:v>
                </c:pt>
                <c:pt idx="160">
                  <c:v>383608</c:v>
                </c:pt>
                <c:pt idx="161">
                  <c:v>365004</c:v>
                </c:pt>
                <c:pt idx="162">
                  <c:v>369297</c:v>
                </c:pt>
                <c:pt idx="163">
                  <c:v>345955</c:v>
                </c:pt>
                <c:pt idx="164">
                  <c:v>347974</c:v>
                </c:pt>
                <c:pt idx="165">
                  <c:v>323572</c:v>
                </c:pt>
                <c:pt idx="166">
                  <c:v>324958</c:v>
                </c:pt>
                <c:pt idx="167">
                  <c:v>304281</c:v>
                </c:pt>
                <c:pt idx="168">
                  <c:v>304256</c:v>
                </c:pt>
                <c:pt idx="169">
                  <c:v>288312</c:v>
                </c:pt>
                <c:pt idx="170">
                  <c:v>283233</c:v>
                </c:pt>
                <c:pt idx="171">
                  <c:v>273216</c:v>
                </c:pt>
                <c:pt idx="172">
                  <c:v>261492</c:v>
                </c:pt>
                <c:pt idx="173">
                  <c:v>257076</c:v>
                </c:pt>
                <c:pt idx="174">
                  <c:v>241818</c:v>
                </c:pt>
                <c:pt idx="175">
                  <c:v>241635</c:v>
                </c:pt>
                <c:pt idx="176">
                  <c:v>226544</c:v>
                </c:pt>
                <c:pt idx="177">
                  <c:v>229538</c:v>
                </c:pt>
                <c:pt idx="178">
                  <c:v>217726</c:v>
                </c:pt>
                <c:pt idx="179">
                  <c:v>218916</c:v>
                </c:pt>
                <c:pt idx="180">
                  <c:v>213779</c:v>
                </c:pt>
                <c:pt idx="181">
                  <c:v>213008</c:v>
                </c:pt>
                <c:pt idx="182">
                  <c:v>215060</c:v>
                </c:pt>
                <c:pt idx="183">
                  <c:v>216362</c:v>
                </c:pt>
                <c:pt idx="184">
                  <c:v>222307</c:v>
                </c:pt>
                <c:pt idx="185">
                  <c:v>230202</c:v>
                </c:pt>
                <c:pt idx="186">
                  <c:v>237568</c:v>
                </c:pt>
                <c:pt idx="187">
                  <c:v>250343</c:v>
                </c:pt>
                <c:pt idx="188">
                  <c:v>252501</c:v>
                </c:pt>
                <c:pt idx="189">
                  <c:v>267709</c:v>
                </c:pt>
                <c:pt idx="190">
                  <c:v>267662</c:v>
                </c:pt>
                <c:pt idx="191">
                  <c:v>283765</c:v>
                </c:pt>
                <c:pt idx="192">
                  <c:v>284394</c:v>
                </c:pt>
                <c:pt idx="193">
                  <c:v>301691</c:v>
                </c:pt>
                <c:pt idx="194">
                  <c:v>297773</c:v>
                </c:pt>
                <c:pt idx="195">
                  <c:v>321443</c:v>
                </c:pt>
                <c:pt idx="196">
                  <c:v>317172</c:v>
                </c:pt>
                <c:pt idx="197">
                  <c:v>344488</c:v>
                </c:pt>
                <c:pt idx="198">
                  <c:v>352860</c:v>
                </c:pt>
                <c:pt idx="199">
                  <c:v>373519</c:v>
                </c:pt>
                <c:pt idx="200">
                  <c:v>397559</c:v>
                </c:pt>
                <c:pt idx="201">
                  <c:v>400606</c:v>
                </c:pt>
                <c:pt idx="202">
                  <c:v>425880</c:v>
                </c:pt>
                <c:pt idx="203">
                  <c:v>406000</c:v>
                </c:pt>
                <c:pt idx="204">
                  <c:v>419237</c:v>
                </c:pt>
                <c:pt idx="205">
                  <c:v>386104</c:v>
                </c:pt>
                <c:pt idx="206">
                  <c:v>390211</c:v>
                </c:pt>
                <c:pt idx="207">
                  <c:v>364755</c:v>
                </c:pt>
                <c:pt idx="208">
                  <c:v>381290</c:v>
                </c:pt>
                <c:pt idx="209">
                  <c:v>377071</c:v>
                </c:pt>
                <c:pt idx="210">
                  <c:v>413693</c:v>
                </c:pt>
                <c:pt idx="211">
                  <c:v>427303</c:v>
                </c:pt>
                <c:pt idx="212">
                  <c:v>461843</c:v>
                </c:pt>
                <c:pt idx="213">
                  <c:v>486267</c:v>
                </c:pt>
                <c:pt idx="214">
                  <c:v>495017</c:v>
                </c:pt>
                <c:pt idx="215">
                  <c:v>524328</c:v>
                </c:pt>
                <c:pt idx="216">
                  <c:v>509595</c:v>
                </c:pt>
                <c:pt idx="217">
                  <c:v>540508</c:v>
                </c:pt>
                <c:pt idx="218">
                  <c:v>522191</c:v>
                </c:pt>
                <c:pt idx="219">
                  <c:v>554887</c:v>
                </c:pt>
                <c:pt idx="220">
                  <c:v>543988</c:v>
                </c:pt>
                <c:pt idx="221">
                  <c:v>577656</c:v>
                </c:pt>
                <c:pt idx="222">
                  <c:v>570587</c:v>
                </c:pt>
                <c:pt idx="223">
                  <c:v>599027</c:v>
                </c:pt>
                <c:pt idx="224">
                  <c:v>590165</c:v>
                </c:pt>
                <c:pt idx="225">
                  <c:v>609084</c:v>
                </c:pt>
                <c:pt idx="226">
                  <c:v>597017</c:v>
                </c:pt>
                <c:pt idx="227">
                  <c:v>607111</c:v>
                </c:pt>
                <c:pt idx="228">
                  <c:v>599486</c:v>
                </c:pt>
                <c:pt idx="229">
                  <c:v>607455</c:v>
                </c:pt>
                <c:pt idx="230">
                  <c:v>605337</c:v>
                </c:pt>
                <c:pt idx="231">
                  <c:v>615339</c:v>
                </c:pt>
                <c:pt idx="232">
                  <c:v>612466</c:v>
                </c:pt>
                <c:pt idx="233">
                  <c:v>622936</c:v>
                </c:pt>
                <c:pt idx="234">
                  <c:v>617292</c:v>
                </c:pt>
                <c:pt idx="235">
                  <c:v>631274</c:v>
                </c:pt>
                <c:pt idx="236">
                  <c:v>632103</c:v>
                </c:pt>
                <c:pt idx="237">
                  <c:v>652513</c:v>
                </c:pt>
                <c:pt idx="238">
                  <c:v>660921</c:v>
                </c:pt>
                <c:pt idx="239">
                  <c:v>687614</c:v>
                </c:pt>
                <c:pt idx="240">
                  <c:v>699690</c:v>
                </c:pt>
                <c:pt idx="241">
                  <c:v>725613</c:v>
                </c:pt>
                <c:pt idx="242">
                  <c:v>742744</c:v>
                </c:pt>
                <c:pt idx="243">
                  <c:v>764426</c:v>
                </c:pt>
                <c:pt idx="244">
                  <c:v>790975</c:v>
                </c:pt>
                <c:pt idx="245">
                  <c:v>808192</c:v>
                </c:pt>
                <c:pt idx="246">
                  <c:v>844951</c:v>
                </c:pt>
                <c:pt idx="247">
                  <c:v>858698</c:v>
                </c:pt>
                <c:pt idx="248">
                  <c:v>900594</c:v>
                </c:pt>
                <c:pt idx="249">
                  <c:v>909575</c:v>
                </c:pt>
                <c:pt idx="250">
                  <c:v>941562</c:v>
                </c:pt>
                <c:pt idx="251">
                  <c:v>942144</c:v>
                </c:pt>
                <c:pt idx="252">
                  <c:v>954938</c:v>
                </c:pt>
                <c:pt idx="253">
                  <c:v>945126</c:v>
                </c:pt>
                <c:pt idx="254">
                  <c:v>941395</c:v>
                </c:pt>
                <c:pt idx="255">
                  <c:v>921529</c:v>
                </c:pt>
                <c:pt idx="256">
                  <c:v>904650</c:v>
                </c:pt>
                <c:pt idx="257">
                  <c:v>876446</c:v>
                </c:pt>
                <c:pt idx="258">
                  <c:v>845746</c:v>
                </c:pt>
                <c:pt idx="259">
                  <c:v>811763</c:v>
                </c:pt>
                <c:pt idx="260">
                  <c:v>769930</c:v>
                </c:pt>
                <c:pt idx="261">
                  <c:v>733305</c:v>
                </c:pt>
                <c:pt idx="262">
                  <c:v>686036</c:v>
                </c:pt>
                <c:pt idx="263">
                  <c:v>648943</c:v>
                </c:pt>
                <c:pt idx="264">
                  <c:v>603600</c:v>
                </c:pt>
                <c:pt idx="265">
                  <c:v>567258</c:v>
                </c:pt>
                <c:pt idx="266">
                  <c:v>527291</c:v>
                </c:pt>
                <c:pt idx="267">
                  <c:v>494013</c:v>
                </c:pt>
                <c:pt idx="268">
                  <c:v>459314</c:v>
                </c:pt>
                <c:pt idx="269">
                  <c:v>430690</c:v>
                </c:pt>
                <c:pt idx="270">
                  <c:v>400396</c:v>
                </c:pt>
                <c:pt idx="271">
                  <c:v>377013</c:v>
                </c:pt>
                <c:pt idx="272">
                  <c:v>352995</c:v>
                </c:pt>
                <c:pt idx="273">
                  <c:v>333082</c:v>
                </c:pt>
                <c:pt idx="274">
                  <c:v>315860</c:v>
                </c:pt>
                <c:pt idx="275">
                  <c:v>298041</c:v>
                </c:pt>
                <c:pt idx="276">
                  <c:v>287406</c:v>
                </c:pt>
                <c:pt idx="277">
                  <c:v>270673</c:v>
                </c:pt>
                <c:pt idx="278">
                  <c:v>265076</c:v>
                </c:pt>
                <c:pt idx="279">
                  <c:v>249782</c:v>
                </c:pt>
                <c:pt idx="280">
                  <c:v>247843</c:v>
                </c:pt>
                <c:pt idx="281">
                  <c:v>233887</c:v>
                </c:pt>
                <c:pt idx="282">
                  <c:v>235331</c:v>
                </c:pt>
                <c:pt idx="283">
                  <c:v>222673</c:v>
                </c:pt>
                <c:pt idx="284">
                  <c:v>228407</c:v>
                </c:pt>
                <c:pt idx="285">
                  <c:v>217112</c:v>
                </c:pt>
                <c:pt idx="286">
                  <c:v>225929</c:v>
                </c:pt>
                <c:pt idx="287">
                  <c:v>216336</c:v>
                </c:pt>
                <c:pt idx="288">
                  <c:v>226361</c:v>
                </c:pt>
                <c:pt idx="289">
                  <c:v>219271</c:v>
                </c:pt>
                <c:pt idx="290">
                  <c:v>227826</c:v>
                </c:pt>
                <c:pt idx="291">
                  <c:v>222915</c:v>
                </c:pt>
                <c:pt idx="292">
                  <c:v>229081</c:v>
                </c:pt>
                <c:pt idx="293">
                  <c:v>226151</c:v>
                </c:pt>
                <c:pt idx="294">
                  <c:v>230196</c:v>
                </c:pt>
                <c:pt idx="295">
                  <c:v>230457</c:v>
                </c:pt>
                <c:pt idx="296">
                  <c:v>232967</c:v>
                </c:pt>
                <c:pt idx="297">
                  <c:v>238373</c:v>
                </c:pt>
                <c:pt idx="298">
                  <c:v>238644</c:v>
                </c:pt>
                <c:pt idx="299">
                  <c:v>248173</c:v>
                </c:pt>
                <c:pt idx="300">
                  <c:v>246051</c:v>
                </c:pt>
                <c:pt idx="301">
                  <c:v>256984</c:v>
                </c:pt>
                <c:pt idx="302">
                  <c:v>254048</c:v>
                </c:pt>
                <c:pt idx="303">
                  <c:v>262796</c:v>
                </c:pt>
                <c:pt idx="304">
                  <c:v>261231</c:v>
                </c:pt>
                <c:pt idx="305">
                  <c:v>266989</c:v>
                </c:pt>
                <c:pt idx="306">
                  <c:v>266116</c:v>
                </c:pt>
                <c:pt idx="307">
                  <c:v>270640</c:v>
                </c:pt>
                <c:pt idx="308">
                  <c:v>267419</c:v>
                </c:pt>
                <c:pt idx="309">
                  <c:v>272360</c:v>
                </c:pt>
                <c:pt idx="310">
                  <c:v>269667</c:v>
                </c:pt>
                <c:pt idx="311">
                  <c:v>277909</c:v>
                </c:pt>
                <c:pt idx="312">
                  <c:v>278187</c:v>
                </c:pt>
                <c:pt idx="313">
                  <c:v>290285</c:v>
                </c:pt>
                <c:pt idx="314">
                  <c:v>294516</c:v>
                </c:pt>
                <c:pt idx="315">
                  <c:v>310262</c:v>
                </c:pt>
                <c:pt idx="316">
                  <c:v>314959</c:v>
                </c:pt>
                <c:pt idx="317">
                  <c:v>332465</c:v>
                </c:pt>
                <c:pt idx="318">
                  <c:v>340320</c:v>
                </c:pt>
                <c:pt idx="319">
                  <c:v>363639</c:v>
                </c:pt>
                <c:pt idx="320">
                  <c:v>376499</c:v>
                </c:pt>
                <c:pt idx="321">
                  <c:v>406878</c:v>
                </c:pt>
                <c:pt idx="322">
                  <c:v>428279</c:v>
                </c:pt>
                <c:pt idx="323">
                  <c:v>462733</c:v>
                </c:pt>
                <c:pt idx="324">
                  <c:v>484415</c:v>
                </c:pt>
                <c:pt idx="325">
                  <c:v>514698</c:v>
                </c:pt>
                <c:pt idx="326">
                  <c:v>523072</c:v>
                </c:pt>
                <c:pt idx="327">
                  <c:v>534446</c:v>
                </c:pt>
                <c:pt idx="328">
                  <c:v>520039</c:v>
                </c:pt>
                <c:pt idx="329">
                  <c:v>565173</c:v>
                </c:pt>
                <c:pt idx="330">
                  <c:v>590754</c:v>
                </c:pt>
                <c:pt idx="331">
                  <c:v>677052</c:v>
                </c:pt>
                <c:pt idx="332">
                  <c:v>754805</c:v>
                </c:pt>
                <c:pt idx="333">
                  <c:v>865665</c:v>
                </c:pt>
                <c:pt idx="334">
                  <c:v>986664</c:v>
                </c:pt>
                <c:pt idx="335">
                  <c:v>1045340</c:v>
                </c:pt>
                <c:pt idx="336">
                  <c:v>1200920</c:v>
                </c:pt>
                <c:pt idx="337">
                  <c:v>1265340</c:v>
                </c:pt>
                <c:pt idx="338">
                  <c:v>1489460</c:v>
                </c:pt>
                <c:pt idx="339">
                  <c:v>1582650</c:v>
                </c:pt>
                <c:pt idx="340">
                  <c:v>1904150</c:v>
                </c:pt>
                <c:pt idx="341">
                  <c:v>2042380</c:v>
                </c:pt>
                <c:pt idx="342">
                  <c:v>2474570</c:v>
                </c:pt>
                <c:pt idx="343">
                  <c:v>2570770</c:v>
                </c:pt>
                <c:pt idx="344">
                  <c:v>3007190</c:v>
                </c:pt>
                <c:pt idx="345">
                  <c:v>2990430</c:v>
                </c:pt>
                <c:pt idx="346">
                  <c:v>3302300</c:v>
                </c:pt>
                <c:pt idx="347">
                  <c:v>3284730</c:v>
                </c:pt>
                <c:pt idx="348">
                  <c:v>3487000</c:v>
                </c:pt>
                <c:pt idx="349">
                  <c:v>3659950</c:v>
                </c:pt>
                <c:pt idx="350">
                  <c:v>3846190</c:v>
                </c:pt>
                <c:pt idx="351">
                  <c:v>4093550</c:v>
                </c:pt>
                <c:pt idx="352">
                  <c:v>4231000</c:v>
                </c:pt>
                <c:pt idx="353">
                  <c:v>4276940</c:v>
                </c:pt>
                <c:pt idx="354">
                  <c:v>4277190</c:v>
                </c:pt>
                <c:pt idx="355">
                  <c:v>4064920</c:v>
                </c:pt>
                <c:pt idx="356">
                  <c:v>3914060</c:v>
                </c:pt>
                <c:pt idx="357">
                  <c:v>3622410</c:v>
                </c:pt>
                <c:pt idx="358">
                  <c:v>3403200</c:v>
                </c:pt>
                <c:pt idx="359">
                  <c:v>3142820</c:v>
                </c:pt>
                <c:pt idx="360">
                  <c:v>2927980</c:v>
                </c:pt>
                <c:pt idx="361">
                  <c:v>2710580</c:v>
                </c:pt>
                <c:pt idx="362">
                  <c:v>2523630</c:v>
                </c:pt>
                <c:pt idx="363">
                  <c:v>2302940</c:v>
                </c:pt>
                <c:pt idx="364">
                  <c:v>2126440</c:v>
                </c:pt>
                <c:pt idx="365">
                  <c:v>1925750</c:v>
                </c:pt>
                <c:pt idx="366">
                  <c:v>1769650</c:v>
                </c:pt>
                <c:pt idx="367">
                  <c:v>1628690</c:v>
                </c:pt>
                <c:pt idx="368">
                  <c:v>1502610</c:v>
                </c:pt>
                <c:pt idx="369">
                  <c:v>1431670</c:v>
                </c:pt>
                <c:pt idx="370">
                  <c:v>1337430</c:v>
                </c:pt>
                <c:pt idx="371">
                  <c:v>1283780</c:v>
                </c:pt>
                <c:pt idx="372">
                  <c:v>1205740</c:v>
                </c:pt>
                <c:pt idx="373">
                  <c:v>1158480</c:v>
                </c:pt>
                <c:pt idx="374">
                  <c:v>1091180</c:v>
                </c:pt>
                <c:pt idx="375">
                  <c:v>1045140</c:v>
                </c:pt>
                <c:pt idx="376">
                  <c:v>986729</c:v>
                </c:pt>
                <c:pt idx="377">
                  <c:v>950339</c:v>
                </c:pt>
                <c:pt idx="378">
                  <c:v>904045</c:v>
                </c:pt>
                <c:pt idx="379">
                  <c:v>877897</c:v>
                </c:pt>
                <c:pt idx="380">
                  <c:v>844151</c:v>
                </c:pt>
                <c:pt idx="381">
                  <c:v>828728</c:v>
                </c:pt>
                <c:pt idx="382">
                  <c:v>807224</c:v>
                </c:pt>
                <c:pt idx="383">
                  <c:v>803366</c:v>
                </c:pt>
                <c:pt idx="384">
                  <c:v>793801</c:v>
                </c:pt>
                <c:pt idx="385">
                  <c:v>801815</c:v>
                </c:pt>
                <c:pt idx="386">
                  <c:v>803238</c:v>
                </c:pt>
                <c:pt idx="387">
                  <c:v>823626</c:v>
                </c:pt>
                <c:pt idx="388">
                  <c:v>835815</c:v>
                </c:pt>
                <c:pt idx="389">
                  <c:v>869241</c:v>
                </c:pt>
                <c:pt idx="390">
                  <c:v>892813</c:v>
                </c:pt>
                <c:pt idx="391">
                  <c:v>939446</c:v>
                </c:pt>
                <c:pt idx="392">
                  <c:v>974127</c:v>
                </c:pt>
                <c:pt idx="393">
                  <c:v>1031390</c:v>
                </c:pt>
                <c:pt idx="394">
                  <c:v>1074240</c:v>
                </c:pt>
                <c:pt idx="395">
                  <c:v>1136740</c:v>
                </c:pt>
                <c:pt idx="396">
                  <c:v>1185400</c:v>
                </c:pt>
                <c:pt idx="397">
                  <c:v>1246070</c:v>
                </c:pt>
                <c:pt idx="398">
                  <c:v>1296990</c:v>
                </c:pt>
                <c:pt idx="399">
                  <c:v>1350370</c:v>
                </c:pt>
                <c:pt idx="400">
                  <c:v>1397620</c:v>
                </c:pt>
                <c:pt idx="401">
                  <c:v>1438020</c:v>
                </c:pt>
                <c:pt idx="402">
                  <c:v>1473430</c:v>
                </c:pt>
                <c:pt idx="403">
                  <c:v>1496710</c:v>
                </c:pt>
                <c:pt idx="404">
                  <c:v>1512950</c:v>
                </c:pt>
                <c:pt idx="405">
                  <c:v>1515290</c:v>
                </c:pt>
                <c:pt idx="406">
                  <c:v>1509480</c:v>
                </c:pt>
                <c:pt idx="407">
                  <c:v>1489750</c:v>
                </c:pt>
                <c:pt idx="408">
                  <c:v>1462710</c:v>
                </c:pt>
                <c:pt idx="409">
                  <c:v>1422170</c:v>
                </c:pt>
                <c:pt idx="410">
                  <c:v>1376810</c:v>
                </c:pt>
                <c:pt idx="411">
                  <c:v>1320100</c:v>
                </c:pt>
                <c:pt idx="412">
                  <c:v>1260360</c:v>
                </c:pt>
                <c:pt idx="413">
                  <c:v>1195700</c:v>
                </c:pt>
                <c:pt idx="414">
                  <c:v>1126660</c:v>
                </c:pt>
                <c:pt idx="415">
                  <c:v>1062290</c:v>
                </c:pt>
                <c:pt idx="416">
                  <c:v>991044</c:v>
                </c:pt>
                <c:pt idx="417">
                  <c:v>930782</c:v>
                </c:pt>
                <c:pt idx="418">
                  <c:v>863323</c:v>
                </c:pt>
                <c:pt idx="419">
                  <c:v>807603</c:v>
                </c:pt>
                <c:pt idx="420">
                  <c:v>747523</c:v>
                </c:pt>
                <c:pt idx="421">
                  <c:v>697822</c:v>
                </c:pt>
                <c:pt idx="422">
                  <c:v>645564</c:v>
                </c:pt>
                <c:pt idx="423">
                  <c:v>603641</c:v>
                </c:pt>
                <c:pt idx="424">
                  <c:v>559021</c:v>
                </c:pt>
                <c:pt idx="425">
                  <c:v>525753</c:v>
                </c:pt>
                <c:pt idx="426">
                  <c:v>488886</c:v>
                </c:pt>
                <c:pt idx="427">
                  <c:v>462152</c:v>
                </c:pt>
                <c:pt idx="428">
                  <c:v>432868</c:v>
                </c:pt>
                <c:pt idx="429">
                  <c:v>408814</c:v>
                </c:pt>
                <c:pt idx="430">
                  <c:v>385034</c:v>
                </c:pt>
                <c:pt idx="431">
                  <c:v>362905</c:v>
                </c:pt>
                <c:pt idx="432">
                  <c:v>342141</c:v>
                </c:pt>
                <c:pt idx="433">
                  <c:v>323992</c:v>
                </c:pt>
                <c:pt idx="434">
                  <c:v>307327</c:v>
                </c:pt>
                <c:pt idx="435">
                  <c:v>294488</c:v>
                </c:pt>
                <c:pt idx="436">
                  <c:v>283958</c:v>
                </c:pt>
                <c:pt idx="437">
                  <c:v>274803</c:v>
                </c:pt>
                <c:pt idx="438">
                  <c:v>269518</c:v>
                </c:pt>
                <c:pt idx="439">
                  <c:v>262028</c:v>
                </c:pt>
                <c:pt idx="440">
                  <c:v>260351</c:v>
                </c:pt>
                <c:pt idx="441">
                  <c:v>251854</c:v>
                </c:pt>
                <c:pt idx="442">
                  <c:v>251891</c:v>
                </c:pt>
                <c:pt idx="443">
                  <c:v>242205</c:v>
                </c:pt>
                <c:pt idx="444">
                  <c:v>242110</c:v>
                </c:pt>
                <c:pt idx="445">
                  <c:v>23325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9C31-4A1B-9DD8-F246F11BD6D0}"/>
            </c:ext>
          </c:extLst>
        </c:ser>
        <c:ser>
          <c:idx val="2"/>
          <c:order val="2"/>
          <c:tx>
            <c:strRef>
              <c:f>Sheet1!$C$3</c:f>
              <c:strCache>
                <c:ptCount val="1"/>
                <c:pt idx="0">
                  <c:v>edge (enhancement)</c:v>
                </c:pt>
              </c:strCache>
            </c:strRef>
          </c:tx>
          <c:spPr>
            <a:ln w="19050" cap="rnd">
              <a:solidFill>
                <a:srgbClr val="4F81BD"/>
              </a:solidFill>
              <a:round/>
            </a:ln>
            <a:effectLst/>
          </c:spPr>
          <c:marker>
            <c:symbol val="none"/>
          </c:marker>
          <c:cat>
            <c:numRef>
              <c:f>Sheet1!$A$4:$A$449</c:f>
              <c:numCache>
                <c:formatCode>0.00_ </c:formatCode>
                <c:ptCount val="446"/>
                <c:pt idx="0">
                  <c:v>4</c:v>
                </c:pt>
                <c:pt idx="1">
                  <c:v>3.992356</c:v>
                </c:pt>
                <c:pt idx="2">
                  <c:v>3.9847109999999999</c:v>
                </c:pt>
                <c:pt idx="3">
                  <c:v>3.9770669999999999</c:v>
                </c:pt>
                <c:pt idx="4">
                  <c:v>3.9694219999999998</c:v>
                </c:pt>
                <c:pt idx="5">
                  <c:v>3.9617779999999998</c:v>
                </c:pt>
                <c:pt idx="6">
                  <c:v>3.9541339999999998</c:v>
                </c:pt>
                <c:pt idx="7">
                  <c:v>3.9464890000000001</c:v>
                </c:pt>
                <c:pt idx="8">
                  <c:v>3.9388450000000002</c:v>
                </c:pt>
                <c:pt idx="9">
                  <c:v>3.9312</c:v>
                </c:pt>
                <c:pt idx="10">
                  <c:v>3.923556</c:v>
                </c:pt>
                <c:pt idx="11">
                  <c:v>3.9159109999999999</c:v>
                </c:pt>
                <c:pt idx="12">
                  <c:v>3.9082669999999999</c:v>
                </c:pt>
                <c:pt idx="13">
                  <c:v>3.900623</c:v>
                </c:pt>
                <c:pt idx="14">
                  <c:v>3.8929779999999998</c:v>
                </c:pt>
                <c:pt idx="15">
                  <c:v>3.8853339999999998</c:v>
                </c:pt>
                <c:pt idx="16">
                  <c:v>3.8776890000000002</c:v>
                </c:pt>
                <c:pt idx="17">
                  <c:v>3.8700450000000002</c:v>
                </c:pt>
                <c:pt idx="18">
                  <c:v>3.8624010000000002</c:v>
                </c:pt>
                <c:pt idx="19">
                  <c:v>3.8547560000000001</c:v>
                </c:pt>
                <c:pt idx="20">
                  <c:v>3.8471120000000001</c:v>
                </c:pt>
                <c:pt idx="21">
                  <c:v>3.839467</c:v>
                </c:pt>
                <c:pt idx="22">
                  <c:v>3.831823</c:v>
                </c:pt>
                <c:pt idx="23">
                  <c:v>3.8241779999999999</c:v>
                </c:pt>
                <c:pt idx="24">
                  <c:v>3.8165339999999999</c:v>
                </c:pt>
                <c:pt idx="25">
                  <c:v>3.8088899999999999</c:v>
                </c:pt>
                <c:pt idx="26">
                  <c:v>3.8012450000000002</c:v>
                </c:pt>
                <c:pt idx="27">
                  <c:v>3.7936009999999998</c:v>
                </c:pt>
                <c:pt idx="28">
                  <c:v>3.7859560000000001</c:v>
                </c:pt>
                <c:pt idx="29">
                  <c:v>3.7783120000000001</c:v>
                </c:pt>
                <c:pt idx="30">
                  <c:v>3.7706680000000001</c:v>
                </c:pt>
                <c:pt idx="31">
                  <c:v>3.763023</c:v>
                </c:pt>
                <c:pt idx="32">
                  <c:v>3.755379</c:v>
                </c:pt>
                <c:pt idx="33">
                  <c:v>3.7477339999999999</c:v>
                </c:pt>
                <c:pt idx="34">
                  <c:v>3.7400899999999999</c:v>
                </c:pt>
                <c:pt idx="35">
                  <c:v>3.7324449999999998</c:v>
                </c:pt>
                <c:pt idx="36">
                  <c:v>3.7248009999999998</c:v>
                </c:pt>
                <c:pt idx="37">
                  <c:v>3.7171569999999998</c:v>
                </c:pt>
                <c:pt idx="38">
                  <c:v>3.7095120000000001</c:v>
                </c:pt>
                <c:pt idx="39">
                  <c:v>3.7018680000000002</c:v>
                </c:pt>
                <c:pt idx="40">
                  <c:v>3.694223</c:v>
                </c:pt>
                <c:pt idx="41">
                  <c:v>3.6865790000000001</c:v>
                </c:pt>
                <c:pt idx="42">
                  <c:v>3.6789350000000001</c:v>
                </c:pt>
                <c:pt idx="43">
                  <c:v>3.6712899999999999</c:v>
                </c:pt>
                <c:pt idx="44">
                  <c:v>3.663646</c:v>
                </c:pt>
                <c:pt idx="45">
                  <c:v>3.6560009999999998</c:v>
                </c:pt>
                <c:pt idx="46">
                  <c:v>3.6483569999999999</c:v>
                </c:pt>
                <c:pt idx="47">
                  <c:v>3.6407120000000002</c:v>
                </c:pt>
                <c:pt idx="48">
                  <c:v>3.6330680000000002</c:v>
                </c:pt>
                <c:pt idx="49">
                  <c:v>3.6254240000000002</c:v>
                </c:pt>
                <c:pt idx="50">
                  <c:v>3.6177790000000001</c:v>
                </c:pt>
                <c:pt idx="51">
                  <c:v>3.6101350000000001</c:v>
                </c:pt>
                <c:pt idx="52">
                  <c:v>3.60249</c:v>
                </c:pt>
                <c:pt idx="53">
                  <c:v>3.594846</c:v>
                </c:pt>
                <c:pt idx="54">
                  <c:v>3.587202</c:v>
                </c:pt>
                <c:pt idx="55">
                  <c:v>3.5795569999999999</c:v>
                </c:pt>
                <c:pt idx="56">
                  <c:v>3.5719129999999999</c:v>
                </c:pt>
                <c:pt idx="57">
                  <c:v>3.5642680000000002</c:v>
                </c:pt>
                <c:pt idx="58">
                  <c:v>3.5566239999999998</c:v>
                </c:pt>
                <c:pt idx="59">
                  <c:v>3.5489799999999998</c:v>
                </c:pt>
                <c:pt idx="60">
                  <c:v>3.5413350000000001</c:v>
                </c:pt>
                <c:pt idx="61">
                  <c:v>3.5336910000000001</c:v>
                </c:pt>
                <c:pt idx="62">
                  <c:v>3.526046</c:v>
                </c:pt>
                <c:pt idx="63">
                  <c:v>3.518402</c:v>
                </c:pt>
                <c:pt idx="64">
                  <c:v>3.5107569999999999</c:v>
                </c:pt>
                <c:pt idx="65">
                  <c:v>3.5031129999999999</c:v>
                </c:pt>
                <c:pt idx="66">
                  <c:v>3.4954689999999999</c:v>
                </c:pt>
                <c:pt idx="67">
                  <c:v>3.4878239999999998</c:v>
                </c:pt>
                <c:pt idx="68">
                  <c:v>3.4801799999999998</c:v>
                </c:pt>
                <c:pt idx="69">
                  <c:v>3.4725350000000001</c:v>
                </c:pt>
                <c:pt idx="70">
                  <c:v>3.4648910000000002</c:v>
                </c:pt>
                <c:pt idx="71">
                  <c:v>3.4572470000000002</c:v>
                </c:pt>
                <c:pt idx="72">
                  <c:v>3.4496020000000001</c:v>
                </c:pt>
                <c:pt idx="73">
                  <c:v>3.4419580000000001</c:v>
                </c:pt>
                <c:pt idx="74">
                  <c:v>3.4343129999999999</c:v>
                </c:pt>
                <c:pt idx="75">
                  <c:v>3.426669</c:v>
                </c:pt>
                <c:pt idx="76">
                  <c:v>3.4190239999999998</c:v>
                </c:pt>
                <c:pt idx="77">
                  <c:v>3.4113799999999999</c:v>
                </c:pt>
                <c:pt idx="78">
                  <c:v>3.4037359999999999</c:v>
                </c:pt>
                <c:pt idx="79">
                  <c:v>3.3960910000000002</c:v>
                </c:pt>
                <c:pt idx="80">
                  <c:v>3.3884470000000002</c:v>
                </c:pt>
                <c:pt idx="81">
                  <c:v>3.3808020000000001</c:v>
                </c:pt>
                <c:pt idx="82">
                  <c:v>3.3731580000000001</c:v>
                </c:pt>
                <c:pt idx="83">
                  <c:v>3.3655140000000001</c:v>
                </c:pt>
                <c:pt idx="84">
                  <c:v>3.357869</c:v>
                </c:pt>
                <c:pt idx="85">
                  <c:v>3.350225</c:v>
                </c:pt>
                <c:pt idx="86">
                  <c:v>3.3425799999999999</c:v>
                </c:pt>
                <c:pt idx="87">
                  <c:v>3.3349359999999999</c:v>
                </c:pt>
                <c:pt idx="88">
                  <c:v>3.3272910000000002</c:v>
                </c:pt>
                <c:pt idx="89">
                  <c:v>3.3196469999999998</c:v>
                </c:pt>
                <c:pt idx="90">
                  <c:v>3.3120029999999998</c:v>
                </c:pt>
                <c:pt idx="91">
                  <c:v>3.3043580000000001</c:v>
                </c:pt>
                <c:pt idx="92">
                  <c:v>3.2967140000000001</c:v>
                </c:pt>
                <c:pt idx="93">
                  <c:v>3.289069</c:v>
                </c:pt>
                <c:pt idx="94">
                  <c:v>3.281425</c:v>
                </c:pt>
                <c:pt idx="95">
                  <c:v>3.2737810000000001</c:v>
                </c:pt>
                <c:pt idx="96">
                  <c:v>3.2661359999999999</c:v>
                </c:pt>
                <c:pt idx="97">
                  <c:v>3.2584919999999999</c:v>
                </c:pt>
                <c:pt idx="98">
                  <c:v>3.2508469999999998</c:v>
                </c:pt>
                <c:pt idx="99">
                  <c:v>3.2432029999999998</c:v>
                </c:pt>
                <c:pt idx="100">
                  <c:v>3.2355589999999999</c:v>
                </c:pt>
                <c:pt idx="101">
                  <c:v>3.2279140000000002</c:v>
                </c:pt>
                <c:pt idx="102">
                  <c:v>3.2202700000000002</c:v>
                </c:pt>
                <c:pt idx="103">
                  <c:v>3.2126250000000001</c:v>
                </c:pt>
                <c:pt idx="104">
                  <c:v>3.2049810000000001</c:v>
                </c:pt>
                <c:pt idx="105">
                  <c:v>3.197336</c:v>
                </c:pt>
                <c:pt idx="106">
                  <c:v>3.189692</c:v>
                </c:pt>
                <c:pt idx="107">
                  <c:v>3.182048</c:v>
                </c:pt>
                <c:pt idx="108">
                  <c:v>3.1744029999999999</c:v>
                </c:pt>
                <c:pt idx="109">
                  <c:v>3.1667589999999999</c:v>
                </c:pt>
                <c:pt idx="110">
                  <c:v>3.1591140000000002</c:v>
                </c:pt>
                <c:pt idx="111">
                  <c:v>3.1514700000000002</c:v>
                </c:pt>
                <c:pt idx="112">
                  <c:v>3.1438259999999998</c:v>
                </c:pt>
                <c:pt idx="113">
                  <c:v>3.1361810000000001</c:v>
                </c:pt>
                <c:pt idx="114">
                  <c:v>3.1285370000000001</c:v>
                </c:pt>
                <c:pt idx="115">
                  <c:v>3.120892</c:v>
                </c:pt>
                <c:pt idx="116">
                  <c:v>3.113248</c:v>
                </c:pt>
                <c:pt idx="117">
                  <c:v>3.1056029999999999</c:v>
                </c:pt>
                <c:pt idx="118">
                  <c:v>3.0979589999999999</c:v>
                </c:pt>
                <c:pt idx="119">
                  <c:v>3.0903149999999999</c:v>
                </c:pt>
                <c:pt idx="120">
                  <c:v>3.0826699999999998</c:v>
                </c:pt>
                <c:pt idx="121">
                  <c:v>3.0750259999999998</c:v>
                </c:pt>
                <c:pt idx="122">
                  <c:v>3.0673810000000001</c:v>
                </c:pt>
                <c:pt idx="123">
                  <c:v>3.0597370000000002</c:v>
                </c:pt>
                <c:pt idx="124">
                  <c:v>3.0520930000000002</c:v>
                </c:pt>
                <c:pt idx="125">
                  <c:v>3.044448</c:v>
                </c:pt>
                <c:pt idx="126">
                  <c:v>3.0368040000000001</c:v>
                </c:pt>
                <c:pt idx="127">
                  <c:v>3.0291589999999999</c:v>
                </c:pt>
                <c:pt idx="128">
                  <c:v>3.021515</c:v>
                </c:pt>
                <c:pt idx="129">
                  <c:v>3.0138699999999998</c:v>
                </c:pt>
                <c:pt idx="130">
                  <c:v>3.0062259999999998</c:v>
                </c:pt>
                <c:pt idx="131">
                  <c:v>2.9985819999999999</c:v>
                </c:pt>
                <c:pt idx="132">
                  <c:v>2.9909370000000002</c:v>
                </c:pt>
                <c:pt idx="133">
                  <c:v>2.9832930000000002</c:v>
                </c:pt>
                <c:pt idx="134">
                  <c:v>2.9756480000000001</c:v>
                </c:pt>
                <c:pt idx="135">
                  <c:v>2.9680040000000001</c:v>
                </c:pt>
                <c:pt idx="136">
                  <c:v>2.9603600000000001</c:v>
                </c:pt>
                <c:pt idx="137">
                  <c:v>2.952715</c:v>
                </c:pt>
                <c:pt idx="138">
                  <c:v>2.945071</c:v>
                </c:pt>
                <c:pt idx="139">
                  <c:v>2.9374259999999999</c:v>
                </c:pt>
                <c:pt idx="140">
                  <c:v>2.9297819999999999</c:v>
                </c:pt>
                <c:pt idx="141">
                  <c:v>2.9221370000000002</c:v>
                </c:pt>
                <c:pt idx="142">
                  <c:v>2.9144929999999998</c:v>
                </c:pt>
                <c:pt idx="143">
                  <c:v>2.9068489999999998</c:v>
                </c:pt>
                <c:pt idx="144">
                  <c:v>2.8992040000000001</c:v>
                </c:pt>
                <c:pt idx="145">
                  <c:v>2.8915600000000001</c:v>
                </c:pt>
                <c:pt idx="146">
                  <c:v>2.883915</c:v>
                </c:pt>
                <c:pt idx="147">
                  <c:v>2.876271</c:v>
                </c:pt>
                <c:pt idx="148">
                  <c:v>2.868627</c:v>
                </c:pt>
                <c:pt idx="149">
                  <c:v>2.8609819999999999</c:v>
                </c:pt>
                <c:pt idx="150">
                  <c:v>2.8533379999999999</c:v>
                </c:pt>
                <c:pt idx="151">
                  <c:v>2.8456929999999998</c:v>
                </c:pt>
                <c:pt idx="152">
                  <c:v>2.8380489999999998</c:v>
                </c:pt>
                <c:pt idx="153">
                  <c:v>2.8304049999999998</c:v>
                </c:pt>
                <c:pt idx="154">
                  <c:v>2.8227600000000002</c:v>
                </c:pt>
                <c:pt idx="155">
                  <c:v>2.8151160000000002</c:v>
                </c:pt>
                <c:pt idx="156">
                  <c:v>2.807471</c:v>
                </c:pt>
                <c:pt idx="157">
                  <c:v>2.7998270000000001</c:v>
                </c:pt>
                <c:pt idx="158">
                  <c:v>2.7921819999999999</c:v>
                </c:pt>
                <c:pt idx="159">
                  <c:v>2.784538</c:v>
                </c:pt>
                <c:pt idx="160">
                  <c:v>2.776894</c:v>
                </c:pt>
                <c:pt idx="161">
                  <c:v>2.7692489999999998</c:v>
                </c:pt>
                <c:pt idx="162">
                  <c:v>2.7616049999999999</c:v>
                </c:pt>
                <c:pt idx="163">
                  <c:v>2.7539600000000002</c:v>
                </c:pt>
                <c:pt idx="164">
                  <c:v>2.7463160000000002</c:v>
                </c:pt>
                <c:pt idx="165">
                  <c:v>2.7386720000000002</c:v>
                </c:pt>
                <c:pt idx="166">
                  <c:v>2.7310270000000001</c:v>
                </c:pt>
                <c:pt idx="167">
                  <c:v>2.7233830000000001</c:v>
                </c:pt>
                <c:pt idx="168">
                  <c:v>2.715738</c:v>
                </c:pt>
                <c:pt idx="169">
                  <c:v>2.708094</c:v>
                </c:pt>
                <c:pt idx="170">
                  <c:v>2.7004489999999999</c:v>
                </c:pt>
                <c:pt idx="171">
                  <c:v>2.6928049999999999</c:v>
                </c:pt>
                <c:pt idx="172">
                  <c:v>2.6851609999999999</c:v>
                </c:pt>
                <c:pt idx="173">
                  <c:v>2.6775159999999998</c:v>
                </c:pt>
                <c:pt idx="174">
                  <c:v>2.6698719999999998</c:v>
                </c:pt>
                <c:pt idx="175">
                  <c:v>2.6622270000000001</c:v>
                </c:pt>
                <c:pt idx="176">
                  <c:v>2.6545830000000001</c:v>
                </c:pt>
                <c:pt idx="177">
                  <c:v>2.6469390000000002</c:v>
                </c:pt>
                <c:pt idx="178">
                  <c:v>2.639294</c:v>
                </c:pt>
                <c:pt idx="179">
                  <c:v>2.63165</c:v>
                </c:pt>
                <c:pt idx="180">
                  <c:v>2.6240049999999999</c:v>
                </c:pt>
                <c:pt idx="181">
                  <c:v>2.6163609999999999</c:v>
                </c:pt>
                <c:pt idx="182">
                  <c:v>2.6087159999999998</c:v>
                </c:pt>
                <c:pt idx="183">
                  <c:v>2.6010719999999998</c:v>
                </c:pt>
                <c:pt idx="184">
                  <c:v>2.5934279999999998</c:v>
                </c:pt>
                <c:pt idx="185">
                  <c:v>2.5857830000000002</c:v>
                </c:pt>
                <c:pt idx="186">
                  <c:v>2.5781390000000002</c:v>
                </c:pt>
                <c:pt idx="187">
                  <c:v>2.5704940000000001</c:v>
                </c:pt>
                <c:pt idx="188">
                  <c:v>2.5628500000000001</c:v>
                </c:pt>
                <c:pt idx="189">
                  <c:v>2.5552060000000001</c:v>
                </c:pt>
                <c:pt idx="190">
                  <c:v>2.547561</c:v>
                </c:pt>
                <c:pt idx="191">
                  <c:v>2.539917</c:v>
                </c:pt>
                <c:pt idx="192">
                  <c:v>2.5322719999999999</c:v>
                </c:pt>
                <c:pt idx="193">
                  <c:v>2.5246279999999999</c:v>
                </c:pt>
                <c:pt idx="194">
                  <c:v>2.5169839999999999</c:v>
                </c:pt>
                <c:pt idx="195">
                  <c:v>2.5093390000000002</c:v>
                </c:pt>
                <c:pt idx="196">
                  <c:v>2.5016949999999998</c:v>
                </c:pt>
                <c:pt idx="197">
                  <c:v>2.4940500000000001</c:v>
                </c:pt>
                <c:pt idx="198">
                  <c:v>2.4864060000000001</c:v>
                </c:pt>
                <c:pt idx="199">
                  <c:v>2.478761</c:v>
                </c:pt>
                <c:pt idx="200">
                  <c:v>2.471117</c:v>
                </c:pt>
                <c:pt idx="201">
                  <c:v>2.463473</c:v>
                </c:pt>
                <c:pt idx="202">
                  <c:v>2.4558279999999999</c:v>
                </c:pt>
                <c:pt idx="203">
                  <c:v>2.4481839999999999</c:v>
                </c:pt>
                <c:pt idx="204">
                  <c:v>2.4405389999999998</c:v>
                </c:pt>
                <c:pt idx="205">
                  <c:v>2.4328949999999998</c:v>
                </c:pt>
                <c:pt idx="206">
                  <c:v>2.4252509999999998</c:v>
                </c:pt>
                <c:pt idx="207">
                  <c:v>2.4176060000000001</c:v>
                </c:pt>
                <c:pt idx="208">
                  <c:v>2.4099620000000002</c:v>
                </c:pt>
                <c:pt idx="209">
                  <c:v>2.402317</c:v>
                </c:pt>
                <c:pt idx="210">
                  <c:v>2.3946730000000001</c:v>
                </c:pt>
                <c:pt idx="211">
                  <c:v>2.3870279999999999</c:v>
                </c:pt>
                <c:pt idx="212">
                  <c:v>2.3793839999999999</c:v>
                </c:pt>
                <c:pt idx="213">
                  <c:v>2.37174</c:v>
                </c:pt>
                <c:pt idx="214">
                  <c:v>2.3640949999999998</c:v>
                </c:pt>
                <c:pt idx="215">
                  <c:v>2.3564509999999999</c:v>
                </c:pt>
                <c:pt idx="216">
                  <c:v>2.3488060000000002</c:v>
                </c:pt>
                <c:pt idx="217">
                  <c:v>2.3411620000000002</c:v>
                </c:pt>
                <c:pt idx="218">
                  <c:v>2.3335180000000002</c:v>
                </c:pt>
                <c:pt idx="219">
                  <c:v>2.3258730000000001</c:v>
                </c:pt>
                <c:pt idx="220">
                  <c:v>2.3182290000000001</c:v>
                </c:pt>
                <c:pt idx="221">
                  <c:v>2.310584</c:v>
                </c:pt>
                <c:pt idx="222">
                  <c:v>2.30294</c:v>
                </c:pt>
                <c:pt idx="223">
                  <c:v>2.2952949999999999</c:v>
                </c:pt>
                <c:pt idx="224">
                  <c:v>2.2876509999999999</c:v>
                </c:pt>
                <c:pt idx="225">
                  <c:v>2.2800069999999999</c:v>
                </c:pt>
                <c:pt idx="226">
                  <c:v>2.2723620000000002</c:v>
                </c:pt>
                <c:pt idx="227">
                  <c:v>2.2647179999999998</c:v>
                </c:pt>
                <c:pt idx="228">
                  <c:v>2.2570730000000001</c:v>
                </c:pt>
                <c:pt idx="229">
                  <c:v>2.2494290000000001</c:v>
                </c:pt>
                <c:pt idx="230">
                  <c:v>2.2417850000000001</c:v>
                </c:pt>
                <c:pt idx="231">
                  <c:v>2.23414</c:v>
                </c:pt>
                <c:pt idx="232">
                  <c:v>2.226496</c:v>
                </c:pt>
                <c:pt idx="233">
                  <c:v>2.2188509999999999</c:v>
                </c:pt>
                <c:pt idx="234">
                  <c:v>2.2112069999999999</c:v>
                </c:pt>
                <c:pt idx="235">
                  <c:v>2.2035619999999998</c:v>
                </c:pt>
                <c:pt idx="236">
                  <c:v>2.1959179999999998</c:v>
                </c:pt>
                <c:pt idx="237">
                  <c:v>2.1882739999999998</c:v>
                </c:pt>
                <c:pt idx="238">
                  <c:v>2.1806290000000002</c:v>
                </c:pt>
                <c:pt idx="239">
                  <c:v>2.1729850000000002</c:v>
                </c:pt>
                <c:pt idx="240">
                  <c:v>2.16534</c:v>
                </c:pt>
                <c:pt idx="241">
                  <c:v>2.1576960000000001</c:v>
                </c:pt>
                <c:pt idx="242">
                  <c:v>2.1500520000000001</c:v>
                </c:pt>
                <c:pt idx="243">
                  <c:v>2.142407</c:v>
                </c:pt>
                <c:pt idx="244">
                  <c:v>2.134763</c:v>
                </c:pt>
                <c:pt idx="245">
                  <c:v>2.1271179999999998</c:v>
                </c:pt>
                <c:pt idx="246">
                  <c:v>2.1194739999999999</c:v>
                </c:pt>
                <c:pt idx="247">
                  <c:v>2.1118299999999999</c:v>
                </c:pt>
                <c:pt idx="248">
                  <c:v>2.1041850000000002</c:v>
                </c:pt>
                <c:pt idx="249">
                  <c:v>2.0965410000000002</c:v>
                </c:pt>
                <c:pt idx="250">
                  <c:v>2.0888960000000001</c:v>
                </c:pt>
                <c:pt idx="251">
                  <c:v>2.0812520000000001</c:v>
                </c:pt>
                <c:pt idx="252">
                  <c:v>2.073607</c:v>
                </c:pt>
                <c:pt idx="253">
                  <c:v>2.065963</c:v>
                </c:pt>
                <c:pt idx="254">
                  <c:v>2.058319</c:v>
                </c:pt>
                <c:pt idx="255">
                  <c:v>2.0506739999999999</c:v>
                </c:pt>
                <c:pt idx="256">
                  <c:v>2.0430299999999999</c:v>
                </c:pt>
                <c:pt idx="257">
                  <c:v>2.0353850000000002</c:v>
                </c:pt>
                <c:pt idx="258">
                  <c:v>2.0277409999999998</c:v>
                </c:pt>
                <c:pt idx="259">
                  <c:v>2.0200969999999998</c:v>
                </c:pt>
                <c:pt idx="260">
                  <c:v>2.0124520000000001</c:v>
                </c:pt>
                <c:pt idx="261">
                  <c:v>2.0048080000000001</c:v>
                </c:pt>
                <c:pt idx="262">
                  <c:v>1.997163</c:v>
                </c:pt>
                <c:pt idx="263">
                  <c:v>1.989519</c:v>
                </c:pt>
                <c:pt idx="264">
                  <c:v>1.9818750000000001</c:v>
                </c:pt>
                <c:pt idx="265">
                  <c:v>1.9742310000000001</c:v>
                </c:pt>
                <c:pt idx="266">
                  <c:v>1.9665859999999999</c:v>
                </c:pt>
                <c:pt idx="267">
                  <c:v>1.958942</c:v>
                </c:pt>
                <c:pt idx="268">
                  <c:v>1.951298</c:v>
                </c:pt>
                <c:pt idx="269">
                  <c:v>1.9436530000000001</c:v>
                </c:pt>
                <c:pt idx="270">
                  <c:v>1.9360090000000001</c:v>
                </c:pt>
                <c:pt idx="271">
                  <c:v>1.9283650000000001</c:v>
                </c:pt>
                <c:pt idx="272">
                  <c:v>1.92072</c:v>
                </c:pt>
                <c:pt idx="273">
                  <c:v>1.913076</c:v>
                </c:pt>
                <c:pt idx="274">
                  <c:v>1.905432</c:v>
                </c:pt>
                <c:pt idx="275">
                  <c:v>1.897788</c:v>
                </c:pt>
                <c:pt idx="276">
                  <c:v>1.8901429999999999</c:v>
                </c:pt>
                <c:pt idx="277">
                  <c:v>1.8824989999999999</c:v>
                </c:pt>
                <c:pt idx="278">
                  <c:v>1.8748549999999999</c:v>
                </c:pt>
                <c:pt idx="279">
                  <c:v>1.86721</c:v>
                </c:pt>
                <c:pt idx="280">
                  <c:v>1.8595660000000001</c:v>
                </c:pt>
                <c:pt idx="281">
                  <c:v>1.8519220000000001</c:v>
                </c:pt>
                <c:pt idx="282">
                  <c:v>1.8442780000000001</c:v>
                </c:pt>
                <c:pt idx="283">
                  <c:v>1.836633</c:v>
                </c:pt>
                <c:pt idx="284">
                  <c:v>1.828989</c:v>
                </c:pt>
                <c:pt idx="285">
                  <c:v>1.821345</c:v>
                </c:pt>
                <c:pt idx="286">
                  <c:v>1.8137000000000001</c:v>
                </c:pt>
                <c:pt idx="287">
                  <c:v>1.8060560000000001</c:v>
                </c:pt>
                <c:pt idx="288">
                  <c:v>1.7984119999999999</c:v>
                </c:pt>
                <c:pt idx="289">
                  <c:v>1.790767</c:v>
                </c:pt>
                <c:pt idx="290">
                  <c:v>1.783123</c:v>
                </c:pt>
                <c:pt idx="291">
                  <c:v>1.775479</c:v>
                </c:pt>
                <c:pt idx="292">
                  <c:v>1.767835</c:v>
                </c:pt>
                <c:pt idx="293">
                  <c:v>1.7601899999999999</c:v>
                </c:pt>
                <c:pt idx="294">
                  <c:v>1.7525459999999999</c:v>
                </c:pt>
                <c:pt idx="295">
                  <c:v>1.744902</c:v>
                </c:pt>
                <c:pt idx="296">
                  <c:v>1.7372570000000001</c:v>
                </c:pt>
                <c:pt idx="297">
                  <c:v>1.7296130000000001</c:v>
                </c:pt>
                <c:pt idx="298">
                  <c:v>1.7219690000000001</c:v>
                </c:pt>
                <c:pt idx="299">
                  <c:v>1.714324</c:v>
                </c:pt>
                <c:pt idx="300">
                  <c:v>1.70668</c:v>
                </c:pt>
                <c:pt idx="301">
                  <c:v>1.699036</c:v>
                </c:pt>
                <c:pt idx="302">
                  <c:v>1.691392</c:v>
                </c:pt>
                <c:pt idx="303">
                  <c:v>1.6837470000000001</c:v>
                </c:pt>
                <c:pt idx="304">
                  <c:v>1.6761029999999999</c:v>
                </c:pt>
                <c:pt idx="305">
                  <c:v>1.6684589999999999</c:v>
                </c:pt>
                <c:pt idx="306">
                  <c:v>1.660814</c:v>
                </c:pt>
                <c:pt idx="307">
                  <c:v>1.65317</c:v>
                </c:pt>
                <c:pt idx="308">
                  <c:v>1.645526</c:v>
                </c:pt>
                <c:pt idx="309">
                  <c:v>1.6378820000000001</c:v>
                </c:pt>
                <c:pt idx="310">
                  <c:v>1.6302369999999999</c:v>
                </c:pt>
                <c:pt idx="311">
                  <c:v>1.622593</c:v>
                </c:pt>
                <c:pt idx="312">
                  <c:v>1.614949</c:v>
                </c:pt>
                <c:pt idx="313">
                  <c:v>1.6073040000000001</c:v>
                </c:pt>
                <c:pt idx="314">
                  <c:v>1.5996600000000001</c:v>
                </c:pt>
                <c:pt idx="315">
                  <c:v>1.5920160000000001</c:v>
                </c:pt>
                <c:pt idx="316">
                  <c:v>1.584371</c:v>
                </c:pt>
                <c:pt idx="317">
                  <c:v>1.576727</c:v>
                </c:pt>
                <c:pt idx="318">
                  <c:v>1.569083</c:v>
                </c:pt>
                <c:pt idx="319">
                  <c:v>1.561439</c:v>
                </c:pt>
                <c:pt idx="320">
                  <c:v>1.5537939999999999</c:v>
                </c:pt>
                <c:pt idx="321">
                  <c:v>1.5461499999999999</c:v>
                </c:pt>
                <c:pt idx="322">
                  <c:v>1.5385059999999999</c:v>
                </c:pt>
                <c:pt idx="323">
                  <c:v>1.530861</c:v>
                </c:pt>
                <c:pt idx="324">
                  <c:v>1.523217</c:v>
                </c:pt>
                <c:pt idx="325">
                  <c:v>1.5155730000000001</c:v>
                </c:pt>
                <c:pt idx="326">
                  <c:v>1.5079279999999999</c:v>
                </c:pt>
                <c:pt idx="327">
                  <c:v>1.500284</c:v>
                </c:pt>
                <c:pt idx="328">
                  <c:v>1.49264</c:v>
                </c:pt>
                <c:pt idx="329">
                  <c:v>1.484996</c:v>
                </c:pt>
                <c:pt idx="330">
                  <c:v>1.4773510000000001</c:v>
                </c:pt>
                <c:pt idx="331">
                  <c:v>1.4697070000000001</c:v>
                </c:pt>
                <c:pt idx="332">
                  <c:v>1.4620629999999999</c:v>
                </c:pt>
                <c:pt idx="333">
                  <c:v>1.454418</c:v>
                </c:pt>
                <c:pt idx="334">
                  <c:v>1.446774</c:v>
                </c:pt>
                <c:pt idx="335">
                  <c:v>1.43913</c:v>
                </c:pt>
                <c:pt idx="336">
                  <c:v>1.431486</c:v>
                </c:pt>
                <c:pt idx="337">
                  <c:v>1.4238409999999999</c:v>
                </c:pt>
                <c:pt idx="338">
                  <c:v>1.4161969999999999</c:v>
                </c:pt>
                <c:pt idx="339">
                  <c:v>1.4085529999999999</c:v>
                </c:pt>
                <c:pt idx="340">
                  <c:v>1.400908</c:v>
                </c:pt>
                <c:pt idx="341">
                  <c:v>1.3932640000000001</c:v>
                </c:pt>
                <c:pt idx="342">
                  <c:v>1.3856200000000001</c:v>
                </c:pt>
                <c:pt idx="343">
                  <c:v>1.3779749999999999</c:v>
                </c:pt>
                <c:pt idx="344">
                  <c:v>1.370331</c:v>
                </c:pt>
                <c:pt idx="345">
                  <c:v>1.362687</c:v>
                </c:pt>
                <c:pt idx="346">
                  <c:v>1.355043</c:v>
                </c:pt>
                <c:pt idx="347">
                  <c:v>1.3473980000000001</c:v>
                </c:pt>
                <c:pt idx="348">
                  <c:v>1.3397539999999999</c:v>
                </c:pt>
                <c:pt idx="349">
                  <c:v>1.3321099999999999</c:v>
                </c:pt>
                <c:pt idx="350">
                  <c:v>1.324465</c:v>
                </c:pt>
                <c:pt idx="351">
                  <c:v>1.316821</c:v>
                </c:pt>
                <c:pt idx="352">
                  <c:v>1.309177</c:v>
                </c:pt>
                <c:pt idx="353">
                  <c:v>1.3015330000000001</c:v>
                </c:pt>
                <c:pt idx="354">
                  <c:v>1.2938879999999999</c:v>
                </c:pt>
                <c:pt idx="355">
                  <c:v>1.2862439999999999</c:v>
                </c:pt>
                <c:pt idx="356">
                  <c:v>1.2786</c:v>
                </c:pt>
                <c:pt idx="357">
                  <c:v>1.2709550000000001</c:v>
                </c:pt>
                <c:pt idx="358">
                  <c:v>1.2633110000000001</c:v>
                </c:pt>
                <c:pt idx="359">
                  <c:v>1.2556670000000001</c:v>
                </c:pt>
                <c:pt idx="360">
                  <c:v>1.248022</c:v>
                </c:pt>
                <c:pt idx="361">
                  <c:v>1.240378</c:v>
                </c:pt>
                <c:pt idx="362">
                  <c:v>1.232734</c:v>
                </c:pt>
                <c:pt idx="363">
                  <c:v>1.22509</c:v>
                </c:pt>
                <c:pt idx="364">
                  <c:v>1.2174450000000001</c:v>
                </c:pt>
                <c:pt idx="365">
                  <c:v>1.2098009999999999</c:v>
                </c:pt>
                <c:pt idx="366">
                  <c:v>1.2021569999999999</c:v>
                </c:pt>
                <c:pt idx="367">
                  <c:v>1.194512</c:v>
                </c:pt>
                <c:pt idx="368">
                  <c:v>1.186868</c:v>
                </c:pt>
                <c:pt idx="369">
                  <c:v>1.179224</c:v>
                </c:pt>
                <c:pt idx="370">
                  <c:v>1.1715789999999999</c:v>
                </c:pt>
                <c:pt idx="371">
                  <c:v>1.1639349999999999</c:v>
                </c:pt>
                <c:pt idx="372">
                  <c:v>1.156291</c:v>
                </c:pt>
                <c:pt idx="373">
                  <c:v>1.148647</c:v>
                </c:pt>
                <c:pt idx="374">
                  <c:v>1.1410020000000001</c:v>
                </c:pt>
                <c:pt idx="375">
                  <c:v>1.1333580000000001</c:v>
                </c:pt>
                <c:pt idx="376">
                  <c:v>1.1257140000000001</c:v>
                </c:pt>
                <c:pt idx="377">
                  <c:v>1.118069</c:v>
                </c:pt>
                <c:pt idx="378">
                  <c:v>1.110425</c:v>
                </c:pt>
                <c:pt idx="379">
                  <c:v>1.102781</c:v>
                </c:pt>
                <c:pt idx="380">
                  <c:v>1.095137</c:v>
                </c:pt>
                <c:pt idx="381">
                  <c:v>1.0874919999999999</c:v>
                </c:pt>
                <c:pt idx="382">
                  <c:v>1.0798479999999999</c:v>
                </c:pt>
                <c:pt idx="383">
                  <c:v>1.0722039999999999</c:v>
                </c:pt>
                <c:pt idx="384">
                  <c:v>1.064559</c:v>
                </c:pt>
                <c:pt idx="385">
                  <c:v>1.056915</c:v>
                </c:pt>
                <c:pt idx="386">
                  <c:v>1.0492710000000001</c:v>
                </c:pt>
                <c:pt idx="387">
                  <c:v>1.0416259999999999</c:v>
                </c:pt>
                <c:pt idx="388">
                  <c:v>1.033982</c:v>
                </c:pt>
                <c:pt idx="389">
                  <c:v>1.026338</c:v>
                </c:pt>
                <c:pt idx="390">
                  <c:v>1.018694</c:v>
                </c:pt>
                <c:pt idx="391">
                  <c:v>1.0110490000000001</c:v>
                </c:pt>
                <c:pt idx="392">
                  <c:v>1.0034050000000001</c:v>
                </c:pt>
                <c:pt idx="393">
                  <c:v>0.99576100000000001</c:v>
                </c:pt>
                <c:pt idx="394">
                  <c:v>0.98811599999999999</c:v>
                </c:pt>
                <c:pt idx="395">
                  <c:v>0.98047200000000001</c:v>
                </c:pt>
                <c:pt idx="396">
                  <c:v>0.97282800000000003</c:v>
                </c:pt>
                <c:pt idx="397">
                  <c:v>0.96518300000000001</c:v>
                </c:pt>
                <c:pt idx="398">
                  <c:v>0.95753900000000003</c:v>
                </c:pt>
                <c:pt idx="399">
                  <c:v>0.94989500000000004</c:v>
                </c:pt>
                <c:pt idx="400">
                  <c:v>0.94225099999999995</c:v>
                </c:pt>
                <c:pt idx="401">
                  <c:v>0.93460600000000005</c:v>
                </c:pt>
                <c:pt idx="402">
                  <c:v>0.92696199999999995</c:v>
                </c:pt>
                <c:pt idx="403">
                  <c:v>0.91931799999999997</c:v>
                </c:pt>
                <c:pt idx="404">
                  <c:v>0.91167299999999996</c:v>
                </c:pt>
                <c:pt idx="405">
                  <c:v>0.90402899999999997</c:v>
                </c:pt>
                <c:pt idx="406">
                  <c:v>0.89638499999999999</c:v>
                </c:pt>
                <c:pt idx="407">
                  <c:v>0.888741</c:v>
                </c:pt>
                <c:pt idx="408">
                  <c:v>0.88109599999999999</c:v>
                </c:pt>
                <c:pt idx="409">
                  <c:v>0.87345200000000001</c:v>
                </c:pt>
                <c:pt idx="410">
                  <c:v>0.86580800000000002</c:v>
                </c:pt>
                <c:pt idx="411">
                  <c:v>0.85816300000000001</c:v>
                </c:pt>
                <c:pt idx="412">
                  <c:v>0.85051900000000002</c:v>
                </c:pt>
                <c:pt idx="413">
                  <c:v>0.84287500000000004</c:v>
                </c:pt>
                <c:pt idx="414">
                  <c:v>0.83523000000000003</c:v>
                </c:pt>
                <c:pt idx="415">
                  <c:v>0.82758600000000004</c:v>
                </c:pt>
                <c:pt idx="416">
                  <c:v>0.81994199999999995</c:v>
                </c:pt>
                <c:pt idx="417">
                  <c:v>0.81229799999999996</c:v>
                </c:pt>
                <c:pt idx="418">
                  <c:v>0.80465299999999995</c:v>
                </c:pt>
                <c:pt idx="419">
                  <c:v>0.79700899999999997</c:v>
                </c:pt>
                <c:pt idx="420">
                  <c:v>0.78936499999999998</c:v>
                </c:pt>
                <c:pt idx="421">
                  <c:v>0.78171999999999997</c:v>
                </c:pt>
                <c:pt idx="422">
                  <c:v>0.77407599999999999</c:v>
                </c:pt>
                <c:pt idx="423">
                  <c:v>0.766432</c:v>
                </c:pt>
                <c:pt idx="424">
                  <c:v>0.75878800000000002</c:v>
                </c:pt>
                <c:pt idx="425">
                  <c:v>0.75114300000000001</c:v>
                </c:pt>
                <c:pt idx="426">
                  <c:v>0.74349900000000002</c:v>
                </c:pt>
                <c:pt idx="427">
                  <c:v>0.73585500000000004</c:v>
                </c:pt>
                <c:pt idx="428">
                  <c:v>0.72821000000000002</c:v>
                </c:pt>
                <c:pt idx="429">
                  <c:v>0.72056600000000004</c:v>
                </c:pt>
                <c:pt idx="430">
                  <c:v>0.71292199999999994</c:v>
                </c:pt>
                <c:pt idx="431">
                  <c:v>0.70527700000000004</c:v>
                </c:pt>
                <c:pt idx="432">
                  <c:v>0.69763299999999995</c:v>
                </c:pt>
                <c:pt idx="433">
                  <c:v>0.68998899999999996</c:v>
                </c:pt>
                <c:pt idx="434">
                  <c:v>0.68234499999999998</c:v>
                </c:pt>
                <c:pt idx="435">
                  <c:v>0.67469999999999997</c:v>
                </c:pt>
                <c:pt idx="436">
                  <c:v>0.66705599999999998</c:v>
                </c:pt>
                <c:pt idx="437">
                  <c:v>0.659412</c:v>
                </c:pt>
                <c:pt idx="438">
                  <c:v>0.65176699999999999</c:v>
                </c:pt>
                <c:pt idx="439">
                  <c:v>0.644123</c:v>
                </c:pt>
                <c:pt idx="440">
                  <c:v>0.63647900000000002</c:v>
                </c:pt>
                <c:pt idx="441">
                  <c:v>0.628834</c:v>
                </c:pt>
                <c:pt idx="442">
                  <c:v>0.62119000000000002</c:v>
                </c:pt>
                <c:pt idx="443">
                  <c:v>0.61354600000000004</c:v>
                </c:pt>
                <c:pt idx="444">
                  <c:v>0.60590200000000005</c:v>
                </c:pt>
                <c:pt idx="445">
                  <c:v>0.59825700000000004</c:v>
                </c:pt>
              </c:numCache>
            </c:numRef>
          </c:cat>
          <c:val>
            <c:numRef>
              <c:f>Sheet1!$C$4:$C$449</c:f>
              <c:numCache>
                <c:formatCode>0.00E+00</c:formatCode>
                <c:ptCount val="446"/>
                <c:pt idx="0">
                  <c:v>628623</c:v>
                </c:pt>
                <c:pt idx="1">
                  <c:v>629301</c:v>
                </c:pt>
                <c:pt idx="2">
                  <c:v>646962</c:v>
                </c:pt>
                <c:pt idx="3">
                  <c:v>689750</c:v>
                </c:pt>
                <c:pt idx="4">
                  <c:v>761926</c:v>
                </c:pt>
                <c:pt idx="5">
                  <c:v>860561</c:v>
                </c:pt>
                <c:pt idx="6">
                  <c:v>1031650</c:v>
                </c:pt>
                <c:pt idx="7">
                  <c:v>1284200</c:v>
                </c:pt>
                <c:pt idx="8">
                  <c:v>1528300</c:v>
                </c:pt>
                <c:pt idx="9">
                  <c:v>1764660</c:v>
                </c:pt>
                <c:pt idx="10">
                  <c:v>1972740</c:v>
                </c:pt>
                <c:pt idx="11">
                  <c:v>2050530</c:v>
                </c:pt>
                <c:pt idx="12">
                  <c:v>1904810</c:v>
                </c:pt>
                <c:pt idx="13">
                  <c:v>1585550</c:v>
                </c:pt>
                <c:pt idx="14">
                  <c:v>1256260</c:v>
                </c:pt>
                <c:pt idx="15">
                  <c:v>1043420</c:v>
                </c:pt>
                <c:pt idx="16">
                  <c:v>943292</c:v>
                </c:pt>
                <c:pt idx="17">
                  <c:v>861855</c:v>
                </c:pt>
                <c:pt idx="18">
                  <c:v>788669</c:v>
                </c:pt>
                <c:pt idx="19">
                  <c:v>780815</c:v>
                </c:pt>
                <c:pt idx="20">
                  <c:v>813327</c:v>
                </c:pt>
                <c:pt idx="21">
                  <c:v>861302</c:v>
                </c:pt>
                <c:pt idx="22">
                  <c:v>909277</c:v>
                </c:pt>
                <c:pt idx="23">
                  <c:v>971908</c:v>
                </c:pt>
                <c:pt idx="24">
                  <c:v>1040800</c:v>
                </c:pt>
                <c:pt idx="25">
                  <c:v>1099390</c:v>
                </c:pt>
                <c:pt idx="26">
                  <c:v>1141890</c:v>
                </c:pt>
                <c:pt idx="27">
                  <c:v>1189730</c:v>
                </c:pt>
                <c:pt idx="28">
                  <c:v>1262400</c:v>
                </c:pt>
                <c:pt idx="29">
                  <c:v>1352650</c:v>
                </c:pt>
                <c:pt idx="30">
                  <c:v>1417460</c:v>
                </c:pt>
                <c:pt idx="31">
                  <c:v>1398860</c:v>
                </c:pt>
                <c:pt idx="32">
                  <c:v>1288120</c:v>
                </c:pt>
                <c:pt idx="33">
                  <c:v>1150760</c:v>
                </c:pt>
                <c:pt idx="34">
                  <c:v>1051480</c:v>
                </c:pt>
                <c:pt idx="35">
                  <c:v>1025530</c:v>
                </c:pt>
                <c:pt idx="36">
                  <c:v>1050490</c:v>
                </c:pt>
                <c:pt idx="37">
                  <c:v>1069400</c:v>
                </c:pt>
                <c:pt idx="38">
                  <c:v>1032130</c:v>
                </c:pt>
                <c:pt idx="39">
                  <c:v>941328</c:v>
                </c:pt>
                <c:pt idx="40">
                  <c:v>832435</c:v>
                </c:pt>
                <c:pt idx="41">
                  <c:v>749147</c:v>
                </c:pt>
                <c:pt idx="42">
                  <c:v>721033</c:v>
                </c:pt>
                <c:pt idx="43">
                  <c:v>749267</c:v>
                </c:pt>
                <c:pt idx="44">
                  <c:v>816455</c:v>
                </c:pt>
                <c:pt idx="45">
                  <c:v>915964</c:v>
                </c:pt>
                <c:pt idx="46">
                  <c:v>1050960</c:v>
                </c:pt>
                <c:pt idx="47">
                  <c:v>1190050</c:v>
                </c:pt>
                <c:pt idx="48">
                  <c:v>1256710</c:v>
                </c:pt>
                <c:pt idx="49">
                  <c:v>1193640</c:v>
                </c:pt>
                <c:pt idx="50">
                  <c:v>1028650</c:v>
                </c:pt>
                <c:pt idx="51">
                  <c:v>859311</c:v>
                </c:pt>
                <c:pt idx="52">
                  <c:v>771339</c:v>
                </c:pt>
                <c:pt idx="53">
                  <c:v>781147</c:v>
                </c:pt>
                <c:pt idx="54">
                  <c:v>870949</c:v>
                </c:pt>
                <c:pt idx="55">
                  <c:v>1048570</c:v>
                </c:pt>
                <c:pt idx="56">
                  <c:v>1286420</c:v>
                </c:pt>
                <c:pt idx="57">
                  <c:v>1485350</c:v>
                </c:pt>
                <c:pt idx="58">
                  <c:v>1559930</c:v>
                </c:pt>
                <c:pt idx="59">
                  <c:v>1491130</c:v>
                </c:pt>
                <c:pt idx="60">
                  <c:v>1324150</c:v>
                </c:pt>
                <c:pt idx="61">
                  <c:v>1125570</c:v>
                </c:pt>
                <c:pt idx="62">
                  <c:v>942951</c:v>
                </c:pt>
                <c:pt idx="63">
                  <c:v>800194</c:v>
                </c:pt>
                <c:pt idx="64">
                  <c:v>711440</c:v>
                </c:pt>
                <c:pt idx="65">
                  <c:v>671994</c:v>
                </c:pt>
                <c:pt idx="66">
                  <c:v>653716</c:v>
                </c:pt>
                <c:pt idx="67">
                  <c:v>643755</c:v>
                </c:pt>
                <c:pt idx="68">
                  <c:v>641749</c:v>
                </c:pt>
                <c:pt idx="69">
                  <c:v>641787</c:v>
                </c:pt>
                <c:pt idx="70">
                  <c:v>638204</c:v>
                </c:pt>
                <c:pt idx="71">
                  <c:v>623569</c:v>
                </c:pt>
                <c:pt idx="72">
                  <c:v>596467</c:v>
                </c:pt>
                <c:pt idx="73">
                  <c:v>561659</c:v>
                </c:pt>
                <c:pt idx="74">
                  <c:v>526152</c:v>
                </c:pt>
                <c:pt idx="75">
                  <c:v>494957</c:v>
                </c:pt>
                <c:pt idx="76">
                  <c:v>470527</c:v>
                </c:pt>
                <c:pt idx="77">
                  <c:v>454328</c:v>
                </c:pt>
                <c:pt idx="78">
                  <c:v>445985</c:v>
                </c:pt>
                <c:pt idx="79">
                  <c:v>440981</c:v>
                </c:pt>
                <c:pt idx="80">
                  <c:v>439003</c:v>
                </c:pt>
                <c:pt idx="81">
                  <c:v>441851</c:v>
                </c:pt>
                <c:pt idx="82">
                  <c:v>448756</c:v>
                </c:pt>
                <c:pt idx="83">
                  <c:v>461403</c:v>
                </c:pt>
                <c:pt idx="84">
                  <c:v>476111</c:v>
                </c:pt>
                <c:pt idx="85">
                  <c:v>479001</c:v>
                </c:pt>
                <c:pt idx="86">
                  <c:v>457696</c:v>
                </c:pt>
                <c:pt idx="87">
                  <c:v>416599</c:v>
                </c:pt>
                <c:pt idx="88">
                  <c:v>374854</c:v>
                </c:pt>
                <c:pt idx="89">
                  <c:v>350593</c:v>
                </c:pt>
                <c:pt idx="90">
                  <c:v>348781</c:v>
                </c:pt>
                <c:pt idx="91">
                  <c:v>365759</c:v>
                </c:pt>
                <c:pt idx="92">
                  <c:v>395671</c:v>
                </c:pt>
                <c:pt idx="93">
                  <c:v>438533</c:v>
                </c:pt>
                <c:pt idx="94">
                  <c:v>491520</c:v>
                </c:pt>
                <c:pt idx="95">
                  <c:v>537713</c:v>
                </c:pt>
                <c:pt idx="96">
                  <c:v>560073</c:v>
                </c:pt>
                <c:pt idx="97">
                  <c:v>570244</c:v>
                </c:pt>
                <c:pt idx="98">
                  <c:v>638739</c:v>
                </c:pt>
                <c:pt idx="99">
                  <c:v>807140</c:v>
                </c:pt>
                <c:pt idx="100">
                  <c:v>1089150</c:v>
                </c:pt>
                <c:pt idx="101">
                  <c:v>1565240</c:v>
                </c:pt>
                <c:pt idx="102">
                  <c:v>2125990</c:v>
                </c:pt>
                <c:pt idx="103">
                  <c:v>2469120</c:v>
                </c:pt>
                <c:pt idx="104">
                  <c:v>2382180</c:v>
                </c:pt>
                <c:pt idx="105">
                  <c:v>1955450</c:v>
                </c:pt>
                <c:pt idx="106">
                  <c:v>1475350</c:v>
                </c:pt>
                <c:pt idx="107">
                  <c:v>1136030</c:v>
                </c:pt>
                <c:pt idx="108">
                  <c:v>919475</c:v>
                </c:pt>
                <c:pt idx="109">
                  <c:v>728251</c:v>
                </c:pt>
                <c:pt idx="110">
                  <c:v>570254</c:v>
                </c:pt>
                <c:pt idx="111">
                  <c:v>492769</c:v>
                </c:pt>
                <c:pt idx="112">
                  <c:v>451659</c:v>
                </c:pt>
                <c:pt idx="113">
                  <c:v>427636</c:v>
                </c:pt>
                <c:pt idx="114">
                  <c:v>416534</c:v>
                </c:pt>
                <c:pt idx="115">
                  <c:v>412934</c:v>
                </c:pt>
                <c:pt idx="116">
                  <c:v>411888</c:v>
                </c:pt>
                <c:pt idx="117">
                  <c:v>413841</c:v>
                </c:pt>
                <c:pt idx="118">
                  <c:v>420333</c:v>
                </c:pt>
                <c:pt idx="119">
                  <c:v>433412</c:v>
                </c:pt>
                <c:pt idx="120">
                  <c:v>457147</c:v>
                </c:pt>
                <c:pt idx="121">
                  <c:v>513020</c:v>
                </c:pt>
                <c:pt idx="122">
                  <c:v>653883</c:v>
                </c:pt>
                <c:pt idx="123">
                  <c:v>901610</c:v>
                </c:pt>
                <c:pt idx="124">
                  <c:v>1261050</c:v>
                </c:pt>
                <c:pt idx="125">
                  <c:v>1803710</c:v>
                </c:pt>
                <c:pt idx="126">
                  <c:v>2377290</c:v>
                </c:pt>
                <c:pt idx="127">
                  <c:v>2641430</c:v>
                </c:pt>
                <c:pt idx="128">
                  <c:v>2412910</c:v>
                </c:pt>
                <c:pt idx="129">
                  <c:v>1859600</c:v>
                </c:pt>
                <c:pt idx="130">
                  <c:v>1343140</c:v>
                </c:pt>
                <c:pt idx="131">
                  <c:v>1060930</c:v>
                </c:pt>
                <c:pt idx="132">
                  <c:v>918422</c:v>
                </c:pt>
                <c:pt idx="133">
                  <c:v>752351</c:v>
                </c:pt>
                <c:pt idx="134">
                  <c:v>569440</c:v>
                </c:pt>
                <c:pt idx="135">
                  <c:v>461809</c:v>
                </c:pt>
                <c:pt idx="136">
                  <c:v>429125</c:v>
                </c:pt>
                <c:pt idx="137">
                  <c:v>465235</c:v>
                </c:pt>
                <c:pt idx="138">
                  <c:v>537318</c:v>
                </c:pt>
                <c:pt idx="139">
                  <c:v>602396</c:v>
                </c:pt>
                <c:pt idx="140">
                  <c:v>633427</c:v>
                </c:pt>
                <c:pt idx="141">
                  <c:v>617154</c:v>
                </c:pt>
                <c:pt idx="142">
                  <c:v>566831</c:v>
                </c:pt>
                <c:pt idx="143">
                  <c:v>505588</c:v>
                </c:pt>
                <c:pt idx="144">
                  <c:v>450092</c:v>
                </c:pt>
                <c:pt idx="145">
                  <c:v>406936</c:v>
                </c:pt>
                <c:pt idx="146">
                  <c:v>372492</c:v>
                </c:pt>
                <c:pt idx="147">
                  <c:v>343494</c:v>
                </c:pt>
                <c:pt idx="148">
                  <c:v>325227</c:v>
                </c:pt>
                <c:pt idx="149">
                  <c:v>323354</c:v>
                </c:pt>
                <c:pt idx="150">
                  <c:v>333284</c:v>
                </c:pt>
                <c:pt idx="151">
                  <c:v>342189</c:v>
                </c:pt>
                <c:pt idx="152">
                  <c:v>341714</c:v>
                </c:pt>
                <c:pt idx="153">
                  <c:v>334880</c:v>
                </c:pt>
                <c:pt idx="154">
                  <c:v>331462</c:v>
                </c:pt>
                <c:pt idx="155">
                  <c:v>335725</c:v>
                </c:pt>
                <c:pt idx="156">
                  <c:v>344082</c:v>
                </c:pt>
                <c:pt idx="157">
                  <c:v>355997</c:v>
                </c:pt>
                <c:pt idx="158">
                  <c:v>364590</c:v>
                </c:pt>
                <c:pt idx="159">
                  <c:v>362598</c:v>
                </c:pt>
                <c:pt idx="160">
                  <c:v>346969</c:v>
                </c:pt>
                <c:pt idx="161">
                  <c:v>328861</c:v>
                </c:pt>
                <c:pt idx="162">
                  <c:v>327174</c:v>
                </c:pt>
                <c:pt idx="163">
                  <c:v>339014</c:v>
                </c:pt>
                <c:pt idx="164">
                  <c:v>341355</c:v>
                </c:pt>
                <c:pt idx="165">
                  <c:v>318570</c:v>
                </c:pt>
                <c:pt idx="166">
                  <c:v>280737</c:v>
                </c:pt>
                <c:pt idx="167">
                  <c:v>251937</c:v>
                </c:pt>
                <c:pt idx="168">
                  <c:v>238712</c:v>
                </c:pt>
                <c:pt idx="169">
                  <c:v>237359</c:v>
                </c:pt>
                <c:pt idx="170">
                  <c:v>242467</c:v>
                </c:pt>
                <c:pt idx="171">
                  <c:v>253854</c:v>
                </c:pt>
                <c:pt idx="172">
                  <c:v>268256</c:v>
                </c:pt>
                <c:pt idx="173">
                  <c:v>285536</c:v>
                </c:pt>
                <c:pt idx="174">
                  <c:v>308784</c:v>
                </c:pt>
                <c:pt idx="175">
                  <c:v>335219</c:v>
                </c:pt>
                <c:pt idx="176">
                  <c:v>354740</c:v>
                </c:pt>
                <c:pt idx="177">
                  <c:v>358653</c:v>
                </c:pt>
                <c:pt idx="178">
                  <c:v>354894</c:v>
                </c:pt>
                <c:pt idx="179">
                  <c:v>360278</c:v>
                </c:pt>
                <c:pt idx="180">
                  <c:v>371353</c:v>
                </c:pt>
                <c:pt idx="181">
                  <c:v>368984</c:v>
                </c:pt>
                <c:pt idx="182">
                  <c:v>345801</c:v>
                </c:pt>
                <c:pt idx="183">
                  <c:v>318321</c:v>
                </c:pt>
                <c:pt idx="184">
                  <c:v>306748</c:v>
                </c:pt>
                <c:pt idx="185">
                  <c:v>319754</c:v>
                </c:pt>
                <c:pt idx="186">
                  <c:v>351107</c:v>
                </c:pt>
                <c:pt idx="187">
                  <c:v>387540</c:v>
                </c:pt>
                <c:pt idx="188">
                  <c:v>421497</c:v>
                </c:pt>
                <c:pt idx="189">
                  <c:v>446489</c:v>
                </c:pt>
                <c:pt idx="190">
                  <c:v>459641</c:v>
                </c:pt>
                <c:pt idx="191">
                  <c:v>458704</c:v>
                </c:pt>
                <c:pt idx="192">
                  <c:v>437796</c:v>
                </c:pt>
                <c:pt idx="193">
                  <c:v>400605</c:v>
                </c:pt>
                <c:pt idx="194">
                  <c:v>361625</c:v>
                </c:pt>
                <c:pt idx="195">
                  <c:v>337580</c:v>
                </c:pt>
                <c:pt idx="196">
                  <c:v>337667</c:v>
                </c:pt>
                <c:pt idx="197">
                  <c:v>360094</c:v>
                </c:pt>
                <c:pt idx="198">
                  <c:v>408607</c:v>
                </c:pt>
                <c:pt idx="199">
                  <c:v>481457</c:v>
                </c:pt>
                <c:pt idx="200">
                  <c:v>569998</c:v>
                </c:pt>
                <c:pt idx="201">
                  <c:v>641520</c:v>
                </c:pt>
                <c:pt idx="202">
                  <c:v>670794</c:v>
                </c:pt>
                <c:pt idx="203">
                  <c:v>651951</c:v>
                </c:pt>
                <c:pt idx="204">
                  <c:v>606480</c:v>
                </c:pt>
                <c:pt idx="205">
                  <c:v>549296</c:v>
                </c:pt>
                <c:pt idx="206">
                  <c:v>487218</c:v>
                </c:pt>
                <c:pt idx="207">
                  <c:v>425174</c:v>
                </c:pt>
                <c:pt idx="208">
                  <c:v>388410</c:v>
                </c:pt>
                <c:pt idx="209">
                  <c:v>396046</c:v>
                </c:pt>
                <c:pt idx="210">
                  <c:v>444422</c:v>
                </c:pt>
                <c:pt idx="211">
                  <c:v>524538</c:v>
                </c:pt>
                <c:pt idx="212">
                  <c:v>622429</c:v>
                </c:pt>
                <c:pt idx="213">
                  <c:v>729542</c:v>
                </c:pt>
                <c:pt idx="214">
                  <c:v>837186</c:v>
                </c:pt>
                <c:pt idx="215">
                  <c:v>909749</c:v>
                </c:pt>
                <c:pt idx="216">
                  <c:v>915505</c:v>
                </c:pt>
                <c:pt idx="217">
                  <c:v>843693</c:v>
                </c:pt>
                <c:pt idx="218">
                  <c:v>726645</c:v>
                </c:pt>
                <c:pt idx="219">
                  <c:v>604694</c:v>
                </c:pt>
                <c:pt idx="220">
                  <c:v>516506</c:v>
                </c:pt>
                <c:pt idx="221">
                  <c:v>488584</c:v>
                </c:pt>
                <c:pt idx="222">
                  <c:v>525377</c:v>
                </c:pt>
                <c:pt idx="223">
                  <c:v>610201</c:v>
                </c:pt>
                <c:pt idx="224">
                  <c:v>691363</c:v>
                </c:pt>
                <c:pt idx="225">
                  <c:v>726266</c:v>
                </c:pt>
                <c:pt idx="226">
                  <c:v>716067</c:v>
                </c:pt>
                <c:pt idx="227">
                  <c:v>689089</c:v>
                </c:pt>
                <c:pt idx="228">
                  <c:v>664873</c:v>
                </c:pt>
                <c:pt idx="229">
                  <c:v>638486</c:v>
                </c:pt>
                <c:pt idx="230">
                  <c:v>609200</c:v>
                </c:pt>
                <c:pt idx="231">
                  <c:v>588628</c:v>
                </c:pt>
                <c:pt idx="232">
                  <c:v>583144</c:v>
                </c:pt>
                <c:pt idx="233">
                  <c:v>583920</c:v>
                </c:pt>
                <c:pt idx="234">
                  <c:v>586386</c:v>
                </c:pt>
                <c:pt idx="235">
                  <c:v>600832</c:v>
                </c:pt>
                <c:pt idx="236">
                  <c:v>631852</c:v>
                </c:pt>
                <c:pt idx="237">
                  <c:v>677334</c:v>
                </c:pt>
                <c:pt idx="238">
                  <c:v>722287</c:v>
                </c:pt>
                <c:pt idx="239">
                  <c:v>742227</c:v>
                </c:pt>
                <c:pt idx="240">
                  <c:v>731850</c:v>
                </c:pt>
                <c:pt idx="241">
                  <c:v>708781</c:v>
                </c:pt>
                <c:pt idx="242">
                  <c:v>702231</c:v>
                </c:pt>
                <c:pt idx="243">
                  <c:v>728088</c:v>
                </c:pt>
                <c:pt idx="244">
                  <c:v>781055</c:v>
                </c:pt>
                <c:pt idx="245">
                  <c:v>839661</c:v>
                </c:pt>
                <c:pt idx="246">
                  <c:v>881705</c:v>
                </c:pt>
                <c:pt idx="247">
                  <c:v>902889</c:v>
                </c:pt>
                <c:pt idx="248">
                  <c:v>907749</c:v>
                </c:pt>
                <c:pt idx="249">
                  <c:v>911650</c:v>
                </c:pt>
                <c:pt idx="250">
                  <c:v>935749</c:v>
                </c:pt>
                <c:pt idx="251">
                  <c:v>969130</c:v>
                </c:pt>
                <c:pt idx="252">
                  <c:v>1011310</c:v>
                </c:pt>
                <c:pt idx="253">
                  <c:v>1091490</c:v>
                </c:pt>
                <c:pt idx="254">
                  <c:v>1205010</c:v>
                </c:pt>
                <c:pt idx="255">
                  <c:v>1339990</c:v>
                </c:pt>
                <c:pt idx="256">
                  <c:v>1436080</c:v>
                </c:pt>
                <c:pt idx="257">
                  <c:v>1550180</c:v>
                </c:pt>
                <c:pt idx="258">
                  <c:v>1763820</c:v>
                </c:pt>
                <c:pt idx="259">
                  <c:v>1982550</c:v>
                </c:pt>
                <c:pt idx="260">
                  <c:v>2008460</c:v>
                </c:pt>
                <c:pt idx="261">
                  <c:v>1764160</c:v>
                </c:pt>
                <c:pt idx="262">
                  <c:v>1397570</c:v>
                </c:pt>
                <c:pt idx="263">
                  <c:v>1102270</c:v>
                </c:pt>
                <c:pt idx="264">
                  <c:v>929052</c:v>
                </c:pt>
                <c:pt idx="265">
                  <c:v>814071</c:v>
                </c:pt>
                <c:pt idx="266">
                  <c:v>692276</c:v>
                </c:pt>
                <c:pt idx="267">
                  <c:v>604405</c:v>
                </c:pt>
                <c:pt idx="268">
                  <c:v>552877</c:v>
                </c:pt>
                <c:pt idx="269">
                  <c:v>515875</c:v>
                </c:pt>
                <c:pt idx="270">
                  <c:v>489629</c:v>
                </c:pt>
                <c:pt idx="271">
                  <c:v>470651</c:v>
                </c:pt>
                <c:pt idx="272">
                  <c:v>454713</c:v>
                </c:pt>
                <c:pt idx="273">
                  <c:v>437514</c:v>
                </c:pt>
                <c:pt idx="274">
                  <c:v>417908</c:v>
                </c:pt>
                <c:pt idx="275">
                  <c:v>398551</c:v>
                </c:pt>
                <c:pt idx="276">
                  <c:v>379786</c:v>
                </c:pt>
                <c:pt idx="277">
                  <c:v>362925</c:v>
                </c:pt>
                <c:pt idx="278">
                  <c:v>347953</c:v>
                </c:pt>
                <c:pt idx="279">
                  <c:v>334639</c:v>
                </c:pt>
                <c:pt idx="280">
                  <c:v>322334</c:v>
                </c:pt>
                <c:pt idx="281">
                  <c:v>310155</c:v>
                </c:pt>
                <c:pt idx="282">
                  <c:v>299353</c:v>
                </c:pt>
                <c:pt idx="283">
                  <c:v>293294</c:v>
                </c:pt>
                <c:pt idx="284">
                  <c:v>291366</c:v>
                </c:pt>
                <c:pt idx="285">
                  <c:v>292239</c:v>
                </c:pt>
                <c:pt idx="286">
                  <c:v>293718</c:v>
                </c:pt>
                <c:pt idx="287">
                  <c:v>295268</c:v>
                </c:pt>
                <c:pt idx="288">
                  <c:v>296459</c:v>
                </c:pt>
                <c:pt idx="289">
                  <c:v>298819</c:v>
                </c:pt>
                <c:pt idx="290">
                  <c:v>304370</c:v>
                </c:pt>
                <c:pt idx="291">
                  <c:v>313368</c:v>
                </c:pt>
                <c:pt idx="292">
                  <c:v>322124</c:v>
                </c:pt>
                <c:pt idx="293">
                  <c:v>325453</c:v>
                </c:pt>
                <c:pt idx="294">
                  <c:v>321955</c:v>
                </c:pt>
                <c:pt idx="295">
                  <c:v>316164</c:v>
                </c:pt>
                <c:pt idx="296">
                  <c:v>314925</c:v>
                </c:pt>
                <c:pt idx="297">
                  <c:v>320500</c:v>
                </c:pt>
                <c:pt idx="298">
                  <c:v>329790</c:v>
                </c:pt>
                <c:pt idx="299">
                  <c:v>338476</c:v>
                </c:pt>
                <c:pt idx="300">
                  <c:v>345098</c:v>
                </c:pt>
                <c:pt idx="301">
                  <c:v>351108</c:v>
                </c:pt>
                <c:pt idx="302">
                  <c:v>354668</c:v>
                </c:pt>
                <c:pt idx="303">
                  <c:v>355297</c:v>
                </c:pt>
                <c:pt idx="304">
                  <c:v>353979</c:v>
                </c:pt>
                <c:pt idx="305">
                  <c:v>351799</c:v>
                </c:pt>
                <c:pt idx="306">
                  <c:v>351029</c:v>
                </c:pt>
                <c:pt idx="307">
                  <c:v>348207</c:v>
                </c:pt>
                <c:pt idx="308">
                  <c:v>339697</c:v>
                </c:pt>
                <c:pt idx="309">
                  <c:v>326117</c:v>
                </c:pt>
                <c:pt idx="310">
                  <c:v>313402</c:v>
                </c:pt>
                <c:pt idx="311">
                  <c:v>305014</c:v>
                </c:pt>
                <c:pt idx="312">
                  <c:v>300578</c:v>
                </c:pt>
                <c:pt idx="313">
                  <c:v>298412</c:v>
                </c:pt>
                <c:pt idx="314">
                  <c:v>295600</c:v>
                </c:pt>
                <c:pt idx="315">
                  <c:v>292400</c:v>
                </c:pt>
                <c:pt idx="316">
                  <c:v>288709</c:v>
                </c:pt>
                <c:pt idx="317">
                  <c:v>282909</c:v>
                </c:pt>
                <c:pt idx="318">
                  <c:v>274635</c:v>
                </c:pt>
                <c:pt idx="319">
                  <c:v>265361</c:v>
                </c:pt>
                <c:pt idx="320">
                  <c:v>259490</c:v>
                </c:pt>
                <c:pt idx="321">
                  <c:v>257492</c:v>
                </c:pt>
                <c:pt idx="322">
                  <c:v>258259</c:v>
                </c:pt>
                <c:pt idx="323">
                  <c:v>260167</c:v>
                </c:pt>
                <c:pt idx="324">
                  <c:v>264747</c:v>
                </c:pt>
                <c:pt idx="325">
                  <c:v>272380</c:v>
                </c:pt>
                <c:pt idx="326">
                  <c:v>278356</c:v>
                </c:pt>
                <c:pt idx="327">
                  <c:v>277385</c:v>
                </c:pt>
                <c:pt idx="328">
                  <c:v>270994</c:v>
                </c:pt>
                <c:pt idx="329">
                  <c:v>266891</c:v>
                </c:pt>
                <c:pt idx="330">
                  <c:v>269508</c:v>
                </c:pt>
                <c:pt idx="331">
                  <c:v>277364</c:v>
                </c:pt>
                <c:pt idx="332">
                  <c:v>288011</c:v>
                </c:pt>
                <c:pt idx="333">
                  <c:v>298667</c:v>
                </c:pt>
                <c:pt idx="334">
                  <c:v>306482</c:v>
                </c:pt>
                <c:pt idx="335">
                  <c:v>309700</c:v>
                </c:pt>
                <c:pt idx="336">
                  <c:v>309152</c:v>
                </c:pt>
                <c:pt idx="337">
                  <c:v>306703</c:v>
                </c:pt>
                <c:pt idx="338">
                  <c:v>306028</c:v>
                </c:pt>
                <c:pt idx="339">
                  <c:v>307346</c:v>
                </c:pt>
                <c:pt idx="340">
                  <c:v>313575</c:v>
                </c:pt>
                <c:pt idx="341">
                  <c:v>334679</c:v>
                </c:pt>
                <c:pt idx="342">
                  <c:v>364868</c:v>
                </c:pt>
                <c:pt idx="343">
                  <c:v>411616</c:v>
                </c:pt>
                <c:pt idx="344">
                  <c:v>476863</c:v>
                </c:pt>
                <c:pt idx="345">
                  <c:v>533825</c:v>
                </c:pt>
                <c:pt idx="346">
                  <c:v>540657</c:v>
                </c:pt>
                <c:pt idx="347">
                  <c:v>484886</c:v>
                </c:pt>
                <c:pt idx="348">
                  <c:v>402460</c:v>
                </c:pt>
                <c:pt idx="349">
                  <c:v>350329</c:v>
                </c:pt>
                <c:pt idx="350">
                  <c:v>340731</c:v>
                </c:pt>
                <c:pt idx="351">
                  <c:v>387567</c:v>
                </c:pt>
                <c:pt idx="352">
                  <c:v>481707</c:v>
                </c:pt>
                <c:pt idx="353">
                  <c:v>581089</c:v>
                </c:pt>
                <c:pt idx="354">
                  <c:v>622869</c:v>
                </c:pt>
                <c:pt idx="355">
                  <c:v>586634</c:v>
                </c:pt>
                <c:pt idx="356">
                  <c:v>508884</c:v>
                </c:pt>
                <c:pt idx="357">
                  <c:v>440266</c:v>
                </c:pt>
                <c:pt idx="358">
                  <c:v>395680</c:v>
                </c:pt>
                <c:pt idx="359">
                  <c:v>358202</c:v>
                </c:pt>
                <c:pt idx="360">
                  <c:v>317788</c:v>
                </c:pt>
                <c:pt idx="361">
                  <c:v>290111</c:v>
                </c:pt>
                <c:pt idx="362">
                  <c:v>267683</c:v>
                </c:pt>
                <c:pt idx="363">
                  <c:v>247719</c:v>
                </c:pt>
                <c:pt idx="364">
                  <c:v>228722</c:v>
                </c:pt>
                <c:pt idx="365">
                  <c:v>209998</c:v>
                </c:pt>
                <c:pt idx="366">
                  <c:v>193431</c:v>
                </c:pt>
                <c:pt idx="367">
                  <c:v>178355</c:v>
                </c:pt>
                <c:pt idx="368">
                  <c:v>164707</c:v>
                </c:pt>
                <c:pt idx="369">
                  <c:v>155172</c:v>
                </c:pt>
                <c:pt idx="370">
                  <c:v>150702</c:v>
                </c:pt>
                <c:pt idx="371">
                  <c:v>147657</c:v>
                </c:pt>
                <c:pt idx="372">
                  <c:v>144027</c:v>
                </c:pt>
                <c:pt idx="373">
                  <c:v>139828</c:v>
                </c:pt>
                <c:pt idx="374">
                  <c:v>136176</c:v>
                </c:pt>
                <c:pt idx="375">
                  <c:v>133043</c:v>
                </c:pt>
                <c:pt idx="376">
                  <c:v>129972</c:v>
                </c:pt>
                <c:pt idx="377">
                  <c:v>129073</c:v>
                </c:pt>
                <c:pt idx="378">
                  <c:v>131970</c:v>
                </c:pt>
                <c:pt idx="379">
                  <c:v>136041</c:v>
                </c:pt>
                <c:pt idx="380">
                  <c:v>137541</c:v>
                </c:pt>
                <c:pt idx="381">
                  <c:v>136369</c:v>
                </c:pt>
                <c:pt idx="382">
                  <c:v>135355</c:v>
                </c:pt>
                <c:pt idx="383">
                  <c:v>136276</c:v>
                </c:pt>
                <c:pt idx="384">
                  <c:v>138465</c:v>
                </c:pt>
                <c:pt idx="385">
                  <c:v>142014</c:v>
                </c:pt>
                <c:pt idx="386">
                  <c:v>147319</c:v>
                </c:pt>
                <c:pt idx="387">
                  <c:v>153418</c:v>
                </c:pt>
                <c:pt idx="388">
                  <c:v>160053</c:v>
                </c:pt>
                <c:pt idx="389">
                  <c:v>167907</c:v>
                </c:pt>
                <c:pt idx="390">
                  <c:v>179339</c:v>
                </c:pt>
                <c:pt idx="391">
                  <c:v>192539</c:v>
                </c:pt>
                <c:pt idx="392">
                  <c:v>206536</c:v>
                </c:pt>
                <c:pt idx="393">
                  <c:v>221438</c:v>
                </c:pt>
                <c:pt idx="394">
                  <c:v>238001</c:v>
                </c:pt>
                <c:pt idx="395">
                  <c:v>256958</c:v>
                </c:pt>
                <c:pt idx="396">
                  <c:v>277827</c:v>
                </c:pt>
                <c:pt idx="397">
                  <c:v>299442</c:v>
                </c:pt>
                <c:pt idx="398">
                  <c:v>320231</c:v>
                </c:pt>
                <c:pt idx="399">
                  <c:v>338897</c:v>
                </c:pt>
                <c:pt idx="400">
                  <c:v>355749</c:v>
                </c:pt>
                <c:pt idx="401">
                  <c:v>371982</c:v>
                </c:pt>
                <c:pt idx="402">
                  <c:v>389470</c:v>
                </c:pt>
                <c:pt idx="403">
                  <c:v>407530</c:v>
                </c:pt>
                <c:pt idx="404">
                  <c:v>424757</c:v>
                </c:pt>
                <c:pt idx="405">
                  <c:v>439938</c:v>
                </c:pt>
                <c:pt idx="406">
                  <c:v>452932</c:v>
                </c:pt>
                <c:pt idx="407">
                  <c:v>461842</c:v>
                </c:pt>
                <c:pt idx="408">
                  <c:v>465311</c:v>
                </c:pt>
                <c:pt idx="409">
                  <c:v>463867</c:v>
                </c:pt>
                <c:pt idx="410">
                  <c:v>459082</c:v>
                </c:pt>
                <c:pt idx="411">
                  <c:v>452240</c:v>
                </c:pt>
                <c:pt idx="412">
                  <c:v>444676</c:v>
                </c:pt>
                <c:pt idx="413">
                  <c:v>436330</c:v>
                </c:pt>
                <c:pt idx="414">
                  <c:v>426530</c:v>
                </c:pt>
                <c:pt idx="415">
                  <c:v>414661</c:v>
                </c:pt>
                <c:pt idx="416">
                  <c:v>400118</c:v>
                </c:pt>
                <c:pt idx="417">
                  <c:v>382121</c:v>
                </c:pt>
                <c:pt idx="418">
                  <c:v>361571</c:v>
                </c:pt>
                <c:pt idx="419">
                  <c:v>339683</c:v>
                </c:pt>
                <c:pt idx="420">
                  <c:v>319001</c:v>
                </c:pt>
                <c:pt idx="421">
                  <c:v>300851</c:v>
                </c:pt>
                <c:pt idx="422">
                  <c:v>284112</c:v>
                </c:pt>
                <c:pt idx="423">
                  <c:v>267150</c:v>
                </c:pt>
                <c:pt idx="424">
                  <c:v>249777</c:v>
                </c:pt>
                <c:pt idx="425">
                  <c:v>233446</c:v>
                </c:pt>
                <c:pt idx="426">
                  <c:v>220965</c:v>
                </c:pt>
                <c:pt idx="427">
                  <c:v>211511</c:v>
                </c:pt>
                <c:pt idx="428">
                  <c:v>202638</c:v>
                </c:pt>
                <c:pt idx="429">
                  <c:v>194125</c:v>
                </c:pt>
                <c:pt idx="430">
                  <c:v>186077</c:v>
                </c:pt>
                <c:pt idx="431">
                  <c:v>176566</c:v>
                </c:pt>
                <c:pt idx="432">
                  <c:v>162410</c:v>
                </c:pt>
                <c:pt idx="433">
                  <c:v>143289</c:v>
                </c:pt>
                <c:pt idx="434">
                  <c:v>121817</c:v>
                </c:pt>
                <c:pt idx="435">
                  <c:v>104939</c:v>
                </c:pt>
                <c:pt idx="436">
                  <c:v>95290</c:v>
                </c:pt>
                <c:pt idx="437">
                  <c:v>91061.3</c:v>
                </c:pt>
                <c:pt idx="438">
                  <c:v>89655.6</c:v>
                </c:pt>
                <c:pt idx="439">
                  <c:v>90776.6</c:v>
                </c:pt>
                <c:pt idx="440">
                  <c:v>94184.6</c:v>
                </c:pt>
                <c:pt idx="441">
                  <c:v>98109.5</c:v>
                </c:pt>
                <c:pt idx="442">
                  <c:v>98734.2</c:v>
                </c:pt>
                <c:pt idx="443">
                  <c:v>93732.4</c:v>
                </c:pt>
                <c:pt idx="444">
                  <c:v>84568</c:v>
                </c:pt>
                <c:pt idx="445">
                  <c:v>74803.1999999999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9C31-4A1B-9DD8-F246F11BD6D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441468776"/>
        <c:axId val="441468384"/>
      </c:lineChart>
      <c:catAx>
        <c:axId val="44146877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dirty="0"/>
                  <a:t>Chemical shift (ppm)</a:t>
                </a:r>
                <a:endParaRPr lang="ja-JP" altLang="en-US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0.00_ 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41468384"/>
        <c:crosses val="autoZero"/>
        <c:auto val="1"/>
        <c:lblAlgn val="ctr"/>
        <c:lblOffset val="100"/>
        <c:noMultiLvlLbl val="0"/>
      </c:catAx>
      <c:valAx>
        <c:axId val="441468384"/>
        <c:scaling>
          <c:orientation val="minMax"/>
        </c:scaling>
        <c:delete val="1"/>
        <c:axPos val="l"/>
        <c:numFmt formatCode="0.00E+00" sourceLinked="1"/>
        <c:majorTickMark val="none"/>
        <c:minorTickMark val="none"/>
        <c:tickLblPos val="nextTo"/>
        <c:crossAx val="44146877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3.4864391448732351E-2"/>
          <c:y val="2.3543711743399497E-2"/>
          <c:w val="0.52063473602835042"/>
          <c:h val="0.1770697224468281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900"/>
      </a:pPr>
      <a:endParaRPr lang="ja-JP"/>
    </a:p>
  </c:txPr>
  <c:externalData r:id="rId4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8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A172</a:t>
            </a:r>
            <a:endParaRPr lang="ja-JP"/>
          </a:p>
        </c:rich>
      </c:tx>
      <c:layout>
        <c:manualLayout>
          <c:xMode val="edge"/>
          <c:yMode val="edge"/>
          <c:x val="0.483396959586051"/>
          <c:y val="2.987852146018922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8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35562970033122532"/>
          <c:y val="0.12370570225853313"/>
          <c:w val="0.56733986961620986"/>
          <c:h val="0.6641833992632965"/>
        </c:manualLayout>
      </c:layout>
      <c:lineChart>
        <c:grouping val="standard"/>
        <c:varyColors val="0"/>
        <c:ser>
          <c:idx val="0"/>
          <c:order val="0"/>
          <c:tx>
            <c:strRef>
              <c:f>A172まとめ!$A$21</c:f>
              <c:strCache>
                <c:ptCount val="1"/>
                <c:pt idx="0">
                  <c:v>Glc+/Gln+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A172まとめ!$G$21:$J$21</c:f>
                <c:numCache>
                  <c:formatCode>General</c:formatCode>
                  <c:ptCount val="4"/>
                  <c:pt idx="0">
                    <c:v>2.1448905695991918E-2</c:v>
                  </c:pt>
                  <c:pt idx="1">
                    <c:v>1.1793501035174694E-2</c:v>
                  </c:pt>
                  <c:pt idx="2">
                    <c:v>1.6354960171832345E-2</c:v>
                  </c:pt>
                  <c:pt idx="3">
                    <c:v>2.9822735547825847E-2</c:v>
                  </c:pt>
                </c:numCache>
              </c:numRef>
            </c:plus>
            <c:minus>
              <c:numRef>
                <c:f>A172まとめ!$G$21:$J$21</c:f>
                <c:numCache>
                  <c:formatCode>General</c:formatCode>
                  <c:ptCount val="4"/>
                  <c:pt idx="0">
                    <c:v>2.1448905695991918E-2</c:v>
                  </c:pt>
                  <c:pt idx="1">
                    <c:v>1.1793501035174694E-2</c:v>
                  </c:pt>
                  <c:pt idx="2">
                    <c:v>1.6354960171832345E-2</c:v>
                  </c:pt>
                  <c:pt idx="3">
                    <c:v>2.982273554782584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A172まとめ!$B$20:$E$20</c:f>
              <c:numCache>
                <c:formatCode>General</c:formatCode>
                <c:ptCount val="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</c:numCache>
            </c:numRef>
          </c:cat>
          <c:val>
            <c:numRef>
              <c:f>A172まとめ!$B$21:$E$21</c:f>
              <c:numCache>
                <c:formatCode>0.0000</c:formatCode>
                <c:ptCount val="4"/>
                <c:pt idx="0">
                  <c:v>0.15103333333333332</c:v>
                </c:pt>
                <c:pt idx="1">
                  <c:v>0.17179999999999998</c:v>
                </c:pt>
                <c:pt idx="2">
                  <c:v>0.21708333333333332</c:v>
                </c:pt>
                <c:pt idx="3">
                  <c:v>0.3238333333333333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A968-4422-9DE8-F18A2142950B}"/>
            </c:ext>
          </c:extLst>
        </c:ser>
        <c:ser>
          <c:idx val="1"/>
          <c:order val="1"/>
          <c:tx>
            <c:strRef>
              <c:f>A172まとめ!$A$22</c:f>
              <c:strCache>
                <c:ptCount val="1"/>
                <c:pt idx="0">
                  <c:v>Glc-/Gln+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A172まとめ!$G$22:$J$22</c:f>
                <c:numCache>
                  <c:formatCode>General</c:formatCode>
                  <c:ptCount val="4"/>
                  <c:pt idx="0">
                    <c:v>2.1448905695991918E-2</c:v>
                  </c:pt>
                  <c:pt idx="1">
                    <c:v>1.2859939951475495E-2</c:v>
                  </c:pt>
                  <c:pt idx="2">
                    <c:v>8.7838235157336568E-3</c:v>
                  </c:pt>
                  <c:pt idx="3">
                    <c:v>5.390320542932074E-3</c:v>
                  </c:pt>
                </c:numCache>
              </c:numRef>
            </c:plus>
            <c:minus>
              <c:numRef>
                <c:f>A172まとめ!$G$22:$J$22</c:f>
                <c:numCache>
                  <c:formatCode>General</c:formatCode>
                  <c:ptCount val="4"/>
                  <c:pt idx="0">
                    <c:v>2.1448905695991918E-2</c:v>
                  </c:pt>
                  <c:pt idx="1">
                    <c:v>1.2859939951475495E-2</c:v>
                  </c:pt>
                  <c:pt idx="2">
                    <c:v>8.7838235157336568E-3</c:v>
                  </c:pt>
                  <c:pt idx="3">
                    <c:v>5.390320542932074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A172まとめ!$B$20:$E$20</c:f>
              <c:numCache>
                <c:formatCode>General</c:formatCode>
                <c:ptCount val="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</c:numCache>
            </c:numRef>
          </c:cat>
          <c:val>
            <c:numRef>
              <c:f>A172まとめ!$B$22:$E$22</c:f>
              <c:numCache>
                <c:formatCode>0.0000</c:formatCode>
                <c:ptCount val="4"/>
                <c:pt idx="0">
                  <c:v>0.15103333333333332</c:v>
                </c:pt>
                <c:pt idx="1">
                  <c:v>0.13588333333333333</c:v>
                </c:pt>
                <c:pt idx="2">
                  <c:v>9.3266666666666678E-2</c:v>
                </c:pt>
                <c:pt idx="3">
                  <c:v>8.6833333333333332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A968-4422-9DE8-F18A2142950B}"/>
            </c:ext>
          </c:extLst>
        </c:ser>
        <c:ser>
          <c:idx val="2"/>
          <c:order val="2"/>
          <c:tx>
            <c:strRef>
              <c:f>A172まとめ!$A$23</c:f>
              <c:strCache>
                <c:ptCount val="1"/>
                <c:pt idx="0">
                  <c:v>Glc+/Gln-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A172まとめ!$G$23:$J$23</c:f>
                <c:numCache>
                  <c:formatCode>General</c:formatCode>
                  <c:ptCount val="4"/>
                  <c:pt idx="0">
                    <c:v>2.1448905695991918E-2</c:v>
                  </c:pt>
                  <c:pt idx="1">
                    <c:v>1.1793501035174694E-2</c:v>
                  </c:pt>
                  <c:pt idx="2">
                    <c:v>1.6354960171832345E-2</c:v>
                  </c:pt>
                  <c:pt idx="3">
                    <c:v>2.9822735547825847E-2</c:v>
                  </c:pt>
                </c:numCache>
              </c:numRef>
            </c:plus>
            <c:minus>
              <c:numRef>
                <c:f>A172まとめ!$G$23:$J$23</c:f>
                <c:numCache>
                  <c:formatCode>General</c:formatCode>
                  <c:ptCount val="4"/>
                  <c:pt idx="0">
                    <c:v>2.1448905695991918E-2</c:v>
                  </c:pt>
                  <c:pt idx="1">
                    <c:v>1.1793501035174694E-2</c:v>
                  </c:pt>
                  <c:pt idx="2">
                    <c:v>1.6354960171832345E-2</c:v>
                  </c:pt>
                  <c:pt idx="3">
                    <c:v>2.982273554782584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A172まとめ!$B$20:$E$20</c:f>
              <c:numCache>
                <c:formatCode>General</c:formatCode>
                <c:ptCount val="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</c:numCache>
            </c:numRef>
          </c:cat>
          <c:val>
            <c:numRef>
              <c:f>A172まとめ!$B$23:$E$23</c:f>
              <c:numCache>
                <c:formatCode>0.0000</c:formatCode>
                <c:ptCount val="4"/>
                <c:pt idx="0">
                  <c:v>0.15103333333333332</c:v>
                </c:pt>
                <c:pt idx="1">
                  <c:v>0.16301666666666667</c:v>
                </c:pt>
                <c:pt idx="2">
                  <c:v>0.18731666666666669</c:v>
                </c:pt>
                <c:pt idx="3">
                  <c:v>0.2341833333333333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A968-4422-9DE8-F18A2142950B}"/>
            </c:ext>
          </c:extLst>
        </c:ser>
        <c:ser>
          <c:idx val="3"/>
          <c:order val="3"/>
          <c:tx>
            <c:strRef>
              <c:f>A172まとめ!$A$24</c:f>
              <c:strCache>
                <c:ptCount val="1"/>
                <c:pt idx="0">
                  <c:v>Glc-/Gln-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A172まとめ!$G$24:$J$24</c:f>
                <c:numCache>
                  <c:formatCode>General</c:formatCode>
                  <c:ptCount val="4"/>
                  <c:pt idx="0">
                    <c:v>2.1448905695991918E-2</c:v>
                  </c:pt>
                  <c:pt idx="1">
                    <c:v>9.0179450726500503E-3</c:v>
                  </c:pt>
                  <c:pt idx="2">
                    <c:v>8.3812787409400305E-3</c:v>
                  </c:pt>
                  <c:pt idx="3">
                    <c:v>4.8592409100827912E-3</c:v>
                  </c:pt>
                </c:numCache>
              </c:numRef>
            </c:plus>
            <c:minus>
              <c:numRef>
                <c:f>A172まとめ!$G$24:$J$24</c:f>
                <c:numCache>
                  <c:formatCode>General</c:formatCode>
                  <c:ptCount val="4"/>
                  <c:pt idx="0">
                    <c:v>2.1448905695991918E-2</c:v>
                  </c:pt>
                  <c:pt idx="1">
                    <c:v>9.0179450726500503E-3</c:v>
                  </c:pt>
                  <c:pt idx="2">
                    <c:v>8.3812787409400305E-3</c:v>
                  </c:pt>
                  <c:pt idx="3">
                    <c:v>4.8592409100827912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A172まとめ!$B$20:$E$20</c:f>
              <c:numCache>
                <c:formatCode>General</c:formatCode>
                <c:ptCount val="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</c:numCache>
            </c:numRef>
          </c:cat>
          <c:val>
            <c:numRef>
              <c:f>A172まとめ!$B$24:$E$24</c:f>
              <c:numCache>
                <c:formatCode>0.0000</c:formatCode>
                <c:ptCount val="4"/>
                <c:pt idx="0">
                  <c:v>0.15103333333333332</c:v>
                </c:pt>
                <c:pt idx="1">
                  <c:v>0.1469</c:v>
                </c:pt>
                <c:pt idx="2">
                  <c:v>9.7550000000000012E-2</c:v>
                </c:pt>
                <c:pt idx="3">
                  <c:v>8.5766666666666658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A968-4422-9DE8-F18A2142950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443423808"/>
        <c:axId val="443428512"/>
      </c:lineChart>
      <c:catAx>
        <c:axId val="44342380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Day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43428512"/>
        <c:crosses val="autoZero"/>
        <c:auto val="1"/>
        <c:lblAlgn val="ctr"/>
        <c:lblOffset val="100"/>
        <c:noMultiLvlLbl val="0"/>
      </c:catAx>
      <c:valAx>
        <c:axId val="44342851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/>
                  <a:t>Relative cell proliferat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4342380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900"/>
      </a:pPr>
      <a:endParaRPr lang="ja-JP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8352916930329225"/>
          <c:y val="0.11415114213778228"/>
          <c:w val="0.67948598863299914"/>
          <c:h val="0.5995681301475996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Result-1'!$D$59:$D$60</c:f>
              <c:strCache>
                <c:ptCount val="2"/>
                <c:pt idx="0">
                  <c:v>U87/EGFRvIII</c:v>
                </c:pt>
                <c:pt idx="1">
                  <c:v>Gln+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Result-1'!$G$61:$G$78</c:f>
                <c:numCache>
                  <c:formatCode>General</c:formatCode>
                  <c:ptCount val="5"/>
                  <c:pt idx="0">
                    <c:v>0.56685675223471499</c:v>
                  </c:pt>
                  <c:pt idx="1">
                    <c:v>0.14396146032420051</c:v>
                  </c:pt>
                  <c:pt idx="2">
                    <c:v>8.4248816078358102E-2</c:v>
                  </c:pt>
                  <c:pt idx="3">
                    <c:v>9.1097230650484494E-3</c:v>
                  </c:pt>
                  <c:pt idx="4">
                    <c:v>1.6588182407159681E-2</c:v>
                  </c:pt>
                </c:numCache>
              </c:numRef>
            </c:plus>
            <c:minus>
              <c:numRef>
                <c:f>'Result-1'!$G$61:$G$78</c:f>
                <c:numCache>
                  <c:formatCode>General</c:formatCode>
                  <c:ptCount val="5"/>
                  <c:pt idx="0">
                    <c:v>0.56685675223471499</c:v>
                  </c:pt>
                  <c:pt idx="1">
                    <c:v>0.14396146032420051</c:v>
                  </c:pt>
                  <c:pt idx="2">
                    <c:v>8.4248816078358102E-2</c:v>
                  </c:pt>
                  <c:pt idx="3">
                    <c:v>9.1097230650484494E-3</c:v>
                  </c:pt>
                  <c:pt idx="4">
                    <c:v>1.658818240715968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esult-1'!$A$61:$A$78</c:f>
              <c:strCache>
                <c:ptCount val="5"/>
                <c:pt idx="0">
                  <c:v>Glutamate </c:v>
                </c:pt>
                <c:pt idx="1">
                  <c:v>Glutamine</c:v>
                </c:pt>
                <c:pt idx="2">
                  <c:v>Glycine </c:v>
                </c:pt>
                <c:pt idx="3">
                  <c:v>Methionine</c:v>
                </c:pt>
                <c:pt idx="4">
                  <c:v>Serine </c:v>
                </c:pt>
              </c:strCache>
            </c:strRef>
          </c:cat>
          <c:val>
            <c:numRef>
              <c:f>'Result-1'!$D$61:$D$78</c:f>
              <c:numCache>
                <c:formatCode>General</c:formatCode>
                <c:ptCount val="5"/>
                <c:pt idx="0">
                  <c:v>6.1044319391722182</c:v>
                </c:pt>
                <c:pt idx="1">
                  <c:v>1.1211781007180299</c:v>
                </c:pt>
                <c:pt idx="2">
                  <c:v>0.36534837653161517</c:v>
                </c:pt>
                <c:pt idx="3">
                  <c:v>0.14214598842227255</c:v>
                </c:pt>
                <c:pt idx="4">
                  <c:v>7.39085574696953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7B8-4994-88FE-312A87AF57DB}"/>
            </c:ext>
          </c:extLst>
        </c:ser>
        <c:ser>
          <c:idx val="1"/>
          <c:order val="1"/>
          <c:tx>
            <c:strRef>
              <c:f>'Result-1'!$E$59:$E$60</c:f>
              <c:strCache>
                <c:ptCount val="2"/>
                <c:pt idx="0">
                  <c:v>U87/EGFRvIII</c:v>
                </c:pt>
                <c:pt idx="1">
                  <c:v>Gln-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Result-1'!$H$61:$H$78</c:f>
                <c:numCache>
                  <c:formatCode>General</c:formatCode>
                  <c:ptCount val="5"/>
                  <c:pt idx="0">
                    <c:v>0.12258424034079468</c:v>
                  </c:pt>
                  <c:pt idx="1">
                    <c:v>2.4354727258017362E-4</c:v>
                  </c:pt>
                  <c:pt idx="2">
                    <c:v>5.122626960017683E-2</c:v>
                  </c:pt>
                  <c:pt idx="3">
                    <c:v>7.5623855351446001E-3</c:v>
                  </c:pt>
                  <c:pt idx="4">
                    <c:v>5.8086784763795432E-2</c:v>
                  </c:pt>
                </c:numCache>
              </c:numRef>
            </c:plus>
            <c:minus>
              <c:numRef>
                <c:f>'Result-1'!$H$61:$H$78</c:f>
                <c:numCache>
                  <c:formatCode>General</c:formatCode>
                  <c:ptCount val="5"/>
                  <c:pt idx="0">
                    <c:v>0.12258424034079468</c:v>
                  </c:pt>
                  <c:pt idx="1">
                    <c:v>2.4354727258017362E-4</c:v>
                  </c:pt>
                  <c:pt idx="2">
                    <c:v>5.122626960017683E-2</c:v>
                  </c:pt>
                  <c:pt idx="3">
                    <c:v>7.5623855351446001E-3</c:v>
                  </c:pt>
                  <c:pt idx="4">
                    <c:v>5.808678476379543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esult-1'!$A$61:$A$78</c:f>
              <c:strCache>
                <c:ptCount val="5"/>
                <c:pt idx="0">
                  <c:v>Glutamate </c:v>
                </c:pt>
                <c:pt idx="1">
                  <c:v>Glutamine</c:v>
                </c:pt>
                <c:pt idx="2">
                  <c:v>Glycine </c:v>
                </c:pt>
                <c:pt idx="3">
                  <c:v>Methionine</c:v>
                </c:pt>
                <c:pt idx="4">
                  <c:v>Serine </c:v>
                </c:pt>
              </c:strCache>
            </c:strRef>
          </c:cat>
          <c:val>
            <c:numRef>
              <c:f>'Result-1'!$E$61:$E$78</c:f>
              <c:numCache>
                <c:formatCode>General</c:formatCode>
                <c:ptCount val="5"/>
                <c:pt idx="0">
                  <c:v>0.13616037465827599</c:v>
                </c:pt>
                <c:pt idx="1">
                  <c:v>1.6975760233336973E-3</c:v>
                </c:pt>
                <c:pt idx="2">
                  <c:v>0.77391541300826328</c:v>
                </c:pt>
                <c:pt idx="3">
                  <c:v>0.31747682728476395</c:v>
                </c:pt>
                <c:pt idx="4">
                  <c:v>0.523084690814859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7B8-4994-88FE-312A87AF57D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43424984"/>
        <c:axId val="443427728"/>
      </c:barChart>
      <c:catAx>
        <c:axId val="4434249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3600000" spcFirstLastPara="1" vertOverflow="ellipsis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43427728"/>
        <c:crosses val="autoZero"/>
        <c:auto val="1"/>
        <c:lblAlgn val="ctr"/>
        <c:lblOffset val="100"/>
        <c:noMultiLvlLbl val="0"/>
      </c:catAx>
      <c:valAx>
        <c:axId val="443427728"/>
        <c:scaling>
          <c:orientation val="minMax"/>
          <c:max val="1.6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b="1" dirty="0"/>
                  <a:t>Relative peak level</a:t>
                </a:r>
                <a:endParaRPr lang="ja-JP" altLang="en-US" b="1" dirty="0"/>
              </a:p>
            </c:rich>
          </c:tx>
          <c:layout>
            <c:manualLayout>
              <c:xMode val="edge"/>
              <c:yMode val="edge"/>
              <c:x val="5.4821493191216791E-2"/>
              <c:y val="0.2739641343226755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4342498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9.4228814538981395E-2"/>
          <c:y val="0.89731039196416551"/>
          <c:w val="0.84131540973646246"/>
          <c:h val="9.484988440044382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900">
          <a:latin typeface="+mn-lt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4" y="0"/>
            <a:ext cx="2945659" cy="498056"/>
          </a:xfrm>
          <a:prstGeom prst="rect">
            <a:avLst/>
          </a:prstGeom>
        </p:spPr>
        <p:txBody>
          <a:bodyPr vert="horz" lIns="91312" tIns="45657" rIns="91312" bIns="45657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0444" y="0"/>
            <a:ext cx="2945659" cy="498056"/>
          </a:xfrm>
          <a:prstGeom prst="rect">
            <a:avLst/>
          </a:prstGeom>
        </p:spPr>
        <p:txBody>
          <a:bodyPr vert="horz" lIns="91312" tIns="45657" rIns="91312" bIns="45657" rtlCol="0"/>
          <a:lstStyle>
            <a:lvl1pPr algn="r">
              <a:defRPr sz="1200"/>
            </a:lvl1pPr>
          </a:lstStyle>
          <a:p>
            <a:fld id="{3D8C615D-7F3F-402B-9900-DB4A472B8B4C}" type="datetimeFigureOut">
              <a:rPr kumimoji="1" lang="ja-JP" altLang="en-US" smtClean="0"/>
              <a:t>2020/12/1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312" tIns="45657" rIns="91312" bIns="45657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768" y="4777195"/>
            <a:ext cx="5438140" cy="3908613"/>
          </a:xfrm>
          <a:prstGeom prst="rect">
            <a:avLst/>
          </a:prstGeom>
        </p:spPr>
        <p:txBody>
          <a:bodyPr vert="horz" lIns="91312" tIns="45657" rIns="91312" bIns="45657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4" y="9428586"/>
            <a:ext cx="2945659" cy="498055"/>
          </a:xfrm>
          <a:prstGeom prst="rect">
            <a:avLst/>
          </a:prstGeom>
        </p:spPr>
        <p:txBody>
          <a:bodyPr vert="horz" lIns="91312" tIns="45657" rIns="91312" bIns="45657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0444" y="9428586"/>
            <a:ext cx="2945659" cy="498055"/>
          </a:xfrm>
          <a:prstGeom prst="rect">
            <a:avLst/>
          </a:prstGeom>
        </p:spPr>
        <p:txBody>
          <a:bodyPr vert="horz" lIns="91312" tIns="45657" rIns="91312" bIns="45657" rtlCol="0" anchor="b"/>
          <a:lstStyle>
            <a:lvl1pPr algn="r">
              <a:defRPr sz="1200"/>
            </a:lvl1pPr>
          </a:lstStyle>
          <a:p>
            <a:fld id="{EC00390E-BCC7-4FA3-ADFC-0568CB9A3C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90734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3619F-42E1-442E-8C74-591DD688C184}" type="datetimeFigureOut">
              <a:rPr kumimoji="1" lang="ja-JP" altLang="en-US" smtClean="0"/>
              <a:t>2020/12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3E3CCA-B4CC-40EB-B6D6-3F19334F76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6250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3619F-42E1-442E-8C74-591DD688C184}" type="datetimeFigureOut">
              <a:rPr kumimoji="1" lang="ja-JP" altLang="en-US" smtClean="0"/>
              <a:t>2020/12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3E3CCA-B4CC-40EB-B6D6-3F19334F76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22842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3619F-42E1-442E-8C74-591DD688C184}" type="datetimeFigureOut">
              <a:rPr kumimoji="1" lang="ja-JP" altLang="en-US" smtClean="0"/>
              <a:t>2020/12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3E3CCA-B4CC-40EB-B6D6-3F19334F76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66487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3619F-42E1-442E-8C74-591DD688C184}" type="datetimeFigureOut">
              <a:rPr kumimoji="1" lang="ja-JP" altLang="en-US" smtClean="0"/>
              <a:t>2020/12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3E3CCA-B4CC-40EB-B6D6-3F19334F76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13530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3619F-42E1-442E-8C74-591DD688C184}" type="datetimeFigureOut">
              <a:rPr kumimoji="1" lang="ja-JP" altLang="en-US" smtClean="0"/>
              <a:t>2020/12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3E3CCA-B4CC-40EB-B6D6-3F19334F76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4103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3619F-42E1-442E-8C74-591DD688C184}" type="datetimeFigureOut">
              <a:rPr kumimoji="1" lang="ja-JP" altLang="en-US" smtClean="0"/>
              <a:t>2020/12/1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3E3CCA-B4CC-40EB-B6D6-3F19334F76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49373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3619F-42E1-442E-8C74-591DD688C184}" type="datetimeFigureOut">
              <a:rPr kumimoji="1" lang="ja-JP" altLang="en-US" smtClean="0"/>
              <a:t>2020/12/19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3E3CCA-B4CC-40EB-B6D6-3F19334F76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534979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3619F-42E1-442E-8C74-591DD688C184}" type="datetimeFigureOut">
              <a:rPr kumimoji="1" lang="ja-JP" altLang="en-US" smtClean="0"/>
              <a:t>2020/12/19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3E3CCA-B4CC-40EB-B6D6-3F19334F76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149498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3619F-42E1-442E-8C74-591DD688C184}" type="datetimeFigureOut">
              <a:rPr kumimoji="1" lang="ja-JP" altLang="en-US" smtClean="0"/>
              <a:t>2020/12/19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3E3CCA-B4CC-40EB-B6D6-3F19334F76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13107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3619F-42E1-442E-8C74-591DD688C184}" type="datetimeFigureOut">
              <a:rPr kumimoji="1" lang="ja-JP" altLang="en-US" smtClean="0"/>
              <a:t>2020/12/1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3E3CCA-B4CC-40EB-B6D6-3F19334F76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03636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3619F-42E1-442E-8C74-591DD688C184}" type="datetimeFigureOut">
              <a:rPr kumimoji="1" lang="ja-JP" altLang="en-US" smtClean="0"/>
              <a:t>2020/12/1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3E3CCA-B4CC-40EB-B6D6-3F19334F76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157622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73619F-42E1-442E-8C74-591DD688C184}" type="datetimeFigureOut">
              <a:rPr kumimoji="1" lang="ja-JP" altLang="en-US" smtClean="0"/>
              <a:t>2020/12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3E3CCA-B4CC-40EB-B6D6-3F19334F76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54765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4.xml"/><Relationship Id="rId3" Type="http://schemas.openxmlformats.org/officeDocument/2006/relationships/chart" Target="../charts/chart1.xml"/><Relationship Id="rId7" Type="http://schemas.openxmlformats.org/officeDocument/2006/relationships/chart" Target="../charts/chart3.xm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openxmlformats.org/officeDocument/2006/relationships/chart" Target="../charts/chart7.xml"/><Relationship Id="rId5" Type="http://schemas.openxmlformats.org/officeDocument/2006/relationships/image" Target="../media/image2.png"/><Relationship Id="rId10" Type="http://schemas.openxmlformats.org/officeDocument/2006/relationships/chart" Target="../charts/chart6.xml"/><Relationship Id="rId4" Type="http://schemas.openxmlformats.org/officeDocument/2006/relationships/chart" Target="../charts/chart2.xml"/><Relationship Id="rId9" Type="http://schemas.openxmlformats.org/officeDocument/2006/relationships/chart" Target="../charts/chart5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9.xml"/><Relationship Id="rId7" Type="http://schemas.openxmlformats.org/officeDocument/2006/relationships/chart" Target="../charts/chart12.xml"/><Relationship Id="rId2" Type="http://schemas.openxmlformats.org/officeDocument/2006/relationships/chart" Target="../charts/chart8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1.xml"/><Relationship Id="rId5" Type="http://schemas.openxmlformats.org/officeDocument/2006/relationships/chart" Target="../charts/chart10.xml"/><Relationship Id="rId4" Type="http://schemas.openxmlformats.org/officeDocument/2006/relationships/image" Target="../media/image4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chart" Target="../charts/chart13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14.xml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5.xml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13" Type="http://schemas.microsoft.com/office/2007/relationships/hdphoto" Target="../media/hdphoto1.wdp"/><Relationship Id="rId18" Type="http://schemas.openxmlformats.org/officeDocument/2006/relationships/image" Target="../media/image15.png"/><Relationship Id="rId3" Type="http://schemas.openxmlformats.org/officeDocument/2006/relationships/chart" Target="../charts/chart17.xml"/><Relationship Id="rId7" Type="http://schemas.openxmlformats.org/officeDocument/2006/relationships/chart" Target="../charts/chart21.xml"/><Relationship Id="rId12" Type="http://schemas.openxmlformats.org/officeDocument/2006/relationships/image" Target="../media/image12.png"/><Relationship Id="rId17" Type="http://schemas.microsoft.com/office/2007/relationships/hdphoto" Target="../media/hdphoto3.wdp"/><Relationship Id="rId2" Type="http://schemas.openxmlformats.org/officeDocument/2006/relationships/chart" Target="../charts/chart16.xml"/><Relationship Id="rId16" Type="http://schemas.openxmlformats.org/officeDocument/2006/relationships/image" Target="../media/image14.png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20.xml"/><Relationship Id="rId11" Type="http://schemas.openxmlformats.org/officeDocument/2006/relationships/image" Target="../media/image11.png"/><Relationship Id="rId5" Type="http://schemas.openxmlformats.org/officeDocument/2006/relationships/chart" Target="../charts/chart19.xml"/><Relationship Id="rId15" Type="http://schemas.microsoft.com/office/2007/relationships/hdphoto" Target="../media/hdphoto2.wdp"/><Relationship Id="rId10" Type="http://schemas.openxmlformats.org/officeDocument/2006/relationships/image" Target="../media/image10.png"/><Relationship Id="rId4" Type="http://schemas.openxmlformats.org/officeDocument/2006/relationships/chart" Target="../charts/chart18.xml"/><Relationship Id="rId9" Type="http://schemas.openxmlformats.org/officeDocument/2006/relationships/image" Target="../media/image9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6" name="図 65"/>
          <p:cNvPicPr>
            <a:picLocks noChangeAspect="1"/>
          </p:cNvPicPr>
          <p:nvPr/>
        </p:nvPicPr>
        <p:blipFill rotWithShape="1">
          <a:blip r:embed="rId2"/>
          <a:srcRect l="10291" t="15477" r="27163" b="36679"/>
          <a:stretch/>
        </p:blipFill>
        <p:spPr>
          <a:xfrm>
            <a:off x="4804862" y="4362373"/>
            <a:ext cx="1720481" cy="1714251"/>
          </a:xfrm>
          <a:prstGeom prst="rect">
            <a:avLst/>
          </a:prstGeom>
        </p:spPr>
      </p:pic>
      <p:sp>
        <p:nvSpPr>
          <p:cNvPr id="5" name="正方形/長方形 4"/>
          <p:cNvSpPr/>
          <p:nvPr/>
        </p:nvSpPr>
        <p:spPr>
          <a:xfrm>
            <a:off x="456195" y="4077525"/>
            <a:ext cx="2681357" cy="361274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" name="テキスト ボックス 6"/>
          <p:cNvSpPr txBox="1"/>
          <p:nvPr/>
        </p:nvSpPr>
        <p:spPr>
          <a:xfrm>
            <a:off x="103910" y="348143"/>
            <a:ext cx="2712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/>
              <a:t>a</a:t>
            </a:r>
            <a:endParaRPr kumimoji="1" lang="ja-JP" altLang="en-US" sz="1400" b="1" dirty="0"/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4176" y="1313"/>
            <a:ext cx="10647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err="1"/>
              <a:t>Supp</a:t>
            </a:r>
            <a:r>
              <a:rPr kumimoji="1" lang="ja-JP" altLang="en-US" sz="1400" dirty="0" err="1"/>
              <a:t>ｌ</a:t>
            </a:r>
            <a:r>
              <a:rPr kumimoji="1" lang="en-US" altLang="ja-JP" sz="1400" dirty="0"/>
              <a:t>. Fig. </a:t>
            </a:r>
            <a:r>
              <a:rPr lang="en-US" altLang="ja-JP" sz="1400" dirty="0"/>
              <a:t>1</a:t>
            </a:r>
            <a:endParaRPr kumimoji="1" lang="ja-JP" altLang="en-US" sz="1400" dirty="0"/>
          </a:p>
        </p:txBody>
      </p:sp>
      <p:graphicFrame>
        <p:nvGraphicFramePr>
          <p:cNvPr id="36" name="グラフ 3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93056969"/>
              </p:ext>
            </p:extLst>
          </p:nvPr>
        </p:nvGraphicFramePr>
        <p:xfrm>
          <a:off x="4176" y="6154184"/>
          <a:ext cx="1211976" cy="18213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7" name="グラフ 3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83219179"/>
              </p:ext>
            </p:extLst>
          </p:nvPr>
        </p:nvGraphicFramePr>
        <p:xfrm>
          <a:off x="1135561" y="6149294"/>
          <a:ext cx="1173040" cy="18213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44" name="テキスト ボックス 43"/>
          <p:cNvSpPr txBox="1"/>
          <p:nvPr/>
        </p:nvSpPr>
        <p:spPr>
          <a:xfrm>
            <a:off x="55116" y="3983144"/>
            <a:ext cx="2792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/>
              <a:t>b</a:t>
            </a:r>
            <a:endParaRPr kumimoji="1" lang="ja-JP" altLang="en-US" sz="1400" b="1" dirty="0"/>
          </a:p>
        </p:txBody>
      </p:sp>
      <p:pic>
        <p:nvPicPr>
          <p:cNvPr id="27" name="図 26"/>
          <p:cNvPicPr>
            <a:picLocks noChangeAspect="1"/>
          </p:cNvPicPr>
          <p:nvPr/>
        </p:nvPicPr>
        <p:blipFill rotWithShape="1">
          <a:blip r:embed="rId5"/>
          <a:srcRect l="7488" t="23916" r="24343" b="27460"/>
          <a:stretch/>
        </p:blipFill>
        <p:spPr>
          <a:xfrm>
            <a:off x="332656" y="4360090"/>
            <a:ext cx="1661661" cy="1692623"/>
          </a:xfrm>
          <a:prstGeom prst="rect">
            <a:avLst/>
          </a:prstGeom>
        </p:spPr>
      </p:pic>
      <p:sp>
        <p:nvSpPr>
          <p:cNvPr id="46" name="円/楕円 45"/>
          <p:cNvSpPr/>
          <p:nvPr/>
        </p:nvSpPr>
        <p:spPr>
          <a:xfrm>
            <a:off x="1086722" y="5415270"/>
            <a:ext cx="21600" cy="21600"/>
          </a:xfrm>
          <a:prstGeom prst="ellipse">
            <a:avLst/>
          </a:prstGeom>
          <a:solidFill>
            <a:schemeClr val="accent2"/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 dirty="0"/>
          </a:p>
        </p:txBody>
      </p:sp>
      <p:sp>
        <p:nvSpPr>
          <p:cNvPr id="47" name="テキスト ボックス 46"/>
          <p:cNvSpPr txBox="1"/>
          <p:nvPr/>
        </p:nvSpPr>
        <p:spPr>
          <a:xfrm>
            <a:off x="1101203" y="5436310"/>
            <a:ext cx="32593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b="1" dirty="0">
                <a:solidFill>
                  <a:schemeClr val="accent2"/>
                </a:solidFill>
              </a:rPr>
              <a:t>2</a:t>
            </a:r>
            <a:endParaRPr kumimoji="1" lang="ja-JP" altLang="en-US" sz="900" b="1" dirty="0">
              <a:solidFill>
                <a:schemeClr val="accent2"/>
              </a:solidFill>
            </a:endParaRPr>
          </a:p>
        </p:txBody>
      </p:sp>
      <p:sp>
        <p:nvSpPr>
          <p:cNvPr id="48" name="テキスト ボックス 47"/>
          <p:cNvSpPr txBox="1"/>
          <p:nvPr/>
        </p:nvSpPr>
        <p:spPr>
          <a:xfrm>
            <a:off x="691517" y="5107764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b="1" dirty="0">
                <a:solidFill>
                  <a:schemeClr val="accent2"/>
                </a:solidFill>
              </a:rPr>
              <a:t>1</a:t>
            </a:r>
            <a:endParaRPr kumimoji="1" lang="ja-JP" altLang="en-US" sz="900" b="1" dirty="0">
              <a:solidFill>
                <a:schemeClr val="accent2"/>
              </a:solidFill>
            </a:endParaRPr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1097522" y="4948757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b="1" dirty="0">
                <a:solidFill>
                  <a:schemeClr val="accent1"/>
                </a:solidFill>
              </a:rPr>
              <a:t>3</a:t>
            </a:r>
            <a:endParaRPr kumimoji="1" lang="ja-JP" altLang="en-US" sz="900" b="1" dirty="0">
              <a:solidFill>
                <a:schemeClr val="accent1"/>
              </a:solidFill>
            </a:endParaRPr>
          </a:p>
        </p:txBody>
      </p:sp>
      <p:sp>
        <p:nvSpPr>
          <p:cNvPr id="50" name="テキスト ボックス 49"/>
          <p:cNvSpPr txBox="1"/>
          <p:nvPr/>
        </p:nvSpPr>
        <p:spPr>
          <a:xfrm>
            <a:off x="748049" y="5577766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b="1" dirty="0">
                <a:solidFill>
                  <a:schemeClr val="accent1"/>
                </a:solidFill>
              </a:rPr>
              <a:t>4</a:t>
            </a:r>
            <a:endParaRPr kumimoji="1" lang="ja-JP" altLang="en-US" sz="900" b="1" dirty="0">
              <a:solidFill>
                <a:schemeClr val="accent1"/>
              </a:solidFill>
            </a:endParaRPr>
          </a:p>
        </p:txBody>
      </p:sp>
      <p:sp>
        <p:nvSpPr>
          <p:cNvPr id="51" name="円/楕円 50"/>
          <p:cNvSpPr/>
          <p:nvPr/>
        </p:nvSpPr>
        <p:spPr>
          <a:xfrm>
            <a:off x="971026" y="5308658"/>
            <a:ext cx="21600" cy="21600"/>
          </a:xfrm>
          <a:prstGeom prst="ellipse">
            <a:avLst/>
          </a:prstGeom>
          <a:solidFill>
            <a:schemeClr val="accent2"/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 dirty="0"/>
          </a:p>
        </p:txBody>
      </p:sp>
      <p:sp>
        <p:nvSpPr>
          <p:cNvPr id="52" name="円/楕円 51"/>
          <p:cNvSpPr/>
          <p:nvPr/>
        </p:nvSpPr>
        <p:spPr>
          <a:xfrm>
            <a:off x="892336" y="5502111"/>
            <a:ext cx="22860" cy="2286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 dirty="0"/>
          </a:p>
        </p:txBody>
      </p:sp>
      <p:sp>
        <p:nvSpPr>
          <p:cNvPr id="53" name="円/楕円 52"/>
          <p:cNvSpPr/>
          <p:nvPr/>
        </p:nvSpPr>
        <p:spPr>
          <a:xfrm>
            <a:off x="1140626" y="5174515"/>
            <a:ext cx="22860" cy="2286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400" dirty="0"/>
          </a:p>
        </p:txBody>
      </p:sp>
      <p:pic>
        <p:nvPicPr>
          <p:cNvPr id="54" name="図 53"/>
          <p:cNvPicPr>
            <a:picLocks noChangeAspect="1"/>
          </p:cNvPicPr>
          <p:nvPr/>
        </p:nvPicPr>
        <p:blipFill rotWithShape="1">
          <a:blip r:embed="rId6"/>
          <a:srcRect l="40158" t="20838" r="23132" b="39284"/>
          <a:stretch/>
        </p:blipFill>
        <p:spPr>
          <a:xfrm>
            <a:off x="2564904" y="4352842"/>
            <a:ext cx="1683992" cy="1695784"/>
          </a:xfrm>
          <a:prstGeom prst="rect">
            <a:avLst/>
          </a:prstGeom>
        </p:spPr>
      </p:pic>
      <p:sp>
        <p:nvSpPr>
          <p:cNvPr id="55" name="円/楕円 54"/>
          <p:cNvSpPr/>
          <p:nvPr/>
        </p:nvSpPr>
        <p:spPr>
          <a:xfrm>
            <a:off x="3829326" y="5338596"/>
            <a:ext cx="21600" cy="21600"/>
          </a:xfrm>
          <a:prstGeom prst="ellipse">
            <a:avLst/>
          </a:prstGeom>
          <a:solidFill>
            <a:schemeClr val="accent2"/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 dirty="0"/>
          </a:p>
        </p:txBody>
      </p:sp>
      <p:sp>
        <p:nvSpPr>
          <p:cNvPr id="56" name="テキスト ボックス 55"/>
          <p:cNvSpPr txBox="1"/>
          <p:nvPr/>
        </p:nvSpPr>
        <p:spPr>
          <a:xfrm>
            <a:off x="3733409" y="5436310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b="1" dirty="0">
                <a:solidFill>
                  <a:schemeClr val="accent2"/>
                </a:solidFill>
              </a:rPr>
              <a:t>2</a:t>
            </a:r>
            <a:endParaRPr kumimoji="1" lang="ja-JP" altLang="en-US" sz="900" b="1" dirty="0">
              <a:solidFill>
                <a:schemeClr val="accent2"/>
              </a:solidFill>
            </a:endParaRPr>
          </a:p>
        </p:txBody>
      </p:sp>
      <p:sp>
        <p:nvSpPr>
          <p:cNvPr id="57" name="テキスト ボックス 56"/>
          <p:cNvSpPr txBox="1"/>
          <p:nvPr/>
        </p:nvSpPr>
        <p:spPr>
          <a:xfrm>
            <a:off x="3401541" y="5108699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b="1" dirty="0">
                <a:solidFill>
                  <a:schemeClr val="accent2"/>
                </a:solidFill>
              </a:rPr>
              <a:t>1</a:t>
            </a:r>
            <a:endParaRPr kumimoji="1" lang="ja-JP" altLang="en-US" sz="900" b="1" dirty="0">
              <a:solidFill>
                <a:schemeClr val="accent2"/>
              </a:solidFill>
            </a:endParaRPr>
          </a:p>
        </p:txBody>
      </p:sp>
      <p:sp>
        <p:nvSpPr>
          <p:cNvPr id="58" name="テキスト ボックス 57"/>
          <p:cNvSpPr txBox="1"/>
          <p:nvPr/>
        </p:nvSpPr>
        <p:spPr>
          <a:xfrm>
            <a:off x="3685279" y="4816557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b="1" dirty="0">
                <a:solidFill>
                  <a:schemeClr val="accent1"/>
                </a:solidFill>
              </a:rPr>
              <a:t>3</a:t>
            </a:r>
            <a:endParaRPr kumimoji="1" lang="ja-JP" altLang="en-US" sz="900" b="1" dirty="0">
              <a:solidFill>
                <a:schemeClr val="accent1"/>
              </a:solidFill>
            </a:endParaRPr>
          </a:p>
        </p:txBody>
      </p:sp>
      <p:sp>
        <p:nvSpPr>
          <p:cNvPr id="59" name="テキスト ボックス 58"/>
          <p:cNvSpPr txBox="1"/>
          <p:nvPr/>
        </p:nvSpPr>
        <p:spPr>
          <a:xfrm>
            <a:off x="3995722" y="5014362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b="1" dirty="0">
                <a:solidFill>
                  <a:schemeClr val="accent1"/>
                </a:solidFill>
              </a:rPr>
              <a:t>4</a:t>
            </a:r>
            <a:endParaRPr kumimoji="1" lang="ja-JP" altLang="en-US" sz="900" b="1" dirty="0">
              <a:solidFill>
                <a:schemeClr val="accent1"/>
              </a:solidFill>
            </a:endParaRPr>
          </a:p>
        </p:txBody>
      </p:sp>
      <p:sp>
        <p:nvSpPr>
          <p:cNvPr id="60" name="円/楕円 59"/>
          <p:cNvSpPr/>
          <p:nvPr/>
        </p:nvSpPr>
        <p:spPr>
          <a:xfrm>
            <a:off x="3663491" y="5242299"/>
            <a:ext cx="21600" cy="21600"/>
          </a:xfrm>
          <a:prstGeom prst="ellipse">
            <a:avLst/>
          </a:prstGeom>
          <a:solidFill>
            <a:schemeClr val="accent2"/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 dirty="0"/>
          </a:p>
        </p:txBody>
      </p:sp>
      <p:sp>
        <p:nvSpPr>
          <p:cNvPr id="61" name="円/楕円 60"/>
          <p:cNvSpPr/>
          <p:nvPr/>
        </p:nvSpPr>
        <p:spPr>
          <a:xfrm>
            <a:off x="3975783" y="5186862"/>
            <a:ext cx="22860" cy="2286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 dirty="0"/>
          </a:p>
        </p:txBody>
      </p:sp>
      <p:sp>
        <p:nvSpPr>
          <p:cNvPr id="62" name="円/楕円 61"/>
          <p:cNvSpPr/>
          <p:nvPr/>
        </p:nvSpPr>
        <p:spPr>
          <a:xfrm>
            <a:off x="3806466" y="5078683"/>
            <a:ext cx="22860" cy="2286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400" dirty="0"/>
          </a:p>
        </p:txBody>
      </p:sp>
      <p:graphicFrame>
        <p:nvGraphicFramePr>
          <p:cNvPr id="69" name="グラフ 6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80726240"/>
              </p:ext>
            </p:extLst>
          </p:nvPr>
        </p:nvGraphicFramePr>
        <p:xfrm>
          <a:off x="4445834" y="6157047"/>
          <a:ext cx="1332917" cy="179653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70" name="グラフ 6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45030428"/>
              </p:ext>
            </p:extLst>
          </p:nvPr>
        </p:nvGraphicFramePr>
        <p:xfrm>
          <a:off x="5706460" y="6157966"/>
          <a:ext cx="1183989" cy="17956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71" name="グラフ 7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93244700"/>
              </p:ext>
            </p:extLst>
          </p:nvPr>
        </p:nvGraphicFramePr>
        <p:xfrm>
          <a:off x="2268065" y="6157048"/>
          <a:ext cx="1269594" cy="17965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72" name="グラフ 7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53212655"/>
              </p:ext>
            </p:extLst>
          </p:nvPr>
        </p:nvGraphicFramePr>
        <p:xfrm>
          <a:off x="3379304" y="6149294"/>
          <a:ext cx="1129816" cy="18042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sp>
        <p:nvSpPr>
          <p:cNvPr id="73" name="円/楕円 72"/>
          <p:cNvSpPr/>
          <p:nvPr/>
        </p:nvSpPr>
        <p:spPr>
          <a:xfrm>
            <a:off x="5510885" y="5057054"/>
            <a:ext cx="21600" cy="21600"/>
          </a:xfrm>
          <a:prstGeom prst="ellipse">
            <a:avLst/>
          </a:prstGeom>
          <a:solidFill>
            <a:schemeClr val="accent2"/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 dirty="0"/>
          </a:p>
        </p:txBody>
      </p:sp>
      <p:sp>
        <p:nvSpPr>
          <p:cNvPr id="74" name="テキスト ボックス 73"/>
          <p:cNvSpPr txBox="1"/>
          <p:nvPr/>
        </p:nvSpPr>
        <p:spPr>
          <a:xfrm>
            <a:off x="5697511" y="4816557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b="1" dirty="0">
                <a:solidFill>
                  <a:schemeClr val="accent2"/>
                </a:solidFill>
              </a:rPr>
              <a:t>2</a:t>
            </a:r>
            <a:endParaRPr kumimoji="1" lang="ja-JP" altLang="en-US" sz="900" b="1" dirty="0">
              <a:solidFill>
                <a:schemeClr val="accent2"/>
              </a:solidFill>
            </a:endParaRPr>
          </a:p>
        </p:txBody>
      </p:sp>
      <p:sp>
        <p:nvSpPr>
          <p:cNvPr id="75" name="テキスト ボックス 74"/>
          <p:cNvSpPr txBox="1"/>
          <p:nvPr/>
        </p:nvSpPr>
        <p:spPr>
          <a:xfrm>
            <a:off x="5256003" y="4857925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b="1" dirty="0">
                <a:solidFill>
                  <a:schemeClr val="accent2"/>
                </a:solidFill>
              </a:rPr>
              <a:t>1</a:t>
            </a:r>
            <a:endParaRPr kumimoji="1" lang="ja-JP" altLang="en-US" sz="900" b="1" dirty="0">
              <a:solidFill>
                <a:schemeClr val="accent2"/>
              </a:solidFill>
            </a:endParaRPr>
          </a:p>
        </p:txBody>
      </p:sp>
      <p:sp>
        <p:nvSpPr>
          <p:cNvPr id="76" name="テキスト ボックス 75"/>
          <p:cNvSpPr txBox="1"/>
          <p:nvPr/>
        </p:nvSpPr>
        <p:spPr>
          <a:xfrm>
            <a:off x="5377190" y="4596499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b="1" dirty="0">
                <a:solidFill>
                  <a:schemeClr val="accent1"/>
                </a:solidFill>
              </a:rPr>
              <a:t>4</a:t>
            </a:r>
            <a:endParaRPr kumimoji="1" lang="ja-JP" altLang="en-US" sz="900" b="1" dirty="0">
              <a:solidFill>
                <a:schemeClr val="accent1"/>
              </a:solidFill>
            </a:endParaRPr>
          </a:p>
        </p:txBody>
      </p:sp>
      <p:sp>
        <p:nvSpPr>
          <p:cNvPr id="77" name="テキスト ボックス 76"/>
          <p:cNvSpPr txBox="1"/>
          <p:nvPr/>
        </p:nvSpPr>
        <p:spPr>
          <a:xfrm>
            <a:off x="5038685" y="5215115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b="1" dirty="0">
                <a:solidFill>
                  <a:schemeClr val="accent1"/>
                </a:solidFill>
              </a:rPr>
              <a:t>5</a:t>
            </a:r>
            <a:endParaRPr kumimoji="1" lang="ja-JP" altLang="en-US" sz="900" b="1" dirty="0">
              <a:solidFill>
                <a:schemeClr val="accent1"/>
              </a:solidFill>
            </a:endParaRPr>
          </a:p>
        </p:txBody>
      </p:sp>
      <p:sp>
        <p:nvSpPr>
          <p:cNvPr id="78" name="円/楕円 77"/>
          <p:cNvSpPr/>
          <p:nvPr/>
        </p:nvSpPr>
        <p:spPr>
          <a:xfrm>
            <a:off x="5684860" y="4933116"/>
            <a:ext cx="21600" cy="21600"/>
          </a:xfrm>
          <a:prstGeom prst="ellipse">
            <a:avLst/>
          </a:prstGeom>
          <a:solidFill>
            <a:schemeClr val="accent2"/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 dirty="0"/>
          </a:p>
        </p:txBody>
      </p:sp>
      <p:sp>
        <p:nvSpPr>
          <p:cNvPr id="79" name="円/楕円 78"/>
          <p:cNvSpPr/>
          <p:nvPr/>
        </p:nvSpPr>
        <p:spPr>
          <a:xfrm>
            <a:off x="5266646" y="5364325"/>
            <a:ext cx="22860" cy="2286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 dirty="0"/>
          </a:p>
        </p:txBody>
      </p:sp>
      <p:sp>
        <p:nvSpPr>
          <p:cNvPr id="80" name="円/楕円 79"/>
          <p:cNvSpPr/>
          <p:nvPr/>
        </p:nvSpPr>
        <p:spPr>
          <a:xfrm>
            <a:off x="5653672" y="4681571"/>
            <a:ext cx="22860" cy="22860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400" dirty="0"/>
          </a:p>
        </p:txBody>
      </p:sp>
      <p:sp>
        <p:nvSpPr>
          <p:cNvPr id="81" name="テキスト ボックス 80"/>
          <p:cNvSpPr txBox="1"/>
          <p:nvPr/>
        </p:nvSpPr>
        <p:spPr>
          <a:xfrm>
            <a:off x="5576324" y="5288113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b="1" dirty="0">
                <a:solidFill>
                  <a:schemeClr val="accent2"/>
                </a:solidFill>
              </a:rPr>
              <a:t>3</a:t>
            </a:r>
            <a:endParaRPr kumimoji="1" lang="ja-JP" altLang="en-US" sz="900" b="1" dirty="0">
              <a:solidFill>
                <a:schemeClr val="accent2"/>
              </a:solidFill>
            </a:endParaRPr>
          </a:p>
        </p:txBody>
      </p:sp>
      <p:sp>
        <p:nvSpPr>
          <p:cNvPr id="82" name="円/楕円 81"/>
          <p:cNvSpPr/>
          <p:nvPr/>
        </p:nvSpPr>
        <p:spPr>
          <a:xfrm>
            <a:off x="5614637" y="5234394"/>
            <a:ext cx="21600" cy="21600"/>
          </a:xfrm>
          <a:prstGeom prst="ellipse">
            <a:avLst/>
          </a:prstGeom>
          <a:solidFill>
            <a:schemeClr val="accent2"/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 dirty="0"/>
          </a:p>
        </p:txBody>
      </p:sp>
      <p:cxnSp>
        <p:nvCxnSpPr>
          <p:cNvPr id="3" name="直線コネクタ 2"/>
          <p:cNvCxnSpPr/>
          <p:nvPr/>
        </p:nvCxnSpPr>
        <p:spPr>
          <a:xfrm>
            <a:off x="2276872" y="4297216"/>
            <a:ext cx="0" cy="380317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直線コネクタ 82"/>
          <p:cNvCxnSpPr/>
          <p:nvPr/>
        </p:nvCxnSpPr>
        <p:spPr>
          <a:xfrm>
            <a:off x="4437112" y="4297216"/>
            <a:ext cx="0" cy="380317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64" name="グラフ 6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63636391"/>
              </p:ext>
            </p:extLst>
          </p:nvPr>
        </p:nvGraphicFramePr>
        <p:xfrm>
          <a:off x="3022815" y="674927"/>
          <a:ext cx="3214497" cy="303297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cxnSp>
        <p:nvCxnSpPr>
          <p:cNvPr id="68" name="直線矢印コネクタ 67"/>
          <p:cNvCxnSpPr/>
          <p:nvPr/>
        </p:nvCxnSpPr>
        <p:spPr>
          <a:xfrm>
            <a:off x="4515514" y="2570287"/>
            <a:ext cx="0" cy="205783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テキスト ボックス 83"/>
          <p:cNvSpPr txBox="1"/>
          <p:nvPr/>
        </p:nvSpPr>
        <p:spPr>
          <a:xfrm>
            <a:off x="4221089" y="2282835"/>
            <a:ext cx="65559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b="1" dirty="0" err="1">
                <a:cs typeface="Arial" panose="020B0604020202020204" pitchFamily="34" charset="0"/>
              </a:rPr>
              <a:t>Gln+Glu</a:t>
            </a:r>
            <a:endParaRPr kumimoji="1" lang="ja-JP" altLang="en-US" sz="1100" b="1" dirty="0">
              <a:cs typeface="Arial" panose="020B0604020202020204" pitchFamily="34" charset="0"/>
            </a:endParaRPr>
          </a:p>
        </p:txBody>
      </p:sp>
      <p:cxnSp>
        <p:nvCxnSpPr>
          <p:cNvPr id="85" name="直線矢印コネクタ 84"/>
          <p:cNvCxnSpPr/>
          <p:nvPr/>
        </p:nvCxnSpPr>
        <p:spPr>
          <a:xfrm>
            <a:off x="3850086" y="1819217"/>
            <a:ext cx="0" cy="185827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テキスト ボックス 85"/>
          <p:cNvSpPr txBox="1"/>
          <p:nvPr/>
        </p:nvSpPr>
        <p:spPr>
          <a:xfrm>
            <a:off x="3645025" y="1573576"/>
            <a:ext cx="4572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+mj-lt"/>
                <a:cs typeface="Arial" panose="020B0604020202020204" pitchFamily="34" charset="0"/>
              </a:rPr>
              <a:t>Cho</a:t>
            </a:r>
            <a:endParaRPr kumimoji="1" lang="ja-JP" altLang="en-US" sz="1100" b="1" dirty="0">
              <a:latin typeface="+mj-lt"/>
              <a:cs typeface="Arial" panose="020B0604020202020204" pitchFamily="34" charset="0"/>
            </a:endParaRPr>
          </a:p>
        </p:txBody>
      </p:sp>
      <p:cxnSp>
        <p:nvCxnSpPr>
          <p:cNvPr id="87" name="直線矢印コネクタ 86"/>
          <p:cNvCxnSpPr/>
          <p:nvPr/>
        </p:nvCxnSpPr>
        <p:spPr>
          <a:xfrm>
            <a:off x="4875554" y="1274143"/>
            <a:ext cx="0" cy="192429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テキスト ボックス 87"/>
          <p:cNvSpPr txBox="1"/>
          <p:nvPr/>
        </p:nvSpPr>
        <p:spPr>
          <a:xfrm>
            <a:off x="4653137" y="1059279"/>
            <a:ext cx="46429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b="1" dirty="0">
                <a:latin typeface="+mj-lt"/>
                <a:cs typeface="Arial" panose="020B0604020202020204" pitchFamily="34" charset="0"/>
              </a:rPr>
              <a:t>NAA</a:t>
            </a:r>
            <a:endParaRPr kumimoji="1" lang="ja-JP" altLang="en-US" sz="1100" b="1" dirty="0">
              <a:latin typeface="+mj-lt"/>
              <a:cs typeface="Arial" panose="020B0604020202020204" pitchFamily="34" charset="0"/>
            </a:endParaRPr>
          </a:p>
        </p:txBody>
      </p:sp>
      <p:cxnSp>
        <p:nvCxnSpPr>
          <p:cNvPr id="89" name="直線矢印コネクタ 88"/>
          <p:cNvCxnSpPr/>
          <p:nvPr/>
        </p:nvCxnSpPr>
        <p:spPr>
          <a:xfrm>
            <a:off x="5481074" y="1088896"/>
            <a:ext cx="0" cy="185827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テキスト ボックス 89"/>
          <p:cNvSpPr txBox="1"/>
          <p:nvPr/>
        </p:nvSpPr>
        <p:spPr>
          <a:xfrm>
            <a:off x="5276013" y="843254"/>
            <a:ext cx="38523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+mj-lt"/>
                <a:cs typeface="Arial" panose="020B0604020202020204" pitchFamily="34" charset="0"/>
              </a:rPr>
              <a:t>Lac</a:t>
            </a:r>
            <a:endParaRPr kumimoji="1" lang="ja-JP" altLang="en-US" sz="1100" b="1" dirty="0">
              <a:latin typeface="+mj-lt"/>
              <a:cs typeface="Arial" panose="020B0604020202020204" pitchFamily="34" charset="0"/>
            </a:endParaRPr>
          </a:p>
        </p:txBody>
      </p:sp>
      <p:cxnSp>
        <p:nvCxnSpPr>
          <p:cNvPr id="91" name="直線矢印コネクタ 90"/>
          <p:cNvCxnSpPr/>
          <p:nvPr/>
        </p:nvCxnSpPr>
        <p:spPr>
          <a:xfrm>
            <a:off x="3659924" y="2539738"/>
            <a:ext cx="0" cy="185827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テキスト ボックス 91"/>
          <p:cNvSpPr txBox="1"/>
          <p:nvPr/>
        </p:nvSpPr>
        <p:spPr>
          <a:xfrm>
            <a:off x="3454863" y="2294097"/>
            <a:ext cx="4572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b="1" dirty="0" err="1">
                <a:latin typeface="+mj-lt"/>
                <a:cs typeface="Arial" panose="020B0604020202020204" pitchFamily="34" charset="0"/>
              </a:rPr>
              <a:t>Glc</a:t>
            </a:r>
            <a:endParaRPr kumimoji="1" lang="ja-JP" altLang="en-US" sz="1100" b="1" dirty="0">
              <a:latin typeface="+mj-lt"/>
              <a:cs typeface="Arial" panose="020B0604020202020204" pitchFamily="34" charset="0"/>
            </a:endParaRPr>
          </a:p>
        </p:txBody>
      </p:sp>
      <p:pic>
        <p:nvPicPr>
          <p:cNvPr id="63" name="図 62">
            <a:extLst>
              <a:ext uri="{FF2B5EF4-FFF2-40B4-BE49-F238E27FC236}">
                <a16:creationId xmlns:a16="http://schemas.microsoft.com/office/drawing/2014/main" id="{27704654-5A68-41B4-A578-17C24D4B2843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4883" t="23502" r="6880" b="17060"/>
          <a:stretch/>
        </p:blipFill>
        <p:spPr>
          <a:xfrm>
            <a:off x="552742" y="1022609"/>
            <a:ext cx="2034442" cy="1957107"/>
          </a:xfrm>
          <a:prstGeom prst="rect">
            <a:avLst/>
          </a:prstGeom>
        </p:spPr>
      </p:pic>
      <p:sp>
        <p:nvSpPr>
          <p:cNvPr id="65" name="正方形/長方形 64">
            <a:extLst>
              <a:ext uri="{FF2B5EF4-FFF2-40B4-BE49-F238E27FC236}">
                <a16:creationId xmlns:a16="http://schemas.microsoft.com/office/drawing/2014/main" id="{5431FF9E-DD9C-4465-9ED1-CA2AC49C39AA}"/>
              </a:ext>
            </a:extLst>
          </p:cNvPr>
          <p:cNvSpPr/>
          <p:nvPr/>
        </p:nvSpPr>
        <p:spPr>
          <a:xfrm>
            <a:off x="1093012" y="2059314"/>
            <a:ext cx="86298" cy="90398"/>
          </a:xfrm>
          <a:prstGeom prst="rect">
            <a:avLst/>
          </a:prstGeom>
          <a:noFill/>
          <a:ln w="19050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7" name="正方形/長方形 66">
            <a:extLst>
              <a:ext uri="{FF2B5EF4-FFF2-40B4-BE49-F238E27FC236}">
                <a16:creationId xmlns:a16="http://schemas.microsoft.com/office/drawing/2014/main" id="{B31BB0DE-C5B7-45F5-8ABB-6235026EA720}"/>
              </a:ext>
            </a:extLst>
          </p:cNvPr>
          <p:cNvSpPr/>
          <p:nvPr/>
        </p:nvSpPr>
        <p:spPr>
          <a:xfrm>
            <a:off x="1242246" y="1931708"/>
            <a:ext cx="86298" cy="90398"/>
          </a:xfrm>
          <a:prstGeom prst="rect">
            <a:avLst/>
          </a:prstGeom>
          <a:noFill/>
          <a:ln w="19050"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3" name="正方形/長方形 92">
            <a:extLst>
              <a:ext uri="{FF2B5EF4-FFF2-40B4-BE49-F238E27FC236}">
                <a16:creationId xmlns:a16="http://schemas.microsoft.com/office/drawing/2014/main" id="{C407B609-9DD0-4E3E-BB3E-5DAC8ABDBBBD}"/>
              </a:ext>
            </a:extLst>
          </p:cNvPr>
          <p:cNvSpPr/>
          <p:nvPr/>
        </p:nvSpPr>
        <p:spPr>
          <a:xfrm>
            <a:off x="1764175" y="1931708"/>
            <a:ext cx="86298" cy="90398"/>
          </a:xfrm>
          <a:prstGeom prst="rect">
            <a:avLst/>
          </a:prstGeom>
          <a:noFill/>
          <a:ln w="19050">
            <a:solidFill>
              <a:srgbClr val="92D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206132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グループ化 1"/>
          <p:cNvGrpSpPr/>
          <p:nvPr/>
        </p:nvGrpSpPr>
        <p:grpSpPr>
          <a:xfrm>
            <a:off x="1742361" y="1789499"/>
            <a:ext cx="872430" cy="788025"/>
            <a:chOff x="5296462" y="1331640"/>
            <a:chExt cx="872430" cy="788025"/>
          </a:xfrm>
        </p:grpSpPr>
        <p:cxnSp>
          <p:nvCxnSpPr>
            <p:cNvPr id="3" name="直線コネクタ 2"/>
            <p:cNvCxnSpPr/>
            <p:nvPr/>
          </p:nvCxnSpPr>
          <p:spPr>
            <a:xfrm>
              <a:off x="5296462" y="1455668"/>
              <a:ext cx="231918" cy="0"/>
            </a:xfrm>
            <a:prstGeom prst="line">
              <a:avLst/>
            </a:prstGeom>
            <a:ln w="19050">
              <a:solidFill>
                <a:schemeClr val="accent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" name="直線コネクタ 3"/>
            <p:cNvCxnSpPr/>
            <p:nvPr/>
          </p:nvCxnSpPr>
          <p:spPr>
            <a:xfrm>
              <a:off x="5296462" y="1639676"/>
              <a:ext cx="231918" cy="0"/>
            </a:xfrm>
            <a:prstGeom prst="line">
              <a:avLst/>
            </a:prstGeom>
            <a:ln w="190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" name="直線コネクタ 4"/>
            <p:cNvCxnSpPr/>
            <p:nvPr/>
          </p:nvCxnSpPr>
          <p:spPr>
            <a:xfrm>
              <a:off x="5296462" y="1823684"/>
              <a:ext cx="231918" cy="0"/>
            </a:xfrm>
            <a:prstGeom prst="line">
              <a:avLst/>
            </a:prstGeom>
            <a:ln w="19050">
              <a:solidFill>
                <a:schemeClr val="accent3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直線コネクタ 5"/>
            <p:cNvCxnSpPr/>
            <p:nvPr/>
          </p:nvCxnSpPr>
          <p:spPr>
            <a:xfrm>
              <a:off x="5296462" y="2007692"/>
              <a:ext cx="231918" cy="0"/>
            </a:xfrm>
            <a:prstGeom prst="line">
              <a:avLst/>
            </a:prstGeom>
            <a:ln w="19050">
              <a:solidFill>
                <a:schemeClr val="accent4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テキスト ボックス 6"/>
            <p:cNvSpPr txBox="1"/>
            <p:nvPr/>
          </p:nvSpPr>
          <p:spPr>
            <a:xfrm>
              <a:off x="5535385" y="1331640"/>
              <a:ext cx="63350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 err="1"/>
                <a:t>Glc</a:t>
              </a:r>
              <a:r>
                <a:rPr kumimoji="1" lang="en-US" altLang="ja-JP" sz="900" dirty="0"/>
                <a:t>+ </a:t>
              </a:r>
              <a:r>
                <a:rPr kumimoji="1" lang="en-US" altLang="ja-JP" sz="900" dirty="0" err="1"/>
                <a:t>Gln</a:t>
              </a:r>
              <a:r>
                <a:rPr kumimoji="1" lang="en-US" altLang="ja-JP" sz="900" dirty="0"/>
                <a:t>+</a:t>
              </a:r>
              <a:endParaRPr kumimoji="1" lang="ja-JP" altLang="en-US" sz="900" dirty="0"/>
            </a:p>
          </p:txBody>
        </p:sp>
        <p:sp>
          <p:nvSpPr>
            <p:cNvPr id="8" name="テキスト ボックス 7"/>
            <p:cNvSpPr txBox="1"/>
            <p:nvPr/>
          </p:nvSpPr>
          <p:spPr>
            <a:xfrm>
              <a:off x="5535385" y="1517371"/>
              <a:ext cx="61106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 err="1"/>
                <a:t>Glc</a:t>
              </a:r>
              <a:r>
                <a:rPr lang="en-US" altLang="ja-JP" sz="900" dirty="0"/>
                <a:t>- </a:t>
              </a:r>
              <a:r>
                <a:rPr lang="en-US" altLang="ja-JP" sz="900" dirty="0" err="1"/>
                <a:t>Gln</a:t>
              </a:r>
              <a:r>
                <a:rPr lang="en-US" altLang="ja-JP" sz="900" dirty="0"/>
                <a:t>+</a:t>
              </a:r>
              <a:endParaRPr kumimoji="1" lang="ja-JP" altLang="en-US" sz="900" dirty="0"/>
            </a:p>
          </p:txBody>
        </p:sp>
        <p:sp>
          <p:nvSpPr>
            <p:cNvPr id="9" name="テキスト ボックス 8"/>
            <p:cNvSpPr txBox="1"/>
            <p:nvPr/>
          </p:nvSpPr>
          <p:spPr>
            <a:xfrm>
              <a:off x="5535385" y="1703102"/>
              <a:ext cx="61106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 err="1"/>
                <a:t>Glc</a:t>
              </a:r>
              <a:r>
                <a:rPr kumimoji="1" lang="en-US" altLang="ja-JP" sz="900" dirty="0"/>
                <a:t>+ </a:t>
              </a:r>
              <a:r>
                <a:rPr kumimoji="1" lang="en-US" altLang="ja-JP" sz="900" dirty="0" err="1"/>
                <a:t>Gln</a:t>
              </a:r>
              <a:r>
                <a:rPr kumimoji="1" lang="en-US" altLang="ja-JP" sz="900" dirty="0"/>
                <a:t>-</a:t>
              </a:r>
              <a:endParaRPr kumimoji="1" lang="ja-JP" altLang="en-US" sz="900" dirty="0"/>
            </a:p>
          </p:txBody>
        </p:sp>
        <p:sp>
          <p:nvSpPr>
            <p:cNvPr id="10" name="テキスト ボックス 9"/>
            <p:cNvSpPr txBox="1"/>
            <p:nvPr/>
          </p:nvSpPr>
          <p:spPr>
            <a:xfrm>
              <a:off x="5535385" y="1888833"/>
              <a:ext cx="58862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 err="1"/>
                <a:t>Glc</a:t>
              </a:r>
              <a:r>
                <a:rPr kumimoji="1" lang="en-US" altLang="ja-JP" sz="900" dirty="0"/>
                <a:t>- </a:t>
              </a:r>
              <a:r>
                <a:rPr kumimoji="1" lang="en-US" altLang="ja-JP" sz="900" dirty="0" err="1"/>
                <a:t>Gln</a:t>
              </a:r>
              <a:r>
                <a:rPr kumimoji="1" lang="en-US" altLang="ja-JP" sz="900" dirty="0"/>
                <a:t>-</a:t>
              </a:r>
              <a:endParaRPr lang="ja-JP" altLang="en-US" sz="900" dirty="0"/>
            </a:p>
          </p:txBody>
        </p:sp>
      </p:grpSp>
      <p:graphicFrame>
        <p:nvGraphicFramePr>
          <p:cNvPr id="11" name="グラフ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33617252"/>
              </p:ext>
            </p:extLst>
          </p:nvPr>
        </p:nvGraphicFramePr>
        <p:xfrm>
          <a:off x="44624" y="1010509"/>
          <a:ext cx="1788046" cy="31662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2" name="テキスト ボックス 11"/>
          <p:cNvSpPr txBox="1"/>
          <p:nvPr/>
        </p:nvSpPr>
        <p:spPr>
          <a:xfrm>
            <a:off x="4176" y="1313"/>
            <a:ext cx="10647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err="1"/>
              <a:t>Supp</a:t>
            </a:r>
            <a:r>
              <a:rPr kumimoji="1" lang="ja-JP" altLang="en-US" sz="1400" dirty="0" err="1"/>
              <a:t>ｌ</a:t>
            </a:r>
            <a:r>
              <a:rPr kumimoji="1" lang="en-US" altLang="ja-JP" sz="1400" dirty="0"/>
              <a:t>. Fig. 2</a:t>
            </a:r>
            <a:endParaRPr kumimoji="1" lang="ja-JP" altLang="en-US" sz="1400" dirty="0"/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68220" y="539552"/>
            <a:ext cx="2712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/>
              <a:t>a</a:t>
            </a:r>
            <a:endParaRPr kumimoji="1" lang="ja-JP" altLang="en-US" sz="1400" b="1" dirty="0"/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68220" y="4782959"/>
            <a:ext cx="2600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/>
              <a:t>c</a:t>
            </a:r>
            <a:endParaRPr kumimoji="1" lang="ja-JP" altLang="en-US" sz="1400" b="1" dirty="0"/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2615261" y="541659"/>
            <a:ext cx="2792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/>
              <a:t>b</a:t>
            </a:r>
            <a:endParaRPr kumimoji="1" lang="ja-JP" altLang="en-US" sz="1400" b="1" dirty="0"/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3724061" y="3811239"/>
            <a:ext cx="4026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err="1"/>
              <a:t>Gln</a:t>
            </a:r>
            <a:r>
              <a:rPr lang="en-US" altLang="ja-JP" sz="900" dirty="0"/>
              <a:t>+</a:t>
            </a:r>
            <a:endParaRPr kumimoji="1" lang="ja-JP" altLang="en-US" sz="900" dirty="0"/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5293652" y="3805723"/>
            <a:ext cx="38023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err="1"/>
              <a:t>Gln</a:t>
            </a:r>
            <a:r>
              <a:rPr lang="en-US" altLang="ja-JP" sz="900" dirty="0"/>
              <a:t>-</a:t>
            </a:r>
            <a:endParaRPr kumimoji="1" lang="ja-JP" altLang="en-US" sz="900" dirty="0"/>
          </a:p>
        </p:txBody>
      </p:sp>
      <p:cxnSp>
        <p:nvCxnSpPr>
          <p:cNvPr id="31" name="直線コネクタ 30"/>
          <p:cNvCxnSpPr/>
          <p:nvPr/>
        </p:nvCxnSpPr>
        <p:spPr>
          <a:xfrm>
            <a:off x="3420071" y="3805723"/>
            <a:ext cx="107818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テキスト ボックス 32"/>
          <p:cNvSpPr txBox="1"/>
          <p:nvPr/>
        </p:nvSpPr>
        <p:spPr>
          <a:xfrm>
            <a:off x="4284167" y="4093755"/>
            <a:ext cx="80182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/>
              <a:t>U87/</a:t>
            </a:r>
            <a:r>
              <a:rPr kumimoji="1" lang="en-US" altLang="ja-JP" sz="900" dirty="0" err="1"/>
              <a:t>EGFRvIII</a:t>
            </a:r>
            <a:endParaRPr kumimoji="1" lang="ja-JP" altLang="en-US" sz="900" dirty="0"/>
          </a:p>
        </p:txBody>
      </p:sp>
      <p:graphicFrame>
        <p:nvGraphicFramePr>
          <p:cNvPr id="39" name="グラフ 3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81735614"/>
              </p:ext>
            </p:extLst>
          </p:nvPr>
        </p:nvGraphicFramePr>
        <p:xfrm>
          <a:off x="209836" y="4782714"/>
          <a:ext cx="2067036" cy="346169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40" name="グループ化 39"/>
          <p:cNvGrpSpPr/>
          <p:nvPr/>
        </p:nvGrpSpPr>
        <p:grpSpPr>
          <a:xfrm>
            <a:off x="666092" y="4952786"/>
            <a:ext cx="386644" cy="445129"/>
            <a:chOff x="4830782" y="1324381"/>
            <a:chExt cx="386644" cy="445129"/>
          </a:xfrm>
        </p:grpSpPr>
        <p:sp>
          <p:nvSpPr>
            <p:cNvPr id="41" name="テキスト ボックス 40"/>
            <p:cNvSpPr txBox="1"/>
            <p:nvPr/>
          </p:nvSpPr>
          <p:spPr>
            <a:xfrm>
              <a:off x="4830782" y="1324381"/>
              <a:ext cx="38664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/>
                <a:t>6.10</a:t>
              </a:r>
              <a:endParaRPr kumimoji="1" lang="ja-JP" altLang="en-US" sz="900" dirty="0"/>
            </a:p>
          </p:txBody>
        </p:sp>
        <p:grpSp>
          <p:nvGrpSpPr>
            <p:cNvPr id="42" name="グループ化 41"/>
            <p:cNvGrpSpPr/>
            <p:nvPr/>
          </p:nvGrpSpPr>
          <p:grpSpPr>
            <a:xfrm>
              <a:off x="4978861" y="1646418"/>
              <a:ext cx="157183" cy="123092"/>
              <a:chOff x="4863231" y="316523"/>
              <a:chExt cx="157183" cy="123092"/>
            </a:xfrm>
          </p:grpSpPr>
          <p:cxnSp>
            <p:nvCxnSpPr>
              <p:cNvPr id="43" name="直線コネクタ 42"/>
              <p:cNvCxnSpPr/>
              <p:nvPr/>
            </p:nvCxnSpPr>
            <p:spPr>
              <a:xfrm>
                <a:off x="4863231" y="316523"/>
                <a:ext cx="157183" cy="7033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直線コネクタ 43"/>
              <p:cNvCxnSpPr/>
              <p:nvPr/>
            </p:nvCxnSpPr>
            <p:spPr>
              <a:xfrm>
                <a:off x="4863231" y="369277"/>
                <a:ext cx="157183" cy="70338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pic>
        <p:nvPicPr>
          <p:cNvPr id="36" name="図 35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900" b="7849"/>
          <a:stretch/>
        </p:blipFill>
        <p:spPr>
          <a:xfrm>
            <a:off x="2839904" y="709379"/>
            <a:ext cx="3914186" cy="2992040"/>
          </a:xfrm>
          <a:prstGeom prst="rect">
            <a:avLst/>
          </a:prstGeom>
        </p:spPr>
      </p:pic>
      <p:cxnSp>
        <p:nvCxnSpPr>
          <p:cNvPr id="47" name="直線コネクタ 46"/>
          <p:cNvCxnSpPr/>
          <p:nvPr/>
        </p:nvCxnSpPr>
        <p:spPr>
          <a:xfrm>
            <a:off x="4932239" y="3805723"/>
            <a:ext cx="107818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直線コネクタ 47"/>
          <p:cNvCxnSpPr/>
          <p:nvPr/>
        </p:nvCxnSpPr>
        <p:spPr>
          <a:xfrm>
            <a:off x="3724061" y="4093755"/>
            <a:ext cx="192825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0" name="グループ化 29">
            <a:extLst>
              <a:ext uri="{FF2B5EF4-FFF2-40B4-BE49-F238E27FC236}">
                <a16:creationId xmlns:a16="http://schemas.microsoft.com/office/drawing/2014/main" id="{66EAA842-5FBD-4A67-A754-1E3B54C6D18E}"/>
              </a:ext>
            </a:extLst>
          </p:cNvPr>
          <p:cNvGrpSpPr/>
          <p:nvPr/>
        </p:nvGrpSpPr>
        <p:grpSpPr>
          <a:xfrm>
            <a:off x="1464403" y="5929423"/>
            <a:ext cx="62021" cy="63864"/>
            <a:chOff x="4550489" y="2472551"/>
            <a:chExt cx="196718" cy="152271"/>
          </a:xfrm>
        </p:grpSpPr>
        <p:cxnSp>
          <p:nvCxnSpPr>
            <p:cNvPr id="32" name="直線コネクタ 31">
              <a:extLst>
                <a:ext uri="{FF2B5EF4-FFF2-40B4-BE49-F238E27FC236}">
                  <a16:creationId xmlns:a16="http://schemas.microsoft.com/office/drawing/2014/main" id="{C806AE20-B84E-4453-BF56-86F99B0F1C3B}"/>
                </a:ext>
              </a:extLst>
            </p:cNvPr>
            <p:cNvCxnSpPr/>
            <p:nvPr/>
          </p:nvCxnSpPr>
          <p:spPr>
            <a:xfrm flipV="1">
              <a:off x="4550489" y="2472552"/>
              <a:ext cx="0" cy="15227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直線コネクタ 33">
              <a:extLst>
                <a:ext uri="{FF2B5EF4-FFF2-40B4-BE49-F238E27FC236}">
                  <a16:creationId xmlns:a16="http://schemas.microsoft.com/office/drawing/2014/main" id="{2DFCB592-2BCF-447D-80F1-8B14B418E2A8}"/>
                </a:ext>
              </a:extLst>
            </p:cNvPr>
            <p:cNvCxnSpPr/>
            <p:nvPr/>
          </p:nvCxnSpPr>
          <p:spPr>
            <a:xfrm>
              <a:off x="4550489" y="2472551"/>
              <a:ext cx="19671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直線コネクタ 34">
              <a:extLst>
                <a:ext uri="{FF2B5EF4-FFF2-40B4-BE49-F238E27FC236}">
                  <a16:creationId xmlns:a16="http://schemas.microsoft.com/office/drawing/2014/main" id="{B09D2A25-EBAE-4BB3-83F5-094D9E7C128E}"/>
                </a:ext>
              </a:extLst>
            </p:cNvPr>
            <p:cNvCxnSpPr/>
            <p:nvPr/>
          </p:nvCxnSpPr>
          <p:spPr>
            <a:xfrm>
              <a:off x="4747207" y="2472551"/>
              <a:ext cx="0" cy="15227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7" name="グループ化 36">
            <a:extLst>
              <a:ext uri="{FF2B5EF4-FFF2-40B4-BE49-F238E27FC236}">
                <a16:creationId xmlns:a16="http://schemas.microsoft.com/office/drawing/2014/main" id="{180A2407-B14B-4B07-814C-1CD1A663A72D}"/>
              </a:ext>
            </a:extLst>
          </p:cNvPr>
          <p:cNvGrpSpPr/>
          <p:nvPr/>
        </p:nvGrpSpPr>
        <p:grpSpPr>
          <a:xfrm>
            <a:off x="1748189" y="6430022"/>
            <a:ext cx="62021" cy="63864"/>
            <a:chOff x="4550489" y="2472551"/>
            <a:chExt cx="196718" cy="152271"/>
          </a:xfrm>
        </p:grpSpPr>
        <p:cxnSp>
          <p:nvCxnSpPr>
            <p:cNvPr id="38" name="直線コネクタ 37">
              <a:extLst>
                <a:ext uri="{FF2B5EF4-FFF2-40B4-BE49-F238E27FC236}">
                  <a16:creationId xmlns:a16="http://schemas.microsoft.com/office/drawing/2014/main" id="{30738056-31E0-4B76-973B-6015656A6800}"/>
                </a:ext>
              </a:extLst>
            </p:cNvPr>
            <p:cNvCxnSpPr/>
            <p:nvPr/>
          </p:nvCxnSpPr>
          <p:spPr>
            <a:xfrm flipV="1">
              <a:off x="4550489" y="2472552"/>
              <a:ext cx="0" cy="15227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直線コネクタ 44">
              <a:extLst>
                <a:ext uri="{FF2B5EF4-FFF2-40B4-BE49-F238E27FC236}">
                  <a16:creationId xmlns:a16="http://schemas.microsoft.com/office/drawing/2014/main" id="{A49A0F52-8E03-4F68-8904-7AEAE7190E0A}"/>
                </a:ext>
              </a:extLst>
            </p:cNvPr>
            <p:cNvCxnSpPr/>
            <p:nvPr/>
          </p:nvCxnSpPr>
          <p:spPr>
            <a:xfrm>
              <a:off x="4550489" y="2472551"/>
              <a:ext cx="19671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直線コネクタ 45">
              <a:extLst>
                <a:ext uri="{FF2B5EF4-FFF2-40B4-BE49-F238E27FC236}">
                  <a16:creationId xmlns:a16="http://schemas.microsoft.com/office/drawing/2014/main" id="{7BCD775C-5D14-48C6-BEF7-357EF306933D}"/>
                </a:ext>
              </a:extLst>
            </p:cNvPr>
            <p:cNvCxnSpPr/>
            <p:nvPr/>
          </p:nvCxnSpPr>
          <p:spPr>
            <a:xfrm>
              <a:off x="4747207" y="2472551"/>
              <a:ext cx="0" cy="15227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9" name="グループ化 48">
            <a:extLst>
              <a:ext uri="{FF2B5EF4-FFF2-40B4-BE49-F238E27FC236}">
                <a16:creationId xmlns:a16="http://schemas.microsoft.com/office/drawing/2014/main" id="{FA2D373F-7EC9-4F50-A249-5823BEC8CDBB}"/>
              </a:ext>
            </a:extLst>
          </p:cNvPr>
          <p:cNvGrpSpPr/>
          <p:nvPr/>
        </p:nvGrpSpPr>
        <p:grpSpPr>
          <a:xfrm>
            <a:off x="2042705" y="6179631"/>
            <a:ext cx="62021" cy="63864"/>
            <a:chOff x="4550489" y="2472551"/>
            <a:chExt cx="196718" cy="152271"/>
          </a:xfrm>
        </p:grpSpPr>
        <p:cxnSp>
          <p:nvCxnSpPr>
            <p:cNvPr id="50" name="直線コネクタ 49">
              <a:extLst>
                <a:ext uri="{FF2B5EF4-FFF2-40B4-BE49-F238E27FC236}">
                  <a16:creationId xmlns:a16="http://schemas.microsoft.com/office/drawing/2014/main" id="{A298092B-143D-4E99-AA78-E2142001C696}"/>
                </a:ext>
              </a:extLst>
            </p:cNvPr>
            <p:cNvCxnSpPr/>
            <p:nvPr/>
          </p:nvCxnSpPr>
          <p:spPr>
            <a:xfrm flipV="1">
              <a:off x="4550489" y="2472552"/>
              <a:ext cx="0" cy="15227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直線コネクタ 50">
              <a:extLst>
                <a:ext uri="{FF2B5EF4-FFF2-40B4-BE49-F238E27FC236}">
                  <a16:creationId xmlns:a16="http://schemas.microsoft.com/office/drawing/2014/main" id="{776271BD-3A97-493F-B31E-52180DB45786}"/>
                </a:ext>
              </a:extLst>
            </p:cNvPr>
            <p:cNvCxnSpPr/>
            <p:nvPr/>
          </p:nvCxnSpPr>
          <p:spPr>
            <a:xfrm>
              <a:off x="4550489" y="2472551"/>
              <a:ext cx="19671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直線コネクタ 51">
              <a:extLst>
                <a:ext uri="{FF2B5EF4-FFF2-40B4-BE49-F238E27FC236}">
                  <a16:creationId xmlns:a16="http://schemas.microsoft.com/office/drawing/2014/main" id="{9E45C2B1-42C9-4271-8267-C9B2BE915E0C}"/>
                </a:ext>
              </a:extLst>
            </p:cNvPr>
            <p:cNvCxnSpPr/>
            <p:nvPr/>
          </p:nvCxnSpPr>
          <p:spPr>
            <a:xfrm>
              <a:off x="4747207" y="2472551"/>
              <a:ext cx="0" cy="15227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3" name="正方形/長方形 18">
            <a:extLst>
              <a:ext uri="{FF2B5EF4-FFF2-40B4-BE49-F238E27FC236}">
                <a16:creationId xmlns:a16="http://schemas.microsoft.com/office/drawing/2014/main" id="{C6B02B82-5443-438B-AE0D-37A10750018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26414" y="5730433"/>
            <a:ext cx="351656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正方形/長方形 18">
            <a:extLst>
              <a:ext uri="{FF2B5EF4-FFF2-40B4-BE49-F238E27FC236}">
                <a16:creationId xmlns:a16="http://schemas.microsoft.com/office/drawing/2014/main" id="{E5E3B60B-AFC1-47C6-8BCD-5389EADB868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12557" y="6230603"/>
            <a:ext cx="351656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正方形/長方形 18">
            <a:extLst>
              <a:ext uri="{FF2B5EF4-FFF2-40B4-BE49-F238E27FC236}">
                <a16:creationId xmlns:a16="http://schemas.microsoft.com/office/drawing/2014/main" id="{B93D3135-6CC1-449E-9106-CA8513E734A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97887" y="5961355"/>
            <a:ext cx="351656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96B0FEA5-C17B-41C3-96DC-C9B5A6A868B6}"/>
              </a:ext>
            </a:extLst>
          </p:cNvPr>
          <p:cNvSpPr txBox="1"/>
          <p:nvPr/>
        </p:nvSpPr>
        <p:spPr>
          <a:xfrm>
            <a:off x="2428074" y="4781226"/>
            <a:ext cx="280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/>
              <a:t>d</a:t>
            </a:r>
            <a:endParaRPr kumimoji="1" lang="ja-JP" altLang="en-US" sz="1400" b="1" dirty="0"/>
          </a:p>
        </p:txBody>
      </p:sp>
      <p:graphicFrame>
        <p:nvGraphicFramePr>
          <p:cNvPr id="64" name="グラフ 63">
            <a:extLst>
              <a:ext uri="{FF2B5EF4-FFF2-40B4-BE49-F238E27FC236}">
                <a16:creationId xmlns:a16="http://schemas.microsoft.com/office/drawing/2014/main" id="{E50615DD-64C6-4108-A0D6-D755D4F7B60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87340478"/>
              </p:ext>
            </p:extLst>
          </p:nvPr>
        </p:nvGraphicFramePr>
        <p:xfrm>
          <a:off x="2448272" y="5083983"/>
          <a:ext cx="153799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65" name="グラフ 64">
            <a:extLst>
              <a:ext uri="{FF2B5EF4-FFF2-40B4-BE49-F238E27FC236}">
                <a16:creationId xmlns:a16="http://schemas.microsoft.com/office/drawing/2014/main" id="{7E9EDF50-9324-4F3F-9230-89D9B5B75E4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23701270"/>
              </p:ext>
            </p:extLst>
          </p:nvPr>
        </p:nvGraphicFramePr>
        <p:xfrm>
          <a:off x="3841147" y="5083983"/>
          <a:ext cx="1560552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66" name="グラフ 65">
            <a:extLst>
              <a:ext uri="{FF2B5EF4-FFF2-40B4-BE49-F238E27FC236}">
                <a16:creationId xmlns:a16="http://schemas.microsoft.com/office/drawing/2014/main" id="{B7F99FEB-C288-40E0-8103-014A1029821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5226053"/>
              </p:ext>
            </p:extLst>
          </p:nvPr>
        </p:nvGraphicFramePr>
        <p:xfrm>
          <a:off x="5256584" y="5083983"/>
          <a:ext cx="1556792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</p:spTree>
    <p:extLst>
      <p:ext uri="{BB962C8B-B14F-4D97-AF65-F5344CB8AC3E}">
        <p14:creationId xmlns:p14="http://schemas.microsoft.com/office/powerpoint/2010/main" val="407087225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テキスト ボックス 11"/>
          <p:cNvSpPr txBox="1"/>
          <p:nvPr/>
        </p:nvSpPr>
        <p:spPr>
          <a:xfrm>
            <a:off x="4176" y="1313"/>
            <a:ext cx="10647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err="1"/>
              <a:t>Supp</a:t>
            </a:r>
            <a:r>
              <a:rPr kumimoji="1" lang="ja-JP" altLang="en-US" sz="1400" dirty="0" err="1"/>
              <a:t>ｌ</a:t>
            </a:r>
            <a:r>
              <a:rPr kumimoji="1" lang="en-US" altLang="ja-JP" sz="1400" dirty="0"/>
              <a:t>. Fig. 3</a:t>
            </a:r>
            <a:endParaRPr kumimoji="1" lang="ja-JP" altLang="en-US" sz="1400" dirty="0"/>
          </a:p>
        </p:txBody>
      </p:sp>
      <p:graphicFrame>
        <p:nvGraphicFramePr>
          <p:cNvPr id="22" name="グラフ 2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13307837"/>
              </p:ext>
            </p:extLst>
          </p:nvPr>
        </p:nvGraphicFramePr>
        <p:xfrm>
          <a:off x="764704" y="719291"/>
          <a:ext cx="3539910" cy="313262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3" name="図 2">
            <a:extLst>
              <a:ext uri="{FF2B5EF4-FFF2-40B4-BE49-F238E27FC236}">
                <a16:creationId xmlns:a16="http://schemas.microsoft.com/office/drawing/2014/main" id="{1CAA132A-315A-459C-9AE8-7853891DF274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284" t="71807" r="1"/>
          <a:stretch/>
        </p:blipFill>
        <p:spPr>
          <a:xfrm>
            <a:off x="1316739" y="6397189"/>
            <a:ext cx="912155" cy="931036"/>
          </a:xfrm>
          <a:prstGeom prst="rect">
            <a:avLst/>
          </a:prstGeom>
        </p:spPr>
      </p:pic>
      <p:cxnSp>
        <p:nvCxnSpPr>
          <p:cNvPr id="6" name="直線矢印コネクタ 5">
            <a:extLst>
              <a:ext uri="{FF2B5EF4-FFF2-40B4-BE49-F238E27FC236}">
                <a16:creationId xmlns:a16="http://schemas.microsoft.com/office/drawing/2014/main" id="{DB74A3A9-29F6-4C0D-B4D7-99CBA87F0115}"/>
              </a:ext>
            </a:extLst>
          </p:cNvPr>
          <p:cNvCxnSpPr>
            <a:cxnSpLocks/>
          </p:cNvCxnSpPr>
          <p:nvPr/>
        </p:nvCxnSpPr>
        <p:spPr>
          <a:xfrm>
            <a:off x="1777614" y="5852581"/>
            <a:ext cx="0" cy="516418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3943AA6A-DBC8-4AE1-BA2C-C3B10ECCA8FD}"/>
              </a:ext>
            </a:extLst>
          </p:cNvPr>
          <p:cNvSpPr txBox="1"/>
          <p:nvPr/>
        </p:nvSpPr>
        <p:spPr>
          <a:xfrm>
            <a:off x="1302874" y="7988814"/>
            <a:ext cx="100219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/>
              <a:t>Culture condition</a:t>
            </a:r>
            <a:endParaRPr kumimoji="1" lang="ja-JP" altLang="en-US" sz="900" dirty="0"/>
          </a:p>
        </p:txBody>
      </p:sp>
      <p:pic>
        <p:nvPicPr>
          <p:cNvPr id="10" name="図 9">
            <a:extLst>
              <a:ext uri="{FF2B5EF4-FFF2-40B4-BE49-F238E27FC236}">
                <a16:creationId xmlns:a16="http://schemas.microsoft.com/office/drawing/2014/main" id="{47568F8A-60F2-485B-8670-82B70D7F23C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61905" y="4333756"/>
            <a:ext cx="1631417" cy="1433056"/>
          </a:xfrm>
          <a:prstGeom prst="rect">
            <a:avLst/>
          </a:prstGeom>
        </p:spPr>
      </p:pic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7E724E4D-847F-4D11-8289-9B060CE879C0}"/>
              </a:ext>
            </a:extLst>
          </p:cNvPr>
          <p:cNvSpPr txBox="1"/>
          <p:nvPr/>
        </p:nvSpPr>
        <p:spPr>
          <a:xfrm>
            <a:off x="116632" y="4261022"/>
            <a:ext cx="2792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/>
              <a:t>b</a:t>
            </a:r>
            <a:endParaRPr kumimoji="1" lang="ja-JP" altLang="en-US" sz="1400" b="1" dirty="0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A745A90C-410B-40E8-8583-C92A4176B2A5}"/>
              </a:ext>
            </a:extLst>
          </p:cNvPr>
          <p:cNvSpPr txBox="1"/>
          <p:nvPr/>
        </p:nvSpPr>
        <p:spPr>
          <a:xfrm>
            <a:off x="116632" y="447799"/>
            <a:ext cx="2728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/>
              <a:t>a</a:t>
            </a:r>
            <a:endParaRPr kumimoji="1" lang="ja-JP" altLang="en-US" sz="1400" b="1" dirty="0"/>
          </a:p>
        </p:txBody>
      </p:sp>
      <p:cxnSp>
        <p:nvCxnSpPr>
          <p:cNvPr id="11" name="直線矢印コネクタ 10">
            <a:extLst>
              <a:ext uri="{FF2B5EF4-FFF2-40B4-BE49-F238E27FC236}">
                <a16:creationId xmlns:a16="http://schemas.microsoft.com/office/drawing/2014/main" id="{43A06E21-F1FB-48E0-B373-FDADBB9CD791}"/>
              </a:ext>
            </a:extLst>
          </p:cNvPr>
          <p:cNvCxnSpPr/>
          <p:nvPr/>
        </p:nvCxnSpPr>
        <p:spPr>
          <a:xfrm flipH="1">
            <a:off x="1270139" y="7416061"/>
            <a:ext cx="155534" cy="269448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線矢印コネクタ 15">
            <a:extLst>
              <a:ext uri="{FF2B5EF4-FFF2-40B4-BE49-F238E27FC236}">
                <a16:creationId xmlns:a16="http://schemas.microsoft.com/office/drawing/2014/main" id="{0A3295C6-5EC2-4DF0-A2E4-2D7600235940}"/>
              </a:ext>
            </a:extLst>
          </p:cNvPr>
          <p:cNvCxnSpPr>
            <a:cxnSpLocks/>
          </p:cNvCxnSpPr>
          <p:nvPr/>
        </p:nvCxnSpPr>
        <p:spPr>
          <a:xfrm>
            <a:off x="2128476" y="7416061"/>
            <a:ext cx="144016" cy="269448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A5E101AE-1654-4959-B37A-772A2C33F297}"/>
              </a:ext>
            </a:extLst>
          </p:cNvPr>
          <p:cNvSpPr txBox="1"/>
          <p:nvPr/>
        </p:nvSpPr>
        <p:spPr>
          <a:xfrm>
            <a:off x="1077730" y="7728746"/>
            <a:ext cx="4026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err="1"/>
              <a:t>Gln</a:t>
            </a:r>
            <a:r>
              <a:rPr kumimoji="1" lang="en-US" altLang="ja-JP" sz="900" dirty="0"/>
              <a:t>+</a:t>
            </a:r>
            <a:endParaRPr kumimoji="1" lang="ja-JP" altLang="en-US" sz="900" dirty="0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7368A729-7A28-406E-857B-5FC43761F737}"/>
              </a:ext>
            </a:extLst>
          </p:cNvPr>
          <p:cNvSpPr txBox="1"/>
          <p:nvPr/>
        </p:nvSpPr>
        <p:spPr>
          <a:xfrm>
            <a:off x="2082376" y="7736076"/>
            <a:ext cx="38023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err="1"/>
              <a:t>Gln</a:t>
            </a:r>
            <a:r>
              <a:rPr kumimoji="1" lang="en-US" altLang="ja-JP" sz="900" dirty="0"/>
              <a:t>-</a:t>
            </a:r>
            <a:endParaRPr kumimoji="1" lang="ja-JP" altLang="en-US" sz="900" dirty="0"/>
          </a:p>
        </p:txBody>
      </p: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B76F219D-F78C-4EFD-B30D-E12880AD4EBB}"/>
              </a:ext>
            </a:extLst>
          </p:cNvPr>
          <p:cNvCxnSpPr>
            <a:cxnSpLocks/>
          </p:cNvCxnSpPr>
          <p:nvPr/>
        </p:nvCxnSpPr>
        <p:spPr>
          <a:xfrm>
            <a:off x="1120364" y="7972150"/>
            <a:ext cx="127961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51D86433-992A-4BD0-B50E-C1972C159529}"/>
              </a:ext>
            </a:extLst>
          </p:cNvPr>
          <p:cNvSpPr txBox="1"/>
          <p:nvPr/>
        </p:nvSpPr>
        <p:spPr>
          <a:xfrm>
            <a:off x="1777614" y="5855651"/>
            <a:ext cx="1175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/>
              <a:t>GBM patient-derived</a:t>
            </a:r>
          </a:p>
          <a:p>
            <a:r>
              <a:rPr lang="en-US" altLang="ja-JP" sz="900" dirty="0"/>
              <a:t>Sphere model</a:t>
            </a:r>
            <a:r>
              <a:rPr kumimoji="1" lang="en-US" altLang="ja-JP" sz="900" dirty="0"/>
              <a:t> </a:t>
            </a:r>
            <a:endParaRPr kumimoji="1" lang="ja-JP" altLang="en-US" sz="900" dirty="0"/>
          </a:p>
        </p:txBody>
      </p:sp>
      <p:graphicFrame>
        <p:nvGraphicFramePr>
          <p:cNvPr id="18" name="グラフ 17">
            <a:extLst>
              <a:ext uri="{FF2B5EF4-FFF2-40B4-BE49-F238E27FC236}">
                <a16:creationId xmlns:a16="http://schemas.microsoft.com/office/drawing/2014/main" id="{E58E942C-9833-434F-B1B3-6A87EF218AC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00722297"/>
              </p:ext>
            </p:extLst>
          </p:nvPr>
        </p:nvGraphicFramePr>
        <p:xfrm>
          <a:off x="3334531" y="4669621"/>
          <a:ext cx="2675467" cy="35747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pSp>
        <p:nvGrpSpPr>
          <p:cNvPr id="24" name="グループ化 23">
            <a:extLst>
              <a:ext uri="{FF2B5EF4-FFF2-40B4-BE49-F238E27FC236}">
                <a16:creationId xmlns:a16="http://schemas.microsoft.com/office/drawing/2014/main" id="{733DAD3E-2FA3-4644-9755-4BDA3B2F3DC9}"/>
              </a:ext>
            </a:extLst>
          </p:cNvPr>
          <p:cNvGrpSpPr/>
          <p:nvPr/>
        </p:nvGrpSpPr>
        <p:grpSpPr>
          <a:xfrm>
            <a:off x="4701717" y="5065234"/>
            <a:ext cx="62021" cy="63864"/>
            <a:chOff x="4550489" y="2472551"/>
            <a:chExt cx="196718" cy="152271"/>
          </a:xfrm>
        </p:grpSpPr>
        <p:cxnSp>
          <p:nvCxnSpPr>
            <p:cNvPr id="25" name="直線コネクタ 24">
              <a:extLst>
                <a:ext uri="{FF2B5EF4-FFF2-40B4-BE49-F238E27FC236}">
                  <a16:creationId xmlns:a16="http://schemas.microsoft.com/office/drawing/2014/main" id="{9F6B07B2-DA15-417A-9E57-08D73C32AFB0}"/>
                </a:ext>
              </a:extLst>
            </p:cNvPr>
            <p:cNvCxnSpPr/>
            <p:nvPr/>
          </p:nvCxnSpPr>
          <p:spPr>
            <a:xfrm flipV="1">
              <a:off x="4550489" y="2472552"/>
              <a:ext cx="0" cy="15227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直線コネクタ 25">
              <a:extLst>
                <a:ext uri="{FF2B5EF4-FFF2-40B4-BE49-F238E27FC236}">
                  <a16:creationId xmlns:a16="http://schemas.microsoft.com/office/drawing/2014/main" id="{CBEB041F-349B-4431-A092-72522BD7ED0C}"/>
                </a:ext>
              </a:extLst>
            </p:cNvPr>
            <p:cNvCxnSpPr/>
            <p:nvPr/>
          </p:nvCxnSpPr>
          <p:spPr>
            <a:xfrm>
              <a:off x="4550489" y="2472551"/>
              <a:ext cx="19671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直線コネクタ 26">
              <a:extLst>
                <a:ext uri="{FF2B5EF4-FFF2-40B4-BE49-F238E27FC236}">
                  <a16:creationId xmlns:a16="http://schemas.microsoft.com/office/drawing/2014/main" id="{AC5CE0ED-2145-40BA-8C30-F6CB2BDBA38E}"/>
                </a:ext>
              </a:extLst>
            </p:cNvPr>
            <p:cNvCxnSpPr/>
            <p:nvPr/>
          </p:nvCxnSpPr>
          <p:spPr>
            <a:xfrm>
              <a:off x="4747207" y="2472551"/>
              <a:ext cx="0" cy="15227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8" name="正方形/長方形 18">
            <a:extLst>
              <a:ext uri="{FF2B5EF4-FFF2-40B4-BE49-F238E27FC236}">
                <a16:creationId xmlns:a16="http://schemas.microsoft.com/office/drawing/2014/main" id="{F5452480-E92F-4D4B-9B0C-4BE7EED2512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56900" y="4835485"/>
            <a:ext cx="351656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9" name="グループ化 28">
            <a:extLst>
              <a:ext uri="{FF2B5EF4-FFF2-40B4-BE49-F238E27FC236}">
                <a16:creationId xmlns:a16="http://schemas.microsoft.com/office/drawing/2014/main" id="{AD5B4316-6374-4C24-BEDE-CFB66237B905}"/>
              </a:ext>
            </a:extLst>
          </p:cNvPr>
          <p:cNvGrpSpPr/>
          <p:nvPr/>
        </p:nvGrpSpPr>
        <p:grpSpPr>
          <a:xfrm>
            <a:off x="5022362" y="5065234"/>
            <a:ext cx="62021" cy="63864"/>
            <a:chOff x="4550489" y="2472551"/>
            <a:chExt cx="196718" cy="152271"/>
          </a:xfrm>
        </p:grpSpPr>
        <p:cxnSp>
          <p:nvCxnSpPr>
            <p:cNvPr id="30" name="直線コネクタ 29">
              <a:extLst>
                <a:ext uri="{FF2B5EF4-FFF2-40B4-BE49-F238E27FC236}">
                  <a16:creationId xmlns:a16="http://schemas.microsoft.com/office/drawing/2014/main" id="{61E07BDD-1B02-45B4-AA0D-BF3E2B0BD0D2}"/>
                </a:ext>
              </a:extLst>
            </p:cNvPr>
            <p:cNvCxnSpPr/>
            <p:nvPr/>
          </p:nvCxnSpPr>
          <p:spPr>
            <a:xfrm flipV="1">
              <a:off x="4550489" y="2472552"/>
              <a:ext cx="0" cy="15227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直線コネクタ 30">
              <a:extLst>
                <a:ext uri="{FF2B5EF4-FFF2-40B4-BE49-F238E27FC236}">
                  <a16:creationId xmlns:a16="http://schemas.microsoft.com/office/drawing/2014/main" id="{0938EA06-F9F2-49D6-8C6E-98719BDCB67A}"/>
                </a:ext>
              </a:extLst>
            </p:cNvPr>
            <p:cNvCxnSpPr/>
            <p:nvPr/>
          </p:nvCxnSpPr>
          <p:spPr>
            <a:xfrm>
              <a:off x="4550489" y="2472551"/>
              <a:ext cx="19671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直線コネクタ 31">
              <a:extLst>
                <a:ext uri="{FF2B5EF4-FFF2-40B4-BE49-F238E27FC236}">
                  <a16:creationId xmlns:a16="http://schemas.microsoft.com/office/drawing/2014/main" id="{87E93B50-6465-49EA-BF39-F0A0E2224D66}"/>
                </a:ext>
              </a:extLst>
            </p:cNvPr>
            <p:cNvCxnSpPr/>
            <p:nvPr/>
          </p:nvCxnSpPr>
          <p:spPr>
            <a:xfrm>
              <a:off x="4747207" y="2472551"/>
              <a:ext cx="0" cy="15227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3" name="正方形/長方形 18">
            <a:extLst>
              <a:ext uri="{FF2B5EF4-FFF2-40B4-BE49-F238E27FC236}">
                <a16:creationId xmlns:a16="http://schemas.microsoft.com/office/drawing/2014/main" id="{1D1DB16A-3F46-4B1C-99F4-BACDEFC59CD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77544" y="4827409"/>
            <a:ext cx="351656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4" name="グループ化 33">
            <a:extLst>
              <a:ext uri="{FF2B5EF4-FFF2-40B4-BE49-F238E27FC236}">
                <a16:creationId xmlns:a16="http://schemas.microsoft.com/office/drawing/2014/main" id="{BCF845BB-F74F-4F47-8E9C-7D7DFF52BDD4}"/>
              </a:ext>
            </a:extLst>
          </p:cNvPr>
          <p:cNvGrpSpPr/>
          <p:nvPr/>
        </p:nvGrpSpPr>
        <p:grpSpPr>
          <a:xfrm>
            <a:off x="5674608" y="5507155"/>
            <a:ext cx="62021" cy="63864"/>
            <a:chOff x="4550489" y="2472551"/>
            <a:chExt cx="196718" cy="152271"/>
          </a:xfrm>
        </p:grpSpPr>
        <p:cxnSp>
          <p:nvCxnSpPr>
            <p:cNvPr id="35" name="直線コネクタ 34">
              <a:extLst>
                <a:ext uri="{FF2B5EF4-FFF2-40B4-BE49-F238E27FC236}">
                  <a16:creationId xmlns:a16="http://schemas.microsoft.com/office/drawing/2014/main" id="{65EE2DA8-8E2C-4FB0-9E7E-35A35566294B}"/>
                </a:ext>
              </a:extLst>
            </p:cNvPr>
            <p:cNvCxnSpPr/>
            <p:nvPr/>
          </p:nvCxnSpPr>
          <p:spPr>
            <a:xfrm flipV="1">
              <a:off x="4550489" y="2472552"/>
              <a:ext cx="0" cy="15227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直線コネクタ 35">
              <a:extLst>
                <a:ext uri="{FF2B5EF4-FFF2-40B4-BE49-F238E27FC236}">
                  <a16:creationId xmlns:a16="http://schemas.microsoft.com/office/drawing/2014/main" id="{27D37C76-F6AD-4378-813F-25585E96C119}"/>
                </a:ext>
              </a:extLst>
            </p:cNvPr>
            <p:cNvCxnSpPr/>
            <p:nvPr/>
          </p:nvCxnSpPr>
          <p:spPr>
            <a:xfrm>
              <a:off x="4550489" y="2472551"/>
              <a:ext cx="19671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直線コネクタ 36">
              <a:extLst>
                <a:ext uri="{FF2B5EF4-FFF2-40B4-BE49-F238E27FC236}">
                  <a16:creationId xmlns:a16="http://schemas.microsoft.com/office/drawing/2014/main" id="{7767BEAA-7AD5-4022-8639-862BDAA83408}"/>
                </a:ext>
              </a:extLst>
            </p:cNvPr>
            <p:cNvCxnSpPr/>
            <p:nvPr/>
          </p:nvCxnSpPr>
          <p:spPr>
            <a:xfrm>
              <a:off x="4747207" y="2472551"/>
              <a:ext cx="0" cy="15227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8" name="正方形/長方形 18">
            <a:extLst>
              <a:ext uri="{FF2B5EF4-FFF2-40B4-BE49-F238E27FC236}">
                <a16:creationId xmlns:a16="http://schemas.microsoft.com/office/drawing/2014/main" id="{EEC408BA-7EAD-45A0-8EBD-ED2ECCD402FD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29790" y="5288879"/>
            <a:ext cx="351656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5E52F58B-C828-4F20-B767-876F22EA2AC5}"/>
              </a:ext>
            </a:extLst>
          </p:cNvPr>
          <p:cNvSpPr txBox="1"/>
          <p:nvPr/>
        </p:nvSpPr>
        <p:spPr>
          <a:xfrm>
            <a:off x="3284984" y="4261022"/>
            <a:ext cx="2792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/>
              <a:t>C</a:t>
            </a:r>
            <a:endParaRPr kumimoji="1" lang="ja-JP" alt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64036129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テキスト ボックス 11"/>
          <p:cNvSpPr txBox="1"/>
          <p:nvPr/>
        </p:nvSpPr>
        <p:spPr>
          <a:xfrm>
            <a:off x="4176" y="1313"/>
            <a:ext cx="10647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err="1"/>
              <a:t>Supp</a:t>
            </a:r>
            <a:r>
              <a:rPr kumimoji="1" lang="ja-JP" altLang="en-US" sz="1400" dirty="0" err="1"/>
              <a:t>ｌ</a:t>
            </a:r>
            <a:r>
              <a:rPr kumimoji="1" lang="en-US" altLang="ja-JP" sz="1400" dirty="0"/>
              <a:t>. Fig. 4</a:t>
            </a:r>
            <a:endParaRPr kumimoji="1" lang="ja-JP" altLang="en-US" sz="1400" dirty="0"/>
          </a:p>
        </p:txBody>
      </p:sp>
      <p:pic>
        <p:nvPicPr>
          <p:cNvPr id="21" name="図 20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2750" b="6082"/>
          <a:stretch/>
        </p:blipFill>
        <p:spPr>
          <a:xfrm>
            <a:off x="929253" y="683568"/>
            <a:ext cx="3291835" cy="4002002"/>
          </a:xfrm>
          <a:prstGeom prst="rect">
            <a:avLst/>
          </a:prstGeom>
        </p:spPr>
      </p:pic>
      <p:cxnSp>
        <p:nvCxnSpPr>
          <p:cNvPr id="23" name="直線コネクタ 22"/>
          <p:cNvCxnSpPr/>
          <p:nvPr/>
        </p:nvCxnSpPr>
        <p:spPr>
          <a:xfrm>
            <a:off x="1124744" y="4762531"/>
            <a:ext cx="45716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テキスト ボックス 23"/>
          <p:cNvSpPr txBox="1"/>
          <p:nvPr/>
        </p:nvSpPr>
        <p:spPr>
          <a:xfrm>
            <a:off x="1154118" y="4768047"/>
            <a:ext cx="4026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err="1"/>
              <a:t>Gln</a:t>
            </a:r>
            <a:r>
              <a:rPr lang="en-US" altLang="ja-JP" sz="900" dirty="0"/>
              <a:t>+</a:t>
            </a:r>
            <a:endParaRPr kumimoji="1" lang="ja-JP" altLang="en-US" sz="900" dirty="0"/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2797450" y="4762531"/>
            <a:ext cx="4026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err="1"/>
              <a:t>Gln</a:t>
            </a:r>
            <a:r>
              <a:rPr lang="en-US" altLang="ja-JP" sz="900" dirty="0"/>
              <a:t>+</a:t>
            </a:r>
            <a:endParaRPr kumimoji="1" lang="ja-JP" altLang="en-US" sz="900" dirty="0"/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1968648" y="4762531"/>
            <a:ext cx="38023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err="1"/>
              <a:t>Gln</a:t>
            </a:r>
            <a:r>
              <a:rPr lang="en-US" altLang="ja-JP" sz="900" dirty="0"/>
              <a:t>-</a:t>
            </a:r>
            <a:endParaRPr kumimoji="1" lang="ja-JP" altLang="en-US" sz="900" dirty="0"/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3624832" y="4762531"/>
            <a:ext cx="38023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err="1"/>
              <a:t>Gln</a:t>
            </a:r>
            <a:r>
              <a:rPr lang="en-US" altLang="ja-JP" sz="900" dirty="0"/>
              <a:t>-</a:t>
            </a:r>
            <a:endParaRPr kumimoji="1" lang="ja-JP" altLang="en-US" sz="900" dirty="0"/>
          </a:p>
        </p:txBody>
      </p:sp>
      <p:cxnSp>
        <p:nvCxnSpPr>
          <p:cNvPr id="28" name="直線コネクタ 27"/>
          <p:cNvCxnSpPr/>
          <p:nvPr/>
        </p:nvCxnSpPr>
        <p:spPr>
          <a:xfrm>
            <a:off x="1963721" y="4762531"/>
            <a:ext cx="45716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線コネクタ 28"/>
          <p:cNvCxnSpPr/>
          <p:nvPr/>
        </p:nvCxnSpPr>
        <p:spPr>
          <a:xfrm>
            <a:off x="2729385" y="4762531"/>
            <a:ext cx="45716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線コネクタ 29"/>
          <p:cNvCxnSpPr/>
          <p:nvPr/>
        </p:nvCxnSpPr>
        <p:spPr>
          <a:xfrm>
            <a:off x="3546232" y="4762531"/>
            <a:ext cx="45716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線コネクタ 30"/>
          <p:cNvCxnSpPr/>
          <p:nvPr/>
        </p:nvCxnSpPr>
        <p:spPr>
          <a:xfrm>
            <a:off x="1270697" y="5061248"/>
            <a:ext cx="107818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線コネクタ 31"/>
          <p:cNvCxnSpPr/>
          <p:nvPr/>
        </p:nvCxnSpPr>
        <p:spPr>
          <a:xfrm>
            <a:off x="2782865" y="5061248"/>
            <a:ext cx="107818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テキスト ボックス 32"/>
          <p:cNvSpPr txBox="1"/>
          <p:nvPr/>
        </p:nvSpPr>
        <p:spPr>
          <a:xfrm>
            <a:off x="1615020" y="5061248"/>
            <a:ext cx="37382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/>
              <a:t>U87</a:t>
            </a:r>
            <a:endParaRPr kumimoji="1" lang="ja-JP" altLang="en-US" sz="900" dirty="0"/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3212976" y="5061248"/>
            <a:ext cx="35618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/>
              <a:t>T98</a:t>
            </a:r>
            <a:endParaRPr kumimoji="1" lang="ja-JP" altLang="en-US" sz="900" dirty="0"/>
          </a:p>
        </p:txBody>
      </p:sp>
      <p:graphicFrame>
        <p:nvGraphicFramePr>
          <p:cNvPr id="37" name="表 3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76578228"/>
              </p:ext>
            </p:extLst>
          </p:nvPr>
        </p:nvGraphicFramePr>
        <p:xfrm>
          <a:off x="4337999" y="797931"/>
          <a:ext cx="2454845" cy="3838212"/>
        </p:xfrm>
        <a:graphic>
          <a:graphicData uri="http://schemas.openxmlformats.org/drawingml/2006/table">
            <a:tbl>
              <a:tblPr/>
              <a:tblGrid>
                <a:gridCol w="245484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137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2'-Deoxyguanosine 5'-monophosphate</a:t>
                      </a:r>
                    </a:p>
                  </a:txBody>
                  <a:tcPr marL="3625" marR="3625" marT="3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37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5-aminoimidazole-4-carboxamide-1-beta-D-ribofuranosyl 5'-monophosphate</a:t>
                      </a:r>
                    </a:p>
                  </a:txBody>
                  <a:tcPr marL="3625" marR="3625" marT="3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37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Adenosine</a:t>
                      </a:r>
                    </a:p>
                  </a:txBody>
                  <a:tcPr marL="3625" marR="3625" marT="3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37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Adenosine 3',5'-cyclic monophosphate</a:t>
                      </a:r>
                    </a:p>
                  </a:txBody>
                  <a:tcPr marL="3625" marR="3625" marT="3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37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Adenosine 5'-diphosphate</a:t>
                      </a:r>
                    </a:p>
                  </a:txBody>
                  <a:tcPr marL="3625" marR="3625" marT="3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37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Adenosine 5'-monophosphate</a:t>
                      </a:r>
                    </a:p>
                  </a:txBody>
                  <a:tcPr marL="3625" marR="3625" marT="3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37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Adenosine 5'-triphosphate</a:t>
                      </a:r>
                    </a:p>
                  </a:txBody>
                  <a:tcPr marL="3625" marR="3625" marT="3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37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Deoxyadenosine 5'-triphosphate</a:t>
                      </a:r>
                    </a:p>
                  </a:txBody>
                  <a:tcPr marL="3625" marR="3625" marT="3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37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Guanine</a:t>
                      </a:r>
                    </a:p>
                  </a:txBody>
                  <a:tcPr marL="3625" marR="3625" marT="3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37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Guanosine</a:t>
                      </a:r>
                    </a:p>
                  </a:txBody>
                  <a:tcPr marL="3625" marR="3625" marT="3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37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Guanosine 5'-diphosphate</a:t>
                      </a:r>
                    </a:p>
                  </a:txBody>
                  <a:tcPr marL="3625" marR="3625" marT="3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37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Guanosine 5'-monophosphate</a:t>
                      </a:r>
                    </a:p>
                  </a:txBody>
                  <a:tcPr marL="3625" marR="3625" marT="3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37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Guanosine 5'-triphosphate</a:t>
                      </a:r>
                    </a:p>
                  </a:txBody>
                  <a:tcPr marL="3625" marR="3625" marT="3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37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ypoxanthine</a:t>
                      </a:r>
                    </a:p>
                  </a:txBody>
                  <a:tcPr marL="3625" marR="3625" marT="3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37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Inosine 5'-monophosphate</a:t>
                      </a:r>
                    </a:p>
                  </a:txBody>
                  <a:tcPr marL="3625" marR="3625" marT="3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37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Uric acid</a:t>
                      </a:r>
                    </a:p>
                  </a:txBody>
                  <a:tcPr marL="3625" marR="3625" marT="3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37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Cytidine</a:t>
                      </a:r>
                    </a:p>
                  </a:txBody>
                  <a:tcPr marL="3625" marR="3625" marT="3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37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Cytidine 5'-diphosphate</a:t>
                      </a:r>
                    </a:p>
                  </a:txBody>
                  <a:tcPr marL="3625" marR="3625" marT="3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37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Cytidine 5'-triphosphate</a:t>
                      </a:r>
                    </a:p>
                  </a:txBody>
                  <a:tcPr marL="3625" marR="3625" marT="3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37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Cytidine-5'-monophosphate</a:t>
                      </a:r>
                    </a:p>
                  </a:txBody>
                  <a:tcPr marL="3625" marR="3625" marT="3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37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Deoxycytidine 5'-triphosphate</a:t>
                      </a:r>
                    </a:p>
                  </a:txBody>
                  <a:tcPr marL="3625" marR="3625" marT="3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37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Deoxythymidine 5'-triphosphate</a:t>
                      </a:r>
                    </a:p>
                  </a:txBody>
                  <a:tcPr marL="3625" marR="3625" marT="3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137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L-Dihydro-orotate</a:t>
                      </a:r>
                    </a:p>
                  </a:txBody>
                  <a:tcPr marL="3625" marR="3625" marT="3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137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Orotate</a:t>
                      </a:r>
                    </a:p>
                  </a:txBody>
                  <a:tcPr marL="3625" marR="3625" marT="3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137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Uridine 5'-diphosphate</a:t>
                      </a:r>
                    </a:p>
                  </a:txBody>
                  <a:tcPr marL="3625" marR="3625" marT="3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137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Uridine 5'-monophosphate</a:t>
                      </a:r>
                    </a:p>
                  </a:txBody>
                  <a:tcPr marL="3625" marR="3625" marT="3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137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Uridine 5'-triphosphate</a:t>
                      </a:r>
                    </a:p>
                  </a:txBody>
                  <a:tcPr marL="3625" marR="3625" marT="3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137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-Carbamoyl-L-aspartate</a:t>
                      </a:r>
                    </a:p>
                  </a:txBody>
                  <a:tcPr marL="3625" marR="3625" marT="36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</a:tbl>
          </a:graphicData>
        </a:graphic>
      </p:graphicFrame>
      <p:graphicFrame>
        <p:nvGraphicFramePr>
          <p:cNvPr id="38" name="表 3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0256501"/>
              </p:ext>
            </p:extLst>
          </p:nvPr>
        </p:nvGraphicFramePr>
        <p:xfrm>
          <a:off x="116632" y="793841"/>
          <a:ext cx="792088" cy="383821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9208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137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u="none" strike="noStrike" dirty="0">
                          <a:effectLst/>
                        </a:rPr>
                        <a:t>Purine metabolism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5953" marR="5953" marT="5953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37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u="none" strike="noStrike" dirty="0">
                          <a:effectLst/>
                        </a:rPr>
                        <a:t>Purine metabolism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5953" marR="5953" marT="5953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37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u="none" strike="noStrike">
                          <a:effectLst/>
                        </a:rPr>
                        <a:t>Purine metabolism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5953" marR="5953" marT="5953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37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u="none" strike="noStrike" dirty="0">
                          <a:effectLst/>
                        </a:rPr>
                        <a:t>Purine metabolism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5953" marR="5953" marT="5953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37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u="none" strike="noStrike">
                          <a:effectLst/>
                        </a:rPr>
                        <a:t>Purine metabolism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5953" marR="5953" marT="5953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37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u="none" strike="noStrike">
                          <a:effectLst/>
                        </a:rPr>
                        <a:t>Purine metabolism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5953" marR="5953" marT="5953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37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u="none" strike="noStrike">
                          <a:effectLst/>
                        </a:rPr>
                        <a:t>Purine metabolism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5953" marR="5953" marT="5953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37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u="none" strike="noStrike" dirty="0">
                          <a:effectLst/>
                        </a:rPr>
                        <a:t>Purine metabolism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5953" marR="5953" marT="5953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37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u="none" strike="noStrike">
                          <a:effectLst/>
                        </a:rPr>
                        <a:t>Purine metabolism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5953" marR="5953" marT="5953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37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u="none" strike="noStrike">
                          <a:effectLst/>
                        </a:rPr>
                        <a:t>Purine metabolism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5953" marR="5953" marT="5953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37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u="none" strike="noStrike">
                          <a:effectLst/>
                        </a:rPr>
                        <a:t>Purine metabolism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5953" marR="5953" marT="5953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37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u="none" strike="noStrike">
                          <a:effectLst/>
                        </a:rPr>
                        <a:t>Purine metabolism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5953" marR="5953" marT="5953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37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u="none" strike="noStrike" dirty="0">
                          <a:effectLst/>
                        </a:rPr>
                        <a:t>Purine metabolism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5953" marR="5953" marT="5953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37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u="none" strike="noStrike">
                          <a:effectLst/>
                        </a:rPr>
                        <a:t>Purine metabolism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5953" marR="5953" marT="5953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37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u="none" strike="noStrike">
                          <a:effectLst/>
                        </a:rPr>
                        <a:t>Purine metabolism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5953" marR="5953" marT="5953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37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u="none" strike="noStrike">
                          <a:effectLst/>
                        </a:rPr>
                        <a:t>Purine metabolism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5953" marR="5953" marT="5953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37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u="none" strike="noStrike">
                          <a:effectLst/>
                        </a:rPr>
                        <a:t>Pyrimidine metabolism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5953" marR="5953" marT="5953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37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u="none" strike="noStrike">
                          <a:effectLst/>
                        </a:rPr>
                        <a:t>Pyrimidine metabolism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5953" marR="5953" marT="5953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37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u="none" strike="noStrike">
                          <a:effectLst/>
                        </a:rPr>
                        <a:t>Pyrimidine metabolism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5953" marR="5953" marT="5953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37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u="none" strike="noStrike">
                          <a:effectLst/>
                        </a:rPr>
                        <a:t>Pyrimidine metabolism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5953" marR="5953" marT="5953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37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u="none" strike="noStrike">
                          <a:effectLst/>
                        </a:rPr>
                        <a:t>Pyrimidine metabolism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5953" marR="5953" marT="5953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37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u="none" strike="noStrike">
                          <a:effectLst/>
                        </a:rPr>
                        <a:t>Pyrimidine metabolism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5953" marR="5953" marT="5953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137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u="none" strike="noStrike">
                          <a:effectLst/>
                        </a:rPr>
                        <a:t>Pyrimidine metabolism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5953" marR="5953" marT="5953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137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u="none" strike="noStrike">
                          <a:effectLst/>
                        </a:rPr>
                        <a:t>Pyrimidine metabolism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5953" marR="5953" marT="5953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137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u="none" strike="noStrike">
                          <a:effectLst/>
                        </a:rPr>
                        <a:t>Pyrimidine metabolism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5953" marR="5953" marT="5953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137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u="none" strike="noStrike">
                          <a:effectLst/>
                        </a:rPr>
                        <a:t>Pyrimidine metabolism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5953" marR="5953" marT="5953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137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u="none" strike="noStrike">
                          <a:effectLst/>
                        </a:rPr>
                        <a:t>Pyrimidine metabolism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5953" marR="5953" marT="5953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137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u="none" strike="noStrike" dirty="0">
                          <a:effectLst/>
                        </a:rPr>
                        <a:t>Pyrimidine metabolism 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5953" marR="5953" marT="5953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</a:tbl>
          </a:graphicData>
        </a:graphic>
      </p:graphicFrame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871F5C3F-FD6C-4076-B08F-460133C67960}"/>
              </a:ext>
            </a:extLst>
          </p:cNvPr>
          <p:cNvSpPr txBox="1"/>
          <p:nvPr/>
        </p:nvSpPr>
        <p:spPr>
          <a:xfrm>
            <a:off x="57241" y="303783"/>
            <a:ext cx="2712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/>
              <a:t>a</a:t>
            </a:r>
            <a:endParaRPr kumimoji="1" lang="ja-JP" altLang="en-US" sz="1400" b="1" dirty="0"/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3D538148-AADD-4100-AB8D-2C9AF108561C}"/>
              </a:ext>
            </a:extLst>
          </p:cNvPr>
          <p:cNvSpPr txBox="1"/>
          <p:nvPr/>
        </p:nvSpPr>
        <p:spPr>
          <a:xfrm>
            <a:off x="57241" y="5445673"/>
            <a:ext cx="2792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/>
              <a:t>b</a:t>
            </a:r>
            <a:endParaRPr kumimoji="1" lang="ja-JP" altLang="en-US" sz="1400" b="1" dirty="0"/>
          </a:p>
        </p:txBody>
      </p:sp>
      <p:graphicFrame>
        <p:nvGraphicFramePr>
          <p:cNvPr id="50" name="グラフ 49">
            <a:extLst>
              <a:ext uri="{FF2B5EF4-FFF2-40B4-BE49-F238E27FC236}">
                <a16:creationId xmlns:a16="http://schemas.microsoft.com/office/drawing/2014/main" id="{F30050AD-275E-498E-82F3-15E26770809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62389220"/>
              </p:ext>
            </p:extLst>
          </p:nvPr>
        </p:nvGraphicFramePr>
        <p:xfrm>
          <a:off x="476672" y="5753450"/>
          <a:ext cx="2160240" cy="29241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52" name="グループ化 51">
            <a:extLst>
              <a:ext uri="{FF2B5EF4-FFF2-40B4-BE49-F238E27FC236}">
                <a16:creationId xmlns:a16="http://schemas.microsoft.com/office/drawing/2014/main" id="{6A3577E3-2861-4D62-83E1-EC51B9F760F5}"/>
              </a:ext>
            </a:extLst>
          </p:cNvPr>
          <p:cNvGrpSpPr/>
          <p:nvPr/>
        </p:nvGrpSpPr>
        <p:grpSpPr>
          <a:xfrm>
            <a:off x="2176532" y="5798215"/>
            <a:ext cx="231129" cy="524023"/>
            <a:chOff x="5861957" y="4453242"/>
            <a:chExt cx="447365" cy="694822"/>
          </a:xfrm>
        </p:grpSpPr>
        <p:cxnSp>
          <p:nvCxnSpPr>
            <p:cNvPr id="53" name="直線コネクタ 52">
              <a:extLst>
                <a:ext uri="{FF2B5EF4-FFF2-40B4-BE49-F238E27FC236}">
                  <a16:creationId xmlns:a16="http://schemas.microsoft.com/office/drawing/2014/main" id="{7DA435E0-8BFF-478F-B8E0-9C4DDD0C8AD3}"/>
                </a:ext>
              </a:extLst>
            </p:cNvPr>
            <p:cNvCxnSpPr/>
            <p:nvPr/>
          </p:nvCxnSpPr>
          <p:spPr>
            <a:xfrm rot="16200000">
              <a:off x="5741333" y="4573867"/>
              <a:ext cx="24125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直線コネクタ 53">
              <a:extLst>
                <a:ext uri="{FF2B5EF4-FFF2-40B4-BE49-F238E27FC236}">
                  <a16:creationId xmlns:a16="http://schemas.microsoft.com/office/drawing/2014/main" id="{72ACFB31-6D75-4418-A452-AF7ECFF70D55}"/>
                </a:ext>
              </a:extLst>
            </p:cNvPr>
            <p:cNvCxnSpPr/>
            <p:nvPr/>
          </p:nvCxnSpPr>
          <p:spPr>
            <a:xfrm>
              <a:off x="5861957" y="4453242"/>
              <a:ext cx="44736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直線コネクタ 54">
              <a:extLst>
                <a:ext uri="{FF2B5EF4-FFF2-40B4-BE49-F238E27FC236}">
                  <a16:creationId xmlns:a16="http://schemas.microsoft.com/office/drawing/2014/main" id="{B842AE66-31AD-4F6C-9AEB-C92C51EBB8F7}"/>
                </a:ext>
              </a:extLst>
            </p:cNvPr>
            <p:cNvCxnSpPr/>
            <p:nvPr/>
          </p:nvCxnSpPr>
          <p:spPr>
            <a:xfrm flipV="1">
              <a:off x="6309320" y="4453242"/>
              <a:ext cx="0" cy="69482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F0D388D6-37B7-4435-8F98-71F5FB58B9BC}"/>
              </a:ext>
            </a:extLst>
          </p:cNvPr>
          <p:cNvSpPr txBox="1"/>
          <p:nvPr/>
        </p:nvSpPr>
        <p:spPr>
          <a:xfrm>
            <a:off x="2138835" y="5580878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7" name="グループ化 56">
            <a:extLst>
              <a:ext uri="{FF2B5EF4-FFF2-40B4-BE49-F238E27FC236}">
                <a16:creationId xmlns:a16="http://schemas.microsoft.com/office/drawing/2014/main" id="{6B4A03DC-D17D-4BA2-8A9E-473CB5BD293C}"/>
              </a:ext>
            </a:extLst>
          </p:cNvPr>
          <p:cNvGrpSpPr/>
          <p:nvPr/>
        </p:nvGrpSpPr>
        <p:grpSpPr>
          <a:xfrm flipH="1">
            <a:off x="1459184" y="5798215"/>
            <a:ext cx="681652" cy="524023"/>
            <a:chOff x="5861957" y="4453242"/>
            <a:chExt cx="447365" cy="694822"/>
          </a:xfrm>
        </p:grpSpPr>
        <p:cxnSp>
          <p:nvCxnSpPr>
            <p:cNvPr id="58" name="直線コネクタ 57">
              <a:extLst>
                <a:ext uri="{FF2B5EF4-FFF2-40B4-BE49-F238E27FC236}">
                  <a16:creationId xmlns:a16="http://schemas.microsoft.com/office/drawing/2014/main" id="{9EB6E382-A01D-4680-A506-BE2E3025D10C}"/>
                </a:ext>
              </a:extLst>
            </p:cNvPr>
            <p:cNvCxnSpPr/>
            <p:nvPr/>
          </p:nvCxnSpPr>
          <p:spPr>
            <a:xfrm rot="16200000">
              <a:off x="5741333" y="4573867"/>
              <a:ext cx="24125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直線コネクタ 58">
              <a:extLst>
                <a:ext uri="{FF2B5EF4-FFF2-40B4-BE49-F238E27FC236}">
                  <a16:creationId xmlns:a16="http://schemas.microsoft.com/office/drawing/2014/main" id="{28640263-40C8-488A-B4DB-AB27741E44E7}"/>
                </a:ext>
              </a:extLst>
            </p:cNvPr>
            <p:cNvCxnSpPr/>
            <p:nvPr/>
          </p:nvCxnSpPr>
          <p:spPr>
            <a:xfrm>
              <a:off x="5861957" y="4453242"/>
              <a:ext cx="44736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直線コネクタ 59">
              <a:extLst>
                <a:ext uri="{FF2B5EF4-FFF2-40B4-BE49-F238E27FC236}">
                  <a16:creationId xmlns:a16="http://schemas.microsoft.com/office/drawing/2014/main" id="{4166681C-D134-4E85-BAAF-349581DF274F}"/>
                </a:ext>
              </a:extLst>
            </p:cNvPr>
            <p:cNvCxnSpPr/>
            <p:nvPr/>
          </p:nvCxnSpPr>
          <p:spPr>
            <a:xfrm flipV="1">
              <a:off x="6309320" y="4453242"/>
              <a:ext cx="0" cy="69482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1D42AD96-B20B-4D92-BAFB-2193D00718CC}"/>
              </a:ext>
            </a:extLst>
          </p:cNvPr>
          <p:cNvSpPr txBox="1"/>
          <p:nvPr/>
        </p:nvSpPr>
        <p:spPr>
          <a:xfrm>
            <a:off x="1672477" y="5583286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977104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/>
          <p:cNvSpPr txBox="1"/>
          <p:nvPr/>
        </p:nvSpPr>
        <p:spPr>
          <a:xfrm>
            <a:off x="5501606" y="4490876"/>
            <a:ext cx="35618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/>
              <a:t>T98</a:t>
            </a:r>
            <a:endParaRPr kumimoji="1" lang="ja-JP" altLang="en-US" sz="900" dirty="0"/>
          </a:p>
        </p:txBody>
      </p:sp>
      <p:graphicFrame>
        <p:nvGraphicFramePr>
          <p:cNvPr id="4" name="グラフ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81819000"/>
              </p:ext>
            </p:extLst>
          </p:nvPr>
        </p:nvGraphicFramePr>
        <p:xfrm>
          <a:off x="4856717" y="4651284"/>
          <a:ext cx="1496075" cy="24123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7369F8A7-8450-46C7-A5F4-9103E59110C0}"/>
              </a:ext>
            </a:extLst>
          </p:cNvPr>
          <p:cNvGrpSpPr/>
          <p:nvPr/>
        </p:nvGrpSpPr>
        <p:grpSpPr>
          <a:xfrm>
            <a:off x="3933056" y="7153015"/>
            <a:ext cx="2126614" cy="587337"/>
            <a:chOff x="3933056" y="6421361"/>
            <a:chExt cx="2126614" cy="587337"/>
          </a:xfrm>
        </p:grpSpPr>
        <p:cxnSp>
          <p:nvCxnSpPr>
            <p:cNvPr id="6" name="直線コネクタ 5"/>
            <p:cNvCxnSpPr/>
            <p:nvPr/>
          </p:nvCxnSpPr>
          <p:spPr>
            <a:xfrm>
              <a:off x="3933056" y="6545389"/>
              <a:ext cx="231918" cy="0"/>
            </a:xfrm>
            <a:prstGeom prst="line">
              <a:avLst/>
            </a:prstGeom>
            <a:ln w="19050">
              <a:solidFill>
                <a:schemeClr val="accent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直線コネクタ 6"/>
            <p:cNvCxnSpPr/>
            <p:nvPr/>
          </p:nvCxnSpPr>
          <p:spPr>
            <a:xfrm>
              <a:off x="3933056" y="6723642"/>
              <a:ext cx="231918" cy="0"/>
            </a:xfrm>
            <a:prstGeom prst="line">
              <a:avLst/>
            </a:prstGeom>
            <a:ln w="190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直線コネクタ 7"/>
            <p:cNvCxnSpPr/>
            <p:nvPr/>
          </p:nvCxnSpPr>
          <p:spPr>
            <a:xfrm>
              <a:off x="4970834" y="6545389"/>
              <a:ext cx="231918" cy="0"/>
            </a:xfrm>
            <a:prstGeom prst="line">
              <a:avLst/>
            </a:prstGeom>
            <a:ln w="19050">
              <a:solidFill>
                <a:schemeClr val="accent3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直線コネクタ 8"/>
            <p:cNvCxnSpPr/>
            <p:nvPr/>
          </p:nvCxnSpPr>
          <p:spPr>
            <a:xfrm>
              <a:off x="4970834" y="6723642"/>
              <a:ext cx="231918" cy="0"/>
            </a:xfrm>
            <a:prstGeom prst="line">
              <a:avLst/>
            </a:prstGeom>
            <a:ln w="19050">
              <a:solidFill>
                <a:schemeClr val="accent4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直線コネクタ 9"/>
            <p:cNvCxnSpPr/>
            <p:nvPr/>
          </p:nvCxnSpPr>
          <p:spPr>
            <a:xfrm>
              <a:off x="4970834" y="6901894"/>
              <a:ext cx="231918" cy="0"/>
            </a:xfrm>
            <a:prstGeom prst="line">
              <a:avLst/>
            </a:prstGeom>
            <a:ln w="19050">
              <a:solidFill>
                <a:schemeClr val="accent5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テキスト ボックス 10"/>
            <p:cNvSpPr txBox="1"/>
            <p:nvPr/>
          </p:nvSpPr>
          <p:spPr>
            <a:xfrm>
              <a:off x="4171979" y="6421361"/>
              <a:ext cx="4026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 err="1"/>
                <a:t>Gln</a:t>
              </a:r>
              <a:r>
                <a:rPr kumimoji="1" lang="en-US" altLang="ja-JP" sz="900" dirty="0"/>
                <a:t>+</a:t>
              </a:r>
              <a:endParaRPr kumimoji="1" lang="ja-JP" altLang="en-US" sz="900" dirty="0"/>
            </a:p>
          </p:txBody>
        </p:sp>
        <p:sp>
          <p:nvSpPr>
            <p:cNvPr id="12" name="テキスト ボックス 11"/>
            <p:cNvSpPr txBox="1"/>
            <p:nvPr/>
          </p:nvSpPr>
          <p:spPr>
            <a:xfrm>
              <a:off x="4171979" y="6599614"/>
              <a:ext cx="74251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 err="1"/>
                <a:t>Gln</a:t>
              </a:r>
              <a:r>
                <a:rPr kumimoji="1" lang="en-US" altLang="ja-JP" sz="900" dirty="0"/>
                <a:t>- control</a:t>
              </a:r>
              <a:endParaRPr kumimoji="1" lang="ja-JP" altLang="en-US" sz="900" dirty="0"/>
            </a:p>
          </p:txBody>
        </p:sp>
        <p:sp>
          <p:nvSpPr>
            <p:cNvPr id="13" name="テキスト ボックス 12"/>
            <p:cNvSpPr txBox="1"/>
            <p:nvPr/>
          </p:nvSpPr>
          <p:spPr>
            <a:xfrm>
              <a:off x="5209757" y="6421361"/>
              <a:ext cx="84991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 err="1"/>
                <a:t>Gln</a:t>
              </a:r>
              <a:r>
                <a:rPr kumimoji="1" lang="en-US" altLang="ja-JP" sz="900" dirty="0"/>
                <a:t>- CQ 10</a:t>
              </a:r>
              <a:r>
                <a:rPr kumimoji="1" lang="en-US" altLang="ja-JP" sz="900" dirty="0">
                  <a:latin typeface="Symbol" panose="05050102010706020507" pitchFamily="18" charset="2"/>
                </a:rPr>
                <a:t>m</a:t>
              </a:r>
              <a:r>
                <a:rPr kumimoji="1" lang="en-US" altLang="ja-JP" sz="900" dirty="0"/>
                <a:t>M</a:t>
              </a:r>
              <a:endParaRPr kumimoji="1" lang="ja-JP" altLang="en-US" sz="900" dirty="0"/>
            </a:p>
          </p:txBody>
        </p:sp>
        <p:sp>
          <p:nvSpPr>
            <p:cNvPr id="14" name="テキスト ボックス 13"/>
            <p:cNvSpPr txBox="1"/>
            <p:nvPr/>
          </p:nvSpPr>
          <p:spPr>
            <a:xfrm>
              <a:off x="5209757" y="6599614"/>
              <a:ext cx="84991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 err="1"/>
                <a:t>Gln</a:t>
              </a:r>
              <a:r>
                <a:rPr kumimoji="1" lang="en-US" altLang="ja-JP" sz="900" dirty="0"/>
                <a:t>- CQ </a:t>
              </a:r>
              <a:r>
                <a:rPr lang="en-US" altLang="ja-JP" sz="900" dirty="0"/>
                <a:t>20</a:t>
              </a:r>
              <a:r>
                <a:rPr lang="en-US" altLang="ja-JP" sz="900" dirty="0">
                  <a:latin typeface="Symbol" panose="05050102010706020507" pitchFamily="18" charset="2"/>
                </a:rPr>
                <a:t>m</a:t>
              </a:r>
              <a:r>
                <a:rPr lang="en-US" altLang="ja-JP" sz="900" dirty="0"/>
                <a:t>M</a:t>
              </a:r>
              <a:endParaRPr lang="ja-JP" altLang="en-US" sz="900" dirty="0"/>
            </a:p>
          </p:txBody>
        </p:sp>
        <p:sp>
          <p:nvSpPr>
            <p:cNvPr id="15" name="テキスト ボックス 14"/>
            <p:cNvSpPr txBox="1"/>
            <p:nvPr/>
          </p:nvSpPr>
          <p:spPr>
            <a:xfrm>
              <a:off x="5209757" y="6777866"/>
              <a:ext cx="84991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 err="1"/>
                <a:t>Gln</a:t>
              </a:r>
              <a:r>
                <a:rPr kumimoji="1" lang="en-US" altLang="ja-JP" sz="900" dirty="0"/>
                <a:t>- CQ </a:t>
              </a:r>
              <a:r>
                <a:rPr lang="en-US" altLang="ja-JP" sz="900" dirty="0"/>
                <a:t>40</a:t>
              </a:r>
              <a:r>
                <a:rPr lang="en-US" altLang="ja-JP" sz="900" dirty="0">
                  <a:latin typeface="Symbol" panose="05050102010706020507" pitchFamily="18" charset="2"/>
                </a:rPr>
                <a:t>m</a:t>
              </a:r>
              <a:r>
                <a:rPr lang="en-US" altLang="ja-JP" sz="900" dirty="0"/>
                <a:t>M</a:t>
              </a:r>
              <a:endParaRPr lang="ja-JP" altLang="en-US" sz="900" dirty="0"/>
            </a:p>
          </p:txBody>
        </p:sp>
      </p:grpSp>
      <p:sp>
        <p:nvSpPr>
          <p:cNvPr id="16" name="テキスト ボックス 15"/>
          <p:cNvSpPr txBox="1"/>
          <p:nvPr/>
        </p:nvSpPr>
        <p:spPr>
          <a:xfrm>
            <a:off x="4176" y="1313"/>
            <a:ext cx="10615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Suppl. Fig. 5</a:t>
            </a:r>
            <a:endParaRPr kumimoji="1" lang="ja-JP" altLang="en-US" sz="1400" dirty="0"/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57241" y="348143"/>
            <a:ext cx="2712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/>
              <a:t>a</a:t>
            </a:r>
            <a:endParaRPr kumimoji="1" lang="ja-JP" altLang="en-US" sz="1400" b="1" dirty="0"/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57241" y="4081637"/>
            <a:ext cx="2792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/>
              <a:t>b</a:t>
            </a:r>
            <a:endParaRPr kumimoji="1" lang="ja-JP" altLang="en-US" sz="1400" b="1" dirty="0"/>
          </a:p>
        </p:txBody>
      </p:sp>
      <p:graphicFrame>
        <p:nvGraphicFramePr>
          <p:cNvPr id="20" name="グラフ 1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47383512"/>
              </p:ext>
            </p:extLst>
          </p:nvPr>
        </p:nvGraphicFramePr>
        <p:xfrm>
          <a:off x="4667063" y="765757"/>
          <a:ext cx="1642257" cy="218148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21" name="グループ化 20"/>
          <p:cNvGrpSpPr/>
          <p:nvPr/>
        </p:nvGrpSpPr>
        <p:grpSpPr>
          <a:xfrm>
            <a:off x="2708920" y="2987824"/>
            <a:ext cx="1659577" cy="432048"/>
            <a:chOff x="980728" y="2843808"/>
            <a:chExt cx="1659577" cy="432048"/>
          </a:xfrm>
        </p:grpSpPr>
        <p:sp>
          <p:nvSpPr>
            <p:cNvPr id="22" name="正方形/長方形 21"/>
            <p:cNvSpPr/>
            <p:nvPr/>
          </p:nvSpPr>
          <p:spPr>
            <a:xfrm>
              <a:off x="980728" y="2937235"/>
              <a:ext cx="62346" cy="62346"/>
            </a:xfrm>
            <a:prstGeom prst="rect">
              <a:avLst/>
            </a:prstGeom>
            <a:ln>
              <a:solidFill>
                <a:schemeClr val="accent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900"/>
            </a:p>
          </p:txBody>
        </p:sp>
        <p:sp>
          <p:nvSpPr>
            <p:cNvPr id="23" name="正方形/長方形 22"/>
            <p:cNvSpPr/>
            <p:nvPr/>
          </p:nvSpPr>
          <p:spPr>
            <a:xfrm>
              <a:off x="980728" y="3131840"/>
              <a:ext cx="62346" cy="62346"/>
            </a:xfrm>
            <a:prstGeom prst="rect">
              <a:avLst/>
            </a:prstGeom>
            <a:solidFill>
              <a:schemeClr val="accent2"/>
            </a:solidFill>
            <a:ln>
              <a:solidFill>
                <a:schemeClr val="accent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900"/>
            </a:p>
          </p:txBody>
        </p:sp>
        <p:sp>
          <p:nvSpPr>
            <p:cNvPr id="24" name="正方形/長方形 23"/>
            <p:cNvSpPr/>
            <p:nvPr/>
          </p:nvSpPr>
          <p:spPr>
            <a:xfrm>
              <a:off x="1760051" y="2937235"/>
              <a:ext cx="62346" cy="62346"/>
            </a:xfrm>
            <a:prstGeom prst="rect">
              <a:avLst/>
            </a:prstGeom>
            <a:solidFill>
              <a:schemeClr val="accent3"/>
            </a:solidFill>
            <a:ln>
              <a:solidFill>
                <a:schemeClr val="accent3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900"/>
            </a:p>
          </p:txBody>
        </p:sp>
        <p:sp>
          <p:nvSpPr>
            <p:cNvPr id="25" name="正方形/長方形 24"/>
            <p:cNvSpPr/>
            <p:nvPr/>
          </p:nvSpPr>
          <p:spPr>
            <a:xfrm>
              <a:off x="1760051" y="3131840"/>
              <a:ext cx="62346" cy="62346"/>
            </a:xfrm>
            <a:prstGeom prst="rect">
              <a:avLst/>
            </a:prstGeom>
            <a:solidFill>
              <a:schemeClr val="accent4"/>
            </a:solidFill>
            <a:ln>
              <a:solidFill>
                <a:schemeClr val="accent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900"/>
            </a:p>
          </p:txBody>
        </p:sp>
        <p:sp>
          <p:nvSpPr>
            <p:cNvPr id="26" name="テキスト ボックス 25"/>
            <p:cNvSpPr txBox="1"/>
            <p:nvPr/>
          </p:nvSpPr>
          <p:spPr>
            <a:xfrm>
              <a:off x="1022291" y="2843808"/>
              <a:ext cx="61747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/>
                <a:t>U87 </a:t>
              </a:r>
              <a:r>
                <a:rPr kumimoji="1" lang="en-US" altLang="ja-JP" sz="900" dirty="0" err="1"/>
                <a:t>Gln</a:t>
              </a:r>
              <a:r>
                <a:rPr kumimoji="1" lang="en-US" altLang="ja-JP" sz="900" dirty="0"/>
                <a:t>+</a:t>
              </a:r>
              <a:endParaRPr kumimoji="1" lang="ja-JP" altLang="en-US" sz="900" dirty="0"/>
            </a:p>
          </p:txBody>
        </p:sp>
        <p:sp>
          <p:nvSpPr>
            <p:cNvPr id="27" name="テキスト ボックス 26"/>
            <p:cNvSpPr txBox="1"/>
            <p:nvPr/>
          </p:nvSpPr>
          <p:spPr>
            <a:xfrm>
              <a:off x="1022291" y="3045024"/>
              <a:ext cx="59503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/>
                <a:t>U87 </a:t>
              </a:r>
              <a:r>
                <a:rPr kumimoji="1" lang="en-US" altLang="ja-JP" sz="900" dirty="0" err="1"/>
                <a:t>Gln</a:t>
              </a:r>
              <a:r>
                <a:rPr kumimoji="1" lang="en-US" altLang="ja-JP" sz="900" dirty="0"/>
                <a:t>-</a:t>
              </a:r>
              <a:endParaRPr kumimoji="1" lang="ja-JP" altLang="en-US" sz="900" dirty="0"/>
            </a:p>
          </p:txBody>
        </p:sp>
        <p:sp>
          <p:nvSpPr>
            <p:cNvPr id="28" name="テキスト ボックス 27"/>
            <p:cNvSpPr txBox="1"/>
            <p:nvPr/>
          </p:nvSpPr>
          <p:spPr>
            <a:xfrm>
              <a:off x="1801614" y="2843808"/>
              <a:ext cx="83869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/>
                <a:t>U87 </a:t>
              </a:r>
              <a:r>
                <a:rPr kumimoji="1" lang="en-US" altLang="ja-JP" sz="900" dirty="0" err="1"/>
                <a:t>Gln</a:t>
              </a:r>
              <a:r>
                <a:rPr kumimoji="1" lang="en-US" altLang="ja-JP" sz="900" dirty="0"/>
                <a:t>+ CQ+</a:t>
              </a:r>
              <a:endParaRPr kumimoji="1" lang="ja-JP" altLang="en-US" sz="900" dirty="0"/>
            </a:p>
          </p:txBody>
        </p:sp>
        <p:sp>
          <p:nvSpPr>
            <p:cNvPr id="29" name="テキスト ボックス 28"/>
            <p:cNvSpPr txBox="1"/>
            <p:nvPr/>
          </p:nvSpPr>
          <p:spPr>
            <a:xfrm>
              <a:off x="1801614" y="3045024"/>
              <a:ext cx="81624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/>
                <a:t>U87 </a:t>
              </a:r>
              <a:r>
                <a:rPr kumimoji="1" lang="en-US" altLang="ja-JP" sz="900" dirty="0" err="1"/>
                <a:t>Gln</a:t>
              </a:r>
              <a:r>
                <a:rPr kumimoji="1" lang="en-US" altLang="ja-JP" sz="900" dirty="0"/>
                <a:t>- CQ+</a:t>
              </a:r>
              <a:endParaRPr kumimoji="1" lang="ja-JP" altLang="en-US" sz="900" dirty="0"/>
            </a:p>
          </p:txBody>
        </p:sp>
      </p:grpSp>
      <p:graphicFrame>
        <p:nvGraphicFramePr>
          <p:cNvPr id="30" name="グラフ 2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97663588"/>
              </p:ext>
            </p:extLst>
          </p:nvPr>
        </p:nvGraphicFramePr>
        <p:xfrm>
          <a:off x="1665407" y="766895"/>
          <a:ext cx="1642257" cy="218034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32" name="グラフ 3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68480229"/>
              </p:ext>
            </p:extLst>
          </p:nvPr>
        </p:nvGraphicFramePr>
        <p:xfrm>
          <a:off x="3166235" y="766895"/>
          <a:ext cx="1642257" cy="218452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33" name="グラフ 3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42269422"/>
              </p:ext>
            </p:extLst>
          </p:nvPr>
        </p:nvGraphicFramePr>
        <p:xfrm>
          <a:off x="164579" y="766895"/>
          <a:ext cx="1642257" cy="218452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pSp>
        <p:nvGrpSpPr>
          <p:cNvPr id="34" name="グループ化 33">
            <a:extLst>
              <a:ext uri="{FF2B5EF4-FFF2-40B4-BE49-F238E27FC236}">
                <a16:creationId xmlns:a16="http://schemas.microsoft.com/office/drawing/2014/main" id="{C9C5D266-24CB-4BFF-ADFA-1650BCA241E3}"/>
              </a:ext>
            </a:extLst>
          </p:cNvPr>
          <p:cNvGrpSpPr/>
          <p:nvPr/>
        </p:nvGrpSpPr>
        <p:grpSpPr>
          <a:xfrm>
            <a:off x="6576311" y="5870695"/>
            <a:ext cx="54502" cy="724486"/>
            <a:chOff x="2588820" y="1280592"/>
            <a:chExt cx="120100" cy="720080"/>
          </a:xfrm>
        </p:grpSpPr>
        <p:cxnSp>
          <p:nvCxnSpPr>
            <p:cNvPr id="35" name="直線コネクタ 34">
              <a:extLst>
                <a:ext uri="{FF2B5EF4-FFF2-40B4-BE49-F238E27FC236}">
                  <a16:creationId xmlns:a16="http://schemas.microsoft.com/office/drawing/2014/main" id="{506CE1FF-1DEB-41A1-9660-5BAD475610EC}"/>
                </a:ext>
              </a:extLst>
            </p:cNvPr>
            <p:cNvCxnSpPr/>
            <p:nvPr/>
          </p:nvCxnSpPr>
          <p:spPr>
            <a:xfrm>
              <a:off x="2588820" y="1280592"/>
              <a:ext cx="1201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直線コネクタ 35">
              <a:extLst>
                <a:ext uri="{FF2B5EF4-FFF2-40B4-BE49-F238E27FC236}">
                  <a16:creationId xmlns:a16="http://schemas.microsoft.com/office/drawing/2014/main" id="{4BF63A77-245A-43C8-80F1-CA468D528845}"/>
                </a:ext>
              </a:extLst>
            </p:cNvPr>
            <p:cNvCxnSpPr/>
            <p:nvPr/>
          </p:nvCxnSpPr>
          <p:spPr>
            <a:xfrm>
              <a:off x="2708920" y="1280592"/>
              <a:ext cx="0" cy="72008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直線コネクタ 36">
              <a:extLst>
                <a:ext uri="{FF2B5EF4-FFF2-40B4-BE49-F238E27FC236}">
                  <a16:creationId xmlns:a16="http://schemas.microsoft.com/office/drawing/2014/main" id="{DD0BBF76-EFBD-432F-A354-9750446C871F}"/>
                </a:ext>
              </a:extLst>
            </p:cNvPr>
            <p:cNvCxnSpPr/>
            <p:nvPr/>
          </p:nvCxnSpPr>
          <p:spPr>
            <a:xfrm>
              <a:off x="2588820" y="2000672"/>
              <a:ext cx="1201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ACC4F6A8-5615-4473-8C73-0BDC2B6F5FBA}"/>
              </a:ext>
            </a:extLst>
          </p:cNvPr>
          <p:cNvSpPr txBox="1"/>
          <p:nvPr/>
        </p:nvSpPr>
        <p:spPr>
          <a:xfrm>
            <a:off x="6559654" y="6145067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9" name="グループ化 38">
            <a:extLst>
              <a:ext uri="{FF2B5EF4-FFF2-40B4-BE49-F238E27FC236}">
                <a16:creationId xmlns:a16="http://schemas.microsoft.com/office/drawing/2014/main" id="{40F83B6D-FF2B-4233-A40C-11498B50A9A2}"/>
              </a:ext>
            </a:extLst>
          </p:cNvPr>
          <p:cNvGrpSpPr/>
          <p:nvPr/>
        </p:nvGrpSpPr>
        <p:grpSpPr>
          <a:xfrm>
            <a:off x="6244031" y="5870694"/>
            <a:ext cx="45719" cy="438133"/>
            <a:chOff x="2588820" y="1280592"/>
            <a:chExt cx="120100" cy="720080"/>
          </a:xfrm>
        </p:grpSpPr>
        <p:cxnSp>
          <p:nvCxnSpPr>
            <p:cNvPr id="40" name="直線コネクタ 39">
              <a:extLst>
                <a:ext uri="{FF2B5EF4-FFF2-40B4-BE49-F238E27FC236}">
                  <a16:creationId xmlns:a16="http://schemas.microsoft.com/office/drawing/2014/main" id="{478B3A8A-0905-4307-932F-1C963914073A}"/>
                </a:ext>
              </a:extLst>
            </p:cNvPr>
            <p:cNvCxnSpPr/>
            <p:nvPr/>
          </p:nvCxnSpPr>
          <p:spPr>
            <a:xfrm>
              <a:off x="2588820" y="1280592"/>
              <a:ext cx="1201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直線コネクタ 40">
              <a:extLst>
                <a:ext uri="{FF2B5EF4-FFF2-40B4-BE49-F238E27FC236}">
                  <a16:creationId xmlns:a16="http://schemas.microsoft.com/office/drawing/2014/main" id="{F8BA343E-BC69-4366-8888-13EC31F2CE1A}"/>
                </a:ext>
              </a:extLst>
            </p:cNvPr>
            <p:cNvCxnSpPr/>
            <p:nvPr/>
          </p:nvCxnSpPr>
          <p:spPr>
            <a:xfrm>
              <a:off x="2708920" y="1280592"/>
              <a:ext cx="0" cy="72008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直線コネクタ 41">
              <a:extLst>
                <a:ext uri="{FF2B5EF4-FFF2-40B4-BE49-F238E27FC236}">
                  <a16:creationId xmlns:a16="http://schemas.microsoft.com/office/drawing/2014/main" id="{BF522FA3-708D-46A2-854B-FB16173B316C}"/>
                </a:ext>
              </a:extLst>
            </p:cNvPr>
            <p:cNvCxnSpPr/>
            <p:nvPr/>
          </p:nvCxnSpPr>
          <p:spPr>
            <a:xfrm>
              <a:off x="2588820" y="2000672"/>
              <a:ext cx="1201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323074EC-6AAC-4011-B86B-47EC96A9F296}"/>
              </a:ext>
            </a:extLst>
          </p:cNvPr>
          <p:cNvSpPr txBox="1"/>
          <p:nvPr/>
        </p:nvSpPr>
        <p:spPr>
          <a:xfrm>
            <a:off x="6205847" y="6001051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4" name="グループ化 43">
            <a:extLst>
              <a:ext uri="{FF2B5EF4-FFF2-40B4-BE49-F238E27FC236}">
                <a16:creationId xmlns:a16="http://schemas.microsoft.com/office/drawing/2014/main" id="{E6CBC04E-F63E-453B-AB0C-72CFD25EFCF4}"/>
              </a:ext>
            </a:extLst>
          </p:cNvPr>
          <p:cNvGrpSpPr/>
          <p:nvPr/>
        </p:nvGrpSpPr>
        <p:grpSpPr>
          <a:xfrm>
            <a:off x="6397229" y="5870695"/>
            <a:ext cx="45719" cy="582149"/>
            <a:chOff x="2588820" y="1280592"/>
            <a:chExt cx="120100" cy="720080"/>
          </a:xfrm>
        </p:grpSpPr>
        <p:cxnSp>
          <p:nvCxnSpPr>
            <p:cNvPr id="45" name="直線コネクタ 44">
              <a:extLst>
                <a:ext uri="{FF2B5EF4-FFF2-40B4-BE49-F238E27FC236}">
                  <a16:creationId xmlns:a16="http://schemas.microsoft.com/office/drawing/2014/main" id="{13F3A0EC-B512-4A8B-86D3-4A2F9ED22CE0}"/>
                </a:ext>
              </a:extLst>
            </p:cNvPr>
            <p:cNvCxnSpPr/>
            <p:nvPr/>
          </p:nvCxnSpPr>
          <p:spPr>
            <a:xfrm>
              <a:off x="2588820" y="1280592"/>
              <a:ext cx="1201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直線コネクタ 45">
              <a:extLst>
                <a:ext uri="{FF2B5EF4-FFF2-40B4-BE49-F238E27FC236}">
                  <a16:creationId xmlns:a16="http://schemas.microsoft.com/office/drawing/2014/main" id="{B136CDF3-8950-4680-805C-D8F748C97AC0}"/>
                </a:ext>
              </a:extLst>
            </p:cNvPr>
            <p:cNvCxnSpPr/>
            <p:nvPr/>
          </p:nvCxnSpPr>
          <p:spPr>
            <a:xfrm>
              <a:off x="2708920" y="1280592"/>
              <a:ext cx="0" cy="72008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直線コネクタ 46">
              <a:extLst>
                <a:ext uri="{FF2B5EF4-FFF2-40B4-BE49-F238E27FC236}">
                  <a16:creationId xmlns:a16="http://schemas.microsoft.com/office/drawing/2014/main" id="{325B3998-EC9B-4349-BB64-A19EC7F6DF01}"/>
                </a:ext>
              </a:extLst>
            </p:cNvPr>
            <p:cNvCxnSpPr/>
            <p:nvPr/>
          </p:nvCxnSpPr>
          <p:spPr>
            <a:xfrm>
              <a:off x="2588820" y="2000672"/>
              <a:ext cx="1201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586C8A74-B6AC-497A-BF33-DC370799DD58}"/>
              </a:ext>
            </a:extLst>
          </p:cNvPr>
          <p:cNvSpPr txBox="1"/>
          <p:nvPr/>
        </p:nvSpPr>
        <p:spPr>
          <a:xfrm>
            <a:off x="6375103" y="6073059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9" name="グラフ 48">
            <a:extLst>
              <a:ext uri="{FF2B5EF4-FFF2-40B4-BE49-F238E27FC236}">
                <a16:creationId xmlns:a16="http://schemas.microsoft.com/office/drawing/2014/main" id="{96F58180-902A-48F5-B0DB-F80DF52A1A6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45529350"/>
              </p:ext>
            </p:extLst>
          </p:nvPr>
        </p:nvGraphicFramePr>
        <p:xfrm>
          <a:off x="3127690" y="4663568"/>
          <a:ext cx="1383975" cy="240004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pSp>
        <p:nvGrpSpPr>
          <p:cNvPr id="61" name="グループ化 60">
            <a:extLst>
              <a:ext uri="{FF2B5EF4-FFF2-40B4-BE49-F238E27FC236}">
                <a16:creationId xmlns:a16="http://schemas.microsoft.com/office/drawing/2014/main" id="{4EFCB10C-3778-47DF-A2E6-6B638BF99865}"/>
              </a:ext>
            </a:extLst>
          </p:cNvPr>
          <p:cNvGrpSpPr/>
          <p:nvPr/>
        </p:nvGrpSpPr>
        <p:grpSpPr>
          <a:xfrm>
            <a:off x="4704103" y="5937818"/>
            <a:ext cx="54502" cy="724486"/>
            <a:chOff x="2588820" y="1280592"/>
            <a:chExt cx="120100" cy="720080"/>
          </a:xfrm>
        </p:grpSpPr>
        <p:cxnSp>
          <p:nvCxnSpPr>
            <p:cNvPr id="62" name="直線コネクタ 61">
              <a:extLst>
                <a:ext uri="{FF2B5EF4-FFF2-40B4-BE49-F238E27FC236}">
                  <a16:creationId xmlns:a16="http://schemas.microsoft.com/office/drawing/2014/main" id="{3D5B2244-B2A7-4D45-8EF7-2ECE9763E9EB}"/>
                </a:ext>
              </a:extLst>
            </p:cNvPr>
            <p:cNvCxnSpPr/>
            <p:nvPr/>
          </p:nvCxnSpPr>
          <p:spPr>
            <a:xfrm>
              <a:off x="2588820" y="1280592"/>
              <a:ext cx="1201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直線コネクタ 62">
              <a:extLst>
                <a:ext uri="{FF2B5EF4-FFF2-40B4-BE49-F238E27FC236}">
                  <a16:creationId xmlns:a16="http://schemas.microsoft.com/office/drawing/2014/main" id="{85AF2B8F-FA7D-4246-BD13-223A0CAB5BCA}"/>
                </a:ext>
              </a:extLst>
            </p:cNvPr>
            <p:cNvCxnSpPr/>
            <p:nvPr/>
          </p:nvCxnSpPr>
          <p:spPr>
            <a:xfrm>
              <a:off x="2708920" y="1280592"/>
              <a:ext cx="0" cy="72008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直線コネクタ 63">
              <a:extLst>
                <a:ext uri="{FF2B5EF4-FFF2-40B4-BE49-F238E27FC236}">
                  <a16:creationId xmlns:a16="http://schemas.microsoft.com/office/drawing/2014/main" id="{1C2F994D-D777-408E-991F-F7D3627D5A21}"/>
                </a:ext>
              </a:extLst>
            </p:cNvPr>
            <p:cNvCxnSpPr/>
            <p:nvPr/>
          </p:nvCxnSpPr>
          <p:spPr>
            <a:xfrm>
              <a:off x="2588820" y="2000672"/>
              <a:ext cx="1201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57467DFB-EA40-46C5-B076-0F65A6E965A8}"/>
              </a:ext>
            </a:extLst>
          </p:cNvPr>
          <p:cNvSpPr txBox="1"/>
          <p:nvPr/>
        </p:nvSpPr>
        <p:spPr>
          <a:xfrm>
            <a:off x="4687446" y="6212190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6" name="グループ化 65">
            <a:extLst>
              <a:ext uri="{FF2B5EF4-FFF2-40B4-BE49-F238E27FC236}">
                <a16:creationId xmlns:a16="http://schemas.microsoft.com/office/drawing/2014/main" id="{15FFE91C-71D6-4052-92D7-9CEDDD4A5360}"/>
              </a:ext>
            </a:extLst>
          </p:cNvPr>
          <p:cNvGrpSpPr/>
          <p:nvPr/>
        </p:nvGrpSpPr>
        <p:grpSpPr>
          <a:xfrm>
            <a:off x="4371823" y="5937817"/>
            <a:ext cx="45719" cy="438133"/>
            <a:chOff x="2588820" y="1280592"/>
            <a:chExt cx="120100" cy="720080"/>
          </a:xfrm>
        </p:grpSpPr>
        <p:cxnSp>
          <p:nvCxnSpPr>
            <p:cNvPr id="67" name="直線コネクタ 66">
              <a:extLst>
                <a:ext uri="{FF2B5EF4-FFF2-40B4-BE49-F238E27FC236}">
                  <a16:creationId xmlns:a16="http://schemas.microsoft.com/office/drawing/2014/main" id="{D48C6008-C783-4322-B8A6-240F698EAC99}"/>
                </a:ext>
              </a:extLst>
            </p:cNvPr>
            <p:cNvCxnSpPr/>
            <p:nvPr/>
          </p:nvCxnSpPr>
          <p:spPr>
            <a:xfrm>
              <a:off x="2588820" y="1280592"/>
              <a:ext cx="1201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直線コネクタ 67">
              <a:extLst>
                <a:ext uri="{FF2B5EF4-FFF2-40B4-BE49-F238E27FC236}">
                  <a16:creationId xmlns:a16="http://schemas.microsoft.com/office/drawing/2014/main" id="{5138F6B3-FFC3-4D8E-8CDC-39FBD91CC538}"/>
                </a:ext>
              </a:extLst>
            </p:cNvPr>
            <p:cNvCxnSpPr/>
            <p:nvPr/>
          </p:nvCxnSpPr>
          <p:spPr>
            <a:xfrm>
              <a:off x="2708920" y="1280592"/>
              <a:ext cx="0" cy="72008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直線コネクタ 68">
              <a:extLst>
                <a:ext uri="{FF2B5EF4-FFF2-40B4-BE49-F238E27FC236}">
                  <a16:creationId xmlns:a16="http://schemas.microsoft.com/office/drawing/2014/main" id="{C33C8C14-7D67-484D-84DD-82D321862555}"/>
                </a:ext>
              </a:extLst>
            </p:cNvPr>
            <p:cNvCxnSpPr/>
            <p:nvPr/>
          </p:nvCxnSpPr>
          <p:spPr>
            <a:xfrm>
              <a:off x="2588820" y="2000672"/>
              <a:ext cx="1201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A7B5C72F-8853-4569-84DD-CF0B7C887FCC}"/>
              </a:ext>
            </a:extLst>
          </p:cNvPr>
          <p:cNvSpPr txBox="1"/>
          <p:nvPr/>
        </p:nvSpPr>
        <p:spPr>
          <a:xfrm>
            <a:off x="4333639" y="6068174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1" name="グループ化 70">
            <a:extLst>
              <a:ext uri="{FF2B5EF4-FFF2-40B4-BE49-F238E27FC236}">
                <a16:creationId xmlns:a16="http://schemas.microsoft.com/office/drawing/2014/main" id="{7316A37E-A79F-4B6E-9480-4C63E9923632}"/>
              </a:ext>
            </a:extLst>
          </p:cNvPr>
          <p:cNvGrpSpPr/>
          <p:nvPr/>
        </p:nvGrpSpPr>
        <p:grpSpPr>
          <a:xfrm>
            <a:off x="4525021" y="5937818"/>
            <a:ext cx="45719" cy="582149"/>
            <a:chOff x="2588820" y="1280592"/>
            <a:chExt cx="120100" cy="720080"/>
          </a:xfrm>
        </p:grpSpPr>
        <p:cxnSp>
          <p:nvCxnSpPr>
            <p:cNvPr id="72" name="直線コネクタ 71">
              <a:extLst>
                <a:ext uri="{FF2B5EF4-FFF2-40B4-BE49-F238E27FC236}">
                  <a16:creationId xmlns:a16="http://schemas.microsoft.com/office/drawing/2014/main" id="{5D707CE0-4195-4D0C-913E-85C12F367C65}"/>
                </a:ext>
              </a:extLst>
            </p:cNvPr>
            <p:cNvCxnSpPr/>
            <p:nvPr/>
          </p:nvCxnSpPr>
          <p:spPr>
            <a:xfrm>
              <a:off x="2588820" y="1280592"/>
              <a:ext cx="1201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直線コネクタ 72">
              <a:extLst>
                <a:ext uri="{FF2B5EF4-FFF2-40B4-BE49-F238E27FC236}">
                  <a16:creationId xmlns:a16="http://schemas.microsoft.com/office/drawing/2014/main" id="{F623FC9D-19B3-47DC-8BAC-D312EB1B1839}"/>
                </a:ext>
              </a:extLst>
            </p:cNvPr>
            <p:cNvCxnSpPr/>
            <p:nvPr/>
          </p:nvCxnSpPr>
          <p:spPr>
            <a:xfrm>
              <a:off x="2708920" y="1280592"/>
              <a:ext cx="0" cy="72008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直線コネクタ 73">
              <a:extLst>
                <a:ext uri="{FF2B5EF4-FFF2-40B4-BE49-F238E27FC236}">
                  <a16:creationId xmlns:a16="http://schemas.microsoft.com/office/drawing/2014/main" id="{827293A9-90BB-458F-AF57-6AB38EEB1663}"/>
                </a:ext>
              </a:extLst>
            </p:cNvPr>
            <p:cNvCxnSpPr/>
            <p:nvPr/>
          </p:nvCxnSpPr>
          <p:spPr>
            <a:xfrm>
              <a:off x="2588820" y="2000672"/>
              <a:ext cx="1201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8A212C7E-59C7-4960-BB39-65A70028F732}"/>
              </a:ext>
            </a:extLst>
          </p:cNvPr>
          <p:cNvSpPr txBox="1"/>
          <p:nvPr/>
        </p:nvSpPr>
        <p:spPr>
          <a:xfrm>
            <a:off x="4502895" y="6140182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B3091B5D-ED53-41C5-BE49-26EF8A4DAB86}"/>
              </a:ext>
            </a:extLst>
          </p:cNvPr>
          <p:cNvSpPr txBox="1"/>
          <p:nvPr/>
        </p:nvSpPr>
        <p:spPr>
          <a:xfrm>
            <a:off x="3790255" y="4490876"/>
            <a:ext cx="37382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/>
              <a:t>U87</a:t>
            </a:r>
            <a:endParaRPr kumimoji="1" lang="ja-JP" altLang="en-US" sz="900" dirty="0"/>
          </a:p>
        </p:txBody>
      </p:sp>
      <p:grpSp>
        <p:nvGrpSpPr>
          <p:cNvPr id="77" name="グループ化 76">
            <a:extLst>
              <a:ext uri="{FF2B5EF4-FFF2-40B4-BE49-F238E27FC236}">
                <a16:creationId xmlns:a16="http://schemas.microsoft.com/office/drawing/2014/main" id="{136FE6DF-7F63-4B6F-AEB6-7E5C383268D4}"/>
              </a:ext>
            </a:extLst>
          </p:cNvPr>
          <p:cNvGrpSpPr>
            <a:grpSpLocks noChangeAspect="1"/>
          </p:cNvGrpSpPr>
          <p:nvPr/>
        </p:nvGrpSpPr>
        <p:grpSpPr>
          <a:xfrm>
            <a:off x="104093" y="4552409"/>
            <a:ext cx="2952972" cy="2228248"/>
            <a:chOff x="418408" y="385303"/>
            <a:chExt cx="8256351" cy="6230064"/>
          </a:xfrm>
        </p:grpSpPr>
        <p:pic>
          <p:nvPicPr>
            <p:cNvPr id="78" name="図 77">
              <a:extLst>
                <a:ext uri="{FF2B5EF4-FFF2-40B4-BE49-F238E27FC236}">
                  <a16:creationId xmlns:a16="http://schemas.microsoft.com/office/drawing/2014/main" id="{6650D6A3-4E42-4E29-988C-6E5042546EF2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8408" y="3554462"/>
              <a:ext cx="4081206" cy="3060905"/>
            </a:xfrm>
            <a:prstGeom prst="rect">
              <a:avLst/>
            </a:prstGeom>
          </p:spPr>
        </p:pic>
        <p:pic>
          <p:nvPicPr>
            <p:cNvPr id="79" name="図 78">
              <a:extLst>
                <a:ext uri="{FF2B5EF4-FFF2-40B4-BE49-F238E27FC236}">
                  <a16:creationId xmlns:a16="http://schemas.microsoft.com/office/drawing/2014/main" id="{B5A36409-C0EA-4C56-BACD-C37332641014}"/>
                </a:ext>
              </a:extLst>
            </p:cNvPr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8408" y="385306"/>
              <a:ext cx="4081206" cy="3060905"/>
            </a:xfrm>
            <a:prstGeom prst="rect">
              <a:avLst/>
            </a:prstGeom>
          </p:spPr>
        </p:pic>
        <p:sp>
          <p:nvSpPr>
            <p:cNvPr id="80" name="テキスト ボックス 79">
              <a:extLst>
                <a:ext uri="{FF2B5EF4-FFF2-40B4-BE49-F238E27FC236}">
                  <a16:creationId xmlns:a16="http://schemas.microsoft.com/office/drawing/2014/main" id="{F2C1C76E-6421-42BF-9EC0-87A062B5F7FE}"/>
                </a:ext>
              </a:extLst>
            </p:cNvPr>
            <p:cNvSpPr txBox="1"/>
            <p:nvPr/>
          </p:nvSpPr>
          <p:spPr>
            <a:xfrm>
              <a:off x="418414" y="385303"/>
              <a:ext cx="1026453" cy="5884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 err="1">
                  <a:solidFill>
                    <a:schemeClr val="bg1"/>
                  </a:solidFill>
                </a:rPr>
                <a:t>Gln</a:t>
              </a:r>
              <a:r>
                <a:rPr kumimoji="1" lang="en-US" altLang="ja-JP" sz="900" dirty="0">
                  <a:solidFill>
                    <a:schemeClr val="bg1"/>
                  </a:solidFill>
                </a:rPr>
                <a:t>+</a:t>
              </a:r>
              <a:endParaRPr kumimoji="1" lang="ja-JP" altLang="en-US" sz="900" dirty="0">
                <a:solidFill>
                  <a:schemeClr val="bg1"/>
                </a:solidFill>
              </a:endParaRPr>
            </a:p>
          </p:txBody>
        </p:sp>
        <p:pic>
          <p:nvPicPr>
            <p:cNvPr id="81" name="図 80">
              <a:extLst>
                <a:ext uri="{FF2B5EF4-FFF2-40B4-BE49-F238E27FC236}">
                  <a16:creationId xmlns:a16="http://schemas.microsoft.com/office/drawing/2014/main" id="{06D365EB-1ACF-4B20-B4B9-70A64DB90F7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4593550" y="385306"/>
              <a:ext cx="4081209" cy="3060908"/>
            </a:xfrm>
            <a:prstGeom prst="rect">
              <a:avLst/>
            </a:prstGeom>
          </p:spPr>
        </p:pic>
        <p:pic>
          <p:nvPicPr>
            <p:cNvPr id="82" name="図 81">
              <a:extLst>
                <a:ext uri="{FF2B5EF4-FFF2-40B4-BE49-F238E27FC236}">
                  <a16:creationId xmlns:a16="http://schemas.microsoft.com/office/drawing/2014/main" id="{2686CB19-747C-47F1-8E0A-08995291074D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593550" y="3554462"/>
              <a:ext cx="4081204" cy="3060905"/>
            </a:xfrm>
            <a:prstGeom prst="rect">
              <a:avLst/>
            </a:prstGeom>
          </p:spPr>
        </p:pic>
        <p:sp>
          <p:nvSpPr>
            <p:cNvPr id="83" name="テキスト ボックス 82">
              <a:extLst>
                <a:ext uri="{FF2B5EF4-FFF2-40B4-BE49-F238E27FC236}">
                  <a16:creationId xmlns:a16="http://schemas.microsoft.com/office/drawing/2014/main" id="{D168A181-3FA5-44C7-B8FA-D7736EB0A772}"/>
                </a:ext>
              </a:extLst>
            </p:cNvPr>
            <p:cNvSpPr txBox="1"/>
            <p:nvPr/>
          </p:nvSpPr>
          <p:spPr>
            <a:xfrm>
              <a:off x="431021" y="3554462"/>
              <a:ext cx="969246" cy="5884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 err="1">
                  <a:solidFill>
                    <a:schemeClr val="bg1"/>
                  </a:solidFill>
                </a:rPr>
                <a:t>Gln</a:t>
              </a:r>
              <a:r>
                <a:rPr kumimoji="1" lang="en-US" altLang="ja-JP" sz="900" dirty="0">
                  <a:solidFill>
                    <a:schemeClr val="bg1"/>
                  </a:solidFill>
                </a:rPr>
                <a:t>-</a:t>
              </a:r>
              <a:endParaRPr kumimoji="1" lang="ja-JP" altLang="en-US" sz="900" dirty="0">
                <a:solidFill>
                  <a:schemeClr val="bg1"/>
                </a:solidFill>
              </a:endParaRPr>
            </a:p>
          </p:txBody>
        </p:sp>
        <p:sp>
          <p:nvSpPr>
            <p:cNvPr id="84" name="テキスト ボックス 83">
              <a:extLst>
                <a:ext uri="{FF2B5EF4-FFF2-40B4-BE49-F238E27FC236}">
                  <a16:creationId xmlns:a16="http://schemas.microsoft.com/office/drawing/2014/main" id="{0CE1FAD4-0CF0-4C25-B9A2-049332A3BAC6}"/>
                </a:ext>
              </a:extLst>
            </p:cNvPr>
            <p:cNvSpPr txBox="1"/>
            <p:nvPr/>
          </p:nvSpPr>
          <p:spPr>
            <a:xfrm>
              <a:off x="4593550" y="385303"/>
              <a:ext cx="1508628" cy="5884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 err="1">
                  <a:solidFill>
                    <a:schemeClr val="bg1"/>
                  </a:solidFill>
                </a:rPr>
                <a:t>Gln</a:t>
              </a:r>
              <a:r>
                <a:rPr kumimoji="1" lang="en-US" altLang="ja-JP" sz="900" dirty="0">
                  <a:solidFill>
                    <a:schemeClr val="bg1"/>
                  </a:solidFill>
                </a:rPr>
                <a:t>+</a:t>
              </a:r>
              <a:r>
                <a:rPr lang="en-US" altLang="ja-JP" sz="900" dirty="0">
                  <a:solidFill>
                    <a:schemeClr val="bg1"/>
                  </a:solidFill>
                </a:rPr>
                <a:t>  CQ</a:t>
              </a:r>
              <a:endParaRPr kumimoji="1" lang="ja-JP" altLang="en-US" sz="900" dirty="0">
                <a:solidFill>
                  <a:schemeClr val="bg1"/>
                </a:solidFill>
              </a:endParaRPr>
            </a:p>
          </p:txBody>
        </p:sp>
        <p:sp>
          <p:nvSpPr>
            <p:cNvPr id="85" name="テキスト ボックス 84">
              <a:extLst>
                <a:ext uri="{FF2B5EF4-FFF2-40B4-BE49-F238E27FC236}">
                  <a16:creationId xmlns:a16="http://schemas.microsoft.com/office/drawing/2014/main" id="{E48A65B4-E4AF-4BC5-A7F1-224E6365FB5E}"/>
                </a:ext>
              </a:extLst>
            </p:cNvPr>
            <p:cNvSpPr txBox="1"/>
            <p:nvPr/>
          </p:nvSpPr>
          <p:spPr>
            <a:xfrm>
              <a:off x="4593550" y="3554462"/>
              <a:ext cx="1451420" cy="5884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 err="1">
                  <a:solidFill>
                    <a:schemeClr val="bg1"/>
                  </a:solidFill>
                </a:rPr>
                <a:t>Gln</a:t>
              </a:r>
              <a:r>
                <a:rPr lang="en-US" altLang="ja-JP" sz="900" dirty="0">
                  <a:solidFill>
                    <a:schemeClr val="bg1"/>
                  </a:solidFill>
                </a:rPr>
                <a:t>-  CQ</a:t>
              </a:r>
              <a:endParaRPr kumimoji="1" lang="ja-JP" altLang="en-US" sz="900" dirty="0">
                <a:solidFill>
                  <a:schemeClr val="bg1"/>
                </a:solidFill>
              </a:endParaRPr>
            </a:p>
          </p:txBody>
        </p:sp>
        <p:pic>
          <p:nvPicPr>
            <p:cNvPr id="86" name="図 85">
              <a:extLst>
                <a:ext uri="{FF2B5EF4-FFF2-40B4-BE49-F238E27FC236}">
                  <a16:creationId xmlns:a16="http://schemas.microsoft.com/office/drawing/2014/main" id="{2888004B-D04C-4E7B-B0C1-4CBF7BB5F0E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6236" t="2833" r="4974" b="72115"/>
            <a:stretch/>
          </p:blipFill>
          <p:spPr>
            <a:xfrm>
              <a:off x="3318269" y="385303"/>
              <a:ext cx="1181352" cy="1181355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</p:pic>
        <p:pic>
          <p:nvPicPr>
            <p:cNvPr id="87" name="図 86">
              <a:extLst>
                <a:ext uri="{FF2B5EF4-FFF2-40B4-BE49-F238E27FC236}">
                  <a16:creationId xmlns:a16="http://schemas.microsoft.com/office/drawing/2014/main" id="{C4661023-5F47-4CF5-9F6F-5CDFAB50486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 cstate="print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849" t="43625" r="45359" b="31319"/>
            <a:stretch/>
          </p:blipFill>
          <p:spPr>
            <a:xfrm>
              <a:off x="7496126" y="385303"/>
              <a:ext cx="1178628" cy="1178632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88" name="図 87">
              <a:extLst>
                <a:ext uri="{FF2B5EF4-FFF2-40B4-BE49-F238E27FC236}">
                  <a16:creationId xmlns:a16="http://schemas.microsoft.com/office/drawing/2014/main" id="{F0866586-FB39-4673-81F2-CCB89B44835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 cstate="print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7262" t="36309" r="3946" b="38635"/>
            <a:stretch/>
          </p:blipFill>
          <p:spPr>
            <a:xfrm>
              <a:off x="7500904" y="3554459"/>
              <a:ext cx="1173850" cy="1173853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89" name="図 88">
              <a:extLst>
                <a:ext uri="{FF2B5EF4-FFF2-40B4-BE49-F238E27FC236}">
                  <a16:creationId xmlns:a16="http://schemas.microsoft.com/office/drawing/2014/main" id="{C4333F63-DEEA-4D22-B33B-1EE23250604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559" t="52994" r="47618" b="21906"/>
            <a:stretch/>
          </p:blipFill>
          <p:spPr>
            <a:xfrm>
              <a:off x="3306540" y="3565825"/>
              <a:ext cx="1193075" cy="1193075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</p:grp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EC27C8EC-559B-4D71-9E2F-7754FA6293A5}"/>
              </a:ext>
            </a:extLst>
          </p:cNvPr>
          <p:cNvSpPr txBox="1"/>
          <p:nvPr/>
        </p:nvSpPr>
        <p:spPr>
          <a:xfrm>
            <a:off x="3140968" y="4090084"/>
            <a:ext cx="2600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/>
              <a:t>c</a:t>
            </a:r>
            <a:endParaRPr kumimoji="1" lang="ja-JP" alt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908182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 テーマ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 テーマ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 テーマ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4024</TotalTime>
  <Words>372</Words>
  <Application>Microsoft Office PowerPoint</Application>
  <PresentationFormat>レター サイズ 8.5x11 インチ</PresentationFormat>
  <Paragraphs>177</Paragraphs>
  <Slides>5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10" baseType="lpstr">
      <vt:lpstr>ＭＳ Ｐゴシック</vt:lpstr>
      <vt:lpstr>Arial</vt:lpstr>
      <vt:lpstr>Calibri</vt:lpstr>
      <vt:lpstr>Symbol</vt:lpstr>
      <vt:lpstr>Office ​​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azuhiro Tanaka</dc:creator>
  <cp:lastModifiedBy>Tanaka</cp:lastModifiedBy>
  <cp:revision>560</cp:revision>
  <cp:lastPrinted>2020-01-23T08:46:38Z</cp:lastPrinted>
  <dcterms:created xsi:type="dcterms:W3CDTF">2014-04-30T06:51:24Z</dcterms:created>
  <dcterms:modified xsi:type="dcterms:W3CDTF">2020-12-19T02:09:49Z</dcterms:modified>
</cp:coreProperties>
</file>